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FF33CC"/>
    <a:srgbClr val="66FF33"/>
    <a:srgbClr val="92D050"/>
    <a:srgbClr val="00CCFF"/>
    <a:srgbClr val="800080"/>
    <a:srgbClr val="FFCC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2" autoAdjust="0"/>
    <p:restoredTop sz="86514" autoAdjust="0"/>
  </p:normalViewPr>
  <p:slideViewPr>
    <p:cSldViewPr snapToGrid="0" showGuides="1">
      <p:cViewPr varScale="1">
        <p:scale>
          <a:sx n="58" d="100"/>
          <a:sy n="58" d="100"/>
        </p:scale>
        <p:origin x="760" y="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Hoja_de_c_lculo_de_Microsoft_Excel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167746311578174"/>
          <c:y val="6.5165389275590166E-2"/>
          <c:w val="0.77448108139133964"/>
          <c:h val="0.7271283726520487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Hoja1!$D$5</c:f>
              <c:strCache>
                <c:ptCount val="1"/>
                <c:pt idx="0">
                  <c:v>RFU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xVal>
            <c:numRef>
              <c:f>Hoja1!$C$6:$C$31</c:f>
              <c:numCache>
                <c:formatCode>General</c:formatCode>
                <c:ptCount val="26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</c:numCache>
            </c:numRef>
          </c:xVal>
          <c:yVal>
            <c:numRef>
              <c:f>Hoja1!$D$6:$D$28</c:f>
              <c:numCache>
                <c:formatCode>General</c:formatCode>
                <c:ptCount val="23"/>
                <c:pt idx="0">
                  <c:v>3</c:v>
                </c:pt>
                <c:pt idx="1">
                  <c:v>5</c:v>
                </c:pt>
                <c:pt idx="2">
                  <c:v>3</c:v>
                </c:pt>
                <c:pt idx="3">
                  <c:v>5</c:v>
                </c:pt>
                <c:pt idx="4">
                  <c:v>3</c:v>
                </c:pt>
                <c:pt idx="5">
                  <c:v>6</c:v>
                </c:pt>
                <c:pt idx="6">
                  <c:v>3</c:v>
                </c:pt>
                <c:pt idx="7">
                  <c:v>5</c:v>
                </c:pt>
                <c:pt idx="8">
                  <c:v>3</c:v>
                </c:pt>
                <c:pt idx="9">
                  <c:v>6</c:v>
                </c:pt>
                <c:pt idx="10">
                  <c:v>3</c:v>
                </c:pt>
                <c:pt idx="11">
                  <c:v>12</c:v>
                </c:pt>
                <c:pt idx="12">
                  <c:v>35</c:v>
                </c:pt>
                <c:pt idx="13">
                  <c:v>100</c:v>
                </c:pt>
                <c:pt idx="14">
                  <c:v>280</c:v>
                </c:pt>
                <c:pt idx="15">
                  <c:v>460</c:v>
                </c:pt>
                <c:pt idx="16">
                  <c:v>640</c:v>
                </c:pt>
                <c:pt idx="17">
                  <c:v>780</c:v>
                </c:pt>
                <c:pt idx="18">
                  <c:v>860</c:v>
                </c:pt>
                <c:pt idx="19">
                  <c:v>900</c:v>
                </c:pt>
                <c:pt idx="20">
                  <c:v>930</c:v>
                </c:pt>
                <c:pt idx="21">
                  <c:v>950</c:v>
                </c:pt>
                <c:pt idx="22">
                  <c:v>96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8E7-47F6-B4AF-FD2153830E95}"/>
            </c:ext>
          </c:extLst>
        </c:ser>
        <c:ser>
          <c:idx val="1"/>
          <c:order val="1"/>
          <c:tx>
            <c:strRef>
              <c:f>Hoja1!$E$5</c:f>
              <c:strCache>
                <c:ptCount val="1"/>
              </c:strCache>
            </c:strRef>
          </c:tx>
          <c:spPr>
            <a:ln w="28575" cap="rnd">
              <a:solidFill>
                <a:srgbClr val="0000FF"/>
              </a:solidFill>
              <a:round/>
            </a:ln>
            <a:effectLst/>
          </c:spPr>
          <c:marker>
            <c:symbol val="none"/>
          </c:marker>
          <c:xVal>
            <c:numRef>
              <c:f>Hoja1!$C$6:$C$31</c:f>
              <c:numCache>
                <c:formatCode>General</c:formatCode>
                <c:ptCount val="26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</c:numCache>
            </c:numRef>
          </c:xVal>
          <c:yVal>
            <c:numRef>
              <c:f>Hoja1!$D$6:$D$31</c:f>
              <c:numCache>
                <c:formatCode>General</c:formatCode>
                <c:ptCount val="26"/>
                <c:pt idx="0">
                  <c:v>3</c:v>
                </c:pt>
                <c:pt idx="1">
                  <c:v>5</c:v>
                </c:pt>
                <c:pt idx="2">
                  <c:v>3</c:v>
                </c:pt>
                <c:pt idx="3">
                  <c:v>5</c:v>
                </c:pt>
                <c:pt idx="4">
                  <c:v>3</c:v>
                </c:pt>
                <c:pt idx="5">
                  <c:v>6</c:v>
                </c:pt>
                <c:pt idx="6">
                  <c:v>3</c:v>
                </c:pt>
                <c:pt idx="7">
                  <c:v>5</c:v>
                </c:pt>
                <c:pt idx="8">
                  <c:v>3</c:v>
                </c:pt>
                <c:pt idx="9">
                  <c:v>6</c:v>
                </c:pt>
                <c:pt idx="10">
                  <c:v>3</c:v>
                </c:pt>
                <c:pt idx="11">
                  <c:v>12</c:v>
                </c:pt>
                <c:pt idx="12">
                  <c:v>35</c:v>
                </c:pt>
                <c:pt idx="13">
                  <c:v>100</c:v>
                </c:pt>
                <c:pt idx="14">
                  <c:v>280</c:v>
                </c:pt>
                <c:pt idx="15">
                  <c:v>460</c:v>
                </c:pt>
                <c:pt idx="16">
                  <c:v>640</c:v>
                </c:pt>
                <c:pt idx="17">
                  <c:v>780</c:v>
                </c:pt>
                <c:pt idx="18">
                  <c:v>860</c:v>
                </c:pt>
                <c:pt idx="19">
                  <c:v>900</c:v>
                </c:pt>
                <c:pt idx="20">
                  <c:v>930</c:v>
                </c:pt>
                <c:pt idx="21">
                  <c:v>950</c:v>
                </c:pt>
                <c:pt idx="22">
                  <c:v>960</c:v>
                </c:pt>
                <c:pt idx="23">
                  <c:v>965</c:v>
                </c:pt>
                <c:pt idx="24">
                  <c:v>965</c:v>
                </c:pt>
                <c:pt idx="25">
                  <c:v>9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8E7-47F6-B4AF-FD2153830E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84991136"/>
        <c:axId val="1384993632"/>
      </c:scatterChart>
      <c:valAx>
        <c:axId val="1384991136"/>
        <c:scaling>
          <c:orientation val="minMax"/>
          <c:max val="44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prstDash val="sysDot"/>
              <a:round/>
            </a:ln>
            <a:effectLst/>
          </c:spPr>
        </c:majorGridlines>
        <c:numFmt formatCode="General" sourceLinked="0"/>
        <c:majorTickMark val="none"/>
        <c:minorTickMark val="out"/>
        <c:tickLblPos val="low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84993632"/>
        <c:crossesAt val="0"/>
        <c:crossBetween val="midCat"/>
      </c:valAx>
      <c:valAx>
        <c:axId val="1384993632"/>
        <c:scaling>
          <c:orientation val="minMax"/>
          <c:max val="1000"/>
          <c:min val="-10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sysDot"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84991136"/>
        <c:crosses val="autoZero"/>
        <c:crossBetween val="midCat"/>
        <c:majorUnit val="150"/>
      </c:valAx>
      <c:spPr>
        <a:noFill/>
        <a:ln w="952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C09816-0EB5-4A6C-B1C9-445D85CB2EDC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74DB66-5B4D-4FBC-9E05-A09EA126162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4821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74DB66-5B4D-4FBC-9E05-A09EA126162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1008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45443-7500-48D8-8C13-3298BD7EB13C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18B0-8178-417A-9112-438DE98AFC6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439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45443-7500-48D8-8C13-3298BD7EB13C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18B0-8178-417A-9112-438DE98AFC6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480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45443-7500-48D8-8C13-3298BD7EB13C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18B0-8178-417A-9112-438DE98AFC6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8729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45443-7500-48D8-8C13-3298BD7EB13C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18B0-8178-417A-9112-438DE98AFC6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987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45443-7500-48D8-8C13-3298BD7EB13C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18B0-8178-417A-9112-438DE98AFC6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7490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45443-7500-48D8-8C13-3298BD7EB13C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18B0-8178-417A-9112-438DE98AFC6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4295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45443-7500-48D8-8C13-3298BD7EB13C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18B0-8178-417A-9112-438DE98AFC6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908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45443-7500-48D8-8C13-3298BD7EB13C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18B0-8178-417A-9112-438DE98AFC6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231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45443-7500-48D8-8C13-3298BD7EB13C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18B0-8178-417A-9112-438DE98AFC6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06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45443-7500-48D8-8C13-3298BD7EB13C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18B0-8178-417A-9112-438DE98AFC6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127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45443-7500-48D8-8C13-3298BD7EB13C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18B0-8178-417A-9112-438DE98AFC6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939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45443-7500-48D8-8C13-3298BD7EB13C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9218B0-8178-417A-9112-438DE98AFC6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902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Forma libre 218"/>
          <p:cNvSpPr/>
          <p:nvPr/>
        </p:nvSpPr>
        <p:spPr>
          <a:xfrm>
            <a:off x="1193731" y="4058723"/>
            <a:ext cx="1245727" cy="631825"/>
          </a:xfrm>
          <a:custGeom>
            <a:avLst/>
            <a:gdLst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59267 h 795867"/>
              <a:gd name="connsiteX12" fmla="*/ 1176935 w 1193869"/>
              <a:gd name="connsiteY12" fmla="*/ 0 h 795867"/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59267 h 795867"/>
              <a:gd name="connsiteX12" fmla="*/ 1176935 w 1193869"/>
              <a:gd name="connsiteY12" fmla="*/ 0 h 795867"/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59267 h 795867"/>
              <a:gd name="connsiteX12" fmla="*/ 1176935 w 1193869"/>
              <a:gd name="connsiteY12" fmla="*/ 0 h 795867"/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59267 h 795867"/>
              <a:gd name="connsiteX12" fmla="*/ 1176935 w 1193869"/>
              <a:gd name="connsiteY12" fmla="*/ 0 h 795867"/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59267 h 795867"/>
              <a:gd name="connsiteX12" fmla="*/ 1176935 w 1193869"/>
              <a:gd name="connsiteY12" fmla="*/ 0 h 795867"/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59267 h 795867"/>
              <a:gd name="connsiteX12" fmla="*/ 1176935 w 1193869"/>
              <a:gd name="connsiteY12" fmla="*/ 0 h 795867"/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118534 h 795867"/>
              <a:gd name="connsiteX12" fmla="*/ 1176935 w 1193869"/>
              <a:gd name="connsiteY12" fmla="*/ 0 h 795867"/>
              <a:gd name="connsiteX0" fmla="*/ 42402 w 1193869"/>
              <a:gd name="connsiteY0" fmla="*/ 804647 h 804647"/>
              <a:gd name="connsiteX1" fmla="*/ 42402 w 1193869"/>
              <a:gd name="connsiteY1" fmla="*/ 804647 h 804647"/>
              <a:gd name="connsiteX2" fmla="*/ 8535 w 1193869"/>
              <a:gd name="connsiteY2" fmla="*/ 728447 h 804647"/>
              <a:gd name="connsiteX3" fmla="*/ 69 w 1193869"/>
              <a:gd name="connsiteY3" fmla="*/ 576047 h 804647"/>
              <a:gd name="connsiteX4" fmla="*/ 69 w 1193869"/>
              <a:gd name="connsiteY4" fmla="*/ 576047 h 804647"/>
              <a:gd name="connsiteX5" fmla="*/ 25469 w 1193869"/>
              <a:gd name="connsiteY5" fmla="*/ 457513 h 804647"/>
              <a:gd name="connsiteX6" fmla="*/ 101669 w 1193869"/>
              <a:gd name="connsiteY6" fmla="*/ 338980 h 804647"/>
              <a:gd name="connsiteX7" fmla="*/ 304869 w 1193869"/>
              <a:gd name="connsiteY7" fmla="*/ 279713 h 804647"/>
              <a:gd name="connsiteX8" fmla="*/ 635069 w 1193869"/>
              <a:gd name="connsiteY8" fmla="*/ 440580 h 804647"/>
              <a:gd name="connsiteX9" fmla="*/ 999135 w 1193869"/>
              <a:gd name="connsiteY9" fmla="*/ 465980 h 804647"/>
              <a:gd name="connsiteX10" fmla="*/ 1143069 w 1193869"/>
              <a:gd name="connsiteY10" fmla="*/ 313580 h 804647"/>
              <a:gd name="connsiteX11" fmla="*/ 1193869 w 1193869"/>
              <a:gd name="connsiteY11" fmla="*/ 127314 h 804647"/>
              <a:gd name="connsiteX12" fmla="*/ 1176935 w 1193869"/>
              <a:gd name="connsiteY12" fmla="*/ 8780 h 804647"/>
              <a:gd name="connsiteX13" fmla="*/ 1172702 w 1193869"/>
              <a:gd name="connsiteY13" fmla="*/ 8780 h 804647"/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118534 h 795867"/>
              <a:gd name="connsiteX12" fmla="*/ 1176935 w 1193869"/>
              <a:gd name="connsiteY12" fmla="*/ 0 h 795867"/>
              <a:gd name="connsiteX0" fmla="*/ 42402 w 1193869"/>
              <a:gd name="connsiteY0" fmla="*/ 677333 h 677333"/>
              <a:gd name="connsiteX1" fmla="*/ 42402 w 1193869"/>
              <a:gd name="connsiteY1" fmla="*/ 677333 h 677333"/>
              <a:gd name="connsiteX2" fmla="*/ 8535 w 1193869"/>
              <a:gd name="connsiteY2" fmla="*/ 601133 h 677333"/>
              <a:gd name="connsiteX3" fmla="*/ 69 w 1193869"/>
              <a:gd name="connsiteY3" fmla="*/ 448733 h 677333"/>
              <a:gd name="connsiteX4" fmla="*/ 69 w 1193869"/>
              <a:gd name="connsiteY4" fmla="*/ 448733 h 677333"/>
              <a:gd name="connsiteX5" fmla="*/ 25469 w 1193869"/>
              <a:gd name="connsiteY5" fmla="*/ 330199 h 677333"/>
              <a:gd name="connsiteX6" fmla="*/ 101669 w 1193869"/>
              <a:gd name="connsiteY6" fmla="*/ 211666 h 677333"/>
              <a:gd name="connsiteX7" fmla="*/ 304869 w 1193869"/>
              <a:gd name="connsiteY7" fmla="*/ 152399 h 677333"/>
              <a:gd name="connsiteX8" fmla="*/ 635069 w 1193869"/>
              <a:gd name="connsiteY8" fmla="*/ 313266 h 677333"/>
              <a:gd name="connsiteX9" fmla="*/ 999135 w 1193869"/>
              <a:gd name="connsiteY9" fmla="*/ 338666 h 677333"/>
              <a:gd name="connsiteX10" fmla="*/ 1143069 w 1193869"/>
              <a:gd name="connsiteY10" fmla="*/ 186266 h 677333"/>
              <a:gd name="connsiteX11" fmla="*/ 1193869 w 1193869"/>
              <a:gd name="connsiteY11" fmla="*/ 0 h 677333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99135 w 1236202"/>
              <a:gd name="connsiteY9" fmla="*/ 2963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2294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45727"/>
              <a:gd name="connsiteY0" fmla="*/ 631825 h 631825"/>
              <a:gd name="connsiteX1" fmla="*/ 42402 w 1245727"/>
              <a:gd name="connsiteY1" fmla="*/ 631825 h 631825"/>
              <a:gd name="connsiteX2" fmla="*/ 8535 w 1245727"/>
              <a:gd name="connsiteY2" fmla="*/ 555625 h 631825"/>
              <a:gd name="connsiteX3" fmla="*/ 69 w 1245727"/>
              <a:gd name="connsiteY3" fmla="*/ 403225 h 631825"/>
              <a:gd name="connsiteX4" fmla="*/ 69 w 1245727"/>
              <a:gd name="connsiteY4" fmla="*/ 403225 h 631825"/>
              <a:gd name="connsiteX5" fmla="*/ 22294 w 1245727"/>
              <a:gd name="connsiteY5" fmla="*/ 284691 h 631825"/>
              <a:gd name="connsiteX6" fmla="*/ 101669 w 1245727"/>
              <a:gd name="connsiteY6" fmla="*/ 166158 h 631825"/>
              <a:gd name="connsiteX7" fmla="*/ 304869 w 1245727"/>
              <a:gd name="connsiteY7" fmla="*/ 106891 h 631825"/>
              <a:gd name="connsiteX8" fmla="*/ 635069 w 1245727"/>
              <a:gd name="connsiteY8" fmla="*/ 267758 h 631825"/>
              <a:gd name="connsiteX9" fmla="*/ 939868 w 1245727"/>
              <a:gd name="connsiteY9" fmla="*/ 305858 h 631825"/>
              <a:gd name="connsiteX10" fmla="*/ 1143069 w 1245727"/>
              <a:gd name="connsiteY10" fmla="*/ 140758 h 631825"/>
              <a:gd name="connsiteX11" fmla="*/ 1245727 w 1245727"/>
              <a:gd name="connsiteY11" fmla="*/ 0 h 631825"/>
              <a:gd name="connsiteX0" fmla="*/ 42402 w 1245727"/>
              <a:gd name="connsiteY0" fmla="*/ 631825 h 631825"/>
              <a:gd name="connsiteX1" fmla="*/ 42402 w 1245727"/>
              <a:gd name="connsiteY1" fmla="*/ 631825 h 631825"/>
              <a:gd name="connsiteX2" fmla="*/ 8535 w 1245727"/>
              <a:gd name="connsiteY2" fmla="*/ 555625 h 631825"/>
              <a:gd name="connsiteX3" fmla="*/ 69 w 1245727"/>
              <a:gd name="connsiteY3" fmla="*/ 403225 h 631825"/>
              <a:gd name="connsiteX4" fmla="*/ 69 w 1245727"/>
              <a:gd name="connsiteY4" fmla="*/ 403225 h 631825"/>
              <a:gd name="connsiteX5" fmla="*/ 22294 w 1245727"/>
              <a:gd name="connsiteY5" fmla="*/ 284691 h 631825"/>
              <a:gd name="connsiteX6" fmla="*/ 101669 w 1245727"/>
              <a:gd name="connsiteY6" fmla="*/ 166158 h 631825"/>
              <a:gd name="connsiteX7" fmla="*/ 304869 w 1245727"/>
              <a:gd name="connsiteY7" fmla="*/ 106891 h 631825"/>
              <a:gd name="connsiteX8" fmla="*/ 635069 w 1245727"/>
              <a:gd name="connsiteY8" fmla="*/ 267758 h 631825"/>
              <a:gd name="connsiteX9" fmla="*/ 939868 w 1245727"/>
              <a:gd name="connsiteY9" fmla="*/ 305858 h 631825"/>
              <a:gd name="connsiteX10" fmla="*/ 1143069 w 1245727"/>
              <a:gd name="connsiteY10" fmla="*/ 140758 h 631825"/>
              <a:gd name="connsiteX11" fmla="*/ 1245727 w 1245727"/>
              <a:gd name="connsiteY11" fmla="*/ 0 h 631825"/>
              <a:gd name="connsiteX0" fmla="*/ 42402 w 1245727"/>
              <a:gd name="connsiteY0" fmla="*/ 631825 h 631825"/>
              <a:gd name="connsiteX1" fmla="*/ 42402 w 1245727"/>
              <a:gd name="connsiteY1" fmla="*/ 631825 h 631825"/>
              <a:gd name="connsiteX2" fmla="*/ 8535 w 1245727"/>
              <a:gd name="connsiteY2" fmla="*/ 555625 h 631825"/>
              <a:gd name="connsiteX3" fmla="*/ 69 w 1245727"/>
              <a:gd name="connsiteY3" fmla="*/ 403225 h 631825"/>
              <a:gd name="connsiteX4" fmla="*/ 69 w 1245727"/>
              <a:gd name="connsiteY4" fmla="*/ 403225 h 631825"/>
              <a:gd name="connsiteX5" fmla="*/ 22294 w 1245727"/>
              <a:gd name="connsiteY5" fmla="*/ 284691 h 631825"/>
              <a:gd name="connsiteX6" fmla="*/ 101669 w 1245727"/>
              <a:gd name="connsiteY6" fmla="*/ 166158 h 631825"/>
              <a:gd name="connsiteX7" fmla="*/ 304869 w 1245727"/>
              <a:gd name="connsiteY7" fmla="*/ 106891 h 631825"/>
              <a:gd name="connsiteX8" fmla="*/ 635069 w 1245727"/>
              <a:gd name="connsiteY8" fmla="*/ 267758 h 631825"/>
              <a:gd name="connsiteX9" fmla="*/ 939868 w 1245727"/>
              <a:gd name="connsiteY9" fmla="*/ 305858 h 631825"/>
              <a:gd name="connsiteX10" fmla="*/ 1143069 w 1245727"/>
              <a:gd name="connsiteY10" fmla="*/ 140758 h 631825"/>
              <a:gd name="connsiteX11" fmla="*/ 1245727 w 1245727"/>
              <a:gd name="connsiteY11" fmla="*/ 0 h 6318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1245727" h="631825">
                <a:moveTo>
                  <a:pt x="42402" y="631825"/>
                </a:moveTo>
                <a:lnTo>
                  <a:pt x="42402" y="631825"/>
                </a:lnTo>
                <a:cubicBezTo>
                  <a:pt x="31113" y="606425"/>
                  <a:pt x="14973" y="582665"/>
                  <a:pt x="8535" y="555625"/>
                </a:cubicBezTo>
                <a:cubicBezTo>
                  <a:pt x="-1337" y="514162"/>
                  <a:pt x="69" y="449636"/>
                  <a:pt x="69" y="403225"/>
                </a:cubicBezTo>
                <a:lnTo>
                  <a:pt x="69" y="403225"/>
                </a:lnTo>
                <a:cubicBezTo>
                  <a:pt x="3773" y="383469"/>
                  <a:pt x="3244" y="328965"/>
                  <a:pt x="22294" y="284691"/>
                </a:cubicBezTo>
                <a:cubicBezTo>
                  <a:pt x="41344" y="240417"/>
                  <a:pt x="54573" y="195791"/>
                  <a:pt x="101669" y="166158"/>
                </a:cubicBezTo>
                <a:cubicBezTo>
                  <a:pt x="148765" y="136525"/>
                  <a:pt x="215969" y="89958"/>
                  <a:pt x="304869" y="106891"/>
                </a:cubicBezTo>
                <a:cubicBezTo>
                  <a:pt x="393769" y="123824"/>
                  <a:pt x="529236" y="234597"/>
                  <a:pt x="635069" y="267758"/>
                </a:cubicBezTo>
                <a:cubicBezTo>
                  <a:pt x="740902" y="300919"/>
                  <a:pt x="811457" y="352425"/>
                  <a:pt x="939868" y="305858"/>
                </a:cubicBezTo>
                <a:cubicBezTo>
                  <a:pt x="1068279" y="259291"/>
                  <a:pt x="1092093" y="191734"/>
                  <a:pt x="1143069" y="140758"/>
                </a:cubicBezTo>
                <a:cubicBezTo>
                  <a:pt x="1194046" y="89782"/>
                  <a:pt x="1222621" y="50800"/>
                  <a:pt x="1245727" y="0"/>
                </a:cubicBezTo>
              </a:path>
            </a:pathLst>
          </a:custGeom>
          <a:noFill/>
          <a:ln w="88900"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0" name="Forma libre 219"/>
          <p:cNvSpPr/>
          <p:nvPr/>
        </p:nvSpPr>
        <p:spPr>
          <a:xfrm>
            <a:off x="1265165" y="4093647"/>
            <a:ext cx="1237792" cy="566737"/>
          </a:xfrm>
          <a:custGeom>
            <a:avLst/>
            <a:gdLst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59267 h 795867"/>
              <a:gd name="connsiteX12" fmla="*/ 1176935 w 1193869"/>
              <a:gd name="connsiteY12" fmla="*/ 0 h 795867"/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59267 h 795867"/>
              <a:gd name="connsiteX12" fmla="*/ 1176935 w 1193869"/>
              <a:gd name="connsiteY12" fmla="*/ 0 h 795867"/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59267 h 795867"/>
              <a:gd name="connsiteX12" fmla="*/ 1176935 w 1193869"/>
              <a:gd name="connsiteY12" fmla="*/ 0 h 795867"/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59267 h 795867"/>
              <a:gd name="connsiteX12" fmla="*/ 1176935 w 1193869"/>
              <a:gd name="connsiteY12" fmla="*/ 0 h 795867"/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59267 h 795867"/>
              <a:gd name="connsiteX12" fmla="*/ 1176935 w 1193869"/>
              <a:gd name="connsiteY12" fmla="*/ 0 h 795867"/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59267 h 795867"/>
              <a:gd name="connsiteX12" fmla="*/ 1176935 w 1193869"/>
              <a:gd name="connsiteY12" fmla="*/ 0 h 795867"/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118534 h 795867"/>
              <a:gd name="connsiteX12" fmla="*/ 1176935 w 1193869"/>
              <a:gd name="connsiteY12" fmla="*/ 0 h 795867"/>
              <a:gd name="connsiteX0" fmla="*/ 42402 w 1193869"/>
              <a:gd name="connsiteY0" fmla="*/ 804647 h 804647"/>
              <a:gd name="connsiteX1" fmla="*/ 42402 w 1193869"/>
              <a:gd name="connsiteY1" fmla="*/ 804647 h 804647"/>
              <a:gd name="connsiteX2" fmla="*/ 8535 w 1193869"/>
              <a:gd name="connsiteY2" fmla="*/ 728447 h 804647"/>
              <a:gd name="connsiteX3" fmla="*/ 69 w 1193869"/>
              <a:gd name="connsiteY3" fmla="*/ 576047 h 804647"/>
              <a:gd name="connsiteX4" fmla="*/ 69 w 1193869"/>
              <a:gd name="connsiteY4" fmla="*/ 576047 h 804647"/>
              <a:gd name="connsiteX5" fmla="*/ 25469 w 1193869"/>
              <a:gd name="connsiteY5" fmla="*/ 457513 h 804647"/>
              <a:gd name="connsiteX6" fmla="*/ 101669 w 1193869"/>
              <a:gd name="connsiteY6" fmla="*/ 338980 h 804647"/>
              <a:gd name="connsiteX7" fmla="*/ 304869 w 1193869"/>
              <a:gd name="connsiteY7" fmla="*/ 279713 h 804647"/>
              <a:gd name="connsiteX8" fmla="*/ 635069 w 1193869"/>
              <a:gd name="connsiteY8" fmla="*/ 440580 h 804647"/>
              <a:gd name="connsiteX9" fmla="*/ 999135 w 1193869"/>
              <a:gd name="connsiteY9" fmla="*/ 465980 h 804647"/>
              <a:gd name="connsiteX10" fmla="*/ 1143069 w 1193869"/>
              <a:gd name="connsiteY10" fmla="*/ 313580 h 804647"/>
              <a:gd name="connsiteX11" fmla="*/ 1193869 w 1193869"/>
              <a:gd name="connsiteY11" fmla="*/ 127314 h 804647"/>
              <a:gd name="connsiteX12" fmla="*/ 1176935 w 1193869"/>
              <a:gd name="connsiteY12" fmla="*/ 8780 h 804647"/>
              <a:gd name="connsiteX13" fmla="*/ 1172702 w 1193869"/>
              <a:gd name="connsiteY13" fmla="*/ 8780 h 804647"/>
              <a:gd name="connsiteX0" fmla="*/ 42402 w 1193869"/>
              <a:gd name="connsiteY0" fmla="*/ 795867 h 795867"/>
              <a:gd name="connsiteX1" fmla="*/ 42402 w 1193869"/>
              <a:gd name="connsiteY1" fmla="*/ 795867 h 795867"/>
              <a:gd name="connsiteX2" fmla="*/ 8535 w 1193869"/>
              <a:gd name="connsiteY2" fmla="*/ 719667 h 795867"/>
              <a:gd name="connsiteX3" fmla="*/ 69 w 1193869"/>
              <a:gd name="connsiteY3" fmla="*/ 567267 h 795867"/>
              <a:gd name="connsiteX4" fmla="*/ 69 w 1193869"/>
              <a:gd name="connsiteY4" fmla="*/ 567267 h 795867"/>
              <a:gd name="connsiteX5" fmla="*/ 25469 w 1193869"/>
              <a:gd name="connsiteY5" fmla="*/ 448733 h 795867"/>
              <a:gd name="connsiteX6" fmla="*/ 101669 w 1193869"/>
              <a:gd name="connsiteY6" fmla="*/ 330200 h 795867"/>
              <a:gd name="connsiteX7" fmla="*/ 304869 w 1193869"/>
              <a:gd name="connsiteY7" fmla="*/ 270933 h 795867"/>
              <a:gd name="connsiteX8" fmla="*/ 635069 w 1193869"/>
              <a:gd name="connsiteY8" fmla="*/ 431800 h 795867"/>
              <a:gd name="connsiteX9" fmla="*/ 999135 w 1193869"/>
              <a:gd name="connsiteY9" fmla="*/ 457200 h 795867"/>
              <a:gd name="connsiteX10" fmla="*/ 1143069 w 1193869"/>
              <a:gd name="connsiteY10" fmla="*/ 304800 h 795867"/>
              <a:gd name="connsiteX11" fmla="*/ 1193869 w 1193869"/>
              <a:gd name="connsiteY11" fmla="*/ 118534 h 795867"/>
              <a:gd name="connsiteX12" fmla="*/ 1176935 w 1193869"/>
              <a:gd name="connsiteY12" fmla="*/ 0 h 795867"/>
              <a:gd name="connsiteX0" fmla="*/ 42402 w 1193869"/>
              <a:gd name="connsiteY0" fmla="*/ 677333 h 677333"/>
              <a:gd name="connsiteX1" fmla="*/ 42402 w 1193869"/>
              <a:gd name="connsiteY1" fmla="*/ 677333 h 677333"/>
              <a:gd name="connsiteX2" fmla="*/ 8535 w 1193869"/>
              <a:gd name="connsiteY2" fmla="*/ 601133 h 677333"/>
              <a:gd name="connsiteX3" fmla="*/ 69 w 1193869"/>
              <a:gd name="connsiteY3" fmla="*/ 448733 h 677333"/>
              <a:gd name="connsiteX4" fmla="*/ 69 w 1193869"/>
              <a:gd name="connsiteY4" fmla="*/ 448733 h 677333"/>
              <a:gd name="connsiteX5" fmla="*/ 25469 w 1193869"/>
              <a:gd name="connsiteY5" fmla="*/ 330199 h 677333"/>
              <a:gd name="connsiteX6" fmla="*/ 101669 w 1193869"/>
              <a:gd name="connsiteY6" fmla="*/ 211666 h 677333"/>
              <a:gd name="connsiteX7" fmla="*/ 304869 w 1193869"/>
              <a:gd name="connsiteY7" fmla="*/ 152399 h 677333"/>
              <a:gd name="connsiteX8" fmla="*/ 635069 w 1193869"/>
              <a:gd name="connsiteY8" fmla="*/ 313266 h 677333"/>
              <a:gd name="connsiteX9" fmla="*/ 999135 w 1193869"/>
              <a:gd name="connsiteY9" fmla="*/ 338666 h 677333"/>
              <a:gd name="connsiteX10" fmla="*/ 1143069 w 1193869"/>
              <a:gd name="connsiteY10" fmla="*/ 186266 h 677333"/>
              <a:gd name="connsiteX11" fmla="*/ 1193869 w 1193869"/>
              <a:gd name="connsiteY11" fmla="*/ 0 h 677333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99135 w 1236202"/>
              <a:gd name="connsiteY9" fmla="*/ 2963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36202"/>
              <a:gd name="connsiteY0" fmla="*/ 635000 h 635000"/>
              <a:gd name="connsiteX1" fmla="*/ 42402 w 1236202"/>
              <a:gd name="connsiteY1" fmla="*/ 635000 h 635000"/>
              <a:gd name="connsiteX2" fmla="*/ 8535 w 1236202"/>
              <a:gd name="connsiteY2" fmla="*/ 558800 h 635000"/>
              <a:gd name="connsiteX3" fmla="*/ 69 w 1236202"/>
              <a:gd name="connsiteY3" fmla="*/ 406400 h 635000"/>
              <a:gd name="connsiteX4" fmla="*/ 69 w 1236202"/>
              <a:gd name="connsiteY4" fmla="*/ 406400 h 635000"/>
              <a:gd name="connsiteX5" fmla="*/ 25469 w 1236202"/>
              <a:gd name="connsiteY5" fmla="*/ 287866 h 635000"/>
              <a:gd name="connsiteX6" fmla="*/ 101669 w 1236202"/>
              <a:gd name="connsiteY6" fmla="*/ 169333 h 635000"/>
              <a:gd name="connsiteX7" fmla="*/ 304869 w 1236202"/>
              <a:gd name="connsiteY7" fmla="*/ 110066 h 635000"/>
              <a:gd name="connsiteX8" fmla="*/ 635069 w 1236202"/>
              <a:gd name="connsiteY8" fmla="*/ 270933 h 635000"/>
              <a:gd name="connsiteX9" fmla="*/ 939868 w 1236202"/>
              <a:gd name="connsiteY9" fmla="*/ 309033 h 635000"/>
              <a:gd name="connsiteX10" fmla="*/ 1143069 w 1236202"/>
              <a:gd name="connsiteY10" fmla="*/ 143933 h 635000"/>
              <a:gd name="connsiteX11" fmla="*/ 1236202 w 1236202"/>
              <a:gd name="connsiteY11" fmla="*/ 0 h 635000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101669 w 1248131"/>
              <a:gd name="connsiteY6" fmla="*/ 167725 h 633392"/>
              <a:gd name="connsiteX7" fmla="*/ 304869 w 1248131"/>
              <a:gd name="connsiteY7" fmla="*/ 108458 h 633392"/>
              <a:gd name="connsiteX8" fmla="*/ 635069 w 1248131"/>
              <a:gd name="connsiteY8" fmla="*/ 269325 h 633392"/>
              <a:gd name="connsiteX9" fmla="*/ 939868 w 1248131"/>
              <a:gd name="connsiteY9" fmla="*/ 307425 h 633392"/>
              <a:gd name="connsiteX10" fmla="*/ 1143069 w 1248131"/>
              <a:gd name="connsiteY10" fmla="*/ 142325 h 633392"/>
              <a:gd name="connsiteX11" fmla="*/ 1248131 w 1248131"/>
              <a:gd name="connsiteY11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101669 w 1248131"/>
              <a:gd name="connsiteY6" fmla="*/ 167725 h 633392"/>
              <a:gd name="connsiteX7" fmla="*/ 304869 w 1248131"/>
              <a:gd name="connsiteY7" fmla="*/ 108458 h 633392"/>
              <a:gd name="connsiteX8" fmla="*/ 635069 w 1248131"/>
              <a:gd name="connsiteY8" fmla="*/ 269325 h 633392"/>
              <a:gd name="connsiteX9" fmla="*/ 939868 w 1248131"/>
              <a:gd name="connsiteY9" fmla="*/ 307425 h 633392"/>
              <a:gd name="connsiteX10" fmla="*/ 1143069 w 1248131"/>
              <a:gd name="connsiteY10" fmla="*/ 142325 h 633392"/>
              <a:gd name="connsiteX11" fmla="*/ 1248131 w 1248131"/>
              <a:gd name="connsiteY11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101669 w 1248131"/>
              <a:gd name="connsiteY6" fmla="*/ 167725 h 633392"/>
              <a:gd name="connsiteX7" fmla="*/ 345205 w 1248131"/>
              <a:gd name="connsiteY7" fmla="*/ 163000 h 633392"/>
              <a:gd name="connsiteX8" fmla="*/ 635069 w 1248131"/>
              <a:gd name="connsiteY8" fmla="*/ 269325 h 633392"/>
              <a:gd name="connsiteX9" fmla="*/ 939868 w 1248131"/>
              <a:gd name="connsiteY9" fmla="*/ 307425 h 633392"/>
              <a:gd name="connsiteX10" fmla="*/ 1143069 w 1248131"/>
              <a:gd name="connsiteY10" fmla="*/ 142325 h 633392"/>
              <a:gd name="connsiteX11" fmla="*/ 1248131 w 1248131"/>
              <a:gd name="connsiteY11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120961 w 1248131"/>
              <a:gd name="connsiteY6" fmla="*/ 180042 h 633392"/>
              <a:gd name="connsiteX7" fmla="*/ 345205 w 1248131"/>
              <a:gd name="connsiteY7" fmla="*/ 163000 h 633392"/>
              <a:gd name="connsiteX8" fmla="*/ 635069 w 1248131"/>
              <a:gd name="connsiteY8" fmla="*/ 269325 h 633392"/>
              <a:gd name="connsiteX9" fmla="*/ 939868 w 1248131"/>
              <a:gd name="connsiteY9" fmla="*/ 307425 h 633392"/>
              <a:gd name="connsiteX10" fmla="*/ 1143069 w 1248131"/>
              <a:gd name="connsiteY10" fmla="*/ 142325 h 633392"/>
              <a:gd name="connsiteX11" fmla="*/ 1248131 w 1248131"/>
              <a:gd name="connsiteY11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126221 w 1248131"/>
              <a:gd name="connsiteY6" fmla="*/ 185320 h 633392"/>
              <a:gd name="connsiteX7" fmla="*/ 345205 w 1248131"/>
              <a:gd name="connsiteY7" fmla="*/ 163000 h 633392"/>
              <a:gd name="connsiteX8" fmla="*/ 635069 w 1248131"/>
              <a:gd name="connsiteY8" fmla="*/ 269325 h 633392"/>
              <a:gd name="connsiteX9" fmla="*/ 939868 w 1248131"/>
              <a:gd name="connsiteY9" fmla="*/ 307425 h 633392"/>
              <a:gd name="connsiteX10" fmla="*/ 1143069 w 1248131"/>
              <a:gd name="connsiteY10" fmla="*/ 142325 h 633392"/>
              <a:gd name="connsiteX11" fmla="*/ 1248131 w 1248131"/>
              <a:gd name="connsiteY11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126221 w 1248131"/>
              <a:gd name="connsiteY6" fmla="*/ 185320 h 633392"/>
              <a:gd name="connsiteX7" fmla="*/ 346959 w 1248131"/>
              <a:gd name="connsiteY7" fmla="*/ 201707 h 633392"/>
              <a:gd name="connsiteX8" fmla="*/ 635069 w 1248131"/>
              <a:gd name="connsiteY8" fmla="*/ 269325 h 633392"/>
              <a:gd name="connsiteX9" fmla="*/ 939868 w 1248131"/>
              <a:gd name="connsiteY9" fmla="*/ 307425 h 633392"/>
              <a:gd name="connsiteX10" fmla="*/ 1143069 w 1248131"/>
              <a:gd name="connsiteY10" fmla="*/ 142325 h 633392"/>
              <a:gd name="connsiteX11" fmla="*/ 1248131 w 1248131"/>
              <a:gd name="connsiteY11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126221 w 1248131"/>
              <a:gd name="connsiteY6" fmla="*/ 185320 h 633392"/>
              <a:gd name="connsiteX7" fmla="*/ 346959 w 1248131"/>
              <a:gd name="connsiteY7" fmla="*/ 201707 h 633392"/>
              <a:gd name="connsiteX8" fmla="*/ 635069 w 1248131"/>
              <a:gd name="connsiteY8" fmla="*/ 269325 h 633392"/>
              <a:gd name="connsiteX9" fmla="*/ 939868 w 1248131"/>
              <a:gd name="connsiteY9" fmla="*/ 307425 h 633392"/>
              <a:gd name="connsiteX10" fmla="*/ 1143069 w 1248131"/>
              <a:gd name="connsiteY10" fmla="*/ 142325 h 633392"/>
              <a:gd name="connsiteX11" fmla="*/ 1248131 w 1248131"/>
              <a:gd name="connsiteY11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126221 w 1248131"/>
              <a:gd name="connsiteY6" fmla="*/ 185320 h 633392"/>
              <a:gd name="connsiteX7" fmla="*/ 346959 w 1248131"/>
              <a:gd name="connsiteY7" fmla="*/ 201707 h 633392"/>
              <a:gd name="connsiteX8" fmla="*/ 635069 w 1248131"/>
              <a:gd name="connsiteY8" fmla="*/ 269325 h 633392"/>
              <a:gd name="connsiteX9" fmla="*/ 939868 w 1248131"/>
              <a:gd name="connsiteY9" fmla="*/ 307425 h 633392"/>
              <a:gd name="connsiteX10" fmla="*/ 1143069 w 1248131"/>
              <a:gd name="connsiteY10" fmla="*/ 142325 h 633392"/>
              <a:gd name="connsiteX11" fmla="*/ 1248131 w 1248131"/>
              <a:gd name="connsiteY11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136743 w 1248131"/>
              <a:gd name="connsiteY6" fmla="*/ 187080 h 633392"/>
              <a:gd name="connsiteX7" fmla="*/ 346959 w 1248131"/>
              <a:gd name="connsiteY7" fmla="*/ 201707 h 633392"/>
              <a:gd name="connsiteX8" fmla="*/ 635069 w 1248131"/>
              <a:gd name="connsiteY8" fmla="*/ 269325 h 633392"/>
              <a:gd name="connsiteX9" fmla="*/ 939868 w 1248131"/>
              <a:gd name="connsiteY9" fmla="*/ 307425 h 633392"/>
              <a:gd name="connsiteX10" fmla="*/ 1143069 w 1248131"/>
              <a:gd name="connsiteY10" fmla="*/ 142325 h 633392"/>
              <a:gd name="connsiteX11" fmla="*/ 1248131 w 1248131"/>
              <a:gd name="connsiteY11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136743 w 1248131"/>
              <a:gd name="connsiteY6" fmla="*/ 187080 h 633392"/>
              <a:gd name="connsiteX7" fmla="*/ 346959 w 1248131"/>
              <a:gd name="connsiteY7" fmla="*/ 201707 h 633392"/>
              <a:gd name="connsiteX8" fmla="*/ 635069 w 1248131"/>
              <a:gd name="connsiteY8" fmla="*/ 269325 h 633392"/>
              <a:gd name="connsiteX9" fmla="*/ 939868 w 1248131"/>
              <a:gd name="connsiteY9" fmla="*/ 307425 h 633392"/>
              <a:gd name="connsiteX10" fmla="*/ 1143069 w 1248131"/>
              <a:gd name="connsiteY10" fmla="*/ 142325 h 633392"/>
              <a:gd name="connsiteX11" fmla="*/ 1248131 w 1248131"/>
              <a:gd name="connsiteY11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136743 w 1248131"/>
              <a:gd name="connsiteY6" fmla="*/ 187080 h 633392"/>
              <a:gd name="connsiteX7" fmla="*/ 346959 w 1248131"/>
              <a:gd name="connsiteY7" fmla="*/ 201707 h 633392"/>
              <a:gd name="connsiteX8" fmla="*/ 635069 w 1248131"/>
              <a:gd name="connsiteY8" fmla="*/ 269325 h 633392"/>
              <a:gd name="connsiteX9" fmla="*/ 939868 w 1248131"/>
              <a:gd name="connsiteY9" fmla="*/ 307425 h 633392"/>
              <a:gd name="connsiteX10" fmla="*/ 1143069 w 1248131"/>
              <a:gd name="connsiteY10" fmla="*/ 142325 h 633392"/>
              <a:gd name="connsiteX11" fmla="*/ 1248131 w 1248131"/>
              <a:gd name="connsiteY11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131482 w 1248131"/>
              <a:gd name="connsiteY6" fmla="*/ 181802 h 633392"/>
              <a:gd name="connsiteX7" fmla="*/ 346959 w 1248131"/>
              <a:gd name="connsiteY7" fmla="*/ 201707 h 633392"/>
              <a:gd name="connsiteX8" fmla="*/ 635069 w 1248131"/>
              <a:gd name="connsiteY8" fmla="*/ 269325 h 633392"/>
              <a:gd name="connsiteX9" fmla="*/ 939868 w 1248131"/>
              <a:gd name="connsiteY9" fmla="*/ 307425 h 633392"/>
              <a:gd name="connsiteX10" fmla="*/ 1143069 w 1248131"/>
              <a:gd name="connsiteY10" fmla="*/ 142325 h 633392"/>
              <a:gd name="connsiteX11" fmla="*/ 1248131 w 1248131"/>
              <a:gd name="connsiteY11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131482 w 1248131"/>
              <a:gd name="connsiteY6" fmla="*/ 181802 h 633392"/>
              <a:gd name="connsiteX7" fmla="*/ 236245 w 1248131"/>
              <a:gd name="connsiteY7" fmla="*/ 163039 h 633392"/>
              <a:gd name="connsiteX8" fmla="*/ 346959 w 1248131"/>
              <a:gd name="connsiteY8" fmla="*/ 201707 h 633392"/>
              <a:gd name="connsiteX9" fmla="*/ 635069 w 1248131"/>
              <a:gd name="connsiteY9" fmla="*/ 269325 h 633392"/>
              <a:gd name="connsiteX10" fmla="*/ 939868 w 1248131"/>
              <a:gd name="connsiteY10" fmla="*/ 307425 h 633392"/>
              <a:gd name="connsiteX11" fmla="*/ 1143069 w 1248131"/>
              <a:gd name="connsiteY11" fmla="*/ 142325 h 633392"/>
              <a:gd name="connsiteX12" fmla="*/ 1248131 w 1248131"/>
              <a:gd name="connsiteY12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110437 w 1248131"/>
              <a:gd name="connsiteY6" fmla="*/ 195877 h 633392"/>
              <a:gd name="connsiteX7" fmla="*/ 236245 w 1248131"/>
              <a:gd name="connsiteY7" fmla="*/ 163039 h 633392"/>
              <a:gd name="connsiteX8" fmla="*/ 346959 w 1248131"/>
              <a:gd name="connsiteY8" fmla="*/ 201707 h 633392"/>
              <a:gd name="connsiteX9" fmla="*/ 635069 w 1248131"/>
              <a:gd name="connsiteY9" fmla="*/ 269325 h 633392"/>
              <a:gd name="connsiteX10" fmla="*/ 939868 w 1248131"/>
              <a:gd name="connsiteY10" fmla="*/ 307425 h 633392"/>
              <a:gd name="connsiteX11" fmla="*/ 1143069 w 1248131"/>
              <a:gd name="connsiteY11" fmla="*/ 142325 h 633392"/>
              <a:gd name="connsiteX12" fmla="*/ 1248131 w 1248131"/>
              <a:gd name="connsiteY12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46959 w 1248131"/>
              <a:gd name="connsiteY8" fmla="*/ 201707 h 633392"/>
              <a:gd name="connsiteX9" fmla="*/ 635069 w 1248131"/>
              <a:gd name="connsiteY9" fmla="*/ 269325 h 633392"/>
              <a:gd name="connsiteX10" fmla="*/ 939868 w 1248131"/>
              <a:gd name="connsiteY10" fmla="*/ 307425 h 633392"/>
              <a:gd name="connsiteX11" fmla="*/ 1143069 w 1248131"/>
              <a:gd name="connsiteY11" fmla="*/ 142325 h 633392"/>
              <a:gd name="connsiteX12" fmla="*/ 1248131 w 1248131"/>
              <a:gd name="connsiteY12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66250 w 1248131"/>
              <a:gd name="connsiteY8" fmla="*/ 240414 h 633392"/>
              <a:gd name="connsiteX9" fmla="*/ 635069 w 1248131"/>
              <a:gd name="connsiteY9" fmla="*/ 269325 h 633392"/>
              <a:gd name="connsiteX10" fmla="*/ 939868 w 1248131"/>
              <a:gd name="connsiteY10" fmla="*/ 307425 h 633392"/>
              <a:gd name="connsiteX11" fmla="*/ 1143069 w 1248131"/>
              <a:gd name="connsiteY11" fmla="*/ 142325 h 633392"/>
              <a:gd name="connsiteX12" fmla="*/ 1248131 w 1248131"/>
              <a:gd name="connsiteY12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635069 w 1248131"/>
              <a:gd name="connsiteY9" fmla="*/ 269325 h 633392"/>
              <a:gd name="connsiteX10" fmla="*/ 939868 w 1248131"/>
              <a:gd name="connsiteY10" fmla="*/ 307425 h 633392"/>
              <a:gd name="connsiteX11" fmla="*/ 1143069 w 1248131"/>
              <a:gd name="connsiteY11" fmla="*/ 142325 h 633392"/>
              <a:gd name="connsiteX12" fmla="*/ 1248131 w 1248131"/>
              <a:gd name="connsiteY12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628054 w 1248131"/>
              <a:gd name="connsiteY9" fmla="*/ 334424 h 633392"/>
              <a:gd name="connsiteX10" fmla="*/ 939868 w 1248131"/>
              <a:gd name="connsiteY10" fmla="*/ 307425 h 633392"/>
              <a:gd name="connsiteX11" fmla="*/ 1143069 w 1248131"/>
              <a:gd name="connsiteY11" fmla="*/ 142325 h 633392"/>
              <a:gd name="connsiteX12" fmla="*/ 1248131 w 1248131"/>
              <a:gd name="connsiteY12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628054 w 1248131"/>
              <a:gd name="connsiteY9" fmla="*/ 334424 h 633392"/>
              <a:gd name="connsiteX10" fmla="*/ 959160 w 1248131"/>
              <a:gd name="connsiteY10" fmla="*/ 367245 h 633392"/>
              <a:gd name="connsiteX11" fmla="*/ 1143069 w 1248131"/>
              <a:gd name="connsiteY11" fmla="*/ 142325 h 633392"/>
              <a:gd name="connsiteX12" fmla="*/ 1248131 w 1248131"/>
              <a:gd name="connsiteY12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628054 w 1248131"/>
              <a:gd name="connsiteY9" fmla="*/ 334424 h 633392"/>
              <a:gd name="connsiteX10" fmla="*/ 730789 w 1248131"/>
              <a:gd name="connsiteY10" fmla="*/ 388245 h 633392"/>
              <a:gd name="connsiteX11" fmla="*/ 959160 w 1248131"/>
              <a:gd name="connsiteY11" fmla="*/ 367245 h 633392"/>
              <a:gd name="connsiteX12" fmla="*/ 1143069 w 1248131"/>
              <a:gd name="connsiteY12" fmla="*/ 142325 h 633392"/>
              <a:gd name="connsiteX13" fmla="*/ 1248131 w 1248131"/>
              <a:gd name="connsiteY13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628054 w 1248131"/>
              <a:gd name="connsiteY9" fmla="*/ 334424 h 633392"/>
              <a:gd name="connsiteX10" fmla="*/ 730789 w 1248131"/>
              <a:gd name="connsiteY10" fmla="*/ 388245 h 633392"/>
              <a:gd name="connsiteX11" fmla="*/ 959160 w 1248131"/>
              <a:gd name="connsiteY11" fmla="*/ 367245 h 633392"/>
              <a:gd name="connsiteX12" fmla="*/ 1143069 w 1248131"/>
              <a:gd name="connsiteY12" fmla="*/ 142325 h 633392"/>
              <a:gd name="connsiteX13" fmla="*/ 1248131 w 1248131"/>
              <a:gd name="connsiteY13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490532 w 1248131"/>
              <a:gd name="connsiteY9" fmla="*/ 302033 h 633392"/>
              <a:gd name="connsiteX10" fmla="*/ 628054 w 1248131"/>
              <a:gd name="connsiteY10" fmla="*/ 334424 h 633392"/>
              <a:gd name="connsiteX11" fmla="*/ 730789 w 1248131"/>
              <a:gd name="connsiteY11" fmla="*/ 388245 h 633392"/>
              <a:gd name="connsiteX12" fmla="*/ 959160 w 1248131"/>
              <a:gd name="connsiteY12" fmla="*/ 367245 h 633392"/>
              <a:gd name="connsiteX13" fmla="*/ 1143069 w 1248131"/>
              <a:gd name="connsiteY13" fmla="*/ 142325 h 633392"/>
              <a:gd name="connsiteX14" fmla="*/ 1248131 w 1248131"/>
              <a:gd name="connsiteY14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490532 w 1248131"/>
              <a:gd name="connsiteY9" fmla="*/ 302033 h 633392"/>
              <a:gd name="connsiteX10" fmla="*/ 628054 w 1248131"/>
              <a:gd name="connsiteY10" fmla="*/ 346741 h 633392"/>
              <a:gd name="connsiteX11" fmla="*/ 730789 w 1248131"/>
              <a:gd name="connsiteY11" fmla="*/ 388245 h 633392"/>
              <a:gd name="connsiteX12" fmla="*/ 959160 w 1248131"/>
              <a:gd name="connsiteY12" fmla="*/ 367245 h 633392"/>
              <a:gd name="connsiteX13" fmla="*/ 1143069 w 1248131"/>
              <a:gd name="connsiteY13" fmla="*/ 142325 h 633392"/>
              <a:gd name="connsiteX14" fmla="*/ 1248131 w 1248131"/>
              <a:gd name="connsiteY14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494039 w 1248131"/>
              <a:gd name="connsiteY9" fmla="*/ 298514 h 633392"/>
              <a:gd name="connsiteX10" fmla="*/ 628054 w 1248131"/>
              <a:gd name="connsiteY10" fmla="*/ 346741 h 633392"/>
              <a:gd name="connsiteX11" fmla="*/ 730789 w 1248131"/>
              <a:gd name="connsiteY11" fmla="*/ 388245 h 633392"/>
              <a:gd name="connsiteX12" fmla="*/ 959160 w 1248131"/>
              <a:gd name="connsiteY12" fmla="*/ 367245 h 633392"/>
              <a:gd name="connsiteX13" fmla="*/ 1143069 w 1248131"/>
              <a:gd name="connsiteY13" fmla="*/ 142325 h 633392"/>
              <a:gd name="connsiteX14" fmla="*/ 1248131 w 1248131"/>
              <a:gd name="connsiteY14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494039 w 1248131"/>
              <a:gd name="connsiteY9" fmla="*/ 298514 h 633392"/>
              <a:gd name="connsiteX10" fmla="*/ 628054 w 1248131"/>
              <a:gd name="connsiteY10" fmla="*/ 346741 h 633392"/>
              <a:gd name="connsiteX11" fmla="*/ 730789 w 1248131"/>
              <a:gd name="connsiteY11" fmla="*/ 388245 h 633392"/>
              <a:gd name="connsiteX12" fmla="*/ 959160 w 1248131"/>
              <a:gd name="connsiteY12" fmla="*/ 367245 h 633392"/>
              <a:gd name="connsiteX13" fmla="*/ 1143069 w 1248131"/>
              <a:gd name="connsiteY13" fmla="*/ 142325 h 633392"/>
              <a:gd name="connsiteX14" fmla="*/ 1248131 w 1248131"/>
              <a:gd name="connsiteY14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497547 w 1248131"/>
              <a:gd name="connsiteY9" fmla="*/ 294996 h 633392"/>
              <a:gd name="connsiteX10" fmla="*/ 628054 w 1248131"/>
              <a:gd name="connsiteY10" fmla="*/ 346741 h 633392"/>
              <a:gd name="connsiteX11" fmla="*/ 730789 w 1248131"/>
              <a:gd name="connsiteY11" fmla="*/ 388245 h 633392"/>
              <a:gd name="connsiteX12" fmla="*/ 959160 w 1248131"/>
              <a:gd name="connsiteY12" fmla="*/ 367245 h 633392"/>
              <a:gd name="connsiteX13" fmla="*/ 1143069 w 1248131"/>
              <a:gd name="connsiteY13" fmla="*/ 142325 h 633392"/>
              <a:gd name="connsiteX14" fmla="*/ 1248131 w 1248131"/>
              <a:gd name="connsiteY14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497547 w 1248131"/>
              <a:gd name="connsiteY9" fmla="*/ 294996 h 633392"/>
              <a:gd name="connsiteX10" fmla="*/ 628054 w 1248131"/>
              <a:gd name="connsiteY10" fmla="*/ 346741 h 633392"/>
              <a:gd name="connsiteX11" fmla="*/ 730789 w 1248131"/>
              <a:gd name="connsiteY11" fmla="*/ 388245 h 633392"/>
              <a:gd name="connsiteX12" fmla="*/ 959160 w 1248131"/>
              <a:gd name="connsiteY12" fmla="*/ 367245 h 633392"/>
              <a:gd name="connsiteX13" fmla="*/ 1143069 w 1248131"/>
              <a:gd name="connsiteY13" fmla="*/ 142325 h 633392"/>
              <a:gd name="connsiteX14" fmla="*/ 1248131 w 1248131"/>
              <a:gd name="connsiteY14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497547 w 1248131"/>
              <a:gd name="connsiteY9" fmla="*/ 294996 h 633392"/>
              <a:gd name="connsiteX10" fmla="*/ 628054 w 1248131"/>
              <a:gd name="connsiteY10" fmla="*/ 346741 h 633392"/>
              <a:gd name="connsiteX11" fmla="*/ 730789 w 1248131"/>
              <a:gd name="connsiteY11" fmla="*/ 388245 h 633392"/>
              <a:gd name="connsiteX12" fmla="*/ 959160 w 1248131"/>
              <a:gd name="connsiteY12" fmla="*/ 367245 h 633392"/>
              <a:gd name="connsiteX13" fmla="*/ 1143069 w 1248131"/>
              <a:gd name="connsiteY13" fmla="*/ 142325 h 633392"/>
              <a:gd name="connsiteX14" fmla="*/ 1248131 w 1248131"/>
              <a:gd name="connsiteY14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497547 w 1248131"/>
              <a:gd name="connsiteY9" fmla="*/ 294996 h 633392"/>
              <a:gd name="connsiteX10" fmla="*/ 628054 w 1248131"/>
              <a:gd name="connsiteY10" fmla="*/ 346741 h 633392"/>
              <a:gd name="connsiteX11" fmla="*/ 730789 w 1248131"/>
              <a:gd name="connsiteY11" fmla="*/ 388245 h 633392"/>
              <a:gd name="connsiteX12" fmla="*/ 959160 w 1248131"/>
              <a:gd name="connsiteY12" fmla="*/ 367245 h 633392"/>
              <a:gd name="connsiteX13" fmla="*/ 1143069 w 1248131"/>
              <a:gd name="connsiteY13" fmla="*/ 142325 h 633392"/>
              <a:gd name="connsiteX14" fmla="*/ 1248131 w 1248131"/>
              <a:gd name="connsiteY14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497547 w 1248131"/>
              <a:gd name="connsiteY9" fmla="*/ 294996 h 633392"/>
              <a:gd name="connsiteX10" fmla="*/ 628054 w 1248131"/>
              <a:gd name="connsiteY10" fmla="*/ 346741 h 633392"/>
              <a:gd name="connsiteX11" fmla="*/ 771125 w 1248131"/>
              <a:gd name="connsiteY11" fmla="*/ 391764 h 633392"/>
              <a:gd name="connsiteX12" fmla="*/ 959160 w 1248131"/>
              <a:gd name="connsiteY12" fmla="*/ 367245 h 633392"/>
              <a:gd name="connsiteX13" fmla="*/ 1143069 w 1248131"/>
              <a:gd name="connsiteY13" fmla="*/ 142325 h 633392"/>
              <a:gd name="connsiteX14" fmla="*/ 1248131 w 1248131"/>
              <a:gd name="connsiteY14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497547 w 1248131"/>
              <a:gd name="connsiteY9" fmla="*/ 294996 h 633392"/>
              <a:gd name="connsiteX10" fmla="*/ 628054 w 1248131"/>
              <a:gd name="connsiteY10" fmla="*/ 346741 h 633392"/>
              <a:gd name="connsiteX11" fmla="*/ 771125 w 1248131"/>
              <a:gd name="connsiteY11" fmla="*/ 391764 h 633392"/>
              <a:gd name="connsiteX12" fmla="*/ 959160 w 1248131"/>
              <a:gd name="connsiteY12" fmla="*/ 367245 h 633392"/>
              <a:gd name="connsiteX13" fmla="*/ 1143069 w 1248131"/>
              <a:gd name="connsiteY13" fmla="*/ 142325 h 633392"/>
              <a:gd name="connsiteX14" fmla="*/ 1248131 w 1248131"/>
              <a:gd name="connsiteY14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497547 w 1248131"/>
              <a:gd name="connsiteY9" fmla="*/ 294996 h 633392"/>
              <a:gd name="connsiteX10" fmla="*/ 628054 w 1248131"/>
              <a:gd name="connsiteY10" fmla="*/ 346741 h 633392"/>
              <a:gd name="connsiteX11" fmla="*/ 771125 w 1248131"/>
              <a:gd name="connsiteY11" fmla="*/ 391764 h 633392"/>
              <a:gd name="connsiteX12" fmla="*/ 959160 w 1248131"/>
              <a:gd name="connsiteY12" fmla="*/ 367245 h 633392"/>
              <a:gd name="connsiteX13" fmla="*/ 1143069 w 1248131"/>
              <a:gd name="connsiteY13" fmla="*/ 142325 h 633392"/>
              <a:gd name="connsiteX14" fmla="*/ 1248131 w 1248131"/>
              <a:gd name="connsiteY14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497547 w 1248131"/>
              <a:gd name="connsiteY9" fmla="*/ 294996 h 633392"/>
              <a:gd name="connsiteX10" fmla="*/ 628054 w 1248131"/>
              <a:gd name="connsiteY10" fmla="*/ 346741 h 633392"/>
              <a:gd name="connsiteX11" fmla="*/ 771125 w 1248131"/>
              <a:gd name="connsiteY11" fmla="*/ 391764 h 633392"/>
              <a:gd name="connsiteX12" fmla="*/ 959160 w 1248131"/>
              <a:gd name="connsiteY12" fmla="*/ 367245 h 633392"/>
              <a:gd name="connsiteX13" fmla="*/ 1143069 w 1248131"/>
              <a:gd name="connsiteY13" fmla="*/ 142325 h 633392"/>
              <a:gd name="connsiteX14" fmla="*/ 1248131 w 1248131"/>
              <a:gd name="connsiteY14" fmla="*/ 0 h 633392"/>
              <a:gd name="connsiteX0" fmla="*/ 42402 w 1248131"/>
              <a:gd name="connsiteY0" fmla="*/ 633392 h 633392"/>
              <a:gd name="connsiteX1" fmla="*/ 42402 w 1248131"/>
              <a:gd name="connsiteY1" fmla="*/ 633392 h 633392"/>
              <a:gd name="connsiteX2" fmla="*/ 8535 w 1248131"/>
              <a:gd name="connsiteY2" fmla="*/ 557192 h 633392"/>
              <a:gd name="connsiteX3" fmla="*/ 69 w 1248131"/>
              <a:gd name="connsiteY3" fmla="*/ 404792 h 633392"/>
              <a:gd name="connsiteX4" fmla="*/ 69 w 1248131"/>
              <a:gd name="connsiteY4" fmla="*/ 404792 h 633392"/>
              <a:gd name="connsiteX5" fmla="*/ 25469 w 1248131"/>
              <a:gd name="connsiteY5" fmla="*/ 286258 h 633392"/>
              <a:gd name="connsiteX6" fmla="*/ 99915 w 1248131"/>
              <a:gd name="connsiteY6" fmla="*/ 202915 h 633392"/>
              <a:gd name="connsiteX7" fmla="*/ 236245 w 1248131"/>
              <a:gd name="connsiteY7" fmla="*/ 163039 h 633392"/>
              <a:gd name="connsiteX8" fmla="*/ 382034 w 1248131"/>
              <a:gd name="connsiteY8" fmla="*/ 226339 h 633392"/>
              <a:gd name="connsiteX9" fmla="*/ 497547 w 1248131"/>
              <a:gd name="connsiteY9" fmla="*/ 294996 h 633392"/>
              <a:gd name="connsiteX10" fmla="*/ 628054 w 1248131"/>
              <a:gd name="connsiteY10" fmla="*/ 346741 h 633392"/>
              <a:gd name="connsiteX11" fmla="*/ 769371 w 1248131"/>
              <a:gd name="connsiteY11" fmla="*/ 397043 h 633392"/>
              <a:gd name="connsiteX12" fmla="*/ 959160 w 1248131"/>
              <a:gd name="connsiteY12" fmla="*/ 367245 h 633392"/>
              <a:gd name="connsiteX13" fmla="*/ 1143069 w 1248131"/>
              <a:gd name="connsiteY13" fmla="*/ 142325 h 633392"/>
              <a:gd name="connsiteX14" fmla="*/ 1248131 w 1248131"/>
              <a:gd name="connsiteY14" fmla="*/ 0 h 633392"/>
              <a:gd name="connsiteX0" fmla="*/ 42402 w 1351599"/>
              <a:gd name="connsiteY0" fmla="*/ 610519 h 610519"/>
              <a:gd name="connsiteX1" fmla="*/ 42402 w 1351599"/>
              <a:gd name="connsiteY1" fmla="*/ 610519 h 610519"/>
              <a:gd name="connsiteX2" fmla="*/ 8535 w 1351599"/>
              <a:gd name="connsiteY2" fmla="*/ 534319 h 610519"/>
              <a:gd name="connsiteX3" fmla="*/ 69 w 1351599"/>
              <a:gd name="connsiteY3" fmla="*/ 381919 h 610519"/>
              <a:gd name="connsiteX4" fmla="*/ 69 w 1351599"/>
              <a:gd name="connsiteY4" fmla="*/ 381919 h 610519"/>
              <a:gd name="connsiteX5" fmla="*/ 25469 w 1351599"/>
              <a:gd name="connsiteY5" fmla="*/ 263385 h 610519"/>
              <a:gd name="connsiteX6" fmla="*/ 99915 w 1351599"/>
              <a:gd name="connsiteY6" fmla="*/ 180042 h 610519"/>
              <a:gd name="connsiteX7" fmla="*/ 236245 w 1351599"/>
              <a:gd name="connsiteY7" fmla="*/ 140166 h 610519"/>
              <a:gd name="connsiteX8" fmla="*/ 382034 w 1351599"/>
              <a:gd name="connsiteY8" fmla="*/ 203466 h 610519"/>
              <a:gd name="connsiteX9" fmla="*/ 497547 w 1351599"/>
              <a:gd name="connsiteY9" fmla="*/ 272123 h 610519"/>
              <a:gd name="connsiteX10" fmla="*/ 628054 w 1351599"/>
              <a:gd name="connsiteY10" fmla="*/ 323868 h 610519"/>
              <a:gd name="connsiteX11" fmla="*/ 769371 w 1351599"/>
              <a:gd name="connsiteY11" fmla="*/ 374170 h 610519"/>
              <a:gd name="connsiteX12" fmla="*/ 959160 w 1351599"/>
              <a:gd name="connsiteY12" fmla="*/ 344372 h 610519"/>
              <a:gd name="connsiteX13" fmla="*/ 1143069 w 1351599"/>
              <a:gd name="connsiteY13" fmla="*/ 119452 h 610519"/>
              <a:gd name="connsiteX14" fmla="*/ 1351599 w 1351599"/>
              <a:gd name="connsiteY14" fmla="*/ 0 h 610519"/>
              <a:gd name="connsiteX0" fmla="*/ 42402 w 1351599"/>
              <a:gd name="connsiteY0" fmla="*/ 610519 h 610519"/>
              <a:gd name="connsiteX1" fmla="*/ 42402 w 1351599"/>
              <a:gd name="connsiteY1" fmla="*/ 610519 h 610519"/>
              <a:gd name="connsiteX2" fmla="*/ 8535 w 1351599"/>
              <a:gd name="connsiteY2" fmla="*/ 534319 h 610519"/>
              <a:gd name="connsiteX3" fmla="*/ 69 w 1351599"/>
              <a:gd name="connsiteY3" fmla="*/ 381919 h 610519"/>
              <a:gd name="connsiteX4" fmla="*/ 69 w 1351599"/>
              <a:gd name="connsiteY4" fmla="*/ 381919 h 610519"/>
              <a:gd name="connsiteX5" fmla="*/ 25469 w 1351599"/>
              <a:gd name="connsiteY5" fmla="*/ 263385 h 610519"/>
              <a:gd name="connsiteX6" fmla="*/ 99915 w 1351599"/>
              <a:gd name="connsiteY6" fmla="*/ 180042 h 610519"/>
              <a:gd name="connsiteX7" fmla="*/ 236245 w 1351599"/>
              <a:gd name="connsiteY7" fmla="*/ 140166 h 610519"/>
              <a:gd name="connsiteX8" fmla="*/ 382034 w 1351599"/>
              <a:gd name="connsiteY8" fmla="*/ 203466 h 610519"/>
              <a:gd name="connsiteX9" fmla="*/ 497547 w 1351599"/>
              <a:gd name="connsiteY9" fmla="*/ 272123 h 610519"/>
              <a:gd name="connsiteX10" fmla="*/ 628054 w 1351599"/>
              <a:gd name="connsiteY10" fmla="*/ 323868 h 610519"/>
              <a:gd name="connsiteX11" fmla="*/ 769371 w 1351599"/>
              <a:gd name="connsiteY11" fmla="*/ 374170 h 610519"/>
              <a:gd name="connsiteX12" fmla="*/ 959160 w 1351599"/>
              <a:gd name="connsiteY12" fmla="*/ 344372 h 610519"/>
              <a:gd name="connsiteX13" fmla="*/ 1232509 w 1351599"/>
              <a:gd name="connsiteY13" fmla="*/ 175754 h 610519"/>
              <a:gd name="connsiteX14" fmla="*/ 1351599 w 1351599"/>
              <a:gd name="connsiteY14" fmla="*/ 0 h 610519"/>
              <a:gd name="connsiteX0" fmla="*/ 42402 w 1351599"/>
              <a:gd name="connsiteY0" fmla="*/ 610519 h 610519"/>
              <a:gd name="connsiteX1" fmla="*/ 42402 w 1351599"/>
              <a:gd name="connsiteY1" fmla="*/ 610519 h 610519"/>
              <a:gd name="connsiteX2" fmla="*/ 8535 w 1351599"/>
              <a:gd name="connsiteY2" fmla="*/ 534319 h 610519"/>
              <a:gd name="connsiteX3" fmla="*/ 69 w 1351599"/>
              <a:gd name="connsiteY3" fmla="*/ 381919 h 610519"/>
              <a:gd name="connsiteX4" fmla="*/ 69 w 1351599"/>
              <a:gd name="connsiteY4" fmla="*/ 381919 h 610519"/>
              <a:gd name="connsiteX5" fmla="*/ 25469 w 1351599"/>
              <a:gd name="connsiteY5" fmla="*/ 263385 h 610519"/>
              <a:gd name="connsiteX6" fmla="*/ 99915 w 1351599"/>
              <a:gd name="connsiteY6" fmla="*/ 180042 h 610519"/>
              <a:gd name="connsiteX7" fmla="*/ 236245 w 1351599"/>
              <a:gd name="connsiteY7" fmla="*/ 140166 h 610519"/>
              <a:gd name="connsiteX8" fmla="*/ 382034 w 1351599"/>
              <a:gd name="connsiteY8" fmla="*/ 203466 h 610519"/>
              <a:gd name="connsiteX9" fmla="*/ 497547 w 1351599"/>
              <a:gd name="connsiteY9" fmla="*/ 272123 h 610519"/>
              <a:gd name="connsiteX10" fmla="*/ 628054 w 1351599"/>
              <a:gd name="connsiteY10" fmla="*/ 323868 h 610519"/>
              <a:gd name="connsiteX11" fmla="*/ 769371 w 1351599"/>
              <a:gd name="connsiteY11" fmla="*/ 374170 h 610519"/>
              <a:gd name="connsiteX12" fmla="*/ 959160 w 1351599"/>
              <a:gd name="connsiteY12" fmla="*/ 344372 h 610519"/>
              <a:gd name="connsiteX13" fmla="*/ 1232509 w 1351599"/>
              <a:gd name="connsiteY13" fmla="*/ 175754 h 610519"/>
              <a:gd name="connsiteX14" fmla="*/ 1351599 w 1351599"/>
              <a:gd name="connsiteY14" fmla="*/ 0 h 610519"/>
              <a:gd name="connsiteX0" fmla="*/ 42402 w 1351599"/>
              <a:gd name="connsiteY0" fmla="*/ 610519 h 610519"/>
              <a:gd name="connsiteX1" fmla="*/ 42402 w 1351599"/>
              <a:gd name="connsiteY1" fmla="*/ 610519 h 610519"/>
              <a:gd name="connsiteX2" fmla="*/ 8535 w 1351599"/>
              <a:gd name="connsiteY2" fmla="*/ 534319 h 610519"/>
              <a:gd name="connsiteX3" fmla="*/ 69 w 1351599"/>
              <a:gd name="connsiteY3" fmla="*/ 381919 h 610519"/>
              <a:gd name="connsiteX4" fmla="*/ 69 w 1351599"/>
              <a:gd name="connsiteY4" fmla="*/ 381919 h 610519"/>
              <a:gd name="connsiteX5" fmla="*/ 25469 w 1351599"/>
              <a:gd name="connsiteY5" fmla="*/ 263385 h 610519"/>
              <a:gd name="connsiteX6" fmla="*/ 99915 w 1351599"/>
              <a:gd name="connsiteY6" fmla="*/ 180042 h 610519"/>
              <a:gd name="connsiteX7" fmla="*/ 236245 w 1351599"/>
              <a:gd name="connsiteY7" fmla="*/ 140166 h 610519"/>
              <a:gd name="connsiteX8" fmla="*/ 382034 w 1351599"/>
              <a:gd name="connsiteY8" fmla="*/ 203466 h 610519"/>
              <a:gd name="connsiteX9" fmla="*/ 497547 w 1351599"/>
              <a:gd name="connsiteY9" fmla="*/ 272123 h 610519"/>
              <a:gd name="connsiteX10" fmla="*/ 628054 w 1351599"/>
              <a:gd name="connsiteY10" fmla="*/ 323868 h 610519"/>
              <a:gd name="connsiteX11" fmla="*/ 769371 w 1351599"/>
              <a:gd name="connsiteY11" fmla="*/ 374170 h 610519"/>
              <a:gd name="connsiteX12" fmla="*/ 969682 w 1351599"/>
              <a:gd name="connsiteY12" fmla="*/ 353170 h 610519"/>
              <a:gd name="connsiteX13" fmla="*/ 1232509 w 1351599"/>
              <a:gd name="connsiteY13" fmla="*/ 175754 h 610519"/>
              <a:gd name="connsiteX14" fmla="*/ 1351599 w 1351599"/>
              <a:gd name="connsiteY14" fmla="*/ 0 h 610519"/>
              <a:gd name="connsiteX0" fmla="*/ 42402 w 1351599"/>
              <a:gd name="connsiteY0" fmla="*/ 610519 h 610519"/>
              <a:gd name="connsiteX1" fmla="*/ 42402 w 1351599"/>
              <a:gd name="connsiteY1" fmla="*/ 610519 h 610519"/>
              <a:gd name="connsiteX2" fmla="*/ 8535 w 1351599"/>
              <a:gd name="connsiteY2" fmla="*/ 534319 h 610519"/>
              <a:gd name="connsiteX3" fmla="*/ 69 w 1351599"/>
              <a:gd name="connsiteY3" fmla="*/ 381919 h 610519"/>
              <a:gd name="connsiteX4" fmla="*/ 69 w 1351599"/>
              <a:gd name="connsiteY4" fmla="*/ 381919 h 610519"/>
              <a:gd name="connsiteX5" fmla="*/ 25469 w 1351599"/>
              <a:gd name="connsiteY5" fmla="*/ 263385 h 610519"/>
              <a:gd name="connsiteX6" fmla="*/ 99915 w 1351599"/>
              <a:gd name="connsiteY6" fmla="*/ 180042 h 610519"/>
              <a:gd name="connsiteX7" fmla="*/ 236245 w 1351599"/>
              <a:gd name="connsiteY7" fmla="*/ 140166 h 610519"/>
              <a:gd name="connsiteX8" fmla="*/ 382034 w 1351599"/>
              <a:gd name="connsiteY8" fmla="*/ 203466 h 610519"/>
              <a:gd name="connsiteX9" fmla="*/ 497547 w 1351599"/>
              <a:gd name="connsiteY9" fmla="*/ 272123 h 610519"/>
              <a:gd name="connsiteX10" fmla="*/ 628054 w 1351599"/>
              <a:gd name="connsiteY10" fmla="*/ 323868 h 610519"/>
              <a:gd name="connsiteX11" fmla="*/ 771124 w 1351599"/>
              <a:gd name="connsiteY11" fmla="*/ 372410 h 610519"/>
              <a:gd name="connsiteX12" fmla="*/ 969682 w 1351599"/>
              <a:gd name="connsiteY12" fmla="*/ 353170 h 610519"/>
              <a:gd name="connsiteX13" fmla="*/ 1232509 w 1351599"/>
              <a:gd name="connsiteY13" fmla="*/ 175754 h 610519"/>
              <a:gd name="connsiteX14" fmla="*/ 1351599 w 1351599"/>
              <a:gd name="connsiteY14" fmla="*/ 0 h 610519"/>
              <a:gd name="connsiteX0" fmla="*/ 42402 w 1351599"/>
              <a:gd name="connsiteY0" fmla="*/ 610519 h 610519"/>
              <a:gd name="connsiteX1" fmla="*/ 42402 w 1351599"/>
              <a:gd name="connsiteY1" fmla="*/ 610519 h 610519"/>
              <a:gd name="connsiteX2" fmla="*/ 8535 w 1351599"/>
              <a:gd name="connsiteY2" fmla="*/ 534319 h 610519"/>
              <a:gd name="connsiteX3" fmla="*/ 69 w 1351599"/>
              <a:gd name="connsiteY3" fmla="*/ 381919 h 610519"/>
              <a:gd name="connsiteX4" fmla="*/ 69 w 1351599"/>
              <a:gd name="connsiteY4" fmla="*/ 381919 h 610519"/>
              <a:gd name="connsiteX5" fmla="*/ 25469 w 1351599"/>
              <a:gd name="connsiteY5" fmla="*/ 263385 h 610519"/>
              <a:gd name="connsiteX6" fmla="*/ 99915 w 1351599"/>
              <a:gd name="connsiteY6" fmla="*/ 180042 h 610519"/>
              <a:gd name="connsiteX7" fmla="*/ 236245 w 1351599"/>
              <a:gd name="connsiteY7" fmla="*/ 140166 h 610519"/>
              <a:gd name="connsiteX8" fmla="*/ 382034 w 1351599"/>
              <a:gd name="connsiteY8" fmla="*/ 203466 h 610519"/>
              <a:gd name="connsiteX9" fmla="*/ 497547 w 1351599"/>
              <a:gd name="connsiteY9" fmla="*/ 272123 h 610519"/>
              <a:gd name="connsiteX10" fmla="*/ 628054 w 1351599"/>
              <a:gd name="connsiteY10" fmla="*/ 323868 h 610519"/>
              <a:gd name="connsiteX11" fmla="*/ 771124 w 1351599"/>
              <a:gd name="connsiteY11" fmla="*/ 372410 h 610519"/>
              <a:gd name="connsiteX12" fmla="*/ 969682 w 1351599"/>
              <a:gd name="connsiteY12" fmla="*/ 353170 h 610519"/>
              <a:gd name="connsiteX13" fmla="*/ 1120111 w 1351599"/>
              <a:gd name="connsiteY13" fmla="*/ 272123 h 610519"/>
              <a:gd name="connsiteX14" fmla="*/ 1232509 w 1351599"/>
              <a:gd name="connsiteY14" fmla="*/ 175754 h 610519"/>
              <a:gd name="connsiteX15" fmla="*/ 1351599 w 1351599"/>
              <a:gd name="connsiteY15" fmla="*/ 0 h 610519"/>
              <a:gd name="connsiteX0" fmla="*/ 42402 w 1351599"/>
              <a:gd name="connsiteY0" fmla="*/ 610519 h 610519"/>
              <a:gd name="connsiteX1" fmla="*/ 42402 w 1351599"/>
              <a:gd name="connsiteY1" fmla="*/ 610519 h 610519"/>
              <a:gd name="connsiteX2" fmla="*/ 8535 w 1351599"/>
              <a:gd name="connsiteY2" fmla="*/ 534319 h 610519"/>
              <a:gd name="connsiteX3" fmla="*/ 69 w 1351599"/>
              <a:gd name="connsiteY3" fmla="*/ 381919 h 610519"/>
              <a:gd name="connsiteX4" fmla="*/ 69 w 1351599"/>
              <a:gd name="connsiteY4" fmla="*/ 381919 h 610519"/>
              <a:gd name="connsiteX5" fmla="*/ 25469 w 1351599"/>
              <a:gd name="connsiteY5" fmla="*/ 263385 h 610519"/>
              <a:gd name="connsiteX6" fmla="*/ 99915 w 1351599"/>
              <a:gd name="connsiteY6" fmla="*/ 180042 h 610519"/>
              <a:gd name="connsiteX7" fmla="*/ 236245 w 1351599"/>
              <a:gd name="connsiteY7" fmla="*/ 140166 h 610519"/>
              <a:gd name="connsiteX8" fmla="*/ 382034 w 1351599"/>
              <a:gd name="connsiteY8" fmla="*/ 203466 h 610519"/>
              <a:gd name="connsiteX9" fmla="*/ 497547 w 1351599"/>
              <a:gd name="connsiteY9" fmla="*/ 272123 h 610519"/>
              <a:gd name="connsiteX10" fmla="*/ 628054 w 1351599"/>
              <a:gd name="connsiteY10" fmla="*/ 323868 h 610519"/>
              <a:gd name="connsiteX11" fmla="*/ 771124 w 1351599"/>
              <a:gd name="connsiteY11" fmla="*/ 372410 h 610519"/>
              <a:gd name="connsiteX12" fmla="*/ 969682 w 1351599"/>
              <a:gd name="connsiteY12" fmla="*/ 353170 h 610519"/>
              <a:gd name="connsiteX13" fmla="*/ 1120111 w 1351599"/>
              <a:gd name="connsiteY13" fmla="*/ 272123 h 610519"/>
              <a:gd name="connsiteX14" fmla="*/ 1246538 w 1351599"/>
              <a:gd name="connsiteY14" fmla="*/ 168716 h 610519"/>
              <a:gd name="connsiteX15" fmla="*/ 1351599 w 1351599"/>
              <a:gd name="connsiteY15" fmla="*/ 0 h 610519"/>
              <a:gd name="connsiteX0" fmla="*/ 42402 w 1351599"/>
              <a:gd name="connsiteY0" fmla="*/ 610519 h 610519"/>
              <a:gd name="connsiteX1" fmla="*/ 42402 w 1351599"/>
              <a:gd name="connsiteY1" fmla="*/ 610519 h 610519"/>
              <a:gd name="connsiteX2" fmla="*/ 8535 w 1351599"/>
              <a:gd name="connsiteY2" fmla="*/ 534319 h 610519"/>
              <a:gd name="connsiteX3" fmla="*/ 69 w 1351599"/>
              <a:gd name="connsiteY3" fmla="*/ 381919 h 610519"/>
              <a:gd name="connsiteX4" fmla="*/ 69 w 1351599"/>
              <a:gd name="connsiteY4" fmla="*/ 381919 h 610519"/>
              <a:gd name="connsiteX5" fmla="*/ 25469 w 1351599"/>
              <a:gd name="connsiteY5" fmla="*/ 263385 h 610519"/>
              <a:gd name="connsiteX6" fmla="*/ 99915 w 1351599"/>
              <a:gd name="connsiteY6" fmla="*/ 180042 h 610519"/>
              <a:gd name="connsiteX7" fmla="*/ 236245 w 1351599"/>
              <a:gd name="connsiteY7" fmla="*/ 140166 h 610519"/>
              <a:gd name="connsiteX8" fmla="*/ 382034 w 1351599"/>
              <a:gd name="connsiteY8" fmla="*/ 203466 h 610519"/>
              <a:gd name="connsiteX9" fmla="*/ 497547 w 1351599"/>
              <a:gd name="connsiteY9" fmla="*/ 272123 h 610519"/>
              <a:gd name="connsiteX10" fmla="*/ 628054 w 1351599"/>
              <a:gd name="connsiteY10" fmla="*/ 323868 h 610519"/>
              <a:gd name="connsiteX11" fmla="*/ 771124 w 1351599"/>
              <a:gd name="connsiteY11" fmla="*/ 372410 h 610519"/>
              <a:gd name="connsiteX12" fmla="*/ 969682 w 1351599"/>
              <a:gd name="connsiteY12" fmla="*/ 353170 h 610519"/>
              <a:gd name="connsiteX13" fmla="*/ 1120111 w 1351599"/>
              <a:gd name="connsiteY13" fmla="*/ 272123 h 610519"/>
              <a:gd name="connsiteX14" fmla="*/ 1246538 w 1351599"/>
              <a:gd name="connsiteY14" fmla="*/ 163437 h 610519"/>
              <a:gd name="connsiteX15" fmla="*/ 1351599 w 1351599"/>
              <a:gd name="connsiteY15" fmla="*/ 0 h 610519"/>
              <a:gd name="connsiteX0" fmla="*/ 42402 w 1351599"/>
              <a:gd name="connsiteY0" fmla="*/ 610519 h 610519"/>
              <a:gd name="connsiteX1" fmla="*/ 42402 w 1351599"/>
              <a:gd name="connsiteY1" fmla="*/ 610519 h 610519"/>
              <a:gd name="connsiteX2" fmla="*/ 8535 w 1351599"/>
              <a:gd name="connsiteY2" fmla="*/ 534319 h 610519"/>
              <a:gd name="connsiteX3" fmla="*/ 69 w 1351599"/>
              <a:gd name="connsiteY3" fmla="*/ 381919 h 610519"/>
              <a:gd name="connsiteX4" fmla="*/ 69 w 1351599"/>
              <a:gd name="connsiteY4" fmla="*/ 381919 h 610519"/>
              <a:gd name="connsiteX5" fmla="*/ 25469 w 1351599"/>
              <a:gd name="connsiteY5" fmla="*/ 263385 h 610519"/>
              <a:gd name="connsiteX6" fmla="*/ 99915 w 1351599"/>
              <a:gd name="connsiteY6" fmla="*/ 180042 h 610519"/>
              <a:gd name="connsiteX7" fmla="*/ 236245 w 1351599"/>
              <a:gd name="connsiteY7" fmla="*/ 140166 h 610519"/>
              <a:gd name="connsiteX8" fmla="*/ 382034 w 1351599"/>
              <a:gd name="connsiteY8" fmla="*/ 203466 h 610519"/>
              <a:gd name="connsiteX9" fmla="*/ 497547 w 1351599"/>
              <a:gd name="connsiteY9" fmla="*/ 272123 h 610519"/>
              <a:gd name="connsiteX10" fmla="*/ 628054 w 1351599"/>
              <a:gd name="connsiteY10" fmla="*/ 323868 h 610519"/>
              <a:gd name="connsiteX11" fmla="*/ 771124 w 1351599"/>
              <a:gd name="connsiteY11" fmla="*/ 372410 h 610519"/>
              <a:gd name="connsiteX12" fmla="*/ 969682 w 1351599"/>
              <a:gd name="connsiteY12" fmla="*/ 353170 h 610519"/>
              <a:gd name="connsiteX13" fmla="*/ 1120111 w 1351599"/>
              <a:gd name="connsiteY13" fmla="*/ 272123 h 610519"/>
              <a:gd name="connsiteX14" fmla="*/ 1246538 w 1351599"/>
              <a:gd name="connsiteY14" fmla="*/ 161678 h 610519"/>
              <a:gd name="connsiteX15" fmla="*/ 1351599 w 1351599"/>
              <a:gd name="connsiteY15" fmla="*/ 0 h 610519"/>
              <a:gd name="connsiteX0" fmla="*/ 42402 w 1351599"/>
              <a:gd name="connsiteY0" fmla="*/ 610519 h 610519"/>
              <a:gd name="connsiteX1" fmla="*/ 42402 w 1351599"/>
              <a:gd name="connsiteY1" fmla="*/ 610519 h 610519"/>
              <a:gd name="connsiteX2" fmla="*/ 8535 w 1351599"/>
              <a:gd name="connsiteY2" fmla="*/ 534319 h 610519"/>
              <a:gd name="connsiteX3" fmla="*/ 69 w 1351599"/>
              <a:gd name="connsiteY3" fmla="*/ 381919 h 610519"/>
              <a:gd name="connsiteX4" fmla="*/ 69 w 1351599"/>
              <a:gd name="connsiteY4" fmla="*/ 381919 h 610519"/>
              <a:gd name="connsiteX5" fmla="*/ 25469 w 1351599"/>
              <a:gd name="connsiteY5" fmla="*/ 263385 h 610519"/>
              <a:gd name="connsiteX6" fmla="*/ 99915 w 1351599"/>
              <a:gd name="connsiteY6" fmla="*/ 180042 h 610519"/>
              <a:gd name="connsiteX7" fmla="*/ 236245 w 1351599"/>
              <a:gd name="connsiteY7" fmla="*/ 140166 h 610519"/>
              <a:gd name="connsiteX8" fmla="*/ 382034 w 1351599"/>
              <a:gd name="connsiteY8" fmla="*/ 203466 h 610519"/>
              <a:gd name="connsiteX9" fmla="*/ 497547 w 1351599"/>
              <a:gd name="connsiteY9" fmla="*/ 272123 h 610519"/>
              <a:gd name="connsiteX10" fmla="*/ 628054 w 1351599"/>
              <a:gd name="connsiteY10" fmla="*/ 323868 h 610519"/>
              <a:gd name="connsiteX11" fmla="*/ 771124 w 1351599"/>
              <a:gd name="connsiteY11" fmla="*/ 372410 h 610519"/>
              <a:gd name="connsiteX12" fmla="*/ 969682 w 1351599"/>
              <a:gd name="connsiteY12" fmla="*/ 353170 h 610519"/>
              <a:gd name="connsiteX13" fmla="*/ 1120111 w 1351599"/>
              <a:gd name="connsiteY13" fmla="*/ 272123 h 610519"/>
              <a:gd name="connsiteX14" fmla="*/ 1246538 w 1351599"/>
              <a:gd name="connsiteY14" fmla="*/ 161678 h 610519"/>
              <a:gd name="connsiteX15" fmla="*/ 1351599 w 1351599"/>
              <a:gd name="connsiteY15" fmla="*/ 0 h 610519"/>
              <a:gd name="connsiteX0" fmla="*/ 42402 w 1351599"/>
              <a:gd name="connsiteY0" fmla="*/ 610519 h 610519"/>
              <a:gd name="connsiteX1" fmla="*/ 42402 w 1351599"/>
              <a:gd name="connsiteY1" fmla="*/ 610519 h 610519"/>
              <a:gd name="connsiteX2" fmla="*/ 8535 w 1351599"/>
              <a:gd name="connsiteY2" fmla="*/ 534319 h 610519"/>
              <a:gd name="connsiteX3" fmla="*/ 69 w 1351599"/>
              <a:gd name="connsiteY3" fmla="*/ 381919 h 610519"/>
              <a:gd name="connsiteX4" fmla="*/ 69 w 1351599"/>
              <a:gd name="connsiteY4" fmla="*/ 381919 h 610519"/>
              <a:gd name="connsiteX5" fmla="*/ 25469 w 1351599"/>
              <a:gd name="connsiteY5" fmla="*/ 263385 h 610519"/>
              <a:gd name="connsiteX6" fmla="*/ 99915 w 1351599"/>
              <a:gd name="connsiteY6" fmla="*/ 180042 h 610519"/>
              <a:gd name="connsiteX7" fmla="*/ 236245 w 1351599"/>
              <a:gd name="connsiteY7" fmla="*/ 140166 h 610519"/>
              <a:gd name="connsiteX8" fmla="*/ 382034 w 1351599"/>
              <a:gd name="connsiteY8" fmla="*/ 203466 h 610519"/>
              <a:gd name="connsiteX9" fmla="*/ 497547 w 1351599"/>
              <a:gd name="connsiteY9" fmla="*/ 272123 h 610519"/>
              <a:gd name="connsiteX10" fmla="*/ 628054 w 1351599"/>
              <a:gd name="connsiteY10" fmla="*/ 323868 h 610519"/>
              <a:gd name="connsiteX11" fmla="*/ 771124 w 1351599"/>
              <a:gd name="connsiteY11" fmla="*/ 372410 h 610519"/>
              <a:gd name="connsiteX12" fmla="*/ 969682 w 1351599"/>
              <a:gd name="connsiteY12" fmla="*/ 353170 h 610519"/>
              <a:gd name="connsiteX13" fmla="*/ 1120111 w 1351599"/>
              <a:gd name="connsiteY13" fmla="*/ 272123 h 610519"/>
              <a:gd name="connsiteX14" fmla="*/ 1244784 w 1351599"/>
              <a:gd name="connsiteY14" fmla="*/ 154641 h 610519"/>
              <a:gd name="connsiteX15" fmla="*/ 1351599 w 1351599"/>
              <a:gd name="connsiteY15" fmla="*/ 0 h 610519"/>
              <a:gd name="connsiteX0" fmla="*/ 42402 w 1367382"/>
              <a:gd name="connsiteY0" fmla="*/ 628113 h 628113"/>
              <a:gd name="connsiteX1" fmla="*/ 42402 w 1367382"/>
              <a:gd name="connsiteY1" fmla="*/ 628113 h 628113"/>
              <a:gd name="connsiteX2" fmla="*/ 8535 w 1367382"/>
              <a:gd name="connsiteY2" fmla="*/ 551913 h 628113"/>
              <a:gd name="connsiteX3" fmla="*/ 69 w 1367382"/>
              <a:gd name="connsiteY3" fmla="*/ 399513 h 628113"/>
              <a:gd name="connsiteX4" fmla="*/ 69 w 1367382"/>
              <a:gd name="connsiteY4" fmla="*/ 399513 h 628113"/>
              <a:gd name="connsiteX5" fmla="*/ 25469 w 1367382"/>
              <a:gd name="connsiteY5" fmla="*/ 280979 h 628113"/>
              <a:gd name="connsiteX6" fmla="*/ 99915 w 1367382"/>
              <a:gd name="connsiteY6" fmla="*/ 197636 h 628113"/>
              <a:gd name="connsiteX7" fmla="*/ 236245 w 1367382"/>
              <a:gd name="connsiteY7" fmla="*/ 157760 h 628113"/>
              <a:gd name="connsiteX8" fmla="*/ 382034 w 1367382"/>
              <a:gd name="connsiteY8" fmla="*/ 221060 h 628113"/>
              <a:gd name="connsiteX9" fmla="*/ 497547 w 1367382"/>
              <a:gd name="connsiteY9" fmla="*/ 289717 h 628113"/>
              <a:gd name="connsiteX10" fmla="*/ 628054 w 1367382"/>
              <a:gd name="connsiteY10" fmla="*/ 341462 h 628113"/>
              <a:gd name="connsiteX11" fmla="*/ 771124 w 1367382"/>
              <a:gd name="connsiteY11" fmla="*/ 390004 h 628113"/>
              <a:gd name="connsiteX12" fmla="*/ 969682 w 1367382"/>
              <a:gd name="connsiteY12" fmla="*/ 370764 h 628113"/>
              <a:gd name="connsiteX13" fmla="*/ 1120111 w 1367382"/>
              <a:gd name="connsiteY13" fmla="*/ 289717 h 628113"/>
              <a:gd name="connsiteX14" fmla="*/ 1244784 w 1367382"/>
              <a:gd name="connsiteY14" fmla="*/ 172235 h 628113"/>
              <a:gd name="connsiteX15" fmla="*/ 1367382 w 1367382"/>
              <a:gd name="connsiteY15" fmla="*/ 0 h 628113"/>
              <a:gd name="connsiteX0" fmla="*/ 42402 w 1367382"/>
              <a:gd name="connsiteY0" fmla="*/ 628113 h 628113"/>
              <a:gd name="connsiteX1" fmla="*/ 42402 w 1367382"/>
              <a:gd name="connsiteY1" fmla="*/ 628113 h 628113"/>
              <a:gd name="connsiteX2" fmla="*/ 8535 w 1367382"/>
              <a:gd name="connsiteY2" fmla="*/ 551913 h 628113"/>
              <a:gd name="connsiteX3" fmla="*/ 69 w 1367382"/>
              <a:gd name="connsiteY3" fmla="*/ 399513 h 628113"/>
              <a:gd name="connsiteX4" fmla="*/ 69 w 1367382"/>
              <a:gd name="connsiteY4" fmla="*/ 399513 h 628113"/>
              <a:gd name="connsiteX5" fmla="*/ 25469 w 1367382"/>
              <a:gd name="connsiteY5" fmla="*/ 280979 h 628113"/>
              <a:gd name="connsiteX6" fmla="*/ 99915 w 1367382"/>
              <a:gd name="connsiteY6" fmla="*/ 197636 h 628113"/>
              <a:gd name="connsiteX7" fmla="*/ 236245 w 1367382"/>
              <a:gd name="connsiteY7" fmla="*/ 157760 h 628113"/>
              <a:gd name="connsiteX8" fmla="*/ 382034 w 1367382"/>
              <a:gd name="connsiteY8" fmla="*/ 221060 h 628113"/>
              <a:gd name="connsiteX9" fmla="*/ 497547 w 1367382"/>
              <a:gd name="connsiteY9" fmla="*/ 289717 h 628113"/>
              <a:gd name="connsiteX10" fmla="*/ 628054 w 1367382"/>
              <a:gd name="connsiteY10" fmla="*/ 341462 h 628113"/>
              <a:gd name="connsiteX11" fmla="*/ 771124 w 1367382"/>
              <a:gd name="connsiteY11" fmla="*/ 390004 h 628113"/>
              <a:gd name="connsiteX12" fmla="*/ 969682 w 1367382"/>
              <a:gd name="connsiteY12" fmla="*/ 370764 h 628113"/>
              <a:gd name="connsiteX13" fmla="*/ 1120111 w 1367382"/>
              <a:gd name="connsiteY13" fmla="*/ 289717 h 628113"/>
              <a:gd name="connsiteX14" fmla="*/ 1244784 w 1367382"/>
              <a:gd name="connsiteY14" fmla="*/ 172235 h 628113"/>
              <a:gd name="connsiteX15" fmla="*/ 1367382 w 1367382"/>
              <a:gd name="connsiteY15" fmla="*/ 0 h 62811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1367382" h="628113">
                <a:moveTo>
                  <a:pt x="42402" y="628113"/>
                </a:moveTo>
                <a:lnTo>
                  <a:pt x="42402" y="628113"/>
                </a:lnTo>
                <a:cubicBezTo>
                  <a:pt x="31113" y="602713"/>
                  <a:pt x="14973" y="578953"/>
                  <a:pt x="8535" y="551913"/>
                </a:cubicBezTo>
                <a:cubicBezTo>
                  <a:pt x="-1337" y="510450"/>
                  <a:pt x="69" y="445924"/>
                  <a:pt x="69" y="399513"/>
                </a:cubicBezTo>
                <a:lnTo>
                  <a:pt x="69" y="399513"/>
                </a:lnTo>
                <a:cubicBezTo>
                  <a:pt x="4302" y="379757"/>
                  <a:pt x="8828" y="314625"/>
                  <a:pt x="25469" y="280979"/>
                </a:cubicBezTo>
                <a:cubicBezTo>
                  <a:pt x="42110" y="247333"/>
                  <a:pt x="64786" y="218173"/>
                  <a:pt x="99915" y="197636"/>
                </a:cubicBezTo>
                <a:cubicBezTo>
                  <a:pt x="135044" y="177100"/>
                  <a:pt x="200332" y="154443"/>
                  <a:pt x="236245" y="157760"/>
                </a:cubicBezTo>
                <a:cubicBezTo>
                  <a:pt x="272158" y="161077"/>
                  <a:pt x="338484" y="199067"/>
                  <a:pt x="382034" y="221060"/>
                </a:cubicBezTo>
                <a:cubicBezTo>
                  <a:pt x="425584" y="243053"/>
                  <a:pt x="458458" y="272696"/>
                  <a:pt x="497547" y="289717"/>
                </a:cubicBezTo>
                <a:cubicBezTo>
                  <a:pt x="544557" y="312243"/>
                  <a:pt x="582458" y="324748"/>
                  <a:pt x="628054" y="341462"/>
                </a:cubicBezTo>
                <a:cubicBezTo>
                  <a:pt x="673650" y="358176"/>
                  <a:pt x="714186" y="385120"/>
                  <a:pt x="771124" y="390004"/>
                </a:cubicBezTo>
                <a:cubicBezTo>
                  <a:pt x="828062" y="394888"/>
                  <a:pt x="911518" y="387478"/>
                  <a:pt x="969682" y="370764"/>
                </a:cubicBezTo>
                <a:cubicBezTo>
                  <a:pt x="1027846" y="354050"/>
                  <a:pt x="1076307" y="319286"/>
                  <a:pt x="1120111" y="289717"/>
                </a:cubicBezTo>
                <a:cubicBezTo>
                  <a:pt x="1163916" y="260148"/>
                  <a:pt x="1203572" y="220521"/>
                  <a:pt x="1244784" y="172235"/>
                </a:cubicBezTo>
                <a:cubicBezTo>
                  <a:pt x="1285996" y="123949"/>
                  <a:pt x="1335729" y="71913"/>
                  <a:pt x="1367382" y="0"/>
                </a:cubicBezTo>
              </a:path>
            </a:pathLst>
          </a:custGeom>
          <a:noFill/>
          <a:ln w="57150">
            <a:solidFill>
              <a:srgbClr val="00CC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1" name="Estrella de 7 puntas 220"/>
          <p:cNvSpPr/>
          <p:nvPr/>
        </p:nvSpPr>
        <p:spPr>
          <a:xfrm rot="1218321">
            <a:off x="960713" y="4592121"/>
            <a:ext cx="629335" cy="565585"/>
          </a:xfrm>
          <a:prstGeom prst="star7">
            <a:avLst>
              <a:gd name="adj" fmla="val 33068"/>
              <a:gd name="hf" fmla="val 102572"/>
              <a:gd name="vf" fmla="val 105210"/>
            </a:avLst>
          </a:prstGeom>
          <a:solidFill>
            <a:srgbClr val="92D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2" name="Lágrima 221"/>
          <p:cNvSpPr/>
          <p:nvPr/>
        </p:nvSpPr>
        <p:spPr>
          <a:xfrm rot="11328590">
            <a:off x="2435970" y="3659305"/>
            <a:ext cx="560935" cy="500425"/>
          </a:xfrm>
          <a:prstGeom prst="teardrop">
            <a:avLst/>
          </a:prstGeom>
          <a:solidFill>
            <a:srgbClr val="FF33CC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3" name="CuadroTexto 222"/>
          <p:cNvSpPr txBox="1"/>
          <p:nvPr/>
        </p:nvSpPr>
        <p:spPr>
          <a:xfrm>
            <a:off x="1063035" y="4666318"/>
            <a:ext cx="38501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2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sz="2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CuadroTexto 223"/>
          <p:cNvSpPr txBox="1"/>
          <p:nvPr/>
        </p:nvSpPr>
        <p:spPr>
          <a:xfrm>
            <a:off x="2508207" y="3694073"/>
            <a:ext cx="38501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2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en-US" sz="2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6" name="Conector recto de flecha 225"/>
          <p:cNvCxnSpPr/>
          <p:nvPr/>
        </p:nvCxnSpPr>
        <p:spPr>
          <a:xfrm flipV="1">
            <a:off x="1675987" y="4255881"/>
            <a:ext cx="894167" cy="625881"/>
          </a:xfrm>
          <a:prstGeom prst="straightConnector1">
            <a:avLst/>
          </a:prstGeom>
          <a:ln w="44450">
            <a:solidFill>
              <a:srgbClr val="C0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0" name="Rayo 229"/>
          <p:cNvSpPr/>
          <p:nvPr/>
        </p:nvSpPr>
        <p:spPr>
          <a:xfrm rot="543425">
            <a:off x="517368" y="4041599"/>
            <a:ext cx="558486" cy="665203"/>
          </a:xfrm>
          <a:custGeom>
            <a:avLst/>
            <a:gdLst>
              <a:gd name="connsiteX0" fmla="*/ 8472 w 21600"/>
              <a:gd name="connsiteY0" fmla="*/ 0 h 21600"/>
              <a:gd name="connsiteX1" fmla="*/ 12860 w 21600"/>
              <a:gd name="connsiteY1" fmla="*/ 6080 h 21600"/>
              <a:gd name="connsiteX2" fmla="*/ 11050 w 21600"/>
              <a:gd name="connsiteY2" fmla="*/ 6797 h 21600"/>
              <a:gd name="connsiteX3" fmla="*/ 16577 w 21600"/>
              <a:gd name="connsiteY3" fmla="*/ 12007 h 21600"/>
              <a:gd name="connsiteX4" fmla="*/ 14767 w 21600"/>
              <a:gd name="connsiteY4" fmla="*/ 12877 h 21600"/>
              <a:gd name="connsiteX5" fmla="*/ 21600 w 21600"/>
              <a:gd name="connsiteY5" fmla="*/ 21600 h 21600"/>
              <a:gd name="connsiteX6" fmla="*/ 10012 w 21600"/>
              <a:gd name="connsiteY6" fmla="*/ 14915 h 21600"/>
              <a:gd name="connsiteX7" fmla="*/ 12222 w 21600"/>
              <a:gd name="connsiteY7" fmla="*/ 13987 h 21600"/>
              <a:gd name="connsiteX8" fmla="*/ 5022 w 21600"/>
              <a:gd name="connsiteY8" fmla="*/ 9705 h 21600"/>
              <a:gd name="connsiteX9" fmla="*/ 7602 w 21600"/>
              <a:gd name="connsiteY9" fmla="*/ 8382 h 21600"/>
              <a:gd name="connsiteX10" fmla="*/ 0 w 21600"/>
              <a:gd name="connsiteY10" fmla="*/ 3890 h 21600"/>
              <a:gd name="connsiteX11" fmla="*/ 8472 w 21600"/>
              <a:gd name="connsiteY11" fmla="*/ 0 h 21600"/>
              <a:gd name="connsiteX0" fmla="*/ 8472 w 21600"/>
              <a:gd name="connsiteY0" fmla="*/ 0 h 24466"/>
              <a:gd name="connsiteX1" fmla="*/ 12860 w 21600"/>
              <a:gd name="connsiteY1" fmla="*/ 8946 h 24466"/>
              <a:gd name="connsiteX2" fmla="*/ 11050 w 21600"/>
              <a:gd name="connsiteY2" fmla="*/ 9663 h 24466"/>
              <a:gd name="connsiteX3" fmla="*/ 16577 w 21600"/>
              <a:gd name="connsiteY3" fmla="*/ 14873 h 24466"/>
              <a:gd name="connsiteX4" fmla="*/ 14767 w 21600"/>
              <a:gd name="connsiteY4" fmla="*/ 15743 h 24466"/>
              <a:gd name="connsiteX5" fmla="*/ 21600 w 21600"/>
              <a:gd name="connsiteY5" fmla="*/ 24466 h 24466"/>
              <a:gd name="connsiteX6" fmla="*/ 10012 w 21600"/>
              <a:gd name="connsiteY6" fmla="*/ 17781 h 24466"/>
              <a:gd name="connsiteX7" fmla="*/ 12222 w 21600"/>
              <a:gd name="connsiteY7" fmla="*/ 16853 h 24466"/>
              <a:gd name="connsiteX8" fmla="*/ 5022 w 21600"/>
              <a:gd name="connsiteY8" fmla="*/ 12571 h 24466"/>
              <a:gd name="connsiteX9" fmla="*/ 7602 w 21600"/>
              <a:gd name="connsiteY9" fmla="*/ 11248 h 24466"/>
              <a:gd name="connsiteX10" fmla="*/ 0 w 21600"/>
              <a:gd name="connsiteY10" fmla="*/ 6756 h 24466"/>
              <a:gd name="connsiteX11" fmla="*/ 8472 w 21600"/>
              <a:gd name="connsiteY11" fmla="*/ 0 h 24466"/>
              <a:gd name="connsiteX0" fmla="*/ 8472 w 22661"/>
              <a:gd name="connsiteY0" fmla="*/ 0 h 25756"/>
              <a:gd name="connsiteX1" fmla="*/ 12860 w 22661"/>
              <a:gd name="connsiteY1" fmla="*/ 8946 h 25756"/>
              <a:gd name="connsiteX2" fmla="*/ 11050 w 22661"/>
              <a:gd name="connsiteY2" fmla="*/ 9663 h 25756"/>
              <a:gd name="connsiteX3" fmla="*/ 16577 w 22661"/>
              <a:gd name="connsiteY3" fmla="*/ 14873 h 25756"/>
              <a:gd name="connsiteX4" fmla="*/ 14767 w 22661"/>
              <a:gd name="connsiteY4" fmla="*/ 15743 h 25756"/>
              <a:gd name="connsiteX5" fmla="*/ 22661 w 22661"/>
              <a:gd name="connsiteY5" fmla="*/ 25756 h 25756"/>
              <a:gd name="connsiteX6" fmla="*/ 10012 w 22661"/>
              <a:gd name="connsiteY6" fmla="*/ 17781 h 25756"/>
              <a:gd name="connsiteX7" fmla="*/ 12222 w 22661"/>
              <a:gd name="connsiteY7" fmla="*/ 16853 h 25756"/>
              <a:gd name="connsiteX8" fmla="*/ 5022 w 22661"/>
              <a:gd name="connsiteY8" fmla="*/ 12571 h 25756"/>
              <a:gd name="connsiteX9" fmla="*/ 7602 w 22661"/>
              <a:gd name="connsiteY9" fmla="*/ 11248 h 25756"/>
              <a:gd name="connsiteX10" fmla="*/ 0 w 22661"/>
              <a:gd name="connsiteY10" fmla="*/ 6756 h 25756"/>
              <a:gd name="connsiteX11" fmla="*/ 8472 w 22661"/>
              <a:gd name="connsiteY11" fmla="*/ 0 h 257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22661" h="25756">
                <a:moveTo>
                  <a:pt x="8472" y="0"/>
                </a:moveTo>
                <a:lnTo>
                  <a:pt x="12860" y="8946"/>
                </a:lnTo>
                <a:lnTo>
                  <a:pt x="11050" y="9663"/>
                </a:lnTo>
                <a:lnTo>
                  <a:pt x="16577" y="14873"/>
                </a:lnTo>
                <a:lnTo>
                  <a:pt x="14767" y="15743"/>
                </a:lnTo>
                <a:lnTo>
                  <a:pt x="22661" y="25756"/>
                </a:lnTo>
                <a:lnTo>
                  <a:pt x="10012" y="17781"/>
                </a:lnTo>
                <a:lnTo>
                  <a:pt x="12222" y="16853"/>
                </a:lnTo>
                <a:lnTo>
                  <a:pt x="5022" y="12571"/>
                </a:lnTo>
                <a:lnTo>
                  <a:pt x="7602" y="11248"/>
                </a:lnTo>
                <a:lnTo>
                  <a:pt x="0" y="6756"/>
                </a:lnTo>
                <a:lnTo>
                  <a:pt x="8472" y="0"/>
                </a:lnTo>
                <a:close/>
              </a:path>
            </a:pathLst>
          </a:custGeom>
          <a:solidFill>
            <a:srgbClr val="FFFF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1" name="CuadroTexto 230"/>
          <p:cNvSpPr txBox="1"/>
          <p:nvPr/>
        </p:nvSpPr>
        <p:spPr>
          <a:xfrm>
            <a:off x="290059" y="3909516"/>
            <a:ext cx="4910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ight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CuadroTexto 231"/>
          <p:cNvSpPr txBox="1"/>
          <p:nvPr/>
        </p:nvSpPr>
        <p:spPr>
          <a:xfrm rot="19462778">
            <a:off x="1849603" y="4546330"/>
            <a:ext cx="751865" cy="348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eak coupling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CuadroTexto 233"/>
          <p:cNvSpPr txBox="1"/>
          <p:nvPr/>
        </p:nvSpPr>
        <p:spPr>
          <a:xfrm>
            <a:off x="2194220" y="3351075"/>
            <a:ext cx="1086612" cy="348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  <a:p>
            <a:pPr algn="ctr">
              <a:lnSpc>
                <a:spcPts val="1000"/>
              </a:lnSpc>
            </a:pP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Estrella de 7 puntas 236"/>
          <p:cNvSpPr/>
          <p:nvPr/>
        </p:nvSpPr>
        <p:spPr>
          <a:xfrm rot="1218321">
            <a:off x="1144586" y="5827960"/>
            <a:ext cx="711776" cy="686202"/>
          </a:xfrm>
          <a:prstGeom prst="star7">
            <a:avLst>
              <a:gd name="adj" fmla="val 23070"/>
              <a:gd name="hf" fmla="val 102572"/>
              <a:gd name="vf" fmla="val 105210"/>
            </a:avLst>
          </a:prstGeom>
          <a:solidFill>
            <a:srgbClr val="66FF33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8" name="Lágrima 237"/>
          <p:cNvSpPr/>
          <p:nvPr/>
        </p:nvSpPr>
        <p:spPr>
          <a:xfrm rot="11328590">
            <a:off x="3433049" y="4391330"/>
            <a:ext cx="560935" cy="500425"/>
          </a:xfrm>
          <a:prstGeom prst="teardrop">
            <a:avLst/>
          </a:prstGeom>
          <a:solidFill>
            <a:srgbClr val="9999FF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9" name="CuadroTexto 238"/>
          <p:cNvSpPr txBox="1"/>
          <p:nvPr/>
        </p:nvSpPr>
        <p:spPr>
          <a:xfrm>
            <a:off x="1305214" y="5957496"/>
            <a:ext cx="38501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2200" b="1" dirty="0" smtClean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sz="2200" b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CuadroTexto 239"/>
          <p:cNvSpPr txBox="1"/>
          <p:nvPr/>
        </p:nvSpPr>
        <p:spPr>
          <a:xfrm>
            <a:off x="3505286" y="4426098"/>
            <a:ext cx="38501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2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en-US" sz="2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1" name="Conector recto de flecha 240"/>
          <p:cNvCxnSpPr/>
          <p:nvPr/>
        </p:nvCxnSpPr>
        <p:spPr>
          <a:xfrm flipV="1">
            <a:off x="1953310" y="4982138"/>
            <a:ext cx="1282334" cy="1057211"/>
          </a:xfrm>
          <a:prstGeom prst="straightConnector1">
            <a:avLst/>
          </a:prstGeom>
          <a:ln w="44450">
            <a:solidFill>
              <a:srgbClr val="C00000"/>
            </a:solidFill>
            <a:prstDash val="sysDot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2" name="Rayo 229"/>
          <p:cNvSpPr/>
          <p:nvPr/>
        </p:nvSpPr>
        <p:spPr>
          <a:xfrm rot="20614005">
            <a:off x="664452" y="5451978"/>
            <a:ext cx="558486" cy="665203"/>
          </a:xfrm>
          <a:custGeom>
            <a:avLst/>
            <a:gdLst>
              <a:gd name="connsiteX0" fmla="*/ 8472 w 21600"/>
              <a:gd name="connsiteY0" fmla="*/ 0 h 21600"/>
              <a:gd name="connsiteX1" fmla="*/ 12860 w 21600"/>
              <a:gd name="connsiteY1" fmla="*/ 6080 h 21600"/>
              <a:gd name="connsiteX2" fmla="*/ 11050 w 21600"/>
              <a:gd name="connsiteY2" fmla="*/ 6797 h 21600"/>
              <a:gd name="connsiteX3" fmla="*/ 16577 w 21600"/>
              <a:gd name="connsiteY3" fmla="*/ 12007 h 21600"/>
              <a:gd name="connsiteX4" fmla="*/ 14767 w 21600"/>
              <a:gd name="connsiteY4" fmla="*/ 12877 h 21600"/>
              <a:gd name="connsiteX5" fmla="*/ 21600 w 21600"/>
              <a:gd name="connsiteY5" fmla="*/ 21600 h 21600"/>
              <a:gd name="connsiteX6" fmla="*/ 10012 w 21600"/>
              <a:gd name="connsiteY6" fmla="*/ 14915 h 21600"/>
              <a:gd name="connsiteX7" fmla="*/ 12222 w 21600"/>
              <a:gd name="connsiteY7" fmla="*/ 13987 h 21600"/>
              <a:gd name="connsiteX8" fmla="*/ 5022 w 21600"/>
              <a:gd name="connsiteY8" fmla="*/ 9705 h 21600"/>
              <a:gd name="connsiteX9" fmla="*/ 7602 w 21600"/>
              <a:gd name="connsiteY9" fmla="*/ 8382 h 21600"/>
              <a:gd name="connsiteX10" fmla="*/ 0 w 21600"/>
              <a:gd name="connsiteY10" fmla="*/ 3890 h 21600"/>
              <a:gd name="connsiteX11" fmla="*/ 8472 w 21600"/>
              <a:gd name="connsiteY11" fmla="*/ 0 h 21600"/>
              <a:gd name="connsiteX0" fmla="*/ 8472 w 21600"/>
              <a:gd name="connsiteY0" fmla="*/ 0 h 24466"/>
              <a:gd name="connsiteX1" fmla="*/ 12860 w 21600"/>
              <a:gd name="connsiteY1" fmla="*/ 8946 h 24466"/>
              <a:gd name="connsiteX2" fmla="*/ 11050 w 21600"/>
              <a:gd name="connsiteY2" fmla="*/ 9663 h 24466"/>
              <a:gd name="connsiteX3" fmla="*/ 16577 w 21600"/>
              <a:gd name="connsiteY3" fmla="*/ 14873 h 24466"/>
              <a:gd name="connsiteX4" fmla="*/ 14767 w 21600"/>
              <a:gd name="connsiteY4" fmla="*/ 15743 h 24466"/>
              <a:gd name="connsiteX5" fmla="*/ 21600 w 21600"/>
              <a:gd name="connsiteY5" fmla="*/ 24466 h 24466"/>
              <a:gd name="connsiteX6" fmla="*/ 10012 w 21600"/>
              <a:gd name="connsiteY6" fmla="*/ 17781 h 24466"/>
              <a:gd name="connsiteX7" fmla="*/ 12222 w 21600"/>
              <a:gd name="connsiteY7" fmla="*/ 16853 h 24466"/>
              <a:gd name="connsiteX8" fmla="*/ 5022 w 21600"/>
              <a:gd name="connsiteY8" fmla="*/ 12571 h 24466"/>
              <a:gd name="connsiteX9" fmla="*/ 7602 w 21600"/>
              <a:gd name="connsiteY9" fmla="*/ 11248 h 24466"/>
              <a:gd name="connsiteX10" fmla="*/ 0 w 21600"/>
              <a:gd name="connsiteY10" fmla="*/ 6756 h 24466"/>
              <a:gd name="connsiteX11" fmla="*/ 8472 w 21600"/>
              <a:gd name="connsiteY11" fmla="*/ 0 h 24466"/>
              <a:gd name="connsiteX0" fmla="*/ 8472 w 22661"/>
              <a:gd name="connsiteY0" fmla="*/ 0 h 25756"/>
              <a:gd name="connsiteX1" fmla="*/ 12860 w 22661"/>
              <a:gd name="connsiteY1" fmla="*/ 8946 h 25756"/>
              <a:gd name="connsiteX2" fmla="*/ 11050 w 22661"/>
              <a:gd name="connsiteY2" fmla="*/ 9663 h 25756"/>
              <a:gd name="connsiteX3" fmla="*/ 16577 w 22661"/>
              <a:gd name="connsiteY3" fmla="*/ 14873 h 25756"/>
              <a:gd name="connsiteX4" fmla="*/ 14767 w 22661"/>
              <a:gd name="connsiteY4" fmla="*/ 15743 h 25756"/>
              <a:gd name="connsiteX5" fmla="*/ 22661 w 22661"/>
              <a:gd name="connsiteY5" fmla="*/ 25756 h 25756"/>
              <a:gd name="connsiteX6" fmla="*/ 10012 w 22661"/>
              <a:gd name="connsiteY6" fmla="*/ 17781 h 25756"/>
              <a:gd name="connsiteX7" fmla="*/ 12222 w 22661"/>
              <a:gd name="connsiteY7" fmla="*/ 16853 h 25756"/>
              <a:gd name="connsiteX8" fmla="*/ 5022 w 22661"/>
              <a:gd name="connsiteY8" fmla="*/ 12571 h 25756"/>
              <a:gd name="connsiteX9" fmla="*/ 7602 w 22661"/>
              <a:gd name="connsiteY9" fmla="*/ 11248 h 25756"/>
              <a:gd name="connsiteX10" fmla="*/ 0 w 22661"/>
              <a:gd name="connsiteY10" fmla="*/ 6756 h 25756"/>
              <a:gd name="connsiteX11" fmla="*/ 8472 w 22661"/>
              <a:gd name="connsiteY11" fmla="*/ 0 h 257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22661" h="25756">
                <a:moveTo>
                  <a:pt x="8472" y="0"/>
                </a:moveTo>
                <a:lnTo>
                  <a:pt x="12860" y="8946"/>
                </a:lnTo>
                <a:lnTo>
                  <a:pt x="11050" y="9663"/>
                </a:lnTo>
                <a:lnTo>
                  <a:pt x="16577" y="14873"/>
                </a:lnTo>
                <a:lnTo>
                  <a:pt x="14767" y="15743"/>
                </a:lnTo>
                <a:lnTo>
                  <a:pt x="22661" y="25756"/>
                </a:lnTo>
                <a:lnTo>
                  <a:pt x="10012" y="17781"/>
                </a:lnTo>
                <a:lnTo>
                  <a:pt x="12222" y="16853"/>
                </a:lnTo>
                <a:lnTo>
                  <a:pt x="5022" y="12571"/>
                </a:lnTo>
                <a:lnTo>
                  <a:pt x="7602" y="11248"/>
                </a:lnTo>
                <a:lnTo>
                  <a:pt x="0" y="6756"/>
                </a:lnTo>
                <a:lnTo>
                  <a:pt x="8472" y="0"/>
                </a:lnTo>
                <a:close/>
              </a:path>
            </a:pathLst>
          </a:custGeom>
          <a:solidFill>
            <a:srgbClr val="FFFF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5" name="CuadroTexto 244"/>
          <p:cNvSpPr txBox="1"/>
          <p:nvPr/>
        </p:nvSpPr>
        <p:spPr>
          <a:xfrm>
            <a:off x="984197" y="6529909"/>
            <a:ext cx="1086612" cy="220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0" name="Grupo 249"/>
          <p:cNvGrpSpPr/>
          <p:nvPr/>
        </p:nvGrpSpPr>
        <p:grpSpPr>
          <a:xfrm rot="60000" flipV="1">
            <a:off x="11252928" y="4002403"/>
            <a:ext cx="62100" cy="106542"/>
            <a:chOff x="4953375" y="7221921"/>
            <a:chExt cx="82800" cy="142056"/>
          </a:xfrm>
        </p:grpSpPr>
        <p:sp>
          <p:nvSpPr>
            <p:cNvPr id="251" name="Rectángulo 250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52" name="Conector recto 251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3" name="Grupo 252"/>
          <p:cNvGrpSpPr/>
          <p:nvPr/>
        </p:nvGrpSpPr>
        <p:grpSpPr>
          <a:xfrm rot="21540000" flipH="1" flipV="1">
            <a:off x="11326501" y="4002273"/>
            <a:ext cx="62100" cy="106542"/>
            <a:chOff x="4953375" y="7221921"/>
            <a:chExt cx="82800" cy="142056"/>
          </a:xfrm>
        </p:grpSpPr>
        <p:sp>
          <p:nvSpPr>
            <p:cNvPr id="254" name="Rectángulo 253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55" name="Conector recto 254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6" name="Grupo 255"/>
          <p:cNvGrpSpPr/>
          <p:nvPr/>
        </p:nvGrpSpPr>
        <p:grpSpPr>
          <a:xfrm rot="60000" flipV="1">
            <a:off x="11397706" y="4001591"/>
            <a:ext cx="62100" cy="106542"/>
            <a:chOff x="4953375" y="7221921"/>
            <a:chExt cx="82800" cy="142056"/>
          </a:xfrm>
        </p:grpSpPr>
        <p:sp>
          <p:nvSpPr>
            <p:cNvPr id="257" name="Rectángulo 25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58" name="Conector recto 25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9" name="Grupo 258"/>
          <p:cNvGrpSpPr/>
          <p:nvPr/>
        </p:nvGrpSpPr>
        <p:grpSpPr>
          <a:xfrm rot="60000" flipV="1">
            <a:off x="11033329" y="4002423"/>
            <a:ext cx="62100" cy="106542"/>
            <a:chOff x="4953375" y="7221921"/>
            <a:chExt cx="82800" cy="142056"/>
          </a:xfrm>
        </p:grpSpPr>
        <p:sp>
          <p:nvSpPr>
            <p:cNvPr id="260" name="Rectángulo 25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61" name="Conector recto 26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2" name="Grupo 261"/>
          <p:cNvGrpSpPr/>
          <p:nvPr/>
        </p:nvGrpSpPr>
        <p:grpSpPr>
          <a:xfrm rot="21540000" flipH="1" flipV="1">
            <a:off x="11106902" y="4002293"/>
            <a:ext cx="62100" cy="106542"/>
            <a:chOff x="4953375" y="7221921"/>
            <a:chExt cx="82800" cy="142056"/>
          </a:xfrm>
        </p:grpSpPr>
        <p:sp>
          <p:nvSpPr>
            <p:cNvPr id="263" name="Rectángulo 262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64" name="Conector recto 263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5" name="Grupo 264"/>
          <p:cNvGrpSpPr/>
          <p:nvPr/>
        </p:nvGrpSpPr>
        <p:grpSpPr>
          <a:xfrm rot="60000" flipV="1">
            <a:off x="11178107" y="4001611"/>
            <a:ext cx="62100" cy="106542"/>
            <a:chOff x="4953375" y="7221921"/>
            <a:chExt cx="82800" cy="142056"/>
          </a:xfrm>
        </p:grpSpPr>
        <p:sp>
          <p:nvSpPr>
            <p:cNvPr id="266" name="Rectángulo 265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67" name="Conector recto 266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8" name="Grupo 267"/>
          <p:cNvGrpSpPr/>
          <p:nvPr/>
        </p:nvGrpSpPr>
        <p:grpSpPr>
          <a:xfrm rot="60000" flipV="1">
            <a:off x="11472809" y="4002403"/>
            <a:ext cx="62100" cy="106542"/>
            <a:chOff x="4953375" y="7221921"/>
            <a:chExt cx="82800" cy="142056"/>
          </a:xfrm>
        </p:grpSpPr>
        <p:sp>
          <p:nvSpPr>
            <p:cNvPr id="269" name="Rectángulo 268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70" name="Conector recto 269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1" name="Grupo 270"/>
          <p:cNvGrpSpPr/>
          <p:nvPr/>
        </p:nvGrpSpPr>
        <p:grpSpPr>
          <a:xfrm rot="21540000" flipH="1" flipV="1">
            <a:off x="11546382" y="4002273"/>
            <a:ext cx="62100" cy="106542"/>
            <a:chOff x="4953375" y="7221921"/>
            <a:chExt cx="82800" cy="142056"/>
          </a:xfrm>
        </p:grpSpPr>
        <p:sp>
          <p:nvSpPr>
            <p:cNvPr id="272" name="Rectángulo 271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73" name="Conector recto 272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4" name="Grupo 273"/>
          <p:cNvGrpSpPr/>
          <p:nvPr/>
        </p:nvGrpSpPr>
        <p:grpSpPr>
          <a:xfrm rot="60000" flipV="1">
            <a:off x="11617587" y="4001591"/>
            <a:ext cx="62100" cy="106542"/>
            <a:chOff x="4953375" y="7221921"/>
            <a:chExt cx="82800" cy="142056"/>
          </a:xfrm>
        </p:grpSpPr>
        <p:sp>
          <p:nvSpPr>
            <p:cNvPr id="275" name="Rectángulo 274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76" name="Conector recto 275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7" name="Rectángulo 276"/>
          <p:cNvSpPr/>
          <p:nvPr/>
        </p:nvSpPr>
        <p:spPr>
          <a:xfrm>
            <a:off x="9528559" y="3838865"/>
            <a:ext cx="2340000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278" name="Conector recto 277"/>
          <p:cNvCxnSpPr/>
          <p:nvPr/>
        </p:nvCxnSpPr>
        <p:spPr>
          <a:xfrm flipV="1">
            <a:off x="9544002" y="3956826"/>
            <a:ext cx="23400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9" name="Imagen 27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>
            <a:off x="9446234" y="3784060"/>
            <a:ext cx="91418" cy="88266"/>
          </a:xfrm>
          <a:prstGeom prst="rect">
            <a:avLst/>
          </a:prstGeom>
        </p:spPr>
      </p:pic>
      <p:pic>
        <p:nvPicPr>
          <p:cNvPr id="280" name="Imagen 27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>
            <a:off x="11868559" y="3750600"/>
            <a:ext cx="90629" cy="88265"/>
          </a:xfrm>
          <a:prstGeom prst="rect">
            <a:avLst/>
          </a:prstGeom>
        </p:spPr>
      </p:pic>
      <p:sp>
        <p:nvSpPr>
          <p:cNvPr id="301" name="Circular 131"/>
          <p:cNvSpPr/>
          <p:nvPr/>
        </p:nvSpPr>
        <p:spPr>
          <a:xfrm rot="1475539">
            <a:off x="10124289" y="4505744"/>
            <a:ext cx="175841" cy="13620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grpSp>
        <p:nvGrpSpPr>
          <p:cNvPr id="305" name="Grupo 304"/>
          <p:cNvGrpSpPr/>
          <p:nvPr/>
        </p:nvGrpSpPr>
        <p:grpSpPr>
          <a:xfrm flipH="1" flipV="1">
            <a:off x="9553203" y="4500986"/>
            <a:ext cx="189000" cy="130469"/>
            <a:chOff x="4079020" y="6879809"/>
            <a:chExt cx="252000" cy="173958"/>
          </a:xfrm>
        </p:grpSpPr>
        <p:sp>
          <p:nvSpPr>
            <p:cNvPr id="306" name="Forma libre 305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07" name="Conector recto 306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8" name="Grupo 307"/>
          <p:cNvGrpSpPr/>
          <p:nvPr/>
        </p:nvGrpSpPr>
        <p:grpSpPr>
          <a:xfrm>
            <a:off x="11688999" y="4004260"/>
            <a:ext cx="189000" cy="130469"/>
            <a:chOff x="4079020" y="6879809"/>
            <a:chExt cx="252000" cy="173958"/>
          </a:xfrm>
        </p:grpSpPr>
        <p:sp>
          <p:nvSpPr>
            <p:cNvPr id="309" name="Forma libre 308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10" name="Conector recto 309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18" name="Conector recto 317"/>
          <p:cNvCxnSpPr/>
          <p:nvPr/>
        </p:nvCxnSpPr>
        <p:spPr>
          <a:xfrm flipV="1">
            <a:off x="10607277" y="4618550"/>
            <a:ext cx="6480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27" name="Grupo 326"/>
          <p:cNvGrpSpPr/>
          <p:nvPr/>
        </p:nvGrpSpPr>
        <p:grpSpPr>
          <a:xfrm rot="21540000">
            <a:off x="9969118" y="4525098"/>
            <a:ext cx="62100" cy="106542"/>
            <a:chOff x="4953375" y="7221921"/>
            <a:chExt cx="82800" cy="142056"/>
          </a:xfrm>
        </p:grpSpPr>
        <p:sp>
          <p:nvSpPr>
            <p:cNvPr id="328" name="Rectángulo 327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29" name="Conector recto 328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0" name="Grupo 329"/>
          <p:cNvGrpSpPr/>
          <p:nvPr/>
        </p:nvGrpSpPr>
        <p:grpSpPr>
          <a:xfrm rot="60000" flipH="1">
            <a:off x="10042691" y="4524968"/>
            <a:ext cx="62100" cy="106542"/>
            <a:chOff x="4953375" y="7221921"/>
            <a:chExt cx="82800" cy="142056"/>
          </a:xfrm>
        </p:grpSpPr>
        <p:sp>
          <p:nvSpPr>
            <p:cNvPr id="331" name="Rectángulo 330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32" name="Conector recto 331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3" name="Grupo 332"/>
          <p:cNvGrpSpPr/>
          <p:nvPr/>
        </p:nvGrpSpPr>
        <p:grpSpPr>
          <a:xfrm rot="120000">
            <a:off x="10667508" y="5905663"/>
            <a:ext cx="62100" cy="106542"/>
            <a:chOff x="4953375" y="7221921"/>
            <a:chExt cx="82800" cy="142056"/>
          </a:xfrm>
        </p:grpSpPr>
        <p:sp>
          <p:nvSpPr>
            <p:cNvPr id="334" name="Rectángulo 333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35" name="Conector recto 334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6" name="Grupo 335"/>
          <p:cNvGrpSpPr/>
          <p:nvPr/>
        </p:nvGrpSpPr>
        <p:grpSpPr>
          <a:xfrm rot="21540000">
            <a:off x="9749519" y="4525118"/>
            <a:ext cx="62100" cy="106542"/>
            <a:chOff x="4953375" y="7221921"/>
            <a:chExt cx="82800" cy="142056"/>
          </a:xfrm>
        </p:grpSpPr>
        <p:sp>
          <p:nvSpPr>
            <p:cNvPr id="337" name="Rectángulo 33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38" name="Conector recto 33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9" name="Grupo 338"/>
          <p:cNvGrpSpPr/>
          <p:nvPr/>
        </p:nvGrpSpPr>
        <p:grpSpPr>
          <a:xfrm rot="60000" flipH="1">
            <a:off x="9823092" y="4524988"/>
            <a:ext cx="62100" cy="106542"/>
            <a:chOff x="4953375" y="7221921"/>
            <a:chExt cx="82800" cy="142056"/>
          </a:xfrm>
        </p:grpSpPr>
        <p:sp>
          <p:nvSpPr>
            <p:cNvPr id="340" name="Rectángulo 33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41" name="Conector recto 34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2" name="Grupo 341"/>
          <p:cNvGrpSpPr/>
          <p:nvPr/>
        </p:nvGrpSpPr>
        <p:grpSpPr>
          <a:xfrm rot="21540000">
            <a:off x="9894297" y="4524306"/>
            <a:ext cx="62100" cy="106542"/>
            <a:chOff x="4953375" y="7221921"/>
            <a:chExt cx="82800" cy="142056"/>
          </a:xfrm>
        </p:grpSpPr>
        <p:sp>
          <p:nvSpPr>
            <p:cNvPr id="343" name="Rectángulo 342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44" name="Conector recto 343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5" name="Grupo 344"/>
          <p:cNvGrpSpPr/>
          <p:nvPr/>
        </p:nvGrpSpPr>
        <p:grpSpPr>
          <a:xfrm rot="960000">
            <a:off x="10769201" y="5947092"/>
            <a:ext cx="62100" cy="106542"/>
            <a:chOff x="4953375" y="7221921"/>
            <a:chExt cx="82800" cy="142056"/>
          </a:xfrm>
        </p:grpSpPr>
        <p:sp>
          <p:nvSpPr>
            <p:cNvPr id="346" name="Rectángulo 345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47" name="Conector recto 346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8" name="Grupo 347"/>
          <p:cNvGrpSpPr/>
          <p:nvPr/>
        </p:nvGrpSpPr>
        <p:grpSpPr>
          <a:xfrm rot="480000" flipH="1">
            <a:off x="10878519" y="5978964"/>
            <a:ext cx="62100" cy="106542"/>
            <a:chOff x="4953375" y="7221921"/>
            <a:chExt cx="82800" cy="142056"/>
          </a:xfrm>
        </p:grpSpPr>
        <p:sp>
          <p:nvSpPr>
            <p:cNvPr id="349" name="Rectángulo 348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50" name="Conector recto 349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1" name="Grupo 350"/>
          <p:cNvGrpSpPr/>
          <p:nvPr/>
        </p:nvGrpSpPr>
        <p:grpSpPr>
          <a:xfrm rot="960000">
            <a:off x="10966438" y="6033993"/>
            <a:ext cx="62100" cy="106542"/>
            <a:chOff x="4953375" y="7221921"/>
            <a:chExt cx="82800" cy="142056"/>
          </a:xfrm>
        </p:grpSpPr>
        <p:sp>
          <p:nvSpPr>
            <p:cNvPr id="352" name="Rectángulo 351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53" name="Conector recto 352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4" name="Circular 131"/>
          <p:cNvSpPr/>
          <p:nvPr/>
        </p:nvSpPr>
        <p:spPr>
          <a:xfrm rot="20124461" flipH="1">
            <a:off x="10837971" y="3996603"/>
            <a:ext cx="175841" cy="13620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cxnSp>
        <p:nvCxnSpPr>
          <p:cNvPr id="356" name="Conector angular 355"/>
          <p:cNvCxnSpPr/>
          <p:nvPr/>
        </p:nvCxnSpPr>
        <p:spPr>
          <a:xfrm>
            <a:off x="4784605" y="4406375"/>
            <a:ext cx="4192397" cy="1965545"/>
          </a:xfrm>
          <a:prstGeom prst="bentConnector3">
            <a:avLst>
              <a:gd name="adj1" fmla="val 17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0" name="Forma libre 359"/>
          <p:cNvSpPr/>
          <p:nvPr/>
        </p:nvSpPr>
        <p:spPr>
          <a:xfrm>
            <a:off x="4815883" y="4613389"/>
            <a:ext cx="1449882" cy="1751528"/>
          </a:xfrm>
          <a:custGeom>
            <a:avLst/>
            <a:gdLst>
              <a:gd name="connsiteX0" fmla="*/ 0 w 1549400"/>
              <a:gd name="connsiteY0" fmla="*/ 1519581 h 1547636"/>
              <a:gd name="connsiteX1" fmla="*/ 169334 w 1549400"/>
              <a:gd name="connsiteY1" fmla="*/ 1443381 h 1547636"/>
              <a:gd name="connsiteX2" fmla="*/ 279400 w 1549400"/>
              <a:gd name="connsiteY2" fmla="*/ 1274047 h 1547636"/>
              <a:gd name="connsiteX3" fmla="*/ 338667 w 1549400"/>
              <a:gd name="connsiteY3" fmla="*/ 1028514 h 1547636"/>
              <a:gd name="connsiteX4" fmla="*/ 389467 w 1549400"/>
              <a:gd name="connsiteY4" fmla="*/ 867647 h 1547636"/>
              <a:gd name="connsiteX5" fmla="*/ 440267 w 1549400"/>
              <a:gd name="connsiteY5" fmla="*/ 655981 h 1547636"/>
              <a:gd name="connsiteX6" fmla="*/ 482600 w 1549400"/>
              <a:gd name="connsiteY6" fmla="*/ 452781 h 1547636"/>
              <a:gd name="connsiteX7" fmla="*/ 524934 w 1549400"/>
              <a:gd name="connsiteY7" fmla="*/ 249581 h 1547636"/>
              <a:gd name="connsiteX8" fmla="*/ 567267 w 1549400"/>
              <a:gd name="connsiteY8" fmla="*/ 139514 h 1547636"/>
              <a:gd name="connsiteX9" fmla="*/ 668867 w 1549400"/>
              <a:gd name="connsiteY9" fmla="*/ 12514 h 1547636"/>
              <a:gd name="connsiteX10" fmla="*/ 829734 w 1549400"/>
              <a:gd name="connsiteY10" fmla="*/ 20981 h 1547636"/>
              <a:gd name="connsiteX11" fmla="*/ 897467 w 1549400"/>
              <a:gd name="connsiteY11" fmla="*/ 156447 h 1547636"/>
              <a:gd name="connsiteX12" fmla="*/ 948267 w 1549400"/>
              <a:gd name="connsiteY12" fmla="*/ 393514 h 1547636"/>
              <a:gd name="connsiteX13" fmla="*/ 1134534 w 1549400"/>
              <a:gd name="connsiteY13" fmla="*/ 1155514 h 1547636"/>
              <a:gd name="connsiteX14" fmla="*/ 1185334 w 1549400"/>
              <a:gd name="connsiteY14" fmla="*/ 1434914 h 1547636"/>
              <a:gd name="connsiteX15" fmla="*/ 1219200 w 1549400"/>
              <a:gd name="connsiteY15" fmla="*/ 1536514 h 1547636"/>
              <a:gd name="connsiteX16" fmla="*/ 1354667 w 1549400"/>
              <a:gd name="connsiteY16" fmla="*/ 1544981 h 1547636"/>
              <a:gd name="connsiteX17" fmla="*/ 1549400 w 1549400"/>
              <a:gd name="connsiteY17" fmla="*/ 1536514 h 1547636"/>
              <a:gd name="connsiteX18" fmla="*/ 1549400 w 1549400"/>
              <a:gd name="connsiteY18" fmla="*/ 1536514 h 1547636"/>
              <a:gd name="connsiteX19" fmla="*/ 1549400 w 1549400"/>
              <a:gd name="connsiteY19" fmla="*/ 1536514 h 1547636"/>
              <a:gd name="connsiteX0" fmla="*/ 0 w 1549400"/>
              <a:gd name="connsiteY0" fmla="*/ 1519581 h 1547636"/>
              <a:gd name="connsiteX1" fmla="*/ 169334 w 1549400"/>
              <a:gd name="connsiteY1" fmla="*/ 1443381 h 1547636"/>
              <a:gd name="connsiteX2" fmla="*/ 279400 w 1549400"/>
              <a:gd name="connsiteY2" fmla="*/ 1274047 h 1547636"/>
              <a:gd name="connsiteX3" fmla="*/ 338667 w 1549400"/>
              <a:gd name="connsiteY3" fmla="*/ 1028514 h 1547636"/>
              <a:gd name="connsiteX4" fmla="*/ 440267 w 1549400"/>
              <a:gd name="connsiteY4" fmla="*/ 655981 h 1547636"/>
              <a:gd name="connsiteX5" fmla="*/ 482600 w 1549400"/>
              <a:gd name="connsiteY5" fmla="*/ 452781 h 1547636"/>
              <a:gd name="connsiteX6" fmla="*/ 524934 w 1549400"/>
              <a:gd name="connsiteY6" fmla="*/ 249581 h 1547636"/>
              <a:gd name="connsiteX7" fmla="*/ 567267 w 1549400"/>
              <a:gd name="connsiteY7" fmla="*/ 139514 h 1547636"/>
              <a:gd name="connsiteX8" fmla="*/ 668867 w 1549400"/>
              <a:gd name="connsiteY8" fmla="*/ 12514 h 1547636"/>
              <a:gd name="connsiteX9" fmla="*/ 829734 w 1549400"/>
              <a:gd name="connsiteY9" fmla="*/ 20981 h 1547636"/>
              <a:gd name="connsiteX10" fmla="*/ 897467 w 1549400"/>
              <a:gd name="connsiteY10" fmla="*/ 156447 h 1547636"/>
              <a:gd name="connsiteX11" fmla="*/ 948267 w 1549400"/>
              <a:gd name="connsiteY11" fmla="*/ 393514 h 1547636"/>
              <a:gd name="connsiteX12" fmla="*/ 1134534 w 1549400"/>
              <a:gd name="connsiteY12" fmla="*/ 1155514 h 1547636"/>
              <a:gd name="connsiteX13" fmla="*/ 1185334 w 1549400"/>
              <a:gd name="connsiteY13" fmla="*/ 1434914 h 1547636"/>
              <a:gd name="connsiteX14" fmla="*/ 1219200 w 1549400"/>
              <a:gd name="connsiteY14" fmla="*/ 1536514 h 1547636"/>
              <a:gd name="connsiteX15" fmla="*/ 1354667 w 1549400"/>
              <a:gd name="connsiteY15" fmla="*/ 1544981 h 1547636"/>
              <a:gd name="connsiteX16" fmla="*/ 1549400 w 1549400"/>
              <a:gd name="connsiteY16" fmla="*/ 1536514 h 1547636"/>
              <a:gd name="connsiteX17" fmla="*/ 1549400 w 1549400"/>
              <a:gd name="connsiteY17" fmla="*/ 1536514 h 1547636"/>
              <a:gd name="connsiteX18" fmla="*/ 1549400 w 1549400"/>
              <a:gd name="connsiteY18" fmla="*/ 1536514 h 1547636"/>
              <a:gd name="connsiteX0" fmla="*/ 0 w 1549400"/>
              <a:gd name="connsiteY0" fmla="*/ 1519581 h 1547636"/>
              <a:gd name="connsiteX1" fmla="*/ 169334 w 1549400"/>
              <a:gd name="connsiteY1" fmla="*/ 1443381 h 1547636"/>
              <a:gd name="connsiteX2" fmla="*/ 279400 w 1549400"/>
              <a:gd name="connsiteY2" fmla="*/ 1274047 h 1547636"/>
              <a:gd name="connsiteX3" fmla="*/ 440267 w 1549400"/>
              <a:gd name="connsiteY3" fmla="*/ 655981 h 1547636"/>
              <a:gd name="connsiteX4" fmla="*/ 482600 w 1549400"/>
              <a:gd name="connsiteY4" fmla="*/ 452781 h 1547636"/>
              <a:gd name="connsiteX5" fmla="*/ 524934 w 1549400"/>
              <a:gd name="connsiteY5" fmla="*/ 249581 h 1547636"/>
              <a:gd name="connsiteX6" fmla="*/ 567267 w 1549400"/>
              <a:gd name="connsiteY6" fmla="*/ 139514 h 1547636"/>
              <a:gd name="connsiteX7" fmla="*/ 668867 w 1549400"/>
              <a:gd name="connsiteY7" fmla="*/ 12514 h 1547636"/>
              <a:gd name="connsiteX8" fmla="*/ 829734 w 1549400"/>
              <a:gd name="connsiteY8" fmla="*/ 20981 h 1547636"/>
              <a:gd name="connsiteX9" fmla="*/ 897467 w 1549400"/>
              <a:gd name="connsiteY9" fmla="*/ 156447 h 1547636"/>
              <a:gd name="connsiteX10" fmla="*/ 948267 w 1549400"/>
              <a:gd name="connsiteY10" fmla="*/ 393514 h 1547636"/>
              <a:gd name="connsiteX11" fmla="*/ 1134534 w 1549400"/>
              <a:gd name="connsiteY11" fmla="*/ 1155514 h 1547636"/>
              <a:gd name="connsiteX12" fmla="*/ 1185334 w 1549400"/>
              <a:gd name="connsiteY12" fmla="*/ 1434914 h 1547636"/>
              <a:gd name="connsiteX13" fmla="*/ 1219200 w 1549400"/>
              <a:gd name="connsiteY13" fmla="*/ 1536514 h 1547636"/>
              <a:gd name="connsiteX14" fmla="*/ 1354667 w 1549400"/>
              <a:gd name="connsiteY14" fmla="*/ 1544981 h 1547636"/>
              <a:gd name="connsiteX15" fmla="*/ 1549400 w 1549400"/>
              <a:gd name="connsiteY15" fmla="*/ 1536514 h 1547636"/>
              <a:gd name="connsiteX16" fmla="*/ 1549400 w 1549400"/>
              <a:gd name="connsiteY16" fmla="*/ 1536514 h 1547636"/>
              <a:gd name="connsiteX17" fmla="*/ 1549400 w 1549400"/>
              <a:gd name="connsiteY17" fmla="*/ 1536514 h 1547636"/>
              <a:gd name="connsiteX0" fmla="*/ 0 w 1617133"/>
              <a:gd name="connsiteY0" fmla="*/ 1519581 h 1547636"/>
              <a:gd name="connsiteX1" fmla="*/ 237067 w 1617133"/>
              <a:gd name="connsiteY1" fmla="*/ 1443381 h 1547636"/>
              <a:gd name="connsiteX2" fmla="*/ 347133 w 1617133"/>
              <a:gd name="connsiteY2" fmla="*/ 1274047 h 1547636"/>
              <a:gd name="connsiteX3" fmla="*/ 508000 w 1617133"/>
              <a:gd name="connsiteY3" fmla="*/ 655981 h 1547636"/>
              <a:gd name="connsiteX4" fmla="*/ 550333 w 1617133"/>
              <a:gd name="connsiteY4" fmla="*/ 452781 h 1547636"/>
              <a:gd name="connsiteX5" fmla="*/ 592667 w 1617133"/>
              <a:gd name="connsiteY5" fmla="*/ 249581 h 1547636"/>
              <a:gd name="connsiteX6" fmla="*/ 635000 w 1617133"/>
              <a:gd name="connsiteY6" fmla="*/ 139514 h 1547636"/>
              <a:gd name="connsiteX7" fmla="*/ 736600 w 1617133"/>
              <a:gd name="connsiteY7" fmla="*/ 12514 h 1547636"/>
              <a:gd name="connsiteX8" fmla="*/ 897467 w 1617133"/>
              <a:gd name="connsiteY8" fmla="*/ 20981 h 1547636"/>
              <a:gd name="connsiteX9" fmla="*/ 965200 w 1617133"/>
              <a:gd name="connsiteY9" fmla="*/ 156447 h 1547636"/>
              <a:gd name="connsiteX10" fmla="*/ 1016000 w 1617133"/>
              <a:gd name="connsiteY10" fmla="*/ 393514 h 1547636"/>
              <a:gd name="connsiteX11" fmla="*/ 1202267 w 1617133"/>
              <a:gd name="connsiteY11" fmla="*/ 1155514 h 1547636"/>
              <a:gd name="connsiteX12" fmla="*/ 1253067 w 1617133"/>
              <a:gd name="connsiteY12" fmla="*/ 1434914 h 1547636"/>
              <a:gd name="connsiteX13" fmla="*/ 1286933 w 1617133"/>
              <a:gd name="connsiteY13" fmla="*/ 1536514 h 1547636"/>
              <a:gd name="connsiteX14" fmla="*/ 1422400 w 1617133"/>
              <a:gd name="connsiteY14" fmla="*/ 1544981 h 1547636"/>
              <a:gd name="connsiteX15" fmla="*/ 1617133 w 1617133"/>
              <a:gd name="connsiteY15" fmla="*/ 1536514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0" fmla="*/ 0 w 1617133"/>
              <a:gd name="connsiteY0" fmla="*/ 1519581 h 1547636"/>
              <a:gd name="connsiteX1" fmla="*/ 127001 w 1617133"/>
              <a:gd name="connsiteY1" fmla="*/ 1485714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2667 w 1617133"/>
              <a:gd name="connsiteY6" fmla="*/ 2495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2667 w 1617133"/>
              <a:gd name="connsiteY6" fmla="*/ 2495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2667 w 1617133"/>
              <a:gd name="connsiteY6" fmla="*/ 2495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6900 w 1617133"/>
              <a:gd name="connsiteY6" fmla="*/ 272864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6900 w 1617133"/>
              <a:gd name="connsiteY6" fmla="*/ 272864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6900 w 1617133"/>
              <a:gd name="connsiteY6" fmla="*/ 272864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609600 w 1617133"/>
              <a:gd name="connsiteY6" fmla="*/ 2749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63033 w 1617133"/>
              <a:gd name="connsiteY5" fmla="*/ 465481 h 1547636"/>
              <a:gd name="connsiteX6" fmla="*/ 609600 w 1617133"/>
              <a:gd name="connsiteY6" fmla="*/ 2749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729 h 1547784"/>
              <a:gd name="connsiteX1" fmla="*/ 133351 w 1617133"/>
              <a:gd name="connsiteY1" fmla="*/ 1490096 h 1547784"/>
              <a:gd name="connsiteX2" fmla="*/ 237067 w 1617133"/>
              <a:gd name="connsiteY2" fmla="*/ 1443529 h 1547784"/>
              <a:gd name="connsiteX3" fmla="*/ 347133 w 1617133"/>
              <a:gd name="connsiteY3" fmla="*/ 1274195 h 1547784"/>
              <a:gd name="connsiteX4" fmla="*/ 508000 w 1617133"/>
              <a:gd name="connsiteY4" fmla="*/ 656129 h 1547784"/>
              <a:gd name="connsiteX5" fmla="*/ 563033 w 1617133"/>
              <a:gd name="connsiteY5" fmla="*/ 465629 h 1547784"/>
              <a:gd name="connsiteX6" fmla="*/ 609600 w 1617133"/>
              <a:gd name="connsiteY6" fmla="*/ 275129 h 1547784"/>
              <a:gd name="connsiteX7" fmla="*/ 647700 w 1617133"/>
              <a:gd name="connsiteY7" fmla="*/ 141778 h 1547784"/>
              <a:gd name="connsiteX8" fmla="*/ 736600 w 1617133"/>
              <a:gd name="connsiteY8" fmla="*/ 12662 h 1547784"/>
              <a:gd name="connsiteX9" fmla="*/ 897467 w 1617133"/>
              <a:gd name="connsiteY9" fmla="*/ 21129 h 1547784"/>
              <a:gd name="connsiteX10" fmla="*/ 965200 w 1617133"/>
              <a:gd name="connsiteY10" fmla="*/ 156595 h 1547784"/>
              <a:gd name="connsiteX11" fmla="*/ 1016000 w 1617133"/>
              <a:gd name="connsiteY11" fmla="*/ 393662 h 1547784"/>
              <a:gd name="connsiteX12" fmla="*/ 1202267 w 1617133"/>
              <a:gd name="connsiteY12" fmla="*/ 1155662 h 1547784"/>
              <a:gd name="connsiteX13" fmla="*/ 1253067 w 1617133"/>
              <a:gd name="connsiteY13" fmla="*/ 1435062 h 1547784"/>
              <a:gd name="connsiteX14" fmla="*/ 1286933 w 1617133"/>
              <a:gd name="connsiteY14" fmla="*/ 1536662 h 1547784"/>
              <a:gd name="connsiteX15" fmla="*/ 1422400 w 1617133"/>
              <a:gd name="connsiteY15" fmla="*/ 1545129 h 1547784"/>
              <a:gd name="connsiteX16" fmla="*/ 1617133 w 1617133"/>
              <a:gd name="connsiteY16" fmla="*/ 1536662 h 1547784"/>
              <a:gd name="connsiteX17" fmla="*/ 1617133 w 1617133"/>
              <a:gd name="connsiteY17" fmla="*/ 1536662 h 1547784"/>
              <a:gd name="connsiteX18" fmla="*/ 1617133 w 1617133"/>
              <a:gd name="connsiteY18" fmla="*/ 1536662 h 1547784"/>
              <a:gd name="connsiteX0" fmla="*/ 0 w 1617133"/>
              <a:gd name="connsiteY0" fmla="*/ 1519582 h 1547637"/>
              <a:gd name="connsiteX1" fmla="*/ 133351 w 1617133"/>
              <a:gd name="connsiteY1" fmla="*/ 1489949 h 1547637"/>
              <a:gd name="connsiteX2" fmla="*/ 237067 w 1617133"/>
              <a:gd name="connsiteY2" fmla="*/ 1443382 h 1547637"/>
              <a:gd name="connsiteX3" fmla="*/ 347133 w 1617133"/>
              <a:gd name="connsiteY3" fmla="*/ 1274048 h 1547637"/>
              <a:gd name="connsiteX4" fmla="*/ 508000 w 1617133"/>
              <a:gd name="connsiteY4" fmla="*/ 655982 h 1547637"/>
              <a:gd name="connsiteX5" fmla="*/ 563033 w 1617133"/>
              <a:gd name="connsiteY5" fmla="*/ 465482 h 1547637"/>
              <a:gd name="connsiteX6" fmla="*/ 609600 w 1617133"/>
              <a:gd name="connsiteY6" fmla="*/ 274982 h 1547637"/>
              <a:gd name="connsiteX7" fmla="*/ 649816 w 1617133"/>
              <a:gd name="connsiteY7" fmla="*/ 139515 h 1547637"/>
              <a:gd name="connsiteX8" fmla="*/ 736600 w 1617133"/>
              <a:gd name="connsiteY8" fmla="*/ 12515 h 1547637"/>
              <a:gd name="connsiteX9" fmla="*/ 897467 w 1617133"/>
              <a:gd name="connsiteY9" fmla="*/ 20982 h 1547637"/>
              <a:gd name="connsiteX10" fmla="*/ 965200 w 1617133"/>
              <a:gd name="connsiteY10" fmla="*/ 156448 h 1547637"/>
              <a:gd name="connsiteX11" fmla="*/ 1016000 w 1617133"/>
              <a:gd name="connsiteY11" fmla="*/ 393515 h 1547637"/>
              <a:gd name="connsiteX12" fmla="*/ 1202267 w 1617133"/>
              <a:gd name="connsiteY12" fmla="*/ 1155515 h 1547637"/>
              <a:gd name="connsiteX13" fmla="*/ 1253067 w 1617133"/>
              <a:gd name="connsiteY13" fmla="*/ 1434915 h 1547637"/>
              <a:gd name="connsiteX14" fmla="*/ 1286933 w 1617133"/>
              <a:gd name="connsiteY14" fmla="*/ 1536515 h 1547637"/>
              <a:gd name="connsiteX15" fmla="*/ 1422400 w 1617133"/>
              <a:gd name="connsiteY15" fmla="*/ 1544982 h 1547637"/>
              <a:gd name="connsiteX16" fmla="*/ 1617133 w 1617133"/>
              <a:gd name="connsiteY16" fmla="*/ 1536515 h 1547637"/>
              <a:gd name="connsiteX17" fmla="*/ 1617133 w 1617133"/>
              <a:gd name="connsiteY17" fmla="*/ 1536515 h 1547637"/>
              <a:gd name="connsiteX18" fmla="*/ 1617133 w 1617133"/>
              <a:gd name="connsiteY18" fmla="*/ 1536515 h 1547637"/>
              <a:gd name="connsiteX0" fmla="*/ 0 w 1617133"/>
              <a:gd name="connsiteY0" fmla="*/ 1519286 h 1547341"/>
              <a:gd name="connsiteX1" fmla="*/ 133351 w 1617133"/>
              <a:gd name="connsiteY1" fmla="*/ 1489653 h 1547341"/>
              <a:gd name="connsiteX2" fmla="*/ 237067 w 1617133"/>
              <a:gd name="connsiteY2" fmla="*/ 1443086 h 1547341"/>
              <a:gd name="connsiteX3" fmla="*/ 347133 w 1617133"/>
              <a:gd name="connsiteY3" fmla="*/ 1273752 h 1547341"/>
              <a:gd name="connsiteX4" fmla="*/ 508000 w 1617133"/>
              <a:gd name="connsiteY4" fmla="*/ 655686 h 1547341"/>
              <a:gd name="connsiteX5" fmla="*/ 563033 w 1617133"/>
              <a:gd name="connsiteY5" fmla="*/ 465186 h 1547341"/>
              <a:gd name="connsiteX6" fmla="*/ 609600 w 1617133"/>
              <a:gd name="connsiteY6" fmla="*/ 274686 h 1547341"/>
              <a:gd name="connsiteX7" fmla="*/ 651932 w 1617133"/>
              <a:gd name="connsiteY7" fmla="*/ 134985 h 1547341"/>
              <a:gd name="connsiteX8" fmla="*/ 736600 w 1617133"/>
              <a:gd name="connsiteY8" fmla="*/ 12219 h 1547341"/>
              <a:gd name="connsiteX9" fmla="*/ 897467 w 1617133"/>
              <a:gd name="connsiteY9" fmla="*/ 20686 h 1547341"/>
              <a:gd name="connsiteX10" fmla="*/ 965200 w 1617133"/>
              <a:gd name="connsiteY10" fmla="*/ 156152 h 1547341"/>
              <a:gd name="connsiteX11" fmla="*/ 1016000 w 1617133"/>
              <a:gd name="connsiteY11" fmla="*/ 393219 h 1547341"/>
              <a:gd name="connsiteX12" fmla="*/ 1202267 w 1617133"/>
              <a:gd name="connsiteY12" fmla="*/ 1155219 h 1547341"/>
              <a:gd name="connsiteX13" fmla="*/ 1253067 w 1617133"/>
              <a:gd name="connsiteY13" fmla="*/ 1434619 h 1547341"/>
              <a:gd name="connsiteX14" fmla="*/ 1286933 w 1617133"/>
              <a:gd name="connsiteY14" fmla="*/ 1536219 h 1547341"/>
              <a:gd name="connsiteX15" fmla="*/ 1422400 w 1617133"/>
              <a:gd name="connsiteY15" fmla="*/ 1544686 h 1547341"/>
              <a:gd name="connsiteX16" fmla="*/ 1617133 w 1617133"/>
              <a:gd name="connsiteY16" fmla="*/ 1536219 h 1547341"/>
              <a:gd name="connsiteX17" fmla="*/ 1617133 w 1617133"/>
              <a:gd name="connsiteY17" fmla="*/ 1536219 h 1547341"/>
              <a:gd name="connsiteX18" fmla="*/ 1617133 w 1617133"/>
              <a:gd name="connsiteY18" fmla="*/ 1536219 h 1547341"/>
              <a:gd name="connsiteX0" fmla="*/ 0 w 1617133"/>
              <a:gd name="connsiteY0" fmla="*/ 1513144 h 1541199"/>
              <a:gd name="connsiteX1" fmla="*/ 133351 w 1617133"/>
              <a:gd name="connsiteY1" fmla="*/ 1483511 h 1541199"/>
              <a:gd name="connsiteX2" fmla="*/ 237067 w 1617133"/>
              <a:gd name="connsiteY2" fmla="*/ 1436944 h 1541199"/>
              <a:gd name="connsiteX3" fmla="*/ 347133 w 1617133"/>
              <a:gd name="connsiteY3" fmla="*/ 1267610 h 1541199"/>
              <a:gd name="connsiteX4" fmla="*/ 508000 w 1617133"/>
              <a:gd name="connsiteY4" fmla="*/ 649544 h 1541199"/>
              <a:gd name="connsiteX5" fmla="*/ 563033 w 1617133"/>
              <a:gd name="connsiteY5" fmla="*/ 459044 h 1541199"/>
              <a:gd name="connsiteX6" fmla="*/ 609600 w 1617133"/>
              <a:gd name="connsiteY6" fmla="*/ 268544 h 1541199"/>
              <a:gd name="connsiteX7" fmla="*/ 651932 w 1617133"/>
              <a:gd name="connsiteY7" fmla="*/ 128843 h 1541199"/>
              <a:gd name="connsiteX8" fmla="*/ 751417 w 1617133"/>
              <a:gd name="connsiteY8" fmla="*/ 16661 h 1541199"/>
              <a:gd name="connsiteX9" fmla="*/ 897467 w 1617133"/>
              <a:gd name="connsiteY9" fmla="*/ 14544 h 1541199"/>
              <a:gd name="connsiteX10" fmla="*/ 965200 w 1617133"/>
              <a:gd name="connsiteY10" fmla="*/ 150010 h 1541199"/>
              <a:gd name="connsiteX11" fmla="*/ 1016000 w 1617133"/>
              <a:gd name="connsiteY11" fmla="*/ 387077 h 1541199"/>
              <a:gd name="connsiteX12" fmla="*/ 1202267 w 1617133"/>
              <a:gd name="connsiteY12" fmla="*/ 1149077 h 1541199"/>
              <a:gd name="connsiteX13" fmla="*/ 1253067 w 1617133"/>
              <a:gd name="connsiteY13" fmla="*/ 1428477 h 1541199"/>
              <a:gd name="connsiteX14" fmla="*/ 1286933 w 1617133"/>
              <a:gd name="connsiteY14" fmla="*/ 1530077 h 1541199"/>
              <a:gd name="connsiteX15" fmla="*/ 1422400 w 1617133"/>
              <a:gd name="connsiteY15" fmla="*/ 1538544 h 1541199"/>
              <a:gd name="connsiteX16" fmla="*/ 1617133 w 1617133"/>
              <a:gd name="connsiteY16" fmla="*/ 1530077 h 1541199"/>
              <a:gd name="connsiteX17" fmla="*/ 1617133 w 1617133"/>
              <a:gd name="connsiteY17" fmla="*/ 1530077 h 1541199"/>
              <a:gd name="connsiteX18" fmla="*/ 1617133 w 1617133"/>
              <a:gd name="connsiteY18" fmla="*/ 1530077 h 1541199"/>
              <a:gd name="connsiteX0" fmla="*/ 0 w 1617133"/>
              <a:gd name="connsiteY0" fmla="*/ 1510639 h 1538694"/>
              <a:gd name="connsiteX1" fmla="*/ 133351 w 1617133"/>
              <a:gd name="connsiteY1" fmla="*/ 1481006 h 1538694"/>
              <a:gd name="connsiteX2" fmla="*/ 237067 w 1617133"/>
              <a:gd name="connsiteY2" fmla="*/ 1434439 h 1538694"/>
              <a:gd name="connsiteX3" fmla="*/ 347133 w 1617133"/>
              <a:gd name="connsiteY3" fmla="*/ 1265105 h 1538694"/>
              <a:gd name="connsiteX4" fmla="*/ 508000 w 1617133"/>
              <a:gd name="connsiteY4" fmla="*/ 647039 h 1538694"/>
              <a:gd name="connsiteX5" fmla="*/ 563033 w 1617133"/>
              <a:gd name="connsiteY5" fmla="*/ 456539 h 1538694"/>
              <a:gd name="connsiteX6" fmla="*/ 609600 w 1617133"/>
              <a:gd name="connsiteY6" fmla="*/ 266039 h 1538694"/>
              <a:gd name="connsiteX7" fmla="*/ 651932 w 1617133"/>
              <a:gd name="connsiteY7" fmla="*/ 126338 h 1538694"/>
              <a:gd name="connsiteX8" fmla="*/ 751417 w 1617133"/>
              <a:gd name="connsiteY8" fmla="*/ 14156 h 1538694"/>
              <a:gd name="connsiteX9" fmla="*/ 895351 w 1617133"/>
              <a:gd name="connsiteY9" fmla="*/ 16272 h 1538694"/>
              <a:gd name="connsiteX10" fmla="*/ 965200 w 1617133"/>
              <a:gd name="connsiteY10" fmla="*/ 147505 h 1538694"/>
              <a:gd name="connsiteX11" fmla="*/ 1016000 w 1617133"/>
              <a:gd name="connsiteY11" fmla="*/ 384572 h 1538694"/>
              <a:gd name="connsiteX12" fmla="*/ 1202267 w 1617133"/>
              <a:gd name="connsiteY12" fmla="*/ 1146572 h 1538694"/>
              <a:gd name="connsiteX13" fmla="*/ 1253067 w 1617133"/>
              <a:gd name="connsiteY13" fmla="*/ 1425972 h 1538694"/>
              <a:gd name="connsiteX14" fmla="*/ 1286933 w 1617133"/>
              <a:gd name="connsiteY14" fmla="*/ 1527572 h 1538694"/>
              <a:gd name="connsiteX15" fmla="*/ 1422400 w 1617133"/>
              <a:gd name="connsiteY15" fmla="*/ 1536039 h 1538694"/>
              <a:gd name="connsiteX16" fmla="*/ 1617133 w 1617133"/>
              <a:gd name="connsiteY16" fmla="*/ 1527572 h 1538694"/>
              <a:gd name="connsiteX17" fmla="*/ 1617133 w 1617133"/>
              <a:gd name="connsiteY17" fmla="*/ 1527572 h 1538694"/>
              <a:gd name="connsiteX18" fmla="*/ 1617133 w 1617133"/>
              <a:gd name="connsiteY18" fmla="*/ 1527572 h 1538694"/>
              <a:gd name="connsiteX0" fmla="*/ 0 w 1617133"/>
              <a:gd name="connsiteY0" fmla="*/ 1512257 h 1540312"/>
              <a:gd name="connsiteX1" fmla="*/ 133351 w 1617133"/>
              <a:gd name="connsiteY1" fmla="*/ 1482624 h 1540312"/>
              <a:gd name="connsiteX2" fmla="*/ 237067 w 1617133"/>
              <a:gd name="connsiteY2" fmla="*/ 1436057 h 1540312"/>
              <a:gd name="connsiteX3" fmla="*/ 347133 w 1617133"/>
              <a:gd name="connsiteY3" fmla="*/ 1266723 h 1540312"/>
              <a:gd name="connsiteX4" fmla="*/ 508000 w 1617133"/>
              <a:gd name="connsiteY4" fmla="*/ 648657 h 1540312"/>
              <a:gd name="connsiteX5" fmla="*/ 563033 w 1617133"/>
              <a:gd name="connsiteY5" fmla="*/ 458157 h 1540312"/>
              <a:gd name="connsiteX6" fmla="*/ 609600 w 1617133"/>
              <a:gd name="connsiteY6" fmla="*/ 267657 h 1540312"/>
              <a:gd name="connsiteX7" fmla="*/ 651932 w 1617133"/>
              <a:gd name="connsiteY7" fmla="*/ 127956 h 1540312"/>
              <a:gd name="connsiteX8" fmla="*/ 751417 w 1617133"/>
              <a:gd name="connsiteY8" fmla="*/ 15774 h 1540312"/>
              <a:gd name="connsiteX9" fmla="*/ 895351 w 1617133"/>
              <a:gd name="connsiteY9" fmla="*/ 17890 h 1540312"/>
              <a:gd name="connsiteX10" fmla="*/ 965200 w 1617133"/>
              <a:gd name="connsiteY10" fmla="*/ 149123 h 1540312"/>
              <a:gd name="connsiteX11" fmla="*/ 1016000 w 1617133"/>
              <a:gd name="connsiteY11" fmla="*/ 386190 h 1540312"/>
              <a:gd name="connsiteX12" fmla="*/ 1202267 w 1617133"/>
              <a:gd name="connsiteY12" fmla="*/ 1148190 h 1540312"/>
              <a:gd name="connsiteX13" fmla="*/ 1253067 w 1617133"/>
              <a:gd name="connsiteY13" fmla="*/ 1427590 h 1540312"/>
              <a:gd name="connsiteX14" fmla="*/ 1286933 w 1617133"/>
              <a:gd name="connsiteY14" fmla="*/ 1529190 h 1540312"/>
              <a:gd name="connsiteX15" fmla="*/ 1422400 w 1617133"/>
              <a:gd name="connsiteY15" fmla="*/ 1537657 h 1540312"/>
              <a:gd name="connsiteX16" fmla="*/ 1617133 w 1617133"/>
              <a:gd name="connsiteY16" fmla="*/ 1529190 h 1540312"/>
              <a:gd name="connsiteX17" fmla="*/ 1617133 w 1617133"/>
              <a:gd name="connsiteY17" fmla="*/ 1529190 h 1540312"/>
              <a:gd name="connsiteX18" fmla="*/ 1617133 w 1617133"/>
              <a:gd name="connsiteY18" fmla="*/ 1529190 h 1540312"/>
              <a:gd name="connsiteX0" fmla="*/ 0 w 1617133"/>
              <a:gd name="connsiteY0" fmla="*/ 1502989 h 1531044"/>
              <a:gd name="connsiteX1" fmla="*/ 133351 w 1617133"/>
              <a:gd name="connsiteY1" fmla="*/ 1473356 h 1531044"/>
              <a:gd name="connsiteX2" fmla="*/ 237067 w 1617133"/>
              <a:gd name="connsiteY2" fmla="*/ 1426789 h 1531044"/>
              <a:gd name="connsiteX3" fmla="*/ 347133 w 1617133"/>
              <a:gd name="connsiteY3" fmla="*/ 1257455 h 1531044"/>
              <a:gd name="connsiteX4" fmla="*/ 508000 w 1617133"/>
              <a:gd name="connsiteY4" fmla="*/ 639389 h 1531044"/>
              <a:gd name="connsiteX5" fmla="*/ 563033 w 1617133"/>
              <a:gd name="connsiteY5" fmla="*/ 448889 h 1531044"/>
              <a:gd name="connsiteX6" fmla="*/ 609600 w 1617133"/>
              <a:gd name="connsiteY6" fmla="*/ 258389 h 1531044"/>
              <a:gd name="connsiteX7" fmla="*/ 651932 w 1617133"/>
              <a:gd name="connsiteY7" fmla="*/ 118688 h 1531044"/>
              <a:gd name="connsiteX8" fmla="*/ 751417 w 1617133"/>
              <a:gd name="connsiteY8" fmla="*/ 6506 h 1531044"/>
              <a:gd name="connsiteX9" fmla="*/ 889001 w 1617133"/>
              <a:gd name="connsiteY9" fmla="*/ 29789 h 1531044"/>
              <a:gd name="connsiteX10" fmla="*/ 965200 w 1617133"/>
              <a:gd name="connsiteY10" fmla="*/ 139855 h 1531044"/>
              <a:gd name="connsiteX11" fmla="*/ 1016000 w 1617133"/>
              <a:gd name="connsiteY11" fmla="*/ 376922 h 1531044"/>
              <a:gd name="connsiteX12" fmla="*/ 1202267 w 1617133"/>
              <a:gd name="connsiteY12" fmla="*/ 1138922 h 1531044"/>
              <a:gd name="connsiteX13" fmla="*/ 1253067 w 1617133"/>
              <a:gd name="connsiteY13" fmla="*/ 1418322 h 1531044"/>
              <a:gd name="connsiteX14" fmla="*/ 1286933 w 1617133"/>
              <a:gd name="connsiteY14" fmla="*/ 1519922 h 1531044"/>
              <a:gd name="connsiteX15" fmla="*/ 1422400 w 1617133"/>
              <a:gd name="connsiteY15" fmla="*/ 1528389 h 1531044"/>
              <a:gd name="connsiteX16" fmla="*/ 1617133 w 1617133"/>
              <a:gd name="connsiteY16" fmla="*/ 1519922 h 1531044"/>
              <a:gd name="connsiteX17" fmla="*/ 1617133 w 1617133"/>
              <a:gd name="connsiteY17" fmla="*/ 1519922 h 1531044"/>
              <a:gd name="connsiteX18" fmla="*/ 1617133 w 1617133"/>
              <a:gd name="connsiteY18" fmla="*/ 1519922 h 1531044"/>
              <a:gd name="connsiteX0" fmla="*/ 0 w 1617133"/>
              <a:gd name="connsiteY0" fmla="*/ 1483612 h 1511667"/>
              <a:gd name="connsiteX1" fmla="*/ 133351 w 1617133"/>
              <a:gd name="connsiteY1" fmla="*/ 1453979 h 1511667"/>
              <a:gd name="connsiteX2" fmla="*/ 237067 w 1617133"/>
              <a:gd name="connsiteY2" fmla="*/ 1407412 h 1511667"/>
              <a:gd name="connsiteX3" fmla="*/ 347133 w 1617133"/>
              <a:gd name="connsiteY3" fmla="*/ 1238078 h 1511667"/>
              <a:gd name="connsiteX4" fmla="*/ 508000 w 1617133"/>
              <a:gd name="connsiteY4" fmla="*/ 620012 h 1511667"/>
              <a:gd name="connsiteX5" fmla="*/ 563033 w 1617133"/>
              <a:gd name="connsiteY5" fmla="*/ 429512 h 1511667"/>
              <a:gd name="connsiteX6" fmla="*/ 609600 w 1617133"/>
              <a:gd name="connsiteY6" fmla="*/ 239012 h 1511667"/>
              <a:gd name="connsiteX7" fmla="*/ 651932 w 1617133"/>
              <a:gd name="connsiteY7" fmla="*/ 99311 h 1511667"/>
              <a:gd name="connsiteX8" fmla="*/ 713317 w 1617133"/>
              <a:gd name="connsiteY8" fmla="*/ 14645 h 1511667"/>
              <a:gd name="connsiteX9" fmla="*/ 889001 w 1617133"/>
              <a:gd name="connsiteY9" fmla="*/ 10412 h 1511667"/>
              <a:gd name="connsiteX10" fmla="*/ 965200 w 1617133"/>
              <a:gd name="connsiteY10" fmla="*/ 120478 h 1511667"/>
              <a:gd name="connsiteX11" fmla="*/ 1016000 w 1617133"/>
              <a:gd name="connsiteY11" fmla="*/ 357545 h 1511667"/>
              <a:gd name="connsiteX12" fmla="*/ 1202267 w 1617133"/>
              <a:gd name="connsiteY12" fmla="*/ 1119545 h 1511667"/>
              <a:gd name="connsiteX13" fmla="*/ 1253067 w 1617133"/>
              <a:gd name="connsiteY13" fmla="*/ 1398945 h 1511667"/>
              <a:gd name="connsiteX14" fmla="*/ 1286933 w 1617133"/>
              <a:gd name="connsiteY14" fmla="*/ 1500545 h 1511667"/>
              <a:gd name="connsiteX15" fmla="*/ 1422400 w 1617133"/>
              <a:gd name="connsiteY15" fmla="*/ 1509012 h 1511667"/>
              <a:gd name="connsiteX16" fmla="*/ 1617133 w 1617133"/>
              <a:gd name="connsiteY16" fmla="*/ 1500545 h 1511667"/>
              <a:gd name="connsiteX17" fmla="*/ 1617133 w 1617133"/>
              <a:gd name="connsiteY17" fmla="*/ 1500545 h 1511667"/>
              <a:gd name="connsiteX18" fmla="*/ 1617133 w 1617133"/>
              <a:gd name="connsiteY18" fmla="*/ 1500545 h 1511667"/>
              <a:gd name="connsiteX0" fmla="*/ 0 w 1617133"/>
              <a:gd name="connsiteY0" fmla="*/ 1499521 h 1527576"/>
              <a:gd name="connsiteX1" fmla="*/ 133351 w 1617133"/>
              <a:gd name="connsiteY1" fmla="*/ 1469888 h 1527576"/>
              <a:gd name="connsiteX2" fmla="*/ 237067 w 1617133"/>
              <a:gd name="connsiteY2" fmla="*/ 1423321 h 1527576"/>
              <a:gd name="connsiteX3" fmla="*/ 347133 w 1617133"/>
              <a:gd name="connsiteY3" fmla="*/ 1253987 h 1527576"/>
              <a:gd name="connsiteX4" fmla="*/ 508000 w 1617133"/>
              <a:gd name="connsiteY4" fmla="*/ 635921 h 1527576"/>
              <a:gd name="connsiteX5" fmla="*/ 563033 w 1617133"/>
              <a:gd name="connsiteY5" fmla="*/ 445421 h 1527576"/>
              <a:gd name="connsiteX6" fmla="*/ 609600 w 1617133"/>
              <a:gd name="connsiteY6" fmla="*/ 254921 h 1527576"/>
              <a:gd name="connsiteX7" fmla="*/ 651932 w 1617133"/>
              <a:gd name="connsiteY7" fmla="*/ 115220 h 1527576"/>
              <a:gd name="connsiteX8" fmla="*/ 713317 w 1617133"/>
              <a:gd name="connsiteY8" fmla="*/ 30554 h 1527576"/>
              <a:gd name="connsiteX9" fmla="*/ 794918 w 1617133"/>
              <a:gd name="connsiteY9" fmla="*/ 71 h 1527576"/>
              <a:gd name="connsiteX10" fmla="*/ 889001 w 1617133"/>
              <a:gd name="connsiteY10" fmla="*/ 26321 h 1527576"/>
              <a:gd name="connsiteX11" fmla="*/ 965200 w 1617133"/>
              <a:gd name="connsiteY11" fmla="*/ 136387 h 1527576"/>
              <a:gd name="connsiteX12" fmla="*/ 1016000 w 1617133"/>
              <a:gd name="connsiteY12" fmla="*/ 373454 h 1527576"/>
              <a:gd name="connsiteX13" fmla="*/ 1202267 w 1617133"/>
              <a:gd name="connsiteY13" fmla="*/ 1135454 h 1527576"/>
              <a:gd name="connsiteX14" fmla="*/ 1253067 w 1617133"/>
              <a:gd name="connsiteY14" fmla="*/ 1414854 h 1527576"/>
              <a:gd name="connsiteX15" fmla="*/ 1286933 w 1617133"/>
              <a:gd name="connsiteY15" fmla="*/ 1516454 h 1527576"/>
              <a:gd name="connsiteX16" fmla="*/ 1422400 w 1617133"/>
              <a:gd name="connsiteY16" fmla="*/ 1524921 h 1527576"/>
              <a:gd name="connsiteX17" fmla="*/ 1617133 w 1617133"/>
              <a:gd name="connsiteY17" fmla="*/ 1516454 h 1527576"/>
              <a:gd name="connsiteX18" fmla="*/ 1617133 w 1617133"/>
              <a:gd name="connsiteY18" fmla="*/ 1516454 h 1527576"/>
              <a:gd name="connsiteX19" fmla="*/ 1617133 w 1617133"/>
              <a:gd name="connsiteY19" fmla="*/ 1516454 h 1527576"/>
              <a:gd name="connsiteX0" fmla="*/ 0 w 1617133"/>
              <a:gd name="connsiteY0" fmla="*/ 1499521 h 1527576"/>
              <a:gd name="connsiteX1" fmla="*/ 133351 w 1617133"/>
              <a:gd name="connsiteY1" fmla="*/ 1469888 h 1527576"/>
              <a:gd name="connsiteX2" fmla="*/ 237067 w 1617133"/>
              <a:gd name="connsiteY2" fmla="*/ 1423321 h 1527576"/>
              <a:gd name="connsiteX3" fmla="*/ 347133 w 1617133"/>
              <a:gd name="connsiteY3" fmla="*/ 1253987 h 1527576"/>
              <a:gd name="connsiteX4" fmla="*/ 508000 w 1617133"/>
              <a:gd name="connsiteY4" fmla="*/ 635921 h 1527576"/>
              <a:gd name="connsiteX5" fmla="*/ 563033 w 1617133"/>
              <a:gd name="connsiteY5" fmla="*/ 445421 h 1527576"/>
              <a:gd name="connsiteX6" fmla="*/ 609600 w 1617133"/>
              <a:gd name="connsiteY6" fmla="*/ 254921 h 1527576"/>
              <a:gd name="connsiteX7" fmla="*/ 658282 w 1617133"/>
              <a:gd name="connsiteY7" fmla="*/ 115220 h 1527576"/>
              <a:gd name="connsiteX8" fmla="*/ 713317 w 1617133"/>
              <a:gd name="connsiteY8" fmla="*/ 30554 h 1527576"/>
              <a:gd name="connsiteX9" fmla="*/ 794918 w 1617133"/>
              <a:gd name="connsiteY9" fmla="*/ 71 h 1527576"/>
              <a:gd name="connsiteX10" fmla="*/ 889001 w 1617133"/>
              <a:gd name="connsiteY10" fmla="*/ 26321 h 1527576"/>
              <a:gd name="connsiteX11" fmla="*/ 965200 w 1617133"/>
              <a:gd name="connsiteY11" fmla="*/ 136387 h 1527576"/>
              <a:gd name="connsiteX12" fmla="*/ 1016000 w 1617133"/>
              <a:gd name="connsiteY12" fmla="*/ 373454 h 1527576"/>
              <a:gd name="connsiteX13" fmla="*/ 1202267 w 1617133"/>
              <a:gd name="connsiteY13" fmla="*/ 1135454 h 1527576"/>
              <a:gd name="connsiteX14" fmla="*/ 1253067 w 1617133"/>
              <a:gd name="connsiteY14" fmla="*/ 1414854 h 1527576"/>
              <a:gd name="connsiteX15" fmla="*/ 1286933 w 1617133"/>
              <a:gd name="connsiteY15" fmla="*/ 1516454 h 1527576"/>
              <a:gd name="connsiteX16" fmla="*/ 1422400 w 1617133"/>
              <a:gd name="connsiteY16" fmla="*/ 1524921 h 1527576"/>
              <a:gd name="connsiteX17" fmla="*/ 1617133 w 1617133"/>
              <a:gd name="connsiteY17" fmla="*/ 1516454 h 1527576"/>
              <a:gd name="connsiteX18" fmla="*/ 1617133 w 1617133"/>
              <a:gd name="connsiteY18" fmla="*/ 1516454 h 1527576"/>
              <a:gd name="connsiteX19" fmla="*/ 1617133 w 1617133"/>
              <a:gd name="connsiteY19" fmla="*/ 1516454 h 1527576"/>
              <a:gd name="connsiteX0" fmla="*/ 0 w 1617133"/>
              <a:gd name="connsiteY0" fmla="*/ 1499521 h 1527576"/>
              <a:gd name="connsiteX1" fmla="*/ 133351 w 1617133"/>
              <a:gd name="connsiteY1" fmla="*/ 1469888 h 1527576"/>
              <a:gd name="connsiteX2" fmla="*/ 237067 w 1617133"/>
              <a:gd name="connsiteY2" fmla="*/ 1423321 h 1527576"/>
              <a:gd name="connsiteX3" fmla="*/ 347133 w 1617133"/>
              <a:gd name="connsiteY3" fmla="*/ 1253987 h 1527576"/>
              <a:gd name="connsiteX4" fmla="*/ 508000 w 1617133"/>
              <a:gd name="connsiteY4" fmla="*/ 635921 h 1527576"/>
              <a:gd name="connsiteX5" fmla="*/ 563033 w 1617133"/>
              <a:gd name="connsiteY5" fmla="*/ 445421 h 1527576"/>
              <a:gd name="connsiteX6" fmla="*/ 609600 w 1617133"/>
              <a:gd name="connsiteY6" fmla="*/ 254921 h 1527576"/>
              <a:gd name="connsiteX7" fmla="*/ 658282 w 1617133"/>
              <a:gd name="connsiteY7" fmla="*/ 115220 h 1527576"/>
              <a:gd name="connsiteX8" fmla="*/ 723901 w 1617133"/>
              <a:gd name="connsiteY8" fmla="*/ 30554 h 1527576"/>
              <a:gd name="connsiteX9" fmla="*/ 794918 w 1617133"/>
              <a:gd name="connsiteY9" fmla="*/ 71 h 1527576"/>
              <a:gd name="connsiteX10" fmla="*/ 889001 w 1617133"/>
              <a:gd name="connsiteY10" fmla="*/ 26321 h 1527576"/>
              <a:gd name="connsiteX11" fmla="*/ 965200 w 1617133"/>
              <a:gd name="connsiteY11" fmla="*/ 136387 h 1527576"/>
              <a:gd name="connsiteX12" fmla="*/ 1016000 w 1617133"/>
              <a:gd name="connsiteY12" fmla="*/ 373454 h 1527576"/>
              <a:gd name="connsiteX13" fmla="*/ 1202267 w 1617133"/>
              <a:gd name="connsiteY13" fmla="*/ 1135454 h 1527576"/>
              <a:gd name="connsiteX14" fmla="*/ 1253067 w 1617133"/>
              <a:gd name="connsiteY14" fmla="*/ 1414854 h 1527576"/>
              <a:gd name="connsiteX15" fmla="*/ 1286933 w 1617133"/>
              <a:gd name="connsiteY15" fmla="*/ 1516454 h 1527576"/>
              <a:gd name="connsiteX16" fmla="*/ 1422400 w 1617133"/>
              <a:gd name="connsiteY16" fmla="*/ 1524921 h 1527576"/>
              <a:gd name="connsiteX17" fmla="*/ 1617133 w 1617133"/>
              <a:gd name="connsiteY17" fmla="*/ 1516454 h 1527576"/>
              <a:gd name="connsiteX18" fmla="*/ 1617133 w 1617133"/>
              <a:gd name="connsiteY18" fmla="*/ 1516454 h 1527576"/>
              <a:gd name="connsiteX19" fmla="*/ 1617133 w 1617133"/>
              <a:gd name="connsiteY19" fmla="*/ 1516454 h 1527576"/>
              <a:gd name="connsiteX0" fmla="*/ 0 w 1617133"/>
              <a:gd name="connsiteY0" fmla="*/ 1499468 h 1527523"/>
              <a:gd name="connsiteX1" fmla="*/ 133351 w 1617133"/>
              <a:gd name="connsiteY1" fmla="*/ 1469835 h 1527523"/>
              <a:gd name="connsiteX2" fmla="*/ 237067 w 1617133"/>
              <a:gd name="connsiteY2" fmla="*/ 1423268 h 1527523"/>
              <a:gd name="connsiteX3" fmla="*/ 347133 w 1617133"/>
              <a:gd name="connsiteY3" fmla="*/ 1253934 h 1527523"/>
              <a:gd name="connsiteX4" fmla="*/ 508000 w 1617133"/>
              <a:gd name="connsiteY4" fmla="*/ 635868 h 1527523"/>
              <a:gd name="connsiteX5" fmla="*/ 563033 w 1617133"/>
              <a:gd name="connsiteY5" fmla="*/ 445368 h 1527523"/>
              <a:gd name="connsiteX6" fmla="*/ 609600 w 1617133"/>
              <a:gd name="connsiteY6" fmla="*/ 254868 h 1527523"/>
              <a:gd name="connsiteX7" fmla="*/ 658282 w 1617133"/>
              <a:gd name="connsiteY7" fmla="*/ 115167 h 1527523"/>
              <a:gd name="connsiteX8" fmla="*/ 723901 w 1617133"/>
              <a:gd name="connsiteY8" fmla="*/ 30501 h 1527523"/>
              <a:gd name="connsiteX9" fmla="*/ 794918 w 1617133"/>
              <a:gd name="connsiteY9" fmla="*/ 18 h 1527523"/>
              <a:gd name="connsiteX10" fmla="*/ 886884 w 1617133"/>
              <a:gd name="connsiteY10" fmla="*/ 43201 h 1527523"/>
              <a:gd name="connsiteX11" fmla="*/ 965200 w 1617133"/>
              <a:gd name="connsiteY11" fmla="*/ 136334 h 1527523"/>
              <a:gd name="connsiteX12" fmla="*/ 1016000 w 1617133"/>
              <a:gd name="connsiteY12" fmla="*/ 373401 h 1527523"/>
              <a:gd name="connsiteX13" fmla="*/ 1202267 w 1617133"/>
              <a:gd name="connsiteY13" fmla="*/ 1135401 h 1527523"/>
              <a:gd name="connsiteX14" fmla="*/ 1253067 w 1617133"/>
              <a:gd name="connsiteY14" fmla="*/ 1414801 h 1527523"/>
              <a:gd name="connsiteX15" fmla="*/ 1286933 w 1617133"/>
              <a:gd name="connsiteY15" fmla="*/ 1516401 h 1527523"/>
              <a:gd name="connsiteX16" fmla="*/ 1422400 w 1617133"/>
              <a:gd name="connsiteY16" fmla="*/ 1524868 h 1527523"/>
              <a:gd name="connsiteX17" fmla="*/ 1617133 w 1617133"/>
              <a:gd name="connsiteY17" fmla="*/ 1516401 h 1527523"/>
              <a:gd name="connsiteX18" fmla="*/ 1617133 w 1617133"/>
              <a:gd name="connsiteY18" fmla="*/ 1516401 h 1527523"/>
              <a:gd name="connsiteX19" fmla="*/ 1617133 w 1617133"/>
              <a:gd name="connsiteY19" fmla="*/ 1516401 h 1527523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09600 w 1617133"/>
              <a:gd name="connsiteY6" fmla="*/ 254873 h 1527528"/>
              <a:gd name="connsiteX7" fmla="*/ 658282 w 1617133"/>
              <a:gd name="connsiteY7" fmla="*/ 115172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09600 w 1617133"/>
              <a:gd name="connsiteY6" fmla="*/ 254873 h 1527528"/>
              <a:gd name="connsiteX7" fmla="*/ 666748 w 1617133"/>
              <a:gd name="connsiteY7" fmla="*/ 123639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09600 w 1617133"/>
              <a:gd name="connsiteY6" fmla="*/ 254873 h 1527528"/>
              <a:gd name="connsiteX7" fmla="*/ 666748 w 1617133"/>
              <a:gd name="connsiteY7" fmla="*/ 123639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15950 w 1617133"/>
              <a:gd name="connsiteY6" fmla="*/ 263340 h 1527528"/>
              <a:gd name="connsiteX7" fmla="*/ 666748 w 1617133"/>
              <a:gd name="connsiteY7" fmla="*/ 123639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73410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73410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73410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94577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4617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805502 w 1617133"/>
              <a:gd name="connsiteY9" fmla="*/ 27 h 1527532"/>
              <a:gd name="connsiteX10" fmla="*/ 886884 w 1617133"/>
              <a:gd name="connsiteY10" fmla="*/ 43210 h 1527532"/>
              <a:gd name="connsiteX11" fmla="*/ 954617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4877"/>
              <a:gd name="connsiteX1" fmla="*/ 133351 w 1617133"/>
              <a:gd name="connsiteY1" fmla="*/ 1469844 h 1524877"/>
              <a:gd name="connsiteX2" fmla="*/ 237067 w 1617133"/>
              <a:gd name="connsiteY2" fmla="*/ 1423277 h 1524877"/>
              <a:gd name="connsiteX3" fmla="*/ 347133 w 1617133"/>
              <a:gd name="connsiteY3" fmla="*/ 1253943 h 1524877"/>
              <a:gd name="connsiteX4" fmla="*/ 508000 w 1617133"/>
              <a:gd name="connsiteY4" fmla="*/ 635877 h 1524877"/>
              <a:gd name="connsiteX5" fmla="*/ 563033 w 1617133"/>
              <a:gd name="connsiteY5" fmla="*/ 445377 h 1524877"/>
              <a:gd name="connsiteX6" fmla="*/ 615950 w 1617133"/>
              <a:gd name="connsiteY6" fmla="*/ 263344 h 1524877"/>
              <a:gd name="connsiteX7" fmla="*/ 666748 w 1617133"/>
              <a:gd name="connsiteY7" fmla="*/ 123643 h 1524877"/>
              <a:gd name="connsiteX8" fmla="*/ 723901 w 1617133"/>
              <a:gd name="connsiteY8" fmla="*/ 30510 h 1524877"/>
              <a:gd name="connsiteX9" fmla="*/ 805502 w 1617133"/>
              <a:gd name="connsiteY9" fmla="*/ 27 h 1524877"/>
              <a:gd name="connsiteX10" fmla="*/ 886884 w 1617133"/>
              <a:gd name="connsiteY10" fmla="*/ 43210 h 1524877"/>
              <a:gd name="connsiteX11" fmla="*/ 954617 w 1617133"/>
              <a:gd name="connsiteY11" fmla="*/ 185026 h 1524877"/>
              <a:gd name="connsiteX12" fmla="*/ 1016000 w 1617133"/>
              <a:gd name="connsiteY12" fmla="*/ 394577 h 1524877"/>
              <a:gd name="connsiteX13" fmla="*/ 1187451 w 1617133"/>
              <a:gd name="connsiteY13" fmla="*/ 1141760 h 1524877"/>
              <a:gd name="connsiteX14" fmla="*/ 1253067 w 1617133"/>
              <a:gd name="connsiteY14" fmla="*/ 1414810 h 1524877"/>
              <a:gd name="connsiteX15" fmla="*/ 1295400 w 1617133"/>
              <a:gd name="connsiteY15" fmla="*/ 1503710 h 1524877"/>
              <a:gd name="connsiteX16" fmla="*/ 1422400 w 1617133"/>
              <a:gd name="connsiteY16" fmla="*/ 1524877 h 1524877"/>
              <a:gd name="connsiteX17" fmla="*/ 1617133 w 1617133"/>
              <a:gd name="connsiteY17" fmla="*/ 1516410 h 1524877"/>
              <a:gd name="connsiteX18" fmla="*/ 1617133 w 1617133"/>
              <a:gd name="connsiteY18" fmla="*/ 1516410 h 1524877"/>
              <a:gd name="connsiteX19" fmla="*/ 1617133 w 1617133"/>
              <a:gd name="connsiteY19" fmla="*/ 1516410 h 1524877"/>
              <a:gd name="connsiteX0" fmla="*/ 0 w 1617133"/>
              <a:gd name="connsiteY0" fmla="*/ 1499477 h 1524877"/>
              <a:gd name="connsiteX1" fmla="*/ 133351 w 1617133"/>
              <a:gd name="connsiteY1" fmla="*/ 1469844 h 1524877"/>
              <a:gd name="connsiteX2" fmla="*/ 237067 w 1617133"/>
              <a:gd name="connsiteY2" fmla="*/ 1423277 h 1524877"/>
              <a:gd name="connsiteX3" fmla="*/ 347133 w 1617133"/>
              <a:gd name="connsiteY3" fmla="*/ 1253943 h 1524877"/>
              <a:gd name="connsiteX4" fmla="*/ 508000 w 1617133"/>
              <a:gd name="connsiteY4" fmla="*/ 635877 h 1524877"/>
              <a:gd name="connsiteX5" fmla="*/ 563033 w 1617133"/>
              <a:gd name="connsiteY5" fmla="*/ 445377 h 1524877"/>
              <a:gd name="connsiteX6" fmla="*/ 615950 w 1617133"/>
              <a:gd name="connsiteY6" fmla="*/ 263344 h 1524877"/>
              <a:gd name="connsiteX7" fmla="*/ 666748 w 1617133"/>
              <a:gd name="connsiteY7" fmla="*/ 123643 h 1524877"/>
              <a:gd name="connsiteX8" fmla="*/ 723901 w 1617133"/>
              <a:gd name="connsiteY8" fmla="*/ 30510 h 1524877"/>
              <a:gd name="connsiteX9" fmla="*/ 805502 w 1617133"/>
              <a:gd name="connsiteY9" fmla="*/ 27 h 1524877"/>
              <a:gd name="connsiteX10" fmla="*/ 886884 w 1617133"/>
              <a:gd name="connsiteY10" fmla="*/ 43210 h 1524877"/>
              <a:gd name="connsiteX11" fmla="*/ 954617 w 1617133"/>
              <a:gd name="connsiteY11" fmla="*/ 185026 h 1524877"/>
              <a:gd name="connsiteX12" fmla="*/ 1016000 w 1617133"/>
              <a:gd name="connsiteY12" fmla="*/ 394577 h 1524877"/>
              <a:gd name="connsiteX13" fmla="*/ 1187451 w 1617133"/>
              <a:gd name="connsiteY13" fmla="*/ 1141760 h 1524877"/>
              <a:gd name="connsiteX14" fmla="*/ 1253067 w 1617133"/>
              <a:gd name="connsiteY14" fmla="*/ 1414810 h 1524877"/>
              <a:gd name="connsiteX15" fmla="*/ 1295400 w 1617133"/>
              <a:gd name="connsiteY15" fmla="*/ 1503710 h 1524877"/>
              <a:gd name="connsiteX16" fmla="*/ 1422400 w 1617133"/>
              <a:gd name="connsiteY16" fmla="*/ 1524877 h 1524877"/>
              <a:gd name="connsiteX17" fmla="*/ 1617133 w 1617133"/>
              <a:gd name="connsiteY17" fmla="*/ 1516410 h 1524877"/>
              <a:gd name="connsiteX18" fmla="*/ 1617133 w 1617133"/>
              <a:gd name="connsiteY18" fmla="*/ 1516410 h 1524877"/>
              <a:gd name="connsiteX19" fmla="*/ 1617133 w 1617133"/>
              <a:gd name="connsiteY19" fmla="*/ 1516410 h 1524877"/>
              <a:gd name="connsiteX0" fmla="*/ 0 w 1617133"/>
              <a:gd name="connsiteY0" fmla="*/ 1499477 h 1524877"/>
              <a:gd name="connsiteX1" fmla="*/ 133351 w 1617133"/>
              <a:gd name="connsiteY1" fmla="*/ 1469844 h 1524877"/>
              <a:gd name="connsiteX2" fmla="*/ 237067 w 1617133"/>
              <a:gd name="connsiteY2" fmla="*/ 1423277 h 1524877"/>
              <a:gd name="connsiteX3" fmla="*/ 347133 w 1617133"/>
              <a:gd name="connsiteY3" fmla="*/ 1253943 h 1524877"/>
              <a:gd name="connsiteX4" fmla="*/ 508000 w 1617133"/>
              <a:gd name="connsiteY4" fmla="*/ 635877 h 1524877"/>
              <a:gd name="connsiteX5" fmla="*/ 563033 w 1617133"/>
              <a:gd name="connsiteY5" fmla="*/ 445377 h 1524877"/>
              <a:gd name="connsiteX6" fmla="*/ 615950 w 1617133"/>
              <a:gd name="connsiteY6" fmla="*/ 263344 h 1524877"/>
              <a:gd name="connsiteX7" fmla="*/ 666748 w 1617133"/>
              <a:gd name="connsiteY7" fmla="*/ 123643 h 1524877"/>
              <a:gd name="connsiteX8" fmla="*/ 723901 w 1617133"/>
              <a:gd name="connsiteY8" fmla="*/ 30510 h 1524877"/>
              <a:gd name="connsiteX9" fmla="*/ 805502 w 1617133"/>
              <a:gd name="connsiteY9" fmla="*/ 27 h 1524877"/>
              <a:gd name="connsiteX10" fmla="*/ 886884 w 1617133"/>
              <a:gd name="connsiteY10" fmla="*/ 43210 h 1524877"/>
              <a:gd name="connsiteX11" fmla="*/ 954617 w 1617133"/>
              <a:gd name="connsiteY11" fmla="*/ 185026 h 1524877"/>
              <a:gd name="connsiteX12" fmla="*/ 1016000 w 1617133"/>
              <a:gd name="connsiteY12" fmla="*/ 394577 h 1524877"/>
              <a:gd name="connsiteX13" fmla="*/ 1187451 w 1617133"/>
              <a:gd name="connsiteY13" fmla="*/ 1141760 h 1524877"/>
              <a:gd name="connsiteX14" fmla="*/ 1253067 w 1617133"/>
              <a:gd name="connsiteY14" fmla="*/ 1414810 h 1524877"/>
              <a:gd name="connsiteX15" fmla="*/ 1295400 w 1617133"/>
              <a:gd name="connsiteY15" fmla="*/ 1503710 h 1524877"/>
              <a:gd name="connsiteX16" fmla="*/ 1422400 w 1617133"/>
              <a:gd name="connsiteY16" fmla="*/ 1524877 h 1524877"/>
              <a:gd name="connsiteX17" fmla="*/ 1617133 w 1617133"/>
              <a:gd name="connsiteY17" fmla="*/ 1516410 h 1524877"/>
              <a:gd name="connsiteX18" fmla="*/ 1617133 w 1617133"/>
              <a:gd name="connsiteY18" fmla="*/ 1516410 h 1524877"/>
              <a:gd name="connsiteX19" fmla="*/ 1617133 w 1617133"/>
              <a:gd name="connsiteY19" fmla="*/ 1516410 h 1524877"/>
              <a:gd name="connsiteX0" fmla="*/ 0 w 1617133"/>
              <a:gd name="connsiteY0" fmla="*/ 1499477 h 1524884"/>
              <a:gd name="connsiteX1" fmla="*/ 133351 w 1617133"/>
              <a:gd name="connsiteY1" fmla="*/ 1469844 h 1524884"/>
              <a:gd name="connsiteX2" fmla="*/ 237067 w 1617133"/>
              <a:gd name="connsiteY2" fmla="*/ 1423277 h 1524884"/>
              <a:gd name="connsiteX3" fmla="*/ 347133 w 1617133"/>
              <a:gd name="connsiteY3" fmla="*/ 1253943 h 1524884"/>
              <a:gd name="connsiteX4" fmla="*/ 508000 w 1617133"/>
              <a:gd name="connsiteY4" fmla="*/ 635877 h 1524884"/>
              <a:gd name="connsiteX5" fmla="*/ 563033 w 1617133"/>
              <a:gd name="connsiteY5" fmla="*/ 445377 h 1524884"/>
              <a:gd name="connsiteX6" fmla="*/ 615950 w 1617133"/>
              <a:gd name="connsiteY6" fmla="*/ 263344 h 1524884"/>
              <a:gd name="connsiteX7" fmla="*/ 666748 w 1617133"/>
              <a:gd name="connsiteY7" fmla="*/ 123643 h 1524884"/>
              <a:gd name="connsiteX8" fmla="*/ 723901 w 1617133"/>
              <a:gd name="connsiteY8" fmla="*/ 30510 h 1524884"/>
              <a:gd name="connsiteX9" fmla="*/ 805502 w 1617133"/>
              <a:gd name="connsiteY9" fmla="*/ 27 h 1524884"/>
              <a:gd name="connsiteX10" fmla="*/ 886884 w 1617133"/>
              <a:gd name="connsiteY10" fmla="*/ 43210 h 1524884"/>
              <a:gd name="connsiteX11" fmla="*/ 954617 w 1617133"/>
              <a:gd name="connsiteY11" fmla="*/ 185026 h 1524884"/>
              <a:gd name="connsiteX12" fmla="*/ 1016000 w 1617133"/>
              <a:gd name="connsiteY12" fmla="*/ 394577 h 1524884"/>
              <a:gd name="connsiteX13" fmla="*/ 1187451 w 1617133"/>
              <a:gd name="connsiteY13" fmla="*/ 1141760 h 1524884"/>
              <a:gd name="connsiteX14" fmla="*/ 1253067 w 1617133"/>
              <a:gd name="connsiteY14" fmla="*/ 1414810 h 1524884"/>
              <a:gd name="connsiteX15" fmla="*/ 1295400 w 1617133"/>
              <a:gd name="connsiteY15" fmla="*/ 1503710 h 1524884"/>
              <a:gd name="connsiteX16" fmla="*/ 1422400 w 1617133"/>
              <a:gd name="connsiteY16" fmla="*/ 1524877 h 1524884"/>
              <a:gd name="connsiteX17" fmla="*/ 1617133 w 1617133"/>
              <a:gd name="connsiteY17" fmla="*/ 1516410 h 1524884"/>
              <a:gd name="connsiteX18" fmla="*/ 1617133 w 1617133"/>
              <a:gd name="connsiteY18" fmla="*/ 1516410 h 1524884"/>
              <a:gd name="connsiteX19" fmla="*/ 1617133 w 1617133"/>
              <a:gd name="connsiteY19" fmla="*/ 1516410 h 1524884"/>
              <a:gd name="connsiteX0" fmla="*/ 0 w 1617133"/>
              <a:gd name="connsiteY0" fmla="*/ 1499477 h 1524884"/>
              <a:gd name="connsiteX1" fmla="*/ 133351 w 1617133"/>
              <a:gd name="connsiteY1" fmla="*/ 1469844 h 1524884"/>
              <a:gd name="connsiteX2" fmla="*/ 237067 w 1617133"/>
              <a:gd name="connsiteY2" fmla="*/ 1423277 h 1524884"/>
              <a:gd name="connsiteX3" fmla="*/ 347133 w 1617133"/>
              <a:gd name="connsiteY3" fmla="*/ 1253943 h 1524884"/>
              <a:gd name="connsiteX4" fmla="*/ 508000 w 1617133"/>
              <a:gd name="connsiteY4" fmla="*/ 635877 h 1524884"/>
              <a:gd name="connsiteX5" fmla="*/ 563033 w 1617133"/>
              <a:gd name="connsiteY5" fmla="*/ 445377 h 1524884"/>
              <a:gd name="connsiteX6" fmla="*/ 615950 w 1617133"/>
              <a:gd name="connsiteY6" fmla="*/ 263344 h 1524884"/>
              <a:gd name="connsiteX7" fmla="*/ 666748 w 1617133"/>
              <a:gd name="connsiteY7" fmla="*/ 123643 h 1524884"/>
              <a:gd name="connsiteX8" fmla="*/ 723901 w 1617133"/>
              <a:gd name="connsiteY8" fmla="*/ 30510 h 1524884"/>
              <a:gd name="connsiteX9" fmla="*/ 805502 w 1617133"/>
              <a:gd name="connsiteY9" fmla="*/ 27 h 1524884"/>
              <a:gd name="connsiteX10" fmla="*/ 886884 w 1617133"/>
              <a:gd name="connsiteY10" fmla="*/ 43210 h 1524884"/>
              <a:gd name="connsiteX11" fmla="*/ 954617 w 1617133"/>
              <a:gd name="connsiteY11" fmla="*/ 185026 h 1524884"/>
              <a:gd name="connsiteX12" fmla="*/ 1011767 w 1617133"/>
              <a:gd name="connsiteY12" fmla="*/ 396694 h 1524884"/>
              <a:gd name="connsiteX13" fmla="*/ 1187451 w 1617133"/>
              <a:gd name="connsiteY13" fmla="*/ 1141760 h 1524884"/>
              <a:gd name="connsiteX14" fmla="*/ 1253067 w 1617133"/>
              <a:gd name="connsiteY14" fmla="*/ 1414810 h 1524884"/>
              <a:gd name="connsiteX15" fmla="*/ 1295400 w 1617133"/>
              <a:gd name="connsiteY15" fmla="*/ 1503710 h 1524884"/>
              <a:gd name="connsiteX16" fmla="*/ 1422400 w 1617133"/>
              <a:gd name="connsiteY16" fmla="*/ 1524877 h 1524884"/>
              <a:gd name="connsiteX17" fmla="*/ 1617133 w 1617133"/>
              <a:gd name="connsiteY17" fmla="*/ 1516410 h 1524884"/>
              <a:gd name="connsiteX18" fmla="*/ 1617133 w 1617133"/>
              <a:gd name="connsiteY18" fmla="*/ 1516410 h 1524884"/>
              <a:gd name="connsiteX19" fmla="*/ 1617133 w 1617133"/>
              <a:gd name="connsiteY19" fmla="*/ 1516410 h 15248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</a:cxnLst>
            <a:rect l="l" t="t" r="r" b="b"/>
            <a:pathLst>
              <a:path w="1617133" h="1524884">
                <a:moveTo>
                  <a:pt x="0" y="1499477"/>
                </a:moveTo>
                <a:cubicBezTo>
                  <a:pt x="19756" y="1494185"/>
                  <a:pt x="93840" y="1482544"/>
                  <a:pt x="133351" y="1469844"/>
                </a:cubicBezTo>
                <a:cubicBezTo>
                  <a:pt x="172862" y="1457144"/>
                  <a:pt x="201437" y="1459261"/>
                  <a:pt x="237067" y="1423277"/>
                </a:cubicBezTo>
                <a:cubicBezTo>
                  <a:pt x="272697" y="1387293"/>
                  <a:pt x="301978" y="1385176"/>
                  <a:pt x="347133" y="1253943"/>
                </a:cubicBezTo>
                <a:cubicBezTo>
                  <a:pt x="392288" y="1122710"/>
                  <a:pt x="472017" y="770638"/>
                  <a:pt x="508000" y="635877"/>
                </a:cubicBezTo>
                <a:cubicBezTo>
                  <a:pt x="543983" y="501116"/>
                  <a:pt x="545041" y="507466"/>
                  <a:pt x="563033" y="445377"/>
                </a:cubicBezTo>
                <a:cubicBezTo>
                  <a:pt x="581025" y="383288"/>
                  <a:pt x="598664" y="316966"/>
                  <a:pt x="615950" y="263344"/>
                </a:cubicBezTo>
                <a:cubicBezTo>
                  <a:pt x="633236" y="209722"/>
                  <a:pt x="648756" y="162449"/>
                  <a:pt x="666748" y="123643"/>
                </a:cubicBezTo>
                <a:cubicBezTo>
                  <a:pt x="684740" y="84837"/>
                  <a:pt x="700775" y="51113"/>
                  <a:pt x="723901" y="30510"/>
                </a:cubicBezTo>
                <a:cubicBezTo>
                  <a:pt x="747027" y="9907"/>
                  <a:pt x="776221" y="732"/>
                  <a:pt x="805502" y="27"/>
                </a:cubicBezTo>
                <a:cubicBezTo>
                  <a:pt x="834783" y="-678"/>
                  <a:pt x="862032" y="12377"/>
                  <a:pt x="886884" y="43210"/>
                </a:cubicBezTo>
                <a:cubicBezTo>
                  <a:pt x="911736" y="74043"/>
                  <a:pt x="933803" y="126112"/>
                  <a:pt x="954617" y="185026"/>
                </a:cubicBezTo>
                <a:cubicBezTo>
                  <a:pt x="975431" y="243940"/>
                  <a:pt x="972961" y="237238"/>
                  <a:pt x="1011767" y="396694"/>
                </a:cubicBezTo>
                <a:cubicBezTo>
                  <a:pt x="1050573" y="556150"/>
                  <a:pt x="1147234" y="972074"/>
                  <a:pt x="1187451" y="1141760"/>
                </a:cubicBezTo>
                <a:cubicBezTo>
                  <a:pt x="1227668" y="1311446"/>
                  <a:pt x="1235076" y="1354485"/>
                  <a:pt x="1253067" y="1414810"/>
                </a:cubicBezTo>
                <a:cubicBezTo>
                  <a:pt x="1271058" y="1475135"/>
                  <a:pt x="1254478" y="1474783"/>
                  <a:pt x="1295400" y="1503710"/>
                </a:cubicBezTo>
                <a:cubicBezTo>
                  <a:pt x="1336322" y="1532637"/>
                  <a:pt x="1368778" y="1522760"/>
                  <a:pt x="1422400" y="1524877"/>
                </a:cubicBezTo>
                <a:lnTo>
                  <a:pt x="1617133" y="1516410"/>
                </a:lnTo>
                <a:lnTo>
                  <a:pt x="1617133" y="1516410"/>
                </a:lnTo>
                <a:lnTo>
                  <a:pt x="1617133" y="1516410"/>
                </a:lnTo>
              </a:path>
            </a:pathLst>
          </a:custGeom>
          <a:noFill/>
          <a:ln w="28575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1" name="Forma libre 360"/>
          <p:cNvSpPr/>
          <p:nvPr/>
        </p:nvSpPr>
        <p:spPr>
          <a:xfrm>
            <a:off x="5531768" y="4602976"/>
            <a:ext cx="1438227" cy="1753875"/>
          </a:xfrm>
          <a:custGeom>
            <a:avLst/>
            <a:gdLst>
              <a:gd name="connsiteX0" fmla="*/ 0 w 1549400"/>
              <a:gd name="connsiteY0" fmla="*/ 1519581 h 1547636"/>
              <a:gd name="connsiteX1" fmla="*/ 169334 w 1549400"/>
              <a:gd name="connsiteY1" fmla="*/ 1443381 h 1547636"/>
              <a:gd name="connsiteX2" fmla="*/ 279400 w 1549400"/>
              <a:gd name="connsiteY2" fmla="*/ 1274047 h 1547636"/>
              <a:gd name="connsiteX3" fmla="*/ 338667 w 1549400"/>
              <a:gd name="connsiteY3" fmla="*/ 1028514 h 1547636"/>
              <a:gd name="connsiteX4" fmla="*/ 389467 w 1549400"/>
              <a:gd name="connsiteY4" fmla="*/ 867647 h 1547636"/>
              <a:gd name="connsiteX5" fmla="*/ 440267 w 1549400"/>
              <a:gd name="connsiteY5" fmla="*/ 655981 h 1547636"/>
              <a:gd name="connsiteX6" fmla="*/ 482600 w 1549400"/>
              <a:gd name="connsiteY6" fmla="*/ 452781 h 1547636"/>
              <a:gd name="connsiteX7" fmla="*/ 524934 w 1549400"/>
              <a:gd name="connsiteY7" fmla="*/ 249581 h 1547636"/>
              <a:gd name="connsiteX8" fmla="*/ 567267 w 1549400"/>
              <a:gd name="connsiteY8" fmla="*/ 139514 h 1547636"/>
              <a:gd name="connsiteX9" fmla="*/ 668867 w 1549400"/>
              <a:gd name="connsiteY9" fmla="*/ 12514 h 1547636"/>
              <a:gd name="connsiteX10" fmla="*/ 829734 w 1549400"/>
              <a:gd name="connsiteY10" fmla="*/ 20981 h 1547636"/>
              <a:gd name="connsiteX11" fmla="*/ 897467 w 1549400"/>
              <a:gd name="connsiteY11" fmla="*/ 156447 h 1547636"/>
              <a:gd name="connsiteX12" fmla="*/ 948267 w 1549400"/>
              <a:gd name="connsiteY12" fmla="*/ 393514 h 1547636"/>
              <a:gd name="connsiteX13" fmla="*/ 1134534 w 1549400"/>
              <a:gd name="connsiteY13" fmla="*/ 1155514 h 1547636"/>
              <a:gd name="connsiteX14" fmla="*/ 1185334 w 1549400"/>
              <a:gd name="connsiteY14" fmla="*/ 1434914 h 1547636"/>
              <a:gd name="connsiteX15" fmla="*/ 1219200 w 1549400"/>
              <a:gd name="connsiteY15" fmla="*/ 1536514 h 1547636"/>
              <a:gd name="connsiteX16" fmla="*/ 1354667 w 1549400"/>
              <a:gd name="connsiteY16" fmla="*/ 1544981 h 1547636"/>
              <a:gd name="connsiteX17" fmla="*/ 1549400 w 1549400"/>
              <a:gd name="connsiteY17" fmla="*/ 1536514 h 1547636"/>
              <a:gd name="connsiteX18" fmla="*/ 1549400 w 1549400"/>
              <a:gd name="connsiteY18" fmla="*/ 1536514 h 1547636"/>
              <a:gd name="connsiteX19" fmla="*/ 1549400 w 1549400"/>
              <a:gd name="connsiteY19" fmla="*/ 1536514 h 1547636"/>
              <a:gd name="connsiteX0" fmla="*/ 0 w 1549400"/>
              <a:gd name="connsiteY0" fmla="*/ 1519581 h 1547636"/>
              <a:gd name="connsiteX1" fmla="*/ 169334 w 1549400"/>
              <a:gd name="connsiteY1" fmla="*/ 1443381 h 1547636"/>
              <a:gd name="connsiteX2" fmla="*/ 279400 w 1549400"/>
              <a:gd name="connsiteY2" fmla="*/ 1274047 h 1547636"/>
              <a:gd name="connsiteX3" fmla="*/ 338667 w 1549400"/>
              <a:gd name="connsiteY3" fmla="*/ 1028514 h 1547636"/>
              <a:gd name="connsiteX4" fmla="*/ 440267 w 1549400"/>
              <a:gd name="connsiteY4" fmla="*/ 655981 h 1547636"/>
              <a:gd name="connsiteX5" fmla="*/ 482600 w 1549400"/>
              <a:gd name="connsiteY5" fmla="*/ 452781 h 1547636"/>
              <a:gd name="connsiteX6" fmla="*/ 524934 w 1549400"/>
              <a:gd name="connsiteY6" fmla="*/ 249581 h 1547636"/>
              <a:gd name="connsiteX7" fmla="*/ 567267 w 1549400"/>
              <a:gd name="connsiteY7" fmla="*/ 139514 h 1547636"/>
              <a:gd name="connsiteX8" fmla="*/ 668867 w 1549400"/>
              <a:gd name="connsiteY8" fmla="*/ 12514 h 1547636"/>
              <a:gd name="connsiteX9" fmla="*/ 829734 w 1549400"/>
              <a:gd name="connsiteY9" fmla="*/ 20981 h 1547636"/>
              <a:gd name="connsiteX10" fmla="*/ 897467 w 1549400"/>
              <a:gd name="connsiteY10" fmla="*/ 156447 h 1547636"/>
              <a:gd name="connsiteX11" fmla="*/ 948267 w 1549400"/>
              <a:gd name="connsiteY11" fmla="*/ 393514 h 1547636"/>
              <a:gd name="connsiteX12" fmla="*/ 1134534 w 1549400"/>
              <a:gd name="connsiteY12" fmla="*/ 1155514 h 1547636"/>
              <a:gd name="connsiteX13" fmla="*/ 1185334 w 1549400"/>
              <a:gd name="connsiteY13" fmla="*/ 1434914 h 1547636"/>
              <a:gd name="connsiteX14" fmla="*/ 1219200 w 1549400"/>
              <a:gd name="connsiteY14" fmla="*/ 1536514 h 1547636"/>
              <a:gd name="connsiteX15" fmla="*/ 1354667 w 1549400"/>
              <a:gd name="connsiteY15" fmla="*/ 1544981 h 1547636"/>
              <a:gd name="connsiteX16" fmla="*/ 1549400 w 1549400"/>
              <a:gd name="connsiteY16" fmla="*/ 1536514 h 1547636"/>
              <a:gd name="connsiteX17" fmla="*/ 1549400 w 1549400"/>
              <a:gd name="connsiteY17" fmla="*/ 1536514 h 1547636"/>
              <a:gd name="connsiteX18" fmla="*/ 1549400 w 1549400"/>
              <a:gd name="connsiteY18" fmla="*/ 1536514 h 1547636"/>
              <a:gd name="connsiteX0" fmla="*/ 0 w 1549400"/>
              <a:gd name="connsiteY0" fmla="*/ 1519581 h 1547636"/>
              <a:gd name="connsiteX1" fmla="*/ 169334 w 1549400"/>
              <a:gd name="connsiteY1" fmla="*/ 1443381 h 1547636"/>
              <a:gd name="connsiteX2" fmla="*/ 279400 w 1549400"/>
              <a:gd name="connsiteY2" fmla="*/ 1274047 h 1547636"/>
              <a:gd name="connsiteX3" fmla="*/ 440267 w 1549400"/>
              <a:gd name="connsiteY3" fmla="*/ 655981 h 1547636"/>
              <a:gd name="connsiteX4" fmla="*/ 482600 w 1549400"/>
              <a:gd name="connsiteY4" fmla="*/ 452781 h 1547636"/>
              <a:gd name="connsiteX5" fmla="*/ 524934 w 1549400"/>
              <a:gd name="connsiteY5" fmla="*/ 249581 h 1547636"/>
              <a:gd name="connsiteX6" fmla="*/ 567267 w 1549400"/>
              <a:gd name="connsiteY6" fmla="*/ 139514 h 1547636"/>
              <a:gd name="connsiteX7" fmla="*/ 668867 w 1549400"/>
              <a:gd name="connsiteY7" fmla="*/ 12514 h 1547636"/>
              <a:gd name="connsiteX8" fmla="*/ 829734 w 1549400"/>
              <a:gd name="connsiteY8" fmla="*/ 20981 h 1547636"/>
              <a:gd name="connsiteX9" fmla="*/ 897467 w 1549400"/>
              <a:gd name="connsiteY9" fmla="*/ 156447 h 1547636"/>
              <a:gd name="connsiteX10" fmla="*/ 948267 w 1549400"/>
              <a:gd name="connsiteY10" fmla="*/ 393514 h 1547636"/>
              <a:gd name="connsiteX11" fmla="*/ 1134534 w 1549400"/>
              <a:gd name="connsiteY11" fmla="*/ 1155514 h 1547636"/>
              <a:gd name="connsiteX12" fmla="*/ 1185334 w 1549400"/>
              <a:gd name="connsiteY12" fmla="*/ 1434914 h 1547636"/>
              <a:gd name="connsiteX13" fmla="*/ 1219200 w 1549400"/>
              <a:gd name="connsiteY13" fmla="*/ 1536514 h 1547636"/>
              <a:gd name="connsiteX14" fmla="*/ 1354667 w 1549400"/>
              <a:gd name="connsiteY14" fmla="*/ 1544981 h 1547636"/>
              <a:gd name="connsiteX15" fmla="*/ 1549400 w 1549400"/>
              <a:gd name="connsiteY15" fmla="*/ 1536514 h 1547636"/>
              <a:gd name="connsiteX16" fmla="*/ 1549400 w 1549400"/>
              <a:gd name="connsiteY16" fmla="*/ 1536514 h 1547636"/>
              <a:gd name="connsiteX17" fmla="*/ 1549400 w 1549400"/>
              <a:gd name="connsiteY17" fmla="*/ 1536514 h 1547636"/>
              <a:gd name="connsiteX0" fmla="*/ 0 w 1617133"/>
              <a:gd name="connsiteY0" fmla="*/ 1519581 h 1547636"/>
              <a:gd name="connsiteX1" fmla="*/ 237067 w 1617133"/>
              <a:gd name="connsiteY1" fmla="*/ 1443381 h 1547636"/>
              <a:gd name="connsiteX2" fmla="*/ 347133 w 1617133"/>
              <a:gd name="connsiteY2" fmla="*/ 1274047 h 1547636"/>
              <a:gd name="connsiteX3" fmla="*/ 508000 w 1617133"/>
              <a:gd name="connsiteY3" fmla="*/ 655981 h 1547636"/>
              <a:gd name="connsiteX4" fmla="*/ 550333 w 1617133"/>
              <a:gd name="connsiteY4" fmla="*/ 452781 h 1547636"/>
              <a:gd name="connsiteX5" fmla="*/ 592667 w 1617133"/>
              <a:gd name="connsiteY5" fmla="*/ 249581 h 1547636"/>
              <a:gd name="connsiteX6" fmla="*/ 635000 w 1617133"/>
              <a:gd name="connsiteY6" fmla="*/ 139514 h 1547636"/>
              <a:gd name="connsiteX7" fmla="*/ 736600 w 1617133"/>
              <a:gd name="connsiteY7" fmla="*/ 12514 h 1547636"/>
              <a:gd name="connsiteX8" fmla="*/ 897467 w 1617133"/>
              <a:gd name="connsiteY8" fmla="*/ 20981 h 1547636"/>
              <a:gd name="connsiteX9" fmla="*/ 965200 w 1617133"/>
              <a:gd name="connsiteY9" fmla="*/ 156447 h 1547636"/>
              <a:gd name="connsiteX10" fmla="*/ 1016000 w 1617133"/>
              <a:gd name="connsiteY10" fmla="*/ 393514 h 1547636"/>
              <a:gd name="connsiteX11" fmla="*/ 1202267 w 1617133"/>
              <a:gd name="connsiteY11" fmla="*/ 1155514 h 1547636"/>
              <a:gd name="connsiteX12" fmla="*/ 1253067 w 1617133"/>
              <a:gd name="connsiteY12" fmla="*/ 1434914 h 1547636"/>
              <a:gd name="connsiteX13" fmla="*/ 1286933 w 1617133"/>
              <a:gd name="connsiteY13" fmla="*/ 1536514 h 1547636"/>
              <a:gd name="connsiteX14" fmla="*/ 1422400 w 1617133"/>
              <a:gd name="connsiteY14" fmla="*/ 1544981 h 1547636"/>
              <a:gd name="connsiteX15" fmla="*/ 1617133 w 1617133"/>
              <a:gd name="connsiteY15" fmla="*/ 1536514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0" fmla="*/ 0 w 1617133"/>
              <a:gd name="connsiteY0" fmla="*/ 1519581 h 1547636"/>
              <a:gd name="connsiteX1" fmla="*/ 127001 w 1617133"/>
              <a:gd name="connsiteY1" fmla="*/ 1485714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2667 w 1617133"/>
              <a:gd name="connsiteY6" fmla="*/ 2495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2667 w 1617133"/>
              <a:gd name="connsiteY6" fmla="*/ 2495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2667 w 1617133"/>
              <a:gd name="connsiteY6" fmla="*/ 2495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6900 w 1617133"/>
              <a:gd name="connsiteY6" fmla="*/ 272864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6900 w 1617133"/>
              <a:gd name="connsiteY6" fmla="*/ 272864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6900 w 1617133"/>
              <a:gd name="connsiteY6" fmla="*/ 272864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609600 w 1617133"/>
              <a:gd name="connsiteY6" fmla="*/ 2749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63033 w 1617133"/>
              <a:gd name="connsiteY5" fmla="*/ 465481 h 1547636"/>
              <a:gd name="connsiteX6" fmla="*/ 609600 w 1617133"/>
              <a:gd name="connsiteY6" fmla="*/ 2749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729 h 1547784"/>
              <a:gd name="connsiteX1" fmla="*/ 133351 w 1617133"/>
              <a:gd name="connsiteY1" fmla="*/ 1490096 h 1547784"/>
              <a:gd name="connsiteX2" fmla="*/ 237067 w 1617133"/>
              <a:gd name="connsiteY2" fmla="*/ 1443529 h 1547784"/>
              <a:gd name="connsiteX3" fmla="*/ 347133 w 1617133"/>
              <a:gd name="connsiteY3" fmla="*/ 1274195 h 1547784"/>
              <a:gd name="connsiteX4" fmla="*/ 508000 w 1617133"/>
              <a:gd name="connsiteY4" fmla="*/ 656129 h 1547784"/>
              <a:gd name="connsiteX5" fmla="*/ 563033 w 1617133"/>
              <a:gd name="connsiteY5" fmla="*/ 465629 h 1547784"/>
              <a:gd name="connsiteX6" fmla="*/ 609600 w 1617133"/>
              <a:gd name="connsiteY6" fmla="*/ 275129 h 1547784"/>
              <a:gd name="connsiteX7" fmla="*/ 647700 w 1617133"/>
              <a:gd name="connsiteY7" fmla="*/ 141778 h 1547784"/>
              <a:gd name="connsiteX8" fmla="*/ 736600 w 1617133"/>
              <a:gd name="connsiteY8" fmla="*/ 12662 h 1547784"/>
              <a:gd name="connsiteX9" fmla="*/ 897467 w 1617133"/>
              <a:gd name="connsiteY9" fmla="*/ 21129 h 1547784"/>
              <a:gd name="connsiteX10" fmla="*/ 965200 w 1617133"/>
              <a:gd name="connsiteY10" fmla="*/ 156595 h 1547784"/>
              <a:gd name="connsiteX11" fmla="*/ 1016000 w 1617133"/>
              <a:gd name="connsiteY11" fmla="*/ 393662 h 1547784"/>
              <a:gd name="connsiteX12" fmla="*/ 1202267 w 1617133"/>
              <a:gd name="connsiteY12" fmla="*/ 1155662 h 1547784"/>
              <a:gd name="connsiteX13" fmla="*/ 1253067 w 1617133"/>
              <a:gd name="connsiteY13" fmla="*/ 1435062 h 1547784"/>
              <a:gd name="connsiteX14" fmla="*/ 1286933 w 1617133"/>
              <a:gd name="connsiteY14" fmla="*/ 1536662 h 1547784"/>
              <a:gd name="connsiteX15" fmla="*/ 1422400 w 1617133"/>
              <a:gd name="connsiteY15" fmla="*/ 1545129 h 1547784"/>
              <a:gd name="connsiteX16" fmla="*/ 1617133 w 1617133"/>
              <a:gd name="connsiteY16" fmla="*/ 1536662 h 1547784"/>
              <a:gd name="connsiteX17" fmla="*/ 1617133 w 1617133"/>
              <a:gd name="connsiteY17" fmla="*/ 1536662 h 1547784"/>
              <a:gd name="connsiteX18" fmla="*/ 1617133 w 1617133"/>
              <a:gd name="connsiteY18" fmla="*/ 1536662 h 1547784"/>
              <a:gd name="connsiteX0" fmla="*/ 0 w 1617133"/>
              <a:gd name="connsiteY0" fmla="*/ 1519582 h 1547637"/>
              <a:gd name="connsiteX1" fmla="*/ 133351 w 1617133"/>
              <a:gd name="connsiteY1" fmla="*/ 1489949 h 1547637"/>
              <a:gd name="connsiteX2" fmla="*/ 237067 w 1617133"/>
              <a:gd name="connsiteY2" fmla="*/ 1443382 h 1547637"/>
              <a:gd name="connsiteX3" fmla="*/ 347133 w 1617133"/>
              <a:gd name="connsiteY3" fmla="*/ 1274048 h 1547637"/>
              <a:gd name="connsiteX4" fmla="*/ 508000 w 1617133"/>
              <a:gd name="connsiteY4" fmla="*/ 655982 h 1547637"/>
              <a:gd name="connsiteX5" fmla="*/ 563033 w 1617133"/>
              <a:gd name="connsiteY5" fmla="*/ 465482 h 1547637"/>
              <a:gd name="connsiteX6" fmla="*/ 609600 w 1617133"/>
              <a:gd name="connsiteY6" fmla="*/ 274982 h 1547637"/>
              <a:gd name="connsiteX7" fmla="*/ 649816 w 1617133"/>
              <a:gd name="connsiteY7" fmla="*/ 139515 h 1547637"/>
              <a:gd name="connsiteX8" fmla="*/ 736600 w 1617133"/>
              <a:gd name="connsiteY8" fmla="*/ 12515 h 1547637"/>
              <a:gd name="connsiteX9" fmla="*/ 897467 w 1617133"/>
              <a:gd name="connsiteY9" fmla="*/ 20982 h 1547637"/>
              <a:gd name="connsiteX10" fmla="*/ 965200 w 1617133"/>
              <a:gd name="connsiteY10" fmla="*/ 156448 h 1547637"/>
              <a:gd name="connsiteX11" fmla="*/ 1016000 w 1617133"/>
              <a:gd name="connsiteY11" fmla="*/ 393515 h 1547637"/>
              <a:gd name="connsiteX12" fmla="*/ 1202267 w 1617133"/>
              <a:gd name="connsiteY12" fmla="*/ 1155515 h 1547637"/>
              <a:gd name="connsiteX13" fmla="*/ 1253067 w 1617133"/>
              <a:gd name="connsiteY13" fmla="*/ 1434915 h 1547637"/>
              <a:gd name="connsiteX14" fmla="*/ 1286933 w 1617133"/>
              <a:gd name="connsiteY14" fmla="*/ 1536515 h 1547637"/>
              <a:gd name="connsiteX15" fmla="*/ 1422400 w 1617133"/>
              <a:gd name="connsiteY15" fmla="*/ 1544982 h 1547637"/>
              <a:gd name="connsiteX16" fmla="*/ 1617133 w 1617133"/>
              <a:gd name="connsiteY16" fmla="*/ 1536515 h 1547637"/>
              <a:gd name="connsiteX17" fmla="*/ 1617133 w 1617133"/>
              <a:gd name="connsiteY17" fmla="*/ 1536515 h 1547637"/>
              <a:gd name="connsiteX18" fmla="*/ 1617133 w 1617133"/>
              <a:gd name="connsiteY18" fmla="*/ 1536515 h 1547637"/>
              <a:gd name="connsiteX0" fmla="*/ 0 w 1617133"/>
              <a:gd name="connsiteY0" fmla="*/ 1519286 h 1547341"/>
              <a:gd name="connsiteX1" fmla="*/ 133351 w 1617133"/>
              <a:gd name="connsiteY1" fmla="*/ 1489653 h 1547341"/>
              <a:gd name="connsiteX2" fmla="*/ 237067 w 1617133"/>
              <a:gd name="connsiteY2" fmla="*/ 1443086 h 1547341"/>
              <a:gd name="connsiteX3" fmla="*/ 347133 w 1617133"/>
              <a:gd name="connsiteY3" fmla="*/ 1273752 h 1547341"/>
              <a:gd name="connsiteX4" fmla="*/ 508000 w 1617133"/>
              <a:gd name="connsiteY4" fmla="*/ 655686 h 1547341"/>
              <a:gd name="connsiteX5" fmla="*/ 563033 w 1617133"/>
              <a:gd name="connsiteY5" fmla="*/ 465186 h 1547341"/>
              <a:gd name="connsiteX6" fmla="*/ 609600 w 1617133"/>
              <a:gd name="connsiteY6" fmla="*/ 274686 h 1547341"/>
              <a:gd name="connsiteX7" fmla="*/ 651932 w 1617133"/>
              <a:gd name="connsiteY7" fmla="*/ 134985 h 1547341"/>
              <a:gd name="connsiteX8" fmla="*/ 736600 w 1617133"/>
              <a:gd name="connsiteY8" fmla="*/ 12219 h 1547341"/>
              <a:gd name="connsiteX9" fmla="*/ 897467 w 1617133"/>
              <a:gd name="connsiteY9" fmla="*/ 20686 h 1547341"/>
              <a:gd name="connsiteX10" fmla="*/ 965200 w 1617133"/>
              <a:gd name="connsiteY10" fmla="*/ 156152 h 1547341"/>
              <a:gd name="connsiteX11" fmla="*/ 1016000 w 1617133"/>
              <a:gd name="connsiteY11" fmla="*/ 393219 h 1547341"/>
              <a:gd name="connsiteX12" fmla="*/ 1202267 w 1617133"/>
              <a:gd name="connsiteY12" fmla="*/ 1155219 h 1547341"/>
              <a:gd name="connsiteX13" fmla="*/ 1253067 w 1617133"/>
              <a:gd name="connsiteY13" fmla="*/ 1434619 h 1547341"/>
              <a:gd name="connsiteX14" fmla="*/ 1286933 w 1617133"/>
              <a:gd name="connsiteY14" fmla="*/ 1536219 h 1547341"/>
              <a:gd name="connsiteX15" fmla="*/ 1422400 w 1617133"/>
              <a:gd name="connsiteY15" fmla="*/ 1544686 h 1547341"/>
              <a:gd name="connsiteX16" fmla="*/ 1617133 w 1617133"/>
              <a:gd name="connsiteY16" fmla="*/ 1536219 h 1547341"/>
              <a:gd name="connsiteX17" fmla="*/ 1617133 w 1617133"/>
              <a:gd name="connsiteY17" fmla="*/ 1536219 h 1547341"/>
              <a:gd name="connsiteX18" fmla="*/ 1617133 w 1617133"/>
              <a:gd name="connsiteY18" fmla="*/ 1536219 h 1547341"/>
              <a:gd name="connsiteX0" fmla="*/ 0 w 1617133"/>
              <a:gd name="connsiteY0" fmla="*/ 1513144 h 1541199"/>
              <a:gd name="connsiteX1" fmla="*/ 133351 w 1617133"/>
              <a:gd name="connsiteY1" fmla="*/ 1483511 h 1541199"/>
              <a:gd name="connsiteX2" fmla="*/ 237067 w 1617133"/>
              <a:gd name="connsiteY2" fmla="*/ 1436944 h 1541199"/>
              <a:gd name="connsiteX3" fmla="*/ 347133 w 1617133"/>
              <a:gd name="connsiteY3" fmla="*/ 1267610 h 1541199"/>
              <a:gd name="connsiteX4" fmla="*/ 508000 w 1617133"/>
              <a:gd name="connsiteY4" fmla="*/ 649544 h 1541199"/>
              <a:gd name="connsiteX5" fmla="*/ 563033 w 1617133"/>
              <a:gd name="connsiteY5" fmla="*/ 459044 h 1541199"/>
              <a:gd name="connsiteX6" fmla="*/ 609600 w 1617133"/>
              <a:gd name="connsiteY6" fmla="*/ 268544 h 1541199"/>
              <a:gd name="connsiteX7" fmla="*/ 651932 w 1617133"/>
              <a:gd name="connsiteY7" fmla="*/ 128843 h 1541199"/>
              <a:gd name="connsiteX8" fmla="*/ 751417 w 1617133"/>
              <a:gd name="connsiteY8" fmla="*/ 16661 h 1541199"/>
              <a:gd name="connsiteX9" fmla="*/ 897467 w 1617133"/>
              <a:gd name="connsiteY9" fmla="*/ 14544 h 1541199"/>
              <a:gd name="connsiteX10" fmla="*/ 965200 w 1617133"/>
              <a:gd name="connsiteY10" fmla="*/ 150010 h 1541199"/>
              <a:gd name="connsiteX11" fmla="*/ 1016000 w 1617133"/>
              <a:gd name="connsiteY11" fmla="*/ 387077 h 1541199"/>
              <a:gd name="connsiteX12" fmla="*/ 1202267 w 1617133"/>
              <a:gd name="connsiteY12" fmla="*/ 1149077 h 1541199"/>
              <a:gd name="connsiteX13" fmla="*/ 1253067 w 1617133"/>
              <a:gd name="connsiteY13" fmla="*/ 1428477 h 1541199"/>
              <a:gd name="connsiteX14" fmla="*/ 1286933 w 1617133"/>
              <a:gd name="connsiteY14" fmla="*/ 1530077 h 1541199"/>
              <a:gd name="connsiteX15" fmla="*/ 1422400 w 1617133"/>
              <a:gd name="connsiteY15" fmla="*/ 1538544 h 1541199"/>
              <a:gd name="connsiteX16" fmla="*/ 1617133 w 1617133"/>
              <a:gd name="connsiteY16" fmla="*/ 1530077 h 1541199"/>
              <a:gd name="connsiteX17" fmla="*/ 1617133 w 1617133"/>
              <a:gd name="connsiteY17" fmla="*/ 1530077 h 1541199"/>
              <a:gd name="connsiteX18" fmla="*/ 1617133 w 1617133"/>
              <a:gd name="connsiteY18" fmla="*/ 1530077 h 1541199"/>
              <a:gd name="connsiteX0" fmla="*/ 0 w 1617133"/>
              <a:gd name="connsiteY0" fmla="*/ 1510639 h 1538694"/>
              <a:gd name="connsiteX1" fmla="*/ 133351 w 1617133"/>
              <a:gd name="connsiteY1" fmla="*/ 1481006 h 1538694"/>
              <a:gd name="connsiteX2" fmla="*/ 237067 w 1617133"/>
              <a:gd name="connsiteY2" fmla="*/ 1434439 h 1538694"/>
              <a:gd name="connsiteX3" fmla="*/ 347133 w 1617133"/>
              <a:gd name="connsiteY3" fmla="*/ 1265105 h 1538694"/>
              <a:gd name="connsiteX4" fmla="*/ 508000 w 1617133"/>
              <a:gd name="connsiteY4" fmla="*/ 647039 h 1538694"/>
              <a:gd name="connsiteX5" fmla="*/ 563033 w 1617133"/>
              <a:gd name="connsiteY5" fmla="*/ 456539 h 1538694"/>
              <a:gd name="connsiteX6" fmla="*/ 609600 w 1617133"/>
              <a:gd name="connsiteY6" fmla="*/ 266039 h 1538694"/>
              <a:gd name="connsiteX7" fmla="*/ 651932 w 1617133"/>
              <a:gd name="connsiteY7" fmla="*/ 126338 h 1538694"/>
              <a:gd name="connsiteX8" fmla="*/ 751417 w 1617133"/>
              <a:gd name="connsiteY8" fmla="*/ 14156 h 1538694"/>
              <a:gd name="connsiteX9" fmla="*/ 895351 w 1617133"/>
              <a:gd name="connsiteY9" fmla="*/ 16272 h 1538694"/>
              <a:gd name="connsiteX10" fmla="*/ 965200 w 1617133"/>
              <a:gd name="connsiteY10" fmla="*/ 147505 h 1538694"/>
              <a:gd name="connsiteX11" fmla="*/ 1016000 w 1617133"/>
              <a:gd name="connsiteY11" fmla="*/ 384572 h 1538694"/>
              <a:gd name="connsiteX12" fmla="*/ 1202267 w 1617133"/>
              <a:gd name="connsiteY12" fmla="*/ 1146572 h 1538694"/>
              <a:gd name="connsiteX13" fmla="*/ 1253067 w 1617133"/>
              <a:gd name="connsiteY13" fmla="*/ 1425972 h 1538694"/>
              <a:gd name="connsiteX14" fmla="*/ 1286933 w 1617133"/>
              <a:gd name="connsiteY14" fmla="*/ 1527572 h 1538694"/>
              <a:gd name="connsiteX15" fmla="*/ 1422400 w 1617133"/>
              <a:gd name="connsiteY15" fmla="*/ 1536039 h 1538694"/>
              <a:gd name="connsiteX16" fmla="*/ 1617133 w 1617133"/>
              <a:gd name="connsiteY16" fmla="*/ 1527572 h 1538694"/>
              <a:gd name="connsiteX17" fmla="*/ 1617133 w 1617133"/>
              <a:gd name="connsiteY17" fmla="*/ 1527572 h 1538694"/>
              <a:gd name="connsiteX18" fmla="*/ 1617133 w 1617133"/>
              <a:gd name="connsiteY18" fmla="*/ 1527572 h 1538694"/>
              <a:gd name="connsiteX0" fmla="*/ 0 w 1617133"/>
              <a:gd name="connsiteY0" fmla="*/ 1512257 h 1540312"/>
              <a:gd name="connsiteX1" fmla="*/ 133351 w 1617133"/>
              <a:gd name="connsiteY1" fmla="*/ 1482624 h 1540312"/>
              <a:gd name="connsiteX2" fmla="*/ 237067 w 1617133"/>
              <a:gd name="connsiteY2" fmla="*/ 1436057 h 1540312"/>
              <a:gd name="connsiteX3" fmla="*/ 347133 w 1617133"/>
              <a:gd name="connsiteY3" fmla="*/ 1266723 h 1540312"/>
              <a:gd name="connsiteX4" fmla="*/ 508000 w 1617133"/>
              <a:gd name="connsiteY4" fmla="*/ 648657 h 1540312"/>
              <a:gd name="connsiteX5" fmla="*/ 563033 w 1617133"/>
              <a:gd name="connsiteY5" fmla="*/ 458157 h 1540312"/>
              <a:gd name="connsiteX6" fmla="*/ 609600 w 1617133"/>
              <a:gd name="connsiteY6" fmla="*/ 267657 h 1540312"/>
              <a:gd name="connsiteX7" fmla="*/ 651932 w 1617133"/>
              <a:gd name="connsiteY7" fmla="*/ 127956 h 1540312"/>
              <a:gd name="connsiteX8" fmla="*/ 751417 w 1617133"/>
              <a:gd name="connsiteY8" fmla="*/ 15774 h 1540312"/>
              <a:gd name="connsiteX9" fmla="*/ 895351 w 1617133"/>
              <a:gd name="connsiteY9" fmla="*/ 17890 h 1540312"/>
              <a:gd name="connsiteX10" fmla="*/ 965200 w 1617133"/>
              <a:gd name="connsiteY10" fmla="*/ 149123 h 1540312"/>
              <a:gd name="connsiteX11" fmla="*/ 1016000 w 1617133"/>
              <a:gd name="connsiteY11" fmla="*/ 386190 h 1540312"/>
              <a:gd name="connsiteX12" fmla="*/ 1202267 w 1617133"/>
              <a:gd name="connsiteY12" fmla="*/ 1148190 h 1540312"/>
              <a:gd name="connsiteX13" fmla="*/ 1253067 w 1617133"/>
              <a:gd name="connsiteY13" fmla="*/ 1427590 h 1540312"/>
              <a:gd name="connsiteX14" fmla="*/ 1286933 w 1617133"/>
              <a:gd name="connsiteY14" fmla="*/ 1529190 h 1540312"/>
              <a:gd name="connsiteX15" fmla="*/ 1422400 w 1617133"/>
              <a:gd name="connsiteY15" fmla="*/ 1537657 h 1540312"/>
              <a:gd name="connsiteX16" fmla="*/ 1617133 w 1617133"/>
              <a:gd name="connsiteY16" fmla="*/ 1529190 h 1540312"/>
              <a:gd name="connsiteX17" fmla="*/ 1617133 w 1617133"/>
              <a:gd name="connsiteY17" fmla="*/ 1529190 h 1540312"/>
              <a:gd name="connsiteX18" fmla="*/ 1617133 w 1617133"/>
              <a:gd name="connsiteY18" fmla="*/ 1529190 h 1540312"/>
              <a:gd name="connsiteX0" fmla="*/ 0 w 1617133"/>
              <a:gd name="connsiteY0" fmla="*/ 1502989 h 1531044"/>
              <a:gd name="connsiteX1" fmla="*/ 133351 w 1617133"/>
              <a:gd name="connsiteY1" fmla="*/ 1473356 h 1531044"/>
              <a:gd name="connsiteX2" fmla="*/ 237067 w 1617133"/>
              <a:gd name="connsiteY2" fmla="*/ 1426789 h 1531044"/>
              <a:gd name="connsiteX3" fmla="*/ 347133 w 1617133"/>
              <a:gd name="connsiteY3" fmla="*/ 1257455 h 1531044"/>
              <a:gd name="connsiteX4" fmla="*/ 508000 w 1617133"/>
              <a:gd name="connsiteY4" fmla="*/ 639389 h 1531044"/>
              <a:gd name="connsiteX5" fmla="*/ 563033 w 1617133"/>
              <a:gd name="connsiteY5" fmla="*/ 448889 h 1531044"/>
              <a:gd name="connsiteX6" fmla="*/ 609600 w 1617133"/>
              <a:gd name="connsiteY6" fmla="*/ 258389 h 1531044"/>
              <a:gd name="connsiteX7" fmla="*/ 651932 w 1617133"/>
              <a:gd name="connsiteY7" fmla="*/ 118688 h 1531044"/>
              <a:gd name="connsiteX8" fmla="*/ 751417 w 1617133"/>
              <a:gd name="connsiteY8" fmla="*/ 6506 h 1531044"/>
              <a:gd name="connsiteX9" fmla="*/ 889001 w 1617133"/>
              <a:gd name="connsiteY9" fmla="*/ 29789 h 1531044"/>
              <a:gd name="connsiteX10" fmla="*/ 965200 w 1617133"/>
              <a:gd name="connsiteY10" fmla="*/ 139855 h 1531044"/>
              <a:gd name="connsiteX11" fmla="*/ 1016000 w 1617133"/>
              <a:gd name="connsiteY11" fmla="*/ 376922 h 1531044"/>
              <a:gd name="connsiteX12" fmla="*/ 1202267 w 1617133"/>
              <a:gd name="connsiteY12" fmla="*/ 1138922 h 1531044"/>
              <a:gd name="connsiteX13" fmla="*/ 1253067 w 1617133"/>
              <a:gd name="connsiteY13" fmla="*/ 1418322 h 1531044"/>
              <a:gd name="connsiteX14" fmla="*/ 1286933 w 1617133"/>
              <a:gd name="connsiteY14" fmla="*/ 1519922 h 1531044"/>
              <a:gd name="connsiteX15" fmla="*/ 1422400 w 1617133"/>
              <a:gd name="connsiteY15" fmla="*/ 1528389 h 1531044"/>
              <a:gd name="connsiteX16" fmla="*/ 1617133 w 1617133"/>
              <a:gd name="connsiteY16" fmla="*/ 1519922 h 1531044"/>
              <a:gd name="connsiteX17" fmla="*/ 1617133 w 1617133"/>
              <a:gd name="connsiteY17" fmla="*/ 1519922 h 1531044"/>
              <a:gd name="connsiteX18" fmla="*/ 1617133 w 1617133"/>
              <a:gd name="connsiteY18" fmla="*/ 1519922 h 1531044"/>
              <a:gd name="connsiteX0" fmla="*/ 0 w 1617133"/>
              <a:gd name="connsiteY0" fmla="*/ 1483612 h 1511667"/>
              <a:gd name="connsiteX1" fmla="*/ 133351 w 1617133"/>
              <a:gd name="connsiteY1" fmla="*/ 1453979 h 1511667"/>
              <a:gd name="connsiteX2" fmla="*/ 237067 w 1617133"/>
              <a:gd name="connsiteY2" fmla="*/ 1407412 h 1511667"/>
              <a:gd name="connsiteX3" fmla="*/ 347133 w 1617133"/>
              <a:gd name="connsiteY3" fmla="*/ 1238078 h 1511667"/>
              <a:gd name="connsiteX4" fmla="*/ 508000 w 1617133"/>
              <a:gd name="connsiteY4" fmla="*/ 620012 h 1511667"/>
              <a:gd name="connsiteX5" fmla="*/ 563033 w 1617133"/>
              <a:gd name="connsiteY5" fmla="*/ 429512 h 1511667"/>
              <a:gd name="connsiteX6" fmla="*/ 609600 w 1617133"/>
              <a:gd name="connsiteY6" fmla="*/ 239012 h 1511667"/>
              <a:gd name="connsiteX7" fmla="*/ 651932 w 1617133"/>
              <a:gd name="connsiteY7" fmla="*/ 99311 h 1511667"/>
              <a:gd name="connsiteX8" fmla="*/ 713317 w 1617133"/>
              <a:gd name="connsiteY8" fmla="*/ 14645 h 1511667"/>
              <a:gd name="connsiteX9" fmla="*/ 889001 w 1617133"/>
              <a:gd name="connsiteY9" fmla="*/ 10412 h 1511667"/>
              <a:gd name="connsiteX10" fmla="*/ 965200 w 1617133"/>
              <a:gd name="connsiteY10" fmla="*/ 120478 h 1511667"/>
              <a:gd name="connsiteX11" fmla="*/ 1016000 w 1617133"/>
              <a:gd name="connsiteY11" fmla="*/ 357545 h 1511667"/>
              <a:gd name="connsiteX12" fmla="*/ 1202267 w 1617133"/>
              <a:gd name="connsiteY12" fmla="*/ 1119545 h 1511667"/>
              <a:gd name="connsiteX13" fmla="*/ 1253067 w 1617133"/>
              <a:gd name="connsiteY13" fmla="*/ 1398945 h 1511667"/>
              <a:gd name="connsiteX14" fmla="*/ 1286933 w 1617133"/>
              <a:gd name="connsiteY14" fmla="*/ 1500545 h 1511667"/>
              <a:gd name="connsiteX15" fmla="*/ 1422400 w 1617133"/>
              <a:gd name="connsiteY15" fmla="*/ 1509012 h 1511667"/>
              <a:gd name="connsiteX16" fmla="*/ 1617133 w 1617133"/>
              <a:gd name="connsiteY16" fmla="*/ 1500545 h 1511667"/>
              <a:gd name="connsiteX17" fmla="*/ 1617133 w 1617133"/>
              <a:gd name="connsiteY17" fmla="*/ 1500545 h 1511667"/>
              <a:gd name="connsiteX18" fmla="*/ 1617133 w 1617133"/>
              <a:gd name="connsiteY18" fmla="*/ 1500545 h 1511667"/>
              <a:gd name="connsiteX0" fmla="*/ 0 w 1617133"/>
              <a:gd name="connsiteY0" fmla="*/ 1499521 h 1527576"/>
              <a:gd name="connsiteX1" fmla="*/ 133351 w 1617133"/>
              <a:gd name="connsiteY1" fmla="*/ 1469888 h 1527576"/>
              <a:gd name="connsiteX2" fmla="*/ 237067 w 1617133"/>
              <a:gd name="connsiteY2" fmla="*/ 1423321 h 1527576"/>
              <a:gd name="connsiteX3" fmla="*/ 347133 w 1617133"/>
              <a:gd name="connsiteY3" fmla="*/ 1253987 h 1527576"/>
              <a:gd name="connsiteX4" fmla="*/ 508000 w 1617133"/>
              <a:gd name="connsiteY4" fmla="*/ 635921 h 1527576"/>
              <a:gd name="connsiteX5" fmla="*/ 563033 w 1617133"/>
              <a:gd name="connsiteY5" fmla="*/ 445421 h 1527576"/>
              <a:gd name="connsiteX6" fmla="*/ 609600 w 1617133"/>
              <a:gd name="connsiteY6" fmla="*/ 254921 h 1527576"/>
              <a:gd name="connsiteX7" fmla="*/ 651932 w 1617133"/>
              <a:gd name="connsiteY7" fmla="*/ 115220 h 1527576"/>
              <a:gd name="connsiteX8" fmla="*/ 713317 w 1617133"/>
              <a:gd name="connsiteY8" fmla="*/ 30554 h 1527576"/>
              <a:gd name="connsiteX9" fmla="*/ 794918 w 1617133"/>
              <a:gd name="connsiteY9" fmla="*/ 71 h 1527576"/>
              <a:gd name="connsiteX10" fmla="*/ 889001 w 1617133"/>
              <a:gd name="connsiteY10" fmla="*/ 26321 h 1527576"/>
              <a:gd name="connsiteX11" fmla="*/ 965200 w 1617133"/>
              <a:gd name="connsiteY11" fmla="*/ 136387 h 1527576"/>
              <a:gd name="connsiteX12" fmla="*/ 1016000 w 1617133"/>
              <a:gd name="connsiteY12" fmla="*/ 373454 h 1527576"/>
              <a:gd name="connsiteX13" fmla="*/ 1202267 w 1617133"/>
              <a:gd name="connsiteY13" fmla="*/ 1135454 h 1527576"/>
              <a:gd name="connsiteX14" fmla="*/ 1253067 w 1617133"/>
              <a:gd name="connsiteY14" fmla="*/ 1414854 h 1527576"/>
              <a:gd name="connsiteX15" fmla="*/ 1286933 w 1617133"/>
              <a:gd name="connsiteY15" fmla="*/ 1516454 h 1527576"/>
              <a:gd name="connsiteX16" fmla="*/ 1422400 w 1617133"/>
              <a:gd name="connsiteY16" fmla="*/ 1524921 h 1527576"/>
              <a:gd name="connsiteX17" fmla="*/ 1617133 w 1617133"/>
              <a:gd name="connsiteY17" fmla="*/ 1516454 h 1527576"/>
              <a:gd name="connsiteX18" fmla="*/ 1617133 w 1617133"/>
              <a:gd name="connsiteY18" fmla="*/ 1516454 h 1527576"/>
              <a:gd name="connsiteX19" fmla="*/ 1617133 w 1617133"/>
              <a:gd name="connsiteY19" fmla="*/ 1516454 h 1527576"/>
              <a:gd name="connsiteX0" fmla="*/ 0 w 1617133"/>
              <a:gd name="connsiteY0" fmla="*/ 1499521 h 1527576"/>
              <a:gd name="connsiteX1" fmla="*/ 133351 w 1617133"/>
              <a:gd name="connsiteY1" fmla="*/ 1469888 h 1527576"/>
              <a:gd name="connsiteX2" fmla="*/ 237067 w 1617133"/>
              <a:gd name="connsiteY2" fmla="*/ 1423321 h 1527576"/>
              <a:gd name="connsiteX3" fmla="*/ 347133 w 1617133"/>
              <a:gd name="connsiteY3" fmla="*/ 1253987 h 1527576"/>
              <a:gd name="connsiteX4" fmla="*/ 508000 w 1617133"/>
              <a:gd name="connsiteY4" fmla="*/ 635921 h 1527576"/>
              <a:gd name="connsiteX5" fmla="*/ 563033 w 1617133"/>
              <a:gd name="connsiteY5" fmla="*/ 445421 h 1527576"/>
              <a:gd name="connsiteX6" fmla="*/ 609600 w 1617133"/>
              <a:gd name="connsiteY6" fmla="*/ 254921 h 1527576"/>
              <a:gd name="connsiteX7" fmla="*/ 658282 w 1617133"/>
              <a:gd name="connsiteY7" fmla="*/ 115220 h 1527576"/>
              <a:gd name="connsiteX8" fmla="*/ 713317 w 1617133"/>
              <a:gd name="connsiteY8" fmla="*/ 30554 h 1527576"/>
              <a:gd name="connsiteX9" fmla="*/ 794918 w 1617133"/>
              <a:gd name="connsiteY9" fmla="*/ 71 h 1527576"/>
              <a:gd name="connsiteX10" fmla="*/ 889001 w 1617133"/>
              <a:gd name="connsiteY10" fmla="*/ 26321 h 1527576"/>
              <a:gd name="connsiteX11" fmla="*/ 965200 w 1617133"/>
              <a:gd name="connsiteY11" fmla="*/ 136387 h 1527576"/>
              <a:gd name="connsiteX12" fmla="*/ 1016000 w 1617133"/>
              <a:gd name="connsiteY12" fmla="*/ 373454 h 1527576"/>
              <a:gd name="connsiteX13" fmla="*/ 1202267 w 1617133"/>
              <a:gd name="connsiteY13" fmla="*/ 1135454 h 1527576"/>
              <a:gd name="connsiteX14" fmla="*/ 1253067 w 1617133"/>
              <a:gd name="connsiteY14" fmla="*/ 1414854 h 1527576"/>
              <a:gd name="connsiteX15" fmla="*/ 1286933 w 1617133"/>
              <a:gd name="connsiteY15" fmla="*/ 1516454 h 1527576"/>
              <a:gd name="connsiteX16" fmla="*/ 1422400 w 1617133"/>
              <a:gd name="connsiteY16" fmla="*/ 1524921 h 1527576"/>
              <a:gd name="connsiteX17" fmla="*/ 1617133 w 1617133"/>
              <a:gd name="connsiteY17" fmla="*/ 1516454 h 1527576"/>
              <a:gd name="connsiteX18" fmla="*/ 1617133 w 1617133"/>
              <a:gd name="connsiteY18" fmla="*/ 1516454 h 1527576"/>
              <a:gd name="connsiteX19" fmla="*/ 1617133 w 1617133"/>
              <a:gd name="connsiteY19" fmla="*/ 1516454 h 1527576"/>
              <a:gd name="connsiteX0" fmla="*/ 0 w 1617133"/>
              <a:gd name="connsiteY0" fmla="*/ 1499521 h 1527576"/>
              <a:gd name="connsiteX1" fmla="*/ 133351 w 1617133"/>
              <a:gd name="connsiteY1" fmla="*/ 1469888 h 1527576"/>
              <a:gd name="connsiteX2" fmla="*/ 237067 w 1617133"/>
              <a:gd name="connsiteY2" fmla="*/ 1423321 h 1527576"/>
              <a:gd name="connsiteX3" fmla="*/ 347133 w 1617133"/>
              <a:gd name="connsiteY3" fmla="*/ 1253987 h 1527576"/>
              <a:gd name="connsiteX4" fmla="*/ 508000 w 1617133"/>
              <a:gd name="connsiteY4" fmla="*/ 635921 h 1527576"/>
              <a:gd name="connsiteX5" fmla="*/ 563033 w 1617133"/>
              <a:gd name="connsiteY5" fmla="*/ 445421 h 1527576"/>
              <a:gd name="connsiteX6" fmla="*/ 609600 w 1617133"/>
              <a:gd name="connsiteY6" fmla="*/ 254921 h 1527576"/>
              <a:gd name="connsiteX7" fmla="*/ 658282 w 1617133"/>
              <a:gd name="connsiteY7" fmla="*/ 115220 h 1527576"/>
              <a:gd name="connsiteX8" fmla="*/ 723901 w 1617133"/>
              <a:gd name="connsiteY8" fmla="*/ 30554 h 1527576"/>
              <a:gd name="connsiteX9" fmla="*/ 794918 w 1617133"/>
              <a:gd name="connsiteY9" fmla="*/ 71 h 1527576"/>
              <a:gd name="connsiteX10" fmla="*/ 889001 w 1617133"/>
              <a:gd name="connsiteY10" fmla="*/ 26321 h 1527576"/>
              <a:gd name="connsiteX11" fmla="*/ 965200 w 1617133"/>
              <a:gd name="connsiteY11" fmla="*/ 136387 h 1527576"/>
              <a:gd name="connsiteX12" fmla="*/ 1016000 w 1617133"/>
              <a:gd name="connsiteY12" fmla="*/ 373454 h 1527576"/>
              <a:gd name="connsiteX13" fmla="*/ 1202267 w 1617133"/>
              <a:gd name="connsiteY13" fmla="*/ 1135454 h 1527576"/>
              <a:gd name="connsiteX14" fmla="*/ 1253067 w 1617133"/>
              <a:gd name="connsiteY14" fmla="*/ 1414854 h 1527576"/>
              <a:gd name="connsiteX15" fmla="*/ 1286933 w 1617133"/>
              <a:gd name="connsiteY15" fmla="*/ 1516454 h 1527576"/>
              <a:gd name="connsiteX16" fmla="*/ 1422400 w 1617133"/>
              <a:gd name="connsiteY16" fmla="*/ 1524921 h 1527576"/>
              <a:gd name="connsiteX17" fmla="*/ 1617133 w 1617133"/>
              <a:gd name="connsiteY17" fmla="*/ 1516454 h 1527576"/>
              <a:gd name="connsiteX18" fmla="*/ 1617133 w 1617133"/>
              <a:gd name="connsiteY18" fmla="*/ 1516454 h 1527576"/>
              <a:gd name="connsiteX19" fmla="*/ 1617133 w 1617133"/>
              <a:gd name="connsiteY19" fmla="*/ 1516454 h 1527576"/>
              <a:gd name="connsiteX0" fmla="*/ 0 w 1617133"/>
              <a:gd name="connsiteY0" fmla="*/ 1499468 h 1527523"/>
              <a:gd name="connsiteX1" fmla="*/ 133351 w 1617133"/>
              <a:gd name="connsiteY1" fmla="*/ 1469835 h 1527523"/>
              <a:gd name="connsiteX2" fmla="*/ 237067 w 1617133"/>
              <a:gd name="connsiteY2" fmla="*/ 1423268 h 1527523"/>
              <a:gd name="connsiteX3" fmla="*/ 347133 w 1617133"/>
              <a:gd name="connsiteY3" fmla="*/ 1253934 h 1527523"/>
              <a:gd name="connsiteX4" fmla="*/ 508000 w 1617133"/>
              <a:gd name="connsiteY4" fmla="*/ 635868 h 1527523"/>
              <a:gd name="connsiteX5" fmla="*/ 563033 w 1617133"/>
              <a:gd name="connsiteY5" fmla="*/ 445368 h 1527523"/>
              <a:gd name="connsiteX6" fmla="*/ 609600 w 1617133"/>
              <a:gd name="connsiteY6" fmla="*/ 254868 h 1527523"/>
              <a:gd name="connsiteX7" fmla="*/ 658282 w 1617133"/>
              <a:gd name="connsiteY7" fmla="*/ 115167 h 1527523"/>
              <a:gd name="connsiteX8" fmla="*/ 723901 w 1617133"/>
              <a:gd name="connsiteY8" fmla="*/ 30501 h 1527523"/>
              <a:gd name="connsiteX9" fmla="*/ 794918 w 1617133"/>
              <a:gd name="connsiteY9" fmla="*/ 18 h 1527523"/>
              <a:gd name="connsiteX10" fmla="*/ 886884 w 1617133"/>
              <a:gd name="connsiteY10" fmla="*/ 43201 h 1527523"/>
              <a:gd name="connsiteX11" fmla="*/ 965200 w 1617133"/>
              <a:gd name="connsiteY11" fmla="*/ 136334 h 1527523"/>
              <a:gd name="connsiteX12" fmla="*/ 1016000 w 1617133"/>
              <a:gd name="connsiteY12" fmla="*/ 373401 h 1527523"/>
              <a:gd name="connsiteX13" fmla="*/ 1202267 w 1617133"/>
              <a:gd name="connsiteY13" fmla="*/ 1135401 h 1527523"/>
              <a:gd name="connsiteX14" fmla="*/ 1253067 w 1617133"/>
              <a:gd name="connsiteY14" fmla="*/ 1414801 h 1527523"/>
              <a:gd name="connsiteX15" fmla="*/ 1286933 w 1617133"/>
              <a:gd name="connsiteY15" fmla="*/ 1516401 h 1527523"/>
              <a:gd name="connsiteX16" fmla="*/ 1422400 w 1617133"/>
              <a:gd name="connsiteY16" fmla="*/ 1524868 h 1527523"/>
              <a:gd name="connsiteX17" fmla="*/ 1617133 w 1617133"/>
              <a:gd name="connsiteY17" fmla="*/ 1516401 h 1527523"/>
              <a:gd name="connsiteX18" fmla="*/ 1617133 w 1617133"/>
              <a:gd name="connsiteY18" fmla="*/ 1516401 h 1527523"/>
              <a:gd name="connsiteX19" fmla="*/ 1617133 w 1617133"/>
              <a:gd name="connsiteY19" fmla="*/ 1516401 h 1527523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09600 w 1617133"/>
              <a:gd name="connsiteY6" fmla="*/ 254873 h 1527528"/>
              <a:gd name="connsiteX7" fmla="*/ 658282 w 1617133"/>
              <a:gd name="connsiteY7" fmla="*/ 115172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09600 w 1617133"/>
              <a:gd name="connsiteY6" fmla="*/ 254873 h 1527528"/>
              <a:gd name="connsiteX7" fmla="*/ 666748 w 1617133"/>
              <a:gd name="connsiteY7" fmla="*/ 123639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09600 w 1617133"/>
              <a:gd name="connsiteY6" fmla="*/ 254873 h 1527528"/>
              <a:gd name="connsiteX7" fmla="*/ 666748 w 1617133"/>
              <a:gd name="connsiteY7" fmla="*/ 123639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15950 w 1617133"/>
              <a:gd name="connsiteY6" fmla="*/ 263340 h 1527528"/>
              <a:gd name="connsiteX7" fmla="*/ 666748 w 1617133"/>
              <a:gd name="connsiteY7" fmla="*/ 123639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73410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73410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73410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94577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4617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805502 w 1617133"/>
              <a:gd name="connsiteY9" fmla="*/ 27 h 1527532"/>
              <a:gd name="connsiteX10" fmla="*/ 886884 w 1617133"/>
              <a:gd name="connsiteY10" fmla="*/ 43210 h 1527532"/>
              <a:gd name="connsiteX11" fmla="*/ 954617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4877"/>
              <a:gd name="connsiteX1" fmla="*/ 133351 w 1617133"/>
              <a:gd name="connsiteY1" fmla="*/ 1469844 h 1524877"/>
              <a:gd name="connsiteX2" fmla="*/ 237067 w 1617133"/>
              <a:gd name="connsiteY2" fmla="*/ 1423277 h 1524877"/>
              <a:gd name="connsiteX3" fmla="*/ 347133 w 1617133"/>
              <a:gd name="connsiteY3" fmla="*/ 1253943 h 1524877"/>
              <a:gd name="connsiteX4" fmla="*/ 508000 w 1617133"/>
              <a:gd name="connsiteY4" fmla="*/ 635877 h 1524877"/>
              <a:gd name="connsiteX5" fmla="*/ 563033 w 1617133"/>
              <a:gd name="connsiteY5" fmla="*/ 445377 h 1524877"/>
              <a:gd name="connsiteX6" fmla="*/ 615950 w 1617133"/>
              <a:gd name="connsiteY6" fmla="*/ 263344 h 1524877"/>
              <a:gd name="connsiteX7" fmla="*/ 666748 w 1617133"/>
              <a:gd name="connsiteY7" fmla="*/ 123643 h 1524877"/>
              <a:gd name="connsiteX8" fmla="*/ 723901 w 1617133"/>
              <a:gd name="connsiteY8" fmla="*/ 30510 h 1524877"/>
              <a:gd name="connsiteX9" fmla="*/ 805502 w 1617133"/>
              <a:gd name="connsiteY9" fmla="*/ 27 h 1524877"/>
              <a:gd name="connsiteX10" fmla="*/ 886884 w 1617133"/>
              <a:gd name="connsiteY10" fmla="*/ 43210 h 1524877"/>
              <a:gd name="connsiteX11" fmla="*/ 954617 w 1617133"/>
              <a:gd name="connsiteY11" fmla="*/ 185026 h 1524877"/>
              <a:gd name="connsiteX12" fmla="*/ 1016000 w 1617133"/>
              <a:gd name="connsiteY12" fmla="*/ 394577 h 1524877"/>
              <a:gd name="connsiteX13" fmla="*/ 1187451 w 1617133"/>
              <a:gd name="connsiteY13" fmla="*/ 1141760 h 1524877"/>
              <a:gd name="connsiteX14" fmla="*/ 1253067 w 1617133"/>
              <a:gd name="connsiteY14" fmla="*/ 1414810 h 1524877"/>
              <a:gd name="connsiteX15" fmla="*/ 1295400 w 1617133"/>
              <a:gd name="connsiteY15" fmla="*/ 1503710 h 1524877"/>
              <a:gd name="connsiteX16" fmla="*/ 1422400 w 1617133"/>
              <a:gd name="connsiteY16" fmla="*/ 1524877 h 1524877"/>
              <a:gd name="connsiteX17" fmla="*/ 1617133 w 1617133"/>
              <a:gd name="connsiteY17" fmla="*/ 1516410 h 1524877"/>
              <a:gd name="connsiteX18" fmla="*/ 1617133 w 1617133"/>
              <a:gd name="connsiteY18" fmla="*/ 1516410 h 1524877"/>
              <a:gd name="connsiteX19" fmla="*/ 1617133 w 1617133"/>
              <a:gd name="connsiteY19" fmla="*/ 1516410 h 1524877"/>
              <a:gd name="connsiteX0" fmla="*/ 0 w 1617133"/>
              <a:gd name="connsiteY0" fmla="*/ 1499477 h 1524877"/>
              <a:gd name="connsiteX1" fmla="*/ 133351 w 1617133"/>
              <a:gd name="connsiteY1" fmla="*/ 1469844 h 1524877"/>
              <a:gd name="connsiteX2" fmla="*/ 237067 w 1617133"/>
              <a:gd name="connsiteY2" fmla="*/ 1423277 h 1524877"/>
              <a:gd name="connsiteX3" fmla="*/ 347133 w 1617133"/>
              <a:gd name="connsiteY3" fmla="*/ 1253943 h 1524877"/>
              <a:gd name="connsiteX4" fmla="*/ 508000 w 1617133"/>
              <a:gd name="connsiteY4" fmla="*/ 635877 h 1524877"/>
              <a:gd name="connsiteX5" fmla="*/ 563033 w 1617133"/>
              <a:gd name="connsiteY5" fmla="*/ 445377 h 1524877"/>
              <a:gd name="connsiteX6" fmla="*/ 615950 w 1617133"/>
              <a:gd name="connsiteY6" fmla="*/ 263344 h 1524877"/>
              <a:gd name="connsiteX7" fmla="*/ 666748 w 1617133"/>
              <a:gd name="connsiteY7" fmla="*/ 123643 h 1524877"/>
              <a:gd name="connsiteX8" fmla="*/ 723901 w 1617133"/>
              <a:gd name="connsiteY8" fmla="*/ 30510 h 1524877"/>
              <a:gd name="connsiteX9" fmla="*/ 805502 w 1617133"/>
              <a:gd name="connsiteY9" fmla="*/ 27 h 1524877"/>
              <a:gd name="connsiteX10" fmla="*/ 886884 w 1617133"/>
              <a:gd name="connsiteY10" fmla="*/ 43210 h 1524877"/>
              <a:gd name="connsiteX11" fmla="*/ 954617 w 1617133"/>
              <a:gd name="connsiteY11" fmla="*/ 185026 h 1524877"/>
              <a:gd name="connsiteX12" fmla="*/ 1016000 w 1617133"/>
              <a:gd name="connsiteY12" fmla="*/ 394577 h 1524877"/>
              <a:gd name="connsiteX13" fmla="*/ 1187451 w 1617133"/>
              <a:gd name="connsiteY13" fmla="*/ 1141760 h 1524877"/>
              <a:gd name="connsiteX14" fmla="*/ 1253067 w 1617133"/>
              <a:gd name="connsiteY14" fmla="*/ 1414810 h 1524877"/>
              <a:gd name="connsiteX15" fmla="*/ 1295400 w 1617133"/>
              <a:gd name="connsiteY15" fmla="*/ 1503710 h 1524877"/>
              <a:gd name="connsiteX16" fmla="*/ 1422400 w 1617133"/>
              <a:gd name="connsiteY16" fmla="*/ 1524877 h 1524877"/>
              <a:gd name="connsiteX17" fmla="*/ 1617133 w 1617133"/>
              <a:gd name="connsiteY17" fmla="*/ 1516410 h 1524877"/>
              <a:gd name="connsiteX18" fmla="*/ 1617133 w 1617133"/>
              <a:gd name="connsiteY18" fmla="*/ 1516410 h 1524877"/>
              <a:gd name="connsiteX19" fmla="*/ 1617133 w 1617133"/>
              <a:gd name="connsiteY19" fmla="*/ 1516410 h 1524877"/>
              <a:gd name="connsiteX0" fmla="*/ 0 w 1617133"/>
              <a:gd name="connsiteY0" fmla="*/ 1499477 h 1524877"/>
              <a:gd name="connsiteX1" fmla="*/ 133351 w 1617133"/>
              <a:gd name="connsiteY1" fmla="*/ 1469844 h 1524877"/>
              <a:gd name="connsiteX2" fmla="*/ 237067 w 1617133"/>
              <a:gd name="connsiteY2" fmla="*/ 1423277 h 1524877"/>
              <a:gd name="connsiteX3" fmla="*/ 347133 w 1617133"/>
              <a:gd name="connsiteY3" fmla="*/ 1253943 h 1524877"/>
              <a:gd name="connsiteX4" fmla="*/ 508000 w 1617133"/>
              <a:gd name="connsiteY4" fmla="*/ 635877 h 1524877"/>
              <a:gd name="connsiteX5" fmla="*/ 563033 w 1617133"/>
              <a:gd name="connsiteY5" fmla="*/ 445377 h 1524877"/>
              <a:gd name="connsiteX6" fmla="*/ 615950 w 1617133"/>
              <a:gd name="connsiteY6" fmla="*/ 263344 h 1524877"/>
              <a:gd name="connsiteX7" fmla="*/ 666748 w 1617133"/>
              <a:gd name="connsiteY7" fmla="*/ 123643 h 1524877"/>
              <a:gd name="connsiteX8" fmla="*/ 723901 w 1617133"/>
              <a:gd name="connsiteY8" fmla="*/ 30510 h 1524877"/>
              <a:gd name="connsiteX9" fmla="*/ 805502 w 1617133"/>
              <a:gd name="connsiteY9" fmla="*/ 27 h 1524877"/>
              <a:gd name="connsiteX10" fmla="*/ 886884 w 1617133"/>
              <a:gd name="connsiteY10" fmla="*/ 43210 h 1524877"/>
              <a:gd name="connsiteX11" fmla="*/ 954617 w 1617133"/>
              <a:gd name="connsiteY11" fmla="*/ 185026 h 1524877"/>
              <a:gd name="connsiteX12" fmla="*/ 1016000 w 1617133"/>
              <a:gd name="connsiteY12" fmla="*/ 394577 h 1524877"/>
              <a:gd name="connsiteX13" fmla="*/ 1187451 w 1617133"/>
              <a:gd name="connsiteY13" fmla="*/ 1141760 h 1524877"/>
              <a:gd name="connsiteX14" fmla="*/ 1253067 w 1617133"/>
              <a:gd name="connsiteY14" fmla="*/ 1414810 h 1524877"/>
              <a:gd name="connsiteX15" fmla="*/ 1295400 w 1617133"/>
              <a:gd name="connsiteY15" fmla="*/ 1503710 h 1524877"/>
              <a:gd name="connsiteX16" fmla="*/ 1422400 w 1617133"/>
              <a:gd name="connsiteY16" fmla="*/ 1524877 h 1524877"/>
              <a:gd name="connsiteX17" fmla="*/ 1617133 w 1617133"/>
              <a:gd name="connsiteY17" fmla="*/ 1516410 h 1524877"/>
              <a:gd name="connsiteX18" fmla="*/ 1617133 w 1617133"/>
              <a:gd name="connsiteY18" fmla="*/ 1516410 h 1524877"/>
              <a:gd name="connsiteX19" fmla="*/ 1617133 w 1617133"/>
              <a:gd name="connsiteY19" fmla="*/ 1516410 h 1524877"/>
              <a:gd name="connsiteX0" fmla="*/ 0 w 1617133"/>
              <a:gd name="connsiteY0" fmla="*/ 1499477 h 1524884"/>
              <a:gd name="connsiteX1" fmla="*/ 133351 w 1617133"/>
              <a:gd name="connsiteY1" fmla="*/ 1469844 h 1524884"/>
              <a:gd name="connsiteX2" fmla="*/ 237067 w 1617133"/>
              <a:gd name="connsiteY2" fmla="*/ 1423277 h 1524884"/>
              <a:gd name="connsiteX3" fmla="*/ 347133 w 1617133"/>
              <a:gd name="connsiteY3" fmla="*/ 1253943 h 1524884"/>
              <a:gd name="connsiteX4" fmla="*/ 508000 w 1617133"/>
              <a:gd name="connsiteY4" fmla="*/ 635877 h 1524884"/>
              <a:gd name="connsiteX5" fmla="*/ 563033 w 1617133"/>
              <a:gd name="connsiteY5" fmla="*/ 445377 h 1524884"/>
              <a:gd name="connsiteX6" fmla="*/ 615950 w 1617133"/>
              <a:gd name="connsiteY6" fmla="*/ 263344 h 1524884"/>
              <a:gd name="connsiteX7" fmla="*/ 666748 w 1617133"/>
              <a:gd name="connsiteY7" fmla="*/ 123643 h 1524884"/>
              <a:gd name="connsiteX8" fmla="*/ 723901 w 1617133"/>
              <a:gd name="connsiteY8" fmla="*/ 30510 h 1524884"/>
              <a:gd name="connsiteX9" fmla="*/ 805502 w 1617133"/>
              <a:gd name="connsiteY9" fmla="*/ 27 h 1524884"/>
              <a:gd name="connsiteX10" fmla="*/ 886884 w 1617133"/>
              <a:gd name="connsiteY10" fmla="*/ 43210 h 1524884"/>
              <a:gd name="connsiteX11" fmla="*/ 954617 w 1617133"/>
              <a:gd name="connsiteY11" fmla="*/ 185026 h 1524884"/>
              <a:gd name="connsiteX12" fmla="*/ 1016000 w 1617133"/>
              <a:gd name="connsiteY12" fmla="*/ 394577 h 1524884"/>
              <a:gd name="connsiteX13" fmla="*/ 1187451 w 1617133"/>
              <a:gd name="connsiteY13" fmla="*/ 1141760 h 1524884"/>
              <a:gd name="connsiteX14" fmla="*/ 1253067 w 1617133"/>
              <a:gd name="connsiteY14" fmla="*/ 1414810 h 1524884"/>
              <a:gd name="connsiteX15" fmla="*/ 1295400 w 1617133"/>
              <a:gd name="connsiteY15" fmla="*/ 1503710 h 1524884"/>
              <a:gd name="connsiteX16" fmla="*/ 1422400 w 1617133"/>
              <a:gd name="connsiteY16" fmla="*/ 1524877 h 1524884"/>
              <a:gd name="connsiteX17" fmla="*/ 1617133 w 1617133"/>
              <a:gd name="connsiteY17" fmla="*/ 1516410 h 1524884"/>
              <a:gd name="connsiteX18" fmla="*/ 1617133 w 1617133"/>
              <a:gd name="connsiteY18" fmla="*/ 1516410 h 1524884"/>
              <a:gd name="connsiteX19" fmla="*/ 1617133 w 1617133"/>
              <a:gd name="connsiteY19" fmla="*/ 1516410 h 1524884"/>
              <a:gd name="connsiteX0" fmla="*/ 0 w 1617133"/>
              <a:gd name="connsiteY0" fmla="*/ 1499477 h 1524884"/>
              <a:gd name="connsiteX1" fmla="*/ 133351 w 1617133"/>
              <a:gd name="connsiteY1" fmla="*/ 1469844 h 1524884"/>
              <a:gd name="connsiteX2" fmla="*/ 237067 w 1617133"/>
              <a:gd name="connsiteY2" fmla="*/ 1423277 h 1524884"/>
              <a:gd name="connsiteX3" fmla="*/ 347133 w 1617133"/>
              <a:gd name="connsiteY3" fmla="*/ 1253943 h 1524884"/>
              <a:gd name="connsiteX4" fmla="*/ 508000 w 1617133"/>
              <a:gd name="connsiteY4" fmla="*/ 635877 h 1524884"/>
              <a:gd name="connsiteX5" fmla="*/ 563033 w 1617133"/>
              <a:gd name="connsiteY5" fmla="*/ 445377 h 1524884"/>
              <a:gd name="connsiteX6" fmla="*/ 615950 w 1617133"/>
              <a:gd name="connsiteY6" fmla="*/ 263344 h 1524884"/>
              <a:gd name="connsiteX7" fmla="*/ 666748 w 1617133"/>
              <a:gd name="connsiteY7" fmla="*/ 123643 h 1524884"/>
              <a:gd name="connsiteX8" fmla="*/ 723901 w 1617133"/>
              <a:gd name="connsiteY8" fmla="*/ 30510 h 1524884"/>
              <a:gd name="connsiteX9" fmla="*/ 805502 w 1617133"/>
              <a:gd name="connsiteY9" fmla="*/ 27 h 1524884"/>
              <a:gd name="connsiteX10" fmla="*/ 886884 w 1617133"/>
              <a:gd name="connsiteY10" fmla="*/ 43210 h 1524884"/>
              <a:gd name="connsiteX11" fmla="*/ 954617 w 1617133"/>
              <a:gd name="connsiteY11" fmla="*/ 185026 h 1524884"/>
              <a:gd name="connsiteX12" fmla="*/ 1011767 w 1617133"/>
              <a:gd name="connsiteY12" fmla="*/ 396694 h 1524884"/>
              <a:gd name="connsiteX13" fmla="*/ 1187451 w 1617133"/>
              <a:gd name="connsiteY13" fmla="*/ 1141760 h 1524884"/>
              <a:gd name="connsiteX14" fmla="*/ 1253067 w 1617133"/>
              <a:gd name="connsiteY14" fmla="*/ 1414810 h 1524884"/>
              <a:gd name="connsiteX15" fmla="*/ 1295400 w 1617133"/>
              <a:gd name="connsiteY15" fmla="*/ 1503710 h 1524884"/>
              <a:gd name="connsiteX16" fmla="*/ 1422400 w 1617133"/>
              <a:gd name="connsiteY16" fmla="*/ 1524877 h 1524884"/>
              <a:gd name="connsiteX17" fmla="*/ 1617133 w 1617133"/>
              <a:gd name="connsiteY17" fmla="*/ 1516410 h 1524884"/>
              <a:gd name="connsiteX18" fmla="*/ 1617133 w 1617133"/>
              <a:gd name="connsiteY18" fmla="*/ 1516410 h 1524884"/>
              <a:gd name="connsiteX19" fmla="*/ 1617133 w 1617133"/>
              <a:gd name="connsiteY19" fmla="*/ 1516410 h 1524884"/>
              <a:gd name="connsiteX0" fmla="*/ 0 w 1617133"/>
              <a:gd name="connsiteY0" fmla="*/ 1499477 h 1524884"/>
              <a:gd name="connsiteX1" fmla="*/ 133351 w 1617133"/>
              <a:gd name="connsiteY1" fmla="*/ 1469844 h 1524884"/>
              <a:gd name="connsiteX2" fmla="*/ 260880 w 1617133"/>
              <a:gd name="connsiteY2" fmla="*/ 1414810 h 1524884"/>
              <a:gd name="connsiteX3" fmla="*/ 347133 w 1617133"/>
              <a:gd name="connsiteY3" fmla="*/ 1253943 h 1524884"/>
              <a:gd name="connsiteX4" fmla="*/ 508000 w 1617133"/>
              <a:gd name="connsiteY4" fmla="*/ 635877 h 1524884"/>
              <a:gd name="connsiteX5" fmla="*/ 563033 w 1617133"/>
              <a:gd name="connsiteY5" fmla="*/ 445377 h 1524884"/>
              <a:gd name="connsiteX6" fmla="*/ 615950 w 1617133"/>
              <a:gd name="connsiteY6" fmla="*/ 263344 h 1524884"/>
              <a:gd name="connsiteX7" fmla="*/ 666748 w 1617133"/>
              <a:gd name="connsiteY7" fmla="*/ 123643 h 1524884"/>
              <a:gd name="connsiteX8" fmla="*/ 723901 w 1617133"/>
              <a:gd name="connsiteY8" fmla="*/ 30510 h 1524884"/>
              <a:gd name="connsiteX9" fmla="*/ 805502 w 1617133"/>
              <a:gd name="connsiteY9" fmla="*/ 27 h 1524884"/>
              <a:gd name="connsiteX10" fmla="*/ 886884 w 1617133"/>
              <a:gd name="connsiteY10" fmla="*/ 43210 h 1524884"/>
              <a:gd name="connsiteX11" fmla="*/ 954617 w 1617133"/>
              <a:gd name="connsiteY11" fmla="*/ 185026 h 1524884"/>
              <a:gd name="connsiteX12" fmla="*/ 1011767 w 1617133"/>
              <a:gd name="connsiteY12" fmla="*/ 396694 h 1524884"/>
              <a:gd name="connsiteX13" fmla="*/ 1187451 w 1617133"/>
              <a:gd name="connsiteY13" fmla="*/ 1141760 h 1524884"/>
              <a:gd name="connsiteX14" fmla="*/ 1253067 w 1617133"/>
              <a:gd name="connsiteY14" fmla="*/ 1414810 h 1524884"/>
              <a:gd name="connsiteX15" fmla="*/ 1295400 w 1617133"/>
              <a:gd name="connsiteY15" fmla="*/ 1503710 h 1524884"/>
              <a:gd name="connsiteX16" fmla="*/ 1422400 w 1617133"/>
              <a:gd name="connsiteY16" fmla="*/ 1524877 h 1524884"/>
              <a:gd name="connsiteX17" fmla="*/ 1617133 w 1617133"/>
              <a:gd name="connsiteY17" fmla="*/ 1516410 h 1524884"/>
              <a:gd name="connsiteX18" fmla="*/ 1617133 w 1617133"/>
              <a:gd name="connsiteY18" fmla="*/ 1516410 h 1524884"/>
              <a:gd name="connsiteX19" fmla="*/ 1617133 w 1617133"/>
              <a:gd name="connsiteY19" fmla="*/ 1516410 h 1524884"/>
              <a:gd name="connsiteX0" fmla="*/ 7455 w 1624588"/>
              <a:gd name="connsiteY0" fmla="*/ 1499477 h 1524884"/>
              <a:gd name="connsiteX1" fmla="*/ 10640 w 1624588"/>
              <a:gd name="connsiteY1" fmla="*/ 1496036 h 1524884"/>
              <a:gd name="connsiteX2" fmla="*/ 140806 w 1624588"/>
              <a:gd name="connsiteY2" fmla="*/ 1469844 h 1524884"/>
              <a:gd name="connsiteX3" fmla="*/ 268335 w 1624588"/>
              <a:gd name="connsiteY3" fmla="*/ 1414810 h 1524884"/>
              <a:gd name="connsiteX4" fmla="*/ 354588 w 1624588"/>
              <a:gd name="connsiteY4" fmla="*/ 1253943 h 1524884"/>
              <a:gd name="connsiteX5" fmla="*/ 515455 w 1624588"/>
              <a:gd name="connsiteY5" fmla="*/ 635877 h 1524884"/>
              <a:gd name="connsiteX6" fmla="*/ 570488 w 1624588"/>
              <a:gd name="connsiteY6" fmla="*/ 445377 h 1524884"/>
              <a:gd name="connsiteX7" fmla="*/ 623405 w 1624588"/>
              <a:gd name="connsiteY7" fmla="*/ 263344 h 1524884"/>
              <a:gd name="connsiteX8" fmla="*/ 674203 w 1624588"/>
              <a:gd name="connsiteY8" fmla="*/ 123643 h 1524884"/>
              <a:gd name="connsiteX9" fmla="*/ 731356 w 1624588"/>
              <a:gd name="connsiteY9" fmla="*/ 30510 h 1524884"/>
              <a:gd name="connsiteX10" fmla="*/ 812957 w 1624588"/>
              <a:gd name="connsiteY10" fmla="*/ 27 h 1524884"/>
              <a:gd name="connsiteX11" fmla="*/ 894339 w 1624588"/>
              <a:gd name="connsiteY11" fmla="*/ 43210 h 1524884"/>
              <a:gd name="connsiteX12" fmla="*/ 962072 w 1624588"/>
              <a:gd name="connsiteY12" fmla="*/ 185026 h 1524884"/>
              <a:gd name="connsiteX13" fmla="*/ 1019222 w 1624588"/>
              <a:gd name="connsiteY13" fmla="*/ 396694 h 1524884"/>
              <a:gd name="connsiteX14" fmla="*/ 1194906 w 1624588"/>
              <a:gd name="connsiteY14" fmla="*/ 1141760 h 1524884"/>
              <a:gd name="connsiteX15" fmla="*/ 1260522 w 1624588"/>
              <a:gd name="connsiteY15" fmla="*/ 1414810 h 1524884"/>
              <a:gd name="connsiteX16" fmla="*/ 1302855 w 1624588"/>
              <a:gd name="connsiteY16" fmla="*/ 1503710 h 1524884"/>
              <a:gd name="connsiteX17" fmla="*/ 1429855 w 1624588"/>
              <a:gd name="connsiteY17" fmla="*/ 1524877 h 1524884"/>
              <a:gd name="connsiteX18" fmla="*/ 1624588 w 1624588"/>
              <a:gd name="connsiteY18" fmla="*/ 1516410 h 1524884"/>
              <a:gd name="connsiteX19" fmla="*/ 1624588 w 1624588"/>
              <a:gd name="connsiteY19" fmla="*/ 1516410 h 1524884"/>
              <a:gd name="connsiteX20" fmla="*/ 1624588 w 1624588"/>
              <a:gd name="connsiteY20" fmla="*/ 1516410 h 1524884"/>
              <a:gd name="connsiteX0" fmla="*/ 160627 w 1777760"/>
              <a:gd name="connsiteY0" fmla="*/ 1499477 h 1524884"/>
              <a:gd name="connsiteX1" fmla="*/ 1886 w 1777760"/>
              <a:gd name="connsiteY1" fmla="*/ 1510852 h 1524884"/>
              <a:gd name="connsiteX2" fmla="*/ 293978 w 1777760"/>
              <a:gd name="connsiteY2" fmla="*/ 1469844 h 1524884"/>
              <a:gd name="connsiteX3" fmla="*/ 421507 w 1777760"/>
              <a:gd name="connsiteY3" fmla="*/ 1414810 h 1524884"/>
              <a:gd name="connsiteX4" fmla="*/ 507760 w 1777760"/>
              <a:gd name="connsiteY4" fmla="*/ 1253943 h 1524884"/>
              <a:gd name="connsiteX5" fmla="*/ 668627 w 1777760"/>
              <a:gd name="connsiteY5" fmla="*/ 635877 h 1524884"/>
              <a:gd name="connsiteX6" fmla="*/ 723660 w 1777760"/>
              <a:gd name="connsiteY6" fmla="*/ 445377 h 1524884"/>
              <a:gd name="connsiteX7" fmla="*/ 776577 w 1777760"/>
              <a:gd name="connsiteY7" fmla="*/ 263344 h 1524884"/>
              <a:gd name="connsiteX8" fmla="*/ 827375 w 1777760"/>
              <a:gd name="connsiteY8" fmla="*/ 123643 h 1524884"/>
              <a:gd name="connsiteX9" fmla="*/ 884528 w 1777760"/>
              <a:gd name="connsiteY9" fmla="*/ 30510 h 1524884"/>
              <a:gd name="connsiteX10" fmla="*/ 966129 w 1777760"/>
              <a:gd name="connsiteY10" fmla="*/ 27 h 1524884"/>
              <a:gd name="connsiteX11" fmla="*/ 1047511 w 1777760"/>
              <a:gd name="connsiteY11" fmla="*/ 43210 h 1524884"/>
              <a:gd name="connsiteX12" fmla="*/ 1115244 w 1777760"/>
              <a:gd name="connsiteY12" fmla="*/ 185026 h 1524884"/>
              <a:gd name="connsiteX13" fmla="*/ 1172394 w 1777760"/>
              <a:gd name="connsiteY13" fmla="*/ 396694 h 1524884"/>
              <a:gd name="connsiteX14" fmla="*/ 1348078 w 1777760"/>
              <a:gd name="connsiteY14" fmla="*/ 1141760 h 1524884"/>
              <a:gd name="connsiteX15" fmla="*/ 1413694 w 1777760"/>
              <a:gd name="connsiteY15" fmla="*/ 1414810 h 1524884"/>
              <a:gd name="connsiteX16" fmla="*/ 1456027 w 1777760"/>
              <a:gd name="connsiteY16" fmla="*/ 1503710 h 1524884"/>
              <a:gd name="connsiteX17" fmla="*/ 1583027 w 1777760"/>
              <a:gd name="connsiteY17" fmla="*/ 1524877 h 1524884"/>
              <a:gd name="connsiteX18" fmla="*/ 1777760 w 1777760"/>
              <a:gd name="connsiteY18" fmla="*/ 1516410 h 1524884"/>
              <a:gd name="connsiteX19" fmla="*/ 1777760 w 1777760"/>
              <a:gd name="connsiteY19" fmla="*/ 1516410 h 1524884"/>
              <a:gd name="connsiteX20" fmla="*/ 1777760 w 1777760"/>
              <a:gd name="connsiteY20" fmla="*/ 1516410 h 1524884"/>
              <a:gd name="connsiteX0" fmla="*/ 10952 w 1785249"/>
              <a:gd name="connsiteY0" fmla="*/ 1586261 h 1586261"/>
              <a:gd name="connsiteX1" fmla="*/ 9375 w 1785249"/>
              <a:gd name="connsiteY1" fmla="*/ 1510852 h 1586261"/>
              <a:gd name="connsiteX2" fmla="*/ 301467 w 1785249"/>
              <a:gd name="connsiteY2" fmla="*/ 1469844 h 1586261"/>
              <a:gd name="connsiteX3" fmla="*/ 428996 w 1785249"/>
              <a:gd name="connsiteY3" fmla="*/ 1414810 h 1586261"/>
              <a:gd name="connsiteX4" fmla="*/ 515249 w 1785249"/>
              <a:gd name="connsiteY4" fmla="*/ 1253943 h 1586261"/>
              <a:gd name="connsiteX5" fmla="*/ 676116 w 1785249"/>
              <a:gd name="connsiteY5" fmla="*/ 635877 h 1586261"/>
              <a:gd name="connsiteX6" fmla="*/ 731149 w 1785249"/>
              <a:gd name="connsiteY6" fmla="*/ 445377 h 1586261"/>
              <a:gd name="connsiteX7" fmla="*/ 784066 w 1785249"/>
              <a:gd name="connsiteY7" fmla="*/ 263344 h 1586261"/>
              <a:gd name="connsiteX8" fmla="*/ 834864 w 1785249"/>
              <a:gd name="connsiteY8" fmla="*/ 123643 h 1586261"/>
              <a:gd name="connsiteX9" fmla="*/ 892017 w 1785249"/>
              <a:gd name="connsiteY9" fmla="*/ 30510 h 1586261"/>
              <a:gd name="connsiteX10" fmla="*/ 973618 w 1785249"/>
              <a:gd name="connsiteY10" fmla="*/ 27 h 1586261"/>
              <a:gd name="connsiteX11" fmla="*/ 1055000 w 1785249"/>
              <a:gd name="connsiteY11" fmla="*/ 43210 h 1586261"/>
              <a:gd name="connsiteX12" fmla="*/ 1122733 w 1785249"/>
              <a:gd name="connsiteY12" fmla="*/ 185026 h 1586261"/>
              <a:gd name="connsiteX13" fmla="*/ 1179883 w 1785249"/>
              <a:gd name="connsiteY13" fmla="*/ 396694 h 1586261"/>
              <a:gd name="connsiteX14" fmla="*/ 1355567 w 1785249"/>
              <a:gd name="connsiteY14" fmla="*/ 1141760 h 1586261"/>
              <a:gd name="connsiteX15" fmla="*/ 1421183 w 1785249"/>
              <a:gd name="connsiteY15" fmla="*/ 1414810 h 1586261"/>
              <a:gd name="connsiteX16" fmla="*/ 1463516 w 1785249"/>
              <a:gd name="connsiteY16" fmla="*/ 1503710 h 1586261"/>
              <a:gd name="connsiteX17" fmla="*/ 1590516 w 1785249"/>
              <a:gd name="connsiteY17" fmla="*/ 1524877 h 1586261"/>
              <a:gd name="connsiteX18" fmla="*/ 1785249 w 1785249"/>
              <a:gd name="connsiteY18" fmla="*/ 1516410 h 1586261"/>
              <a:gd name="connsiteX19" fmla="*/ 1785249 w 1785249"/>
              <a:gd name="connsiteY19" fmla="*/ 1516410 h 1586261"/>
              <a:gd name="connsiteX20" fmla="*/ 1785249 w 1785249"/>
              <a:gd name="connsiteY20" fmla="*/ 1516410 h 1586261"/>
              <a:gd name="connsiteX0" fmla="*/ 0 w 1774297"/>
              <a:gd name="connsiteY0" fmla="*/ 1586261 h 1586261"/>
              <a:gd name="connsiteX1" fmla="*/ 131774 w 1774297"/>
              <a:gd name="connsiteY1" fmla="*/ 1502385 h 1586261"/>
              <a:gd name="connsiteX2" fmla="*/ 290515 w 1774297"/>
              <a:gd name="connsiteY2" fmla="*/ 1469844 h 1586261"/>
              <a:gd name="connsiteX3" fmla="*/ 418044 w 1774297"/>
              <a:gd name="connsiteY3" fmla="*/ 1414810 h 1586261"/>
              <a:gd name="connsiteX4" fmla="*/ 504297 w 1774297"/>
              <a:gd name="connsiteY4" fmla="*/ 1253943 h 1586261"/>
              <a:gd name="connsiteX5" fmla="*/ 665164 w 1774297"/>
              <a:gd name="connsiteY5" fmla="*/ 635877 h 1586261"/>
              <a:gd name="connsiteX6" fmla="*/ 720197 w 1774297"/>
              <a:gd name="connsiteY6" fmla="*/ 445377 h 1586261"/>
              <a:gd name="connsiteX7" fmla="*/ 773114 w 1774297"/>
              <a:gd name="connsiteY7" fmla="*/ 263344 h 1586261"/>
              <a:gd name="connsiteX8" fmla="*/ 823912 w 1774297"/>
              <a:gd name="connsiteY8" fmla="*/ 123643 h 1586261"/>
              <a:gd name="connsiteX9" fmla="*/ 881065 w 1774297"/>
              <a:gd name="connsiteY9" fmla="*/ 30510 h 1586261"/>
              <a:gd name="connsiteX10" fmla="*/ 962666 w 1774297"/>
              <a:gd name="connsiteY10" fmla="*/ 27 h 1586261"/>
              <a:gd name="connsiteX11" fmla="*/ 1044048 w 1774297"/>
              <a:gd name="connsiteY11" fmla="*/ 43210 h 1586261"/>
              <a:gd name="connsiteX12" fmla="*/ 1111781 w 1774297"/>
              <a:gd name="connsiteY12" fmla="*/ 185026 h 1586261"/>
              <a:gd name="connsiteX13" fmla="*/ 1168931 w 1774297"/>
              <a:gd name="connsiteY13" fmla="*/ 396694 h 1586261"/>
              <a:gd name="connsiteX14" fmla="*/ 1344615 w 1774297"/>
              <a:gd name="connsiteY14" fmla="*/ 1141760 h 1586261"/>
              <a:gd name="connsiteX15" fmla="*/ 1410231 w 1774297"/>
              <a:gd name="connsiteY15" fmla="*/ 1414810 h 1586261"/>
              <a:gd name="connsiteX16" fmla="*/ 1452564 w 1774297"/>
              <a:gd name="connsiteY16" fmla="*/ 1503710 h 1586261"/>
              <a:gd name="connsiteX17" fmla="*/ 1579564 w 1774297"/>
              <a:gd name="connsiteY17" fmla="*/ 1524877 h 1586261"/>
              <a:gd name="connsiteX18" fmla="*/ 1774297 w 1774297"/>
              <a:gd name="connsiteY18" fmla="*/ 1516410 h 1586261"/>
              <a:gd name="connsiteX19" fmla="*/ 1774297 w 1774297"/>
              <a:gd name="connsiteY19" fmla="*/ 1516410 h 1586261"/>
              <a:gd name="connsiteX20" fmla="*/ 1774297 w 1774297"/>
              <a:gd name="connsiteY20" fmla="*/ 1516410 h 1586261"/>
              <a:gd name="connsiteX0" fmla="*/ 0 w 1817160"/>
              <a:gd name="connsiteY0" fmla="*/ 1516411 h 1524884"/>
              <a:gd name="connsiteX1" fmla="*/ 174637 w 1817160"/>
              <a:gd name="connsiteY1" fmla="*/ 1502385 h 1524884"/>
              <a:gd name="connsiteX2" fmla="*/ 333378 w 1817160"/>
              <a:gd name="connsiteY2" fmla="*/ 1469844 h 1524884"/>
              <a:gd name="connsiteX3" fmla="*/ 460907 w 1817160"/>
              <a:gd name="connsiteY3" fmla="*/ 1414810 h 1524884"/>
              <a:gd name="connsiteX4" fmla="*/ 547160 w 1817160"/>
              <a:gd name="connsiteY4" fmla="*/ 1253943 h 1524884"/>
              <a:gd name="connsiteX5" fmla="*/ 708027 w 1817160"/>
              <a:gd name="connsiteY5" fmla="*/ 635877 h 1524884"/>
              <a:gd name="connsiteX6" fmla="*/ 763060 w 1817160"/>
              <a:gd name="connsiteY6" fmla="*/ 445377 h 1524884"/>
              <a:gd name="connsiteX7" fmla="*/ 815977 w 1817160"/>
              <a:gd name="connsiteY7" fmla="*/ 263344 h 1524884"/>
              <a:gd name="connsiteX8" fmla="*/ 866775 w 1817160"/>
              <a:gd name="connsiteY8" fmla="*/ 123643 h 1524884"/>
              <a:gd name="connsiteX9" fmla="*/ 923928 w 1817160"/>
              <a:gd name="connsiteY9" fmla="*/ 30510 h 1524884"/>
              <a:gd name="connsiteX10" fmla="*/ 1005529 w 1817160"/>
              <a:gd name="connsiteY10" fmla="*/ 27 h 1524884"/>
              <a:gd name="connsiteX11" fmla="*/ 1086911 w 1817160"/>
              <a:gd name="connsiteY11" fmla="*/ 43210 h 1524884"/>
              <a:gd name="connsiteX12" fmla="*/ 1154644 w 1817160"/>
              <a:gd name="connsiteY12" fmla="*/ 185026 h 1524884"/>
              <a:gd name="connsiteX13" fmla="*/ 1211794 w 1817160"/>
              <a:gd name="connsiteY13" fmla="*/ 396694 h 1524884"/>
              <a:gd name="connsiteX14" fmla="*/ 1387478 w 1817160"/>
              <a:gd name="connsiteY14" fmla="*/ 1141760 h 1524884"/>
              <a:gd name="connsiteX15" fmla="*/ 1453094 w 1817160"/>
              <a:gd name="connsiteY15" fmla="*/ 1414810 h 1524884"/>
              <a:gd name="connsiteX16" fmla="*/ 1495427 w 1817160"/>
              <a:gd name="connsiteY16" fmla="*/ 1503710 h 1524884"/>
              <a:gd name="connsiteX17" fmla="*/ 1622427 w 1817160"/>
              <a:gd name="connsiteY17" fmla="*/ 1524877 h 1524884"/>
              <a:gd name="connsiteX18" fmla="*/ 1817160 w 1817160"/>
              <a:gd name="connsiteY18" fmla="*/ 1516410 h 1524884"/>
              <a:gd name="connsiteX19" fmla="*/ 1817160 w 1817160"/>
              <a:gd name="connsiteY19" fmla="*/ 1516410 h 1524884"/>
              <a:gd name="connsiteX20" fmla="*/ 1817160 w 1817160"/>
              <a:gd name="connsiteY20" fmla="*/ 1516410 h 1524884"/>
              <a:gd name="connsiteX0" fmla="*/ 0 w 1817160"/>
              <a:gd name="connsiteY0" fmla="*/ 1516411 h 1524884"/>
              <a:gd name="connsiteX1" fmla="*/ 174637 w 1817160"/>
              <a:gd name="connsiteY1" fmla="*/ 1502385 h 1524884"/>
              <a:gd name="connsiteX2" fmla="*/ 333378 w 1817160"/>
              <a:gd name="connsiteY2" fmla="*/ 1469844 h 1524884"/>
              <a:gd name="connsiteX3" fmla="*/ 460907 w 1817160"/>
              <a:gd name="connsiteY3" fmla="*/ 1414810 h 1524884"/>
              <a:gd name="connsiteX4" fmla="*/ 547160 w 1817160"/>
              <a:gd name="connsiteY4" fmla="*/ 1253943 h 1524884"/>
              <a:gd name="connsiteX5" fmla="*/ 708027 w 1817160"/>
              <a:gd name="connsiteY5" fmla="*/ 635877 h 1524884"/>
              <a:gd name="connsiteX6" fmla="*/ 763060 w 1817160"/>
              <a:gd name="connsiteY6" fmla="*/ 445377 h 1524884"/>
              <a:gd name="connsiteX7" fmla="*/ 815977 w 1817160"/>
              <a:gd name="connsiteY7" fmla="*/ 263344 h 1524884"/>
              <a:gd name="connsiteX8" fmla="*/ 866775 w 1817160"/>
              <a:gd name="connsiteY8" fmla="*/ 123643 h 1524884"/>
              <a:gd name="connsiteX9" fmla="*/ 923928 w 1817160"/>
              <a:gd name="connsiteY9" fmla="*/ 30510 h 1524884"/>
              <a:gd name="connsiteX10" fmla="*/ 1005529 w 1817160"/>
              <a:gd name="connsiteY10" fmla="*/ 27 h 1524884"/>
              <a:gd name="connsiteX11" fmla="*/ 1086911 w 1817160"/>
              <a:gd name="connsiteY11" fmla="*/ 43210 h 1524884"/>
              <a:gd name="connsiteX12" fmla="*/ 1154644 w 1817160"/>
              <a:gd name="connsiteY12" fmla="*/ 185026 h 1524884"/>
              <a:gd name="connsiteX13" fmla="*/ 1211794 w 1817160"/>
              <a:gd name="connsiteY13" fmla="*/ 396694 h 1524884"/>
              <a:gd name="connsiteX14" fmla="*/ 1387478 w 1817160"/>
              <a:gd name="connsiteY14" fmla="*/ 1141760 h 1524884"/>
              <a:gd name="connsiteX15" fmla="*/ 1453094 w 1817160"/>
              <a:gd name="connsiteY15" fmla="*/ 1414810 h 1524884"/>
              <a:gd name="connsiteX16" fmla="*/ 1495427 w 1817160"/>
              <a:gd name="connsiteY16" fmla="*/ 1503710 h 1524884"/>
              <a:gd name="connsiteX17" fmla="*/ 1622427 w 1817160"/>
              <a:gd name="connsiteY17" fmla="*/ 1524877 h 1524884"/>
              <a:gd name="connsiteX18" fmla="*/ 1817160 w 1817160"/>
              <a:gd name="connsiteY18" fmla="*/ 1516410 h 1524884"/>
              <a:gd name="connsiteX19" fmla="*/ 1817160 w 1817160"/>
              <a:gd name="connsiteY19" fmla="*/ 1516410 h 1524884"/>
              <a:gd name="connsiteX20" fmla="*/ 1817160 w 1817160"/>
              <a:gd name="connsiteY20" fmla="*/ 1516410 h 1524884"/>
              <a:gd name="connsiteX0" fmla="*/ 0 w 1817160"/>
              <a:gd name="connsiteY0" fmla="*/ 1516411 h 1524884"/>
              <a:gd name="connsiteX1" fmla="*/ 174637 w 1817160"/>
              <a:gd name="connsiteY1" fmla="*/ 1502385 h 1524884"/>
              <a:gd name="connsiteX2" fmla="*/ 335760 w 1817160"/>
              <a:gd name="connsiteY2" fmla="*/ 1474078 h 1524884"/>
              <a:gd name="connsiteX3" fmla="*/ 460907 w 1817160"/>
              <a:gd name="connsiteY3" fmla="*/ 1414810 h 1524884"/>
              <a:gd name="connsiteX4" fmla="*/ 547160 w 1817160"/>
              <a:gd name="connsiteY4" fmla="*/ 1253943 h 1524884"/>
              <a:gd name="connsiteX5" fmla="*/ 708027 w 1817160"/>
              <a:gd name="connsiteY5" fmla="*/ 635877 h 1524884"/>
              <a:gd name="connsiteX6" fmla="*/ 763060 w 1817160"/>
              <a:gd name="connsiteY6" fmla="*/ 445377 h 1524884"/>
              <a:gd name="connsiteX7" fmla="*/ 815977 w 1817160"/>
              <a:gd name="connsiteY7" fmla="*/ 263344 h 1524884"/>
              <a:gd name="connsiteX8" fmla="*/ 866775 w 1817160"/>
              <a:gd name="connsiteY8" fmla="*/ 123643 h 1524884"/>
              <a:gd name="connsiteX9" fmla="*/ 923928 w 1817160"/>
              <a:gd name="connsiteY9" fmla="*/ 30510 h 1524884"/>
              <a:gd name="connsiteX10" fmla="*/ 1005529 w 1817160"/>
              <a:gd name="connsiteY10" fmla="*/ 27 h 1524884"/>
              <a:gd name="connsiteX11" fmla="*/ 1086911 w 1817160"/>
              <a:gd name="connsiteY11" fmla="*/ 43210 h 1524884"/>
              <a:gd name="connsiteX12" fmla="*/ 1154644 w 1817160"/>
              <a:gd name="connsiteY12" fmla="*/ 185026 h 1524884"/>
              <a:gd name="connsiteX13" fmla="*/ 1211794 w 1817160"/>
              <a:gd name="connsiteY13" fmla="*/ 396694 h 1524884"/>
              <a:gd name="connsiteX14" fmla="*/ 1387478 w 1817160"/>
              <a:gd name="connsiteY14" fmla="*/ 1141760 h 1524884"/>
              <a:gd name="connsiteX15" fmla="*/ 1453094 w 1817160"/>
              <a:gd name="connsiteY15" fmla="*/ 1414810 h 1524884"/>
              <a:gd name="connsiteX16" fmla="*/ 1495427 w 1817160"/>
              <a:gd name="connsiteY16" fmla="*/ 1503710 h 1524884"/>
              <a:gd name="connsiteX17" fmla="*/ 1622427 w 1817160"/>
              <a:gd name="connsiteY17" fmla="*/ 1524877 h 1524884"/>
              <a:gd name="connsiteX18" fmla="*/ 1817160 w 1817160"/>
              <a:gd name="connsiteY18" fmla="*/ 1516410 h 1524884"/>
              <a:gd name="connsiteX19" fmla="*/ 1817160 w 1817160"/>
              <a:gd name="connsiteY19" fmla="*/ 1516410 h 1524884"/>
              <a:gd name="connsiteX20" fmla="*/ 1817160 w 1817160"/>
              <a:gd name="connsiteY20" fmla="*/ 1516410 h 1524884"/>
              <a:gd name="connsiteX0" fmla="*/ 0 w 1817160"/>
              <a:gd name="connsiteY0" fmla="*/ 1516411 h 1527374"/>
              <a:gd name="connsiteX1" fmla="*/ 174637 w 1817160"/>
              <a:gd name="connsiteY1" fmla="*/ 1502385 h 1527374"/>
              <a:gd name="connsiteX2" fmla="*/ 335760 w 1817160"/>
              <a:gd name="connsiteY2" fmla="*/ 1474078 h 1527374"/>
              <a:gd name="connsiteX3" fmla="*/ 460907 w 1817160"/>
              <a:gd name="connsiteY3" fmla="*/ 1414810 h 1527374"/>
              <a:gd name="connsiteX4" fmla="*/ 547160 w 1817160"/>
              <a:gd name="connsiteY4" fmla="*/ 1253943 h 1527374"/>
              <a:gd name="connsiteX5" fmla="*/ 708027 w 1817160"/>
              <a:gd name="connsiteY5" fmla="*/ 635877 h 1527374"/>
              <a:gd name="connsiteX6" fmla="*/ 763060 w 1817160"/>
              <a:gd name="connsiteY6" fmla="*/ 445377 h 1527374"/>
              <a:gd name="connsiteX7" fmla="*/ 815977 w 1817160"/>
              <a:gd name="connsiteY7" fmla="*/ 263344 h 1527374"/>
              <a:gd name="connsiteX8" fmla="*/ 866775 w 1817160"/>
              <a:gd name="connsiteY8" fmla="*/ 123643 h 1527374"/>
              <a:gd name="connsiteX9" fmla="*/ 923928 w 1817160"/>
              <a:gd name="connsiteY9" fmla="*/ 30510 h 1527374"/>
              <a:gd name="connsiteX10" fmla="*/ 1005529 w 1817160"/>
              <a:gd name="connsiteY10" fmla="*/ 27 h 1527374"/>
              <a:gd name="connsiteX11" fmla="*/ 1086911 w 1817160"/>
              <a:gd name="connsiteY11" fmla="*/ 43210 h 1527374"/>
              <a:gd name="connsiteX12" fmla="*/ 1154644 w 1817160"/>
              <a:gd name="connsiteY12" fmla="*/ 185026 h 1527374"/>
              <a:gd name="connsiteX13" fmla="*/ 1211794 w 1817160"/>
              <a:gd name="connsiteY13" fmla="*/ 396694 h 1527374"/>
              <a:gd name="connsiteX14" fmla="*/ 1387478 w 1817160"/>
              <a:gd name="connsiteY14" fmla="*/ 1141760 h 1527374"/>
              <a:gd name="connsiteX15" fmla="*/ 1453094 w 1817160"/>
              <a:gd name="connsiteY15" fmla="*/ 1414810 h 1527374"/>
              <a:gd name="connsiteX16" fmla="*/ 1495427 w 1817160"/>
              <a:gd name="connsiteY16" fmla="*/ 1503710 h 1527374"/>
              <a:gd name="connsiteX17" fmla="*/ 1622427 w 1817160"/>
              <a:gd name="connsiteY17" fmla="*/ 1524877 h 1527374"/>
              <a:gd name="connsiteX18" fmla="*/ 1817160 w 1817160"/>
              <a:gd name="connsiteY18" fmla="*/ 1516410 h 1527374"/>
              <a:gd name="connsiteX19" fmla="*/ 1817160 w 1817160"/>
              <a:gd name="connsiteY19" fmla="*/ 1516410 h 1527374"/>
              <a:gd name="connsiteX20" fmla="*/ 1817160 w 1817160"/>
              <a:gd name="connsiteY20" fmla="*/ 1527374 h 1527374"/>
              <a:gd name="connsiteX0" fmla="*/ 0 w 1817160"/>
              <a:gd name="connsiteY0" fmla="*/ 1516411 h 1524884"/>
              <a:gd name="connsiteX1" fmla="*/ 174637 w 1817160"/>
              <a:gd name="connsiteY1" fmla="*/ 1502385 h 1524884"/>
              <a:gd name="connsiteX2" fmla="*/ 335760 w 1817160"/>
              <a:gd name="connsiteY2" fmla="*/ 1474078 h 1524884"/>
              <a:gd name="connsiteX3" fmla="*/ 460907 w 1817160"/>
              <a:gd name="connsiteY3" fmla="*/ 1414810 h 1524884"/>
              <a:gd name="connsiteX4" fmla="*/ 547160 w 1817160"/>
              <a:gd name="connsiteY4" fmla="*/ 1253943 h 1524884"/>
              <a:gd name="connsiteX5" fmla="*/ 708027 w 1817160"/>
              <a:gd name="connsiteY5" fmla="*/ 635877 h 1524884"/>
              <a:gd name="connsiteX6" fmla="*/ 763060 w 1817160"/>
              <a:gd name="connsiteY6" fmla="*/ 445377 h 1524884"/>
              <a:gd name="connsiteX7" fmla="*/ 815977 w 1817160"/>
              <a:gd name="connsiteY7" fmla="*/ 263344 h 1524884"/>
              <a:gd name="connsiteX8" fmla="*/ 866775 w 1817160"/>
              <a:gd name="connsiteY8" fmla="*/ 123643 h 1524884"/>
              <a:gd name="connsiteX9" fmla="*/ 923928 w 1817160"/>
              <a:gd name="connsiteY9" fmla="*/ 30510 h 1524884"/>
              <a:gd name="connsiteX10" fmla="*/ 1005529 w 1817160"/>
              <a:gd name="connsiteY10" fmla="*/ 27 h 1524884"/>
              <a:gd name="connsiteX11" fmla="*/ 1086911 w 1817160"/>
              <a:gd name="connsiteY11" fmla="*/ 43210 h 1524884"/>
              <a:gd name="connsiteX12" fmla="*/ 1154644 w 1817160"/>
              <a:gd name="connsiteY12" fmla="*/ 185026 h 1524884"/>
              <a:gd name="connsiteX13" fmla="*/ 1211794 w 1817160"/>
              <a:gd name="connsiteY13" fmla="*/ 396694 h 1524884"/>
              <a:gd name="connsiteX14" fmla="*/ 1387478 w 1817160"/>
              <a:gd name="connsiteY14" fmla="*/ 1141760 h 1524884"/>
              <a:gd name="connsiteX15" fmla="*/ 1453094 w 1817160"/>
              <a:gd name="connsiteY15" fmla="*/ 1414810 h 1524884"/>
              <a:gd name="connsiteX16" fmla="*/ 1495427 w 1817160"/>
              <a:gd name="connsiteY16" fmla="*/ 1503710 h 1524884"/>
              <a:gd name="connsiteX17" fmla="*/ 1622427 w 1817160"/>
              <a:gd name="connsiteY17" fmla="*/ 1524877 h 1524884"/>
              <a:gd name="connsiteX18" fmla="*/ 1817160 w 1817160"/>
              <a:gd name="connsiteY18" fmla="*/ 1516410 h 1524884"/>
              <a:gd name="connsiteX19" fmla="*/ 1817160 w 1817160"/>
              <a:gd name="connsiteY19" fmla="*/ 1516410 h 1524884"/>
              <a:gd name="connsiteX0" fmla="*/ 0 w 1817160"/>
              <a:gd name="connsiteY0" fmla="*/ 1516411 h 1524884"/>
              <a:gd name="connsiteX1" fmla="*/ 174637 w 1817160"/>
              <a:gd name="connsiteY1" fmla="*/ 1502385 h 1524884"/>
              <a:gd name="connsiteX2" fmla="*/ 335760 w 1817160"/>
              <a:gd name="connsiteY2" fmla="*/ 1474078 h 1524884"/>
              <a:gd name="connsiteX3" fmla="*/ 460907 w 1817160"/>
              <a:gd name="connsiteY3" fmla="*/ 1414810 h 1524884"/>
              <a:gd name="connsiteX4" fmla="*/ 547160 w 1817160"/>
              <a:gd name="connsiteY4" fmla="*/ 1253943 h 1524884"/>
              <a:gd name="connsiteX5" fmla="*/ 708027 w 1817160"/>
              <a:gd name="connsiteY5" fmla="*/ 635877 h 1524884"/>
              <a:gd name="connsiteX6" fmla="*/ 763060 w 1817160"/>
              <a:gd name="connsiteY6" fmla="*/ 445377 h 1524884"/>
              <a:gd name="connsiteX7" fmla="*/ 815977 w 1817160"/>
              <a:gd name="connsiteY7" fmla="*/ 263344 h 1524884"/>
              <a:gd name="connsiteX8" fmla="*/ 866775 w 1817160"/>
              <a:gd name="connsiteY8" fmla="*/ 123643 h 1524884"/>
              <a:gd name="connsiteX9" fmla="*/ 923928 w 1817160"/>
              <a:gd name="connsiteY9" fmla="*/ 30510 h 1524884"/>
              <a:gd name="connsiteX10" fmla="*/ 1005529 w 1817160"/>
              <a:gd name="connsiteY10" fmla="*/ 27 h 1524884"/>
              <a:gd name="connsiteX11" fmla="*/ 1086911 w 1817160"/>
              <a:gd name="connsiteY11" fmla="*/ 43210 h 1524884"/>
              <a:gd name="connsiteX12" fmla="*/ 1154644 w 1817160"/>
              <a:gd name="connsiteY12" fmla="*/ 185026 h 1524884"/>
              <a:gd name="connsiteX13" fmla="*/ 1211794 w 1817160"/>
              <a:gd name="connsiteY13" fmla="*/ 396694 h 1524884"/>
              <a:gd name="connsiteX14" fmla="*/ 1387478 w 1817160"/>
              <a:gd name="connsiteY14" fmla="*/ 1141760 h 1524884"/>
              <a:gd name="connsiteX15" fmla="*/ 1453094 w 1817160"/>
              <a:gd name="connsiteY15" fmla="*/ 1414810 h 1524884"/>
              <a:gd name="connsiteX16" fmla="*/ 1495427 w 1817160"/>
              <a:gd name="connsiteY16" fmla="*/ 1503710 h 1524884"/>
              <a:gd name="connsiteX17" fmla="*/ 1622427 w 1817160"/>
              <a:gd name="connsiteY17" fmla="*/ 1524877 h 1524884"/>
              <a:gd name="connsiteX18" fmla="*/ 1817160 w 1817160"/>
              <a:gd name="connsiteY18" fmla="*/ 1516410 h 1524884"/>
              <a:gd name="connsiteX19" fmla="*/ 1817160 w 1817160"/>
              <a:gd name="connsiteY19" fmla="*/ 1516410 h 1524884"/>
              <a:gd name="connsiteX0" fmla="*/ 0 w 1832929"/>
              <a:gd name="connsiteY0" fmla="*/ 1516411 h 1524884"/>
              <a:gd name="connsiteX1" fmla="*/ 174637 w 1832929"/>
              <a:gd name="connsiteY1" fmla="*/ 1502385 h 1524884"/>
              <a:gd name="connsiteX2" fmla="*/ 335760 w 1832929"/>
              <a:gd name="connsiteY2" fmla="*/ 1474078 h 1524884"/>
              <a:gd name="connsiteX3" fmla="*/ 460907 w 1832929"/>
              <a:gd name="connsiteY3" fmla="*/ 1414810 h 1524884"/>
              <a:gd name="connsiteX4" fmla="*/ 547160 w 1832929"/>
              <a:gd name="connsiteY4" fmla="*/ 1253943 h 1524884"/>
              <a:gd name="connsiteX5" fmla="*/ 708027 w 1832929"/>
              <a:gd name="connsiteY5" fmla="*/ 635877 h 1524884"/>
              <a:gd name="connsiteX6" fmla="*/ 763060 w 1832929"/>
              <a:gd name="connsiteY6" fmla="*/ 445377 h 1524884"/>
              <a:gd name="connsiteX7" fmla="*/ 815977 w 1832929"/>
              <a:gd name="connsiteY7" fmla="*/ 263344 h 1524884"/>
              <a:gd name="connsiteX8" fmla="*/ 866775 w 1832929"/>
              <a:gd name="connsiteY8" fmla="*/ 123643 h 1524884"/>
              <a:gd name="connsiteX9" fmla="*/ 923928 w 1832929"/>
              <a:gd name="connsiteY9" fmla="*/ 30510 h 1524884"/>
              <a:gd name="connsiteX10" fmla="*/ 1005529 w 1832929"/>
              <a:gd name="connsiteY10" fmla="*/ 27 h 1524884"/>
              <a:gd name="connsiteX11" fmla="*/ 1086911 w 1832929"/>
              <a:gd name="connsiteY11" fmla="*/ 43210 h 1524884"/>
              <a:gd name="connsiteX12" fmla="*/ 1154644 w 1832929"/>
              <a:gd name="connsiteY12" fmla="*/ 185026 h 1524884"/>
              <a:gd name="connsiteX13" fmla="*/ 1211794 w 1832929"/>
              <a:gd name="connsiteY13" fmla="*/ 396694 h 1524884"/>
              <a:gd name="connsiteX14" fmla="*/ 1387478 w 1832929"/>
              <a:gd name="connsiteY14" fmla="*/ 1141760 h 1524884"/>
              <a:gd name="connsiteX15" fmla="*/ 1453094 w 1832929"/>
              <a:gd name="connsiteY15" fmla="*/ 1414810 h 1524884"/>
              <a:gd name="connsiteX16" fmla="*/ 1495427 w 1832929"/>
              <a:gd name="connsiteY16" fmla="*/ 1503710 h 1524884"/>
              <a:gd name="connsiteX17" fmla="*/ 1622427 w 1832929"/>
              <a:gd name="connsiteY17" fmla="*/ 1524877 h 1524884"/>
              <a:gd name="connsiteX18" fmla="*/ 1817160 w 1832929"/>
              <a:gd name="connsiteY18" fmla="*/ 1516410 h 1524884"/>
              <a:gd name="connsiteX19" fmla="*/ 1822094 w 1832929"/>
              <a:gd name="connsiteY19" fmla="*/ 1520796 h 1524884"/>
              <a:gd name="connsiteX0" fmla="*/ 0 w 1817160"/>
              <a:gd name="connsiteY0" fmla="*/ 1516411 h 1524884"/>
              <a:gd name="connsiteX1" fmla="*/ 174637 w 1817160"/>
              <a:gd name="connsiteY1" fmla="*/ 1502385 h 1524884"/>
              <a:gd name="connsiteX2" fmla="*/ 335760 w 1817160"/>
              <a:gd name="connsiteY2" fmla="*/ 1474078 h 1524884"/>
              <a:gd name="connsiteX3" fmla="*/ 460907 w 1817160"/>
              <a:gd name="connsiteY3" fmla="*/ 1414810 h 1524884"/>
              <a:gd name="connsiteX4" fmla="*/ 547160 w 1817160"/>
              <a:gd name="connsiteY4" fmla="*/ 1253943 h 1524884"/>
              <a:gd name="connsiteX5" fmla="*/ 708027 w 1817160"/>
              <a:gd name="connsiteY5" fmla="*/ 635877 h 1524884"/>
              <a:gd name="connsiteX6" fmla="*/ 763060 w 1817160"/>
              <a:gd name="connsiteY6" fmla="*/ 445377 h 1524884"/>
              <a:gd name="connsiteX7" fmla="*/ 815977 w 1817160"/>
              <a:gd name="connsiteY7" fmla="*/ 263344 h 1524884"/>
              <a:gd name="connsiteX8" fmla="*/ 866775 w 1817160"/>
              <a:gd name="connsiteY8" fmla="*/ 123643 h 1524884"/>
              <a:gd name="connsiteX9" fmla="*/ 923928 w 1817160"/>
              <a:gd name="connsiteY9" fmla="*/ 30510 h 1524884"/>
              <a:gd name="connsiteX10" fmla="*/ 1005529 w 1817160"/>
              <a:gd name="connsiteY10" fmla="*/ 27 h 1524884"/>
              <a:gd name="connsiteX11" fmla="*/ 1086911 w 1817160"/>
              <a:gd name="connsiteY11" fmla="*/ 43210 h 1524884"/>
              <a:gd name="connsiteX12" fmla="*/ 1154644 w 1817160"/>
              <a:gd name="connsiteY12" fmla="*/ 185026 h 1524884"/>
              <a:gd name="connsiteX13" fmla="*/ 1211794 w 1817160"/>
              <a:gd name="connsiteY13" fmla="*/ 396694 h 1524884"/>
              <a:gd name="connsiteX14" fmla="*/ 1387478 w 1817160"/>
              <a:gd name="connsiteY14" fmla="*/ 1141760 h 1524884"/>
              <a:gd name="connsiteX15" fmla="*/ 1453094 w 1817160"/>
              <a:gd name="connsiteY15" fmla="*/ 1414810 h 1524884"/>
              <a:gd name="connsiteX16" fmla="*/ 1495427 w 1817160"/>
              <a:gd name="connsiteY16" fmla="*/ 1503710 h 1524884"/>
              <a:gd name="connsiteX17" fmla="*/ 1622427 w 1817160"/>
              <a:gd name="connsiteY17" fmla="*/ 1524877 h 1524884"/>
              <a:gd name="connsiteX18" fmla="*/ 1817160 w 1817160"/>
              <a:gd name="connsiteY18" fmla="*/ 1516410 h 1524884"/>
              <a:gd name="connsiteX0" fmla="*/ 0 w 1831962"/>
              <a:gd name="connsiteY0" fmla="*/ 1516411 h 1525676"/>
              <a:gd name="connsiteX1" fmla="*/ 174637 w 1831962"/>
              <a:gd name="connsiteY1" fmla="*/ 1502385 h 1525676"/>
              <a:gd name="connsiteX2" fmla="*/ 335760 w 1831962"/>
              <a:gd name="connsiteY2" fmla="*/ 1474078 h 1525676"/>
              <a:gd name="connsiteX3" fmla="*/ 460907 w 1831962"/>
              <a:gd name="connsiteY3" fmla="*/ 1414810 h 1525676"/>
              <a:gd name="connsiteX4" fmla="*/ 547160 w 1831962"/>
              <a:gd name="connsiteY4" fmla="*/ 1253943 h 1525676"/>
              <a:gd name="connsiteX5" fmla="*/ 708027 w 1831962"/>
              <a:gd name="connsiteY5" fmla="*/ 635877 h 1525676"/>
              <a:gd name="connsiteX6" fmla="*/ 763060 w 1831962"/>
              <a:gd name="connsiteY6" fmla="*/ 445377 h 1525676"/>
              <a:gd name="connsiteX7" fmla="*/ 815977 w 1831962"/>
              <a:gd name="connsiteY7" fmla="*/ 263344 h 1525676"/>
              <a:gd name="connsiteX8" fmla="*/ 866775 w 1831962"/>
              <a:gd name="connsiteY8" fmla="*/ 123643 h 1525676"/>
              <a:gd name="connsiteX9" fmla="*/ 923928 w 1831962"/>
              <a:gd name="connsiteY9" fmla="*/ 30510 h 1525676"/>
              <a:gd name="connsiteX10" fmla="*/ 1005529 w 1831962"/>
              <a:gd name="connsiteY10" fmla="*/ 27 h 1525676"/>
              <a:gd name="connsiteX11" fmla="*/ 1086911 w 1831962"/>
              <a:gd name="connsiteY11" fmla="*/ 43210 h 1525676"/>
              <a:gd name="connsiteX12" fmla="*/ 1154644 w 1831962"/>
              <a:gd name="connsiteY12" fmla="*/ 185026 h 1525676"/>
              <a:gd name="connsiteX13" fmla="*/ 1211794 w 1831962"/>
              <a:gd name="connsiteY13" fmla="*/ 396694 h 1525676"/>
              <a:gd name="connsiteX14" fmla="*/ 1387478 w 1831962"/>
              <a:gd name="connsiteY14" fmla="*/ 1141760 h 1525676"/>
              <a:gd name="connsiteX15" fmla="*/ 1453094 w 1831962"/>
              <a:gd name="connsiteY15" fmla="*/ 1414810 h 1525676"/>
              <a:gd name="connsiteX16" fmla="*/ 1495427 w 1831962"/>
              <a:gd name="connsiteY16" fmla="*/ 1503710 h 1525676"/>
              <a:gd name="connsiteX17" fmla="*/ 1622427 w 1831962"/>
              <a:gd name="connsiteY17" fmla="*/ 1524877 h 1525676"/>
              <a:gd name="connsiteX18" fmla="*/ 1831962 w 1831962"/>
              <a:gd name="connsiteY18" fmla="*/ 1520796 h 1525676"/>
              <a:gd name="connsiteX0" fmla="*/ 0 w 1831962"/>
              <a:gd name="connsiteY0" fmla="*/ 1516411 h 1526145"/>
              <a:gd name="connsiteX1" fmla="*/ 174637 w 1831962"/>
              <a:gd name="connsiteY1" fmla="*/ 1502385 h 1526145"/>
              <a:gd name="connsiteX2" fmla="*/ 335760 w 1831962"/>
              <a:gd name="connsiteY2" fmla="*/ 1474078 h 1526145"/>
              <a:gd name="connsiteX3" fmla="*/ 460907 w 1831962"/>
              <a:gd name="connsiteY3" fmla="*/ 1414810 h 1526145"/>
              <a:gd name="connsiteX4" fmla="*/ 547160 w 1831962"/>
              <a:gd name="connsiteY4" fmla="*/ 1253943 h 1526145"/>
              <a:gd name="connsiteX5" fmla="*/ 708027 w 1831962"/>
              <a:gd name="connsiteY5" fmla="*/ 635877 h 1526145"/>
              <a:gd name="connsiteX6" fmla="*/ 763060 w 1831962"/>
              <a:gd name="connsiteY6" fmla="*/ 445377 h 1526145"/>
              <a:gd name="connsiteX7" fmla="*/ 815977 w 1831962"/>
              <a:gd name="connsiteY7" fmla="*/ 263344 h 1526145"/>
              <a:gd name="connsiteX8" fmla="*/ 866775 w 1831962"/>
              <a:gd name="connsiteY8" fmla="*/ 123643 h 1526145"/>
              <a:gd name="connsiteX9" fmla="*/ 923928 w 1831962"/>
              <a:gd name="connsiteY9" fmla="*/ 30510 h 1526145"/>
              <a:gd name="connsiteX10" fmla="*/ 1005529 w 1831962"/>
              <a:gd name="connsiteY10" fmla="*/ 27 h 1526145"/>
              <a:gd name="connsiteX11" fmla="*/ 1086911 w 1831962"/>
              <a:gd name="connsiteY11" fmla="*/ 43210 h 1526145"/>
              <a:gd name="connsiteX12" fmla="*/ 1154644 w 1831962"/>
              <a:gd name="connsiteY12" fmla="*/ 185026 h 1526145"/>
              <a:gd name="connsiteX13" fmla="*/ 1211794 w 1831962"/>
              <a:gd name="connsiteY13" fmla="*/ 396694 h 1526145"/>
              <a:gd name="connsiteX14" fmla="*/ 1387478 w 1831962"/>
              <a:gd name="connsiteY14" fmla="*/ 1141760 h 1526145"/>
              <a:gd name="connsiteX15" fmla="*/ 1453094 w 1831962"/>
              <a:gd name="connsiteY15" fmla="*/ 1414810 h 1526145"/>
              <a:gd name="connsiteX16" fmla="*/ 1495427 w 1831962"/>
              <a:gd name="connsiteY16" fmla="*/ 1503710 h 1526145"/>
              <a:gd name="connsiteX17" fmla="*/ 1622427 w 1831962"/>
              <a:gd name="connsiteY17" fmla="*/ 1524877 h 1526145"/>
              <a:gd name="connsiteX18" fmla="*/ 1831962 w 1831962"/>
              <a:gd name="connsiteY18" fmla="*/ 1522988 h 1526145"/>
              <a:gd name="connsiteX0" fmla="*/ 0 w 1831962"/>
              <a:gd name="connsiteY0" fmla="*/ 1516411 h 1526927"/>
              <a:gd name="connsiteX1" fmla="*/ 174637 w 1831962"/>
              <a:gd name="connsiteY1" fmla="*/ 1502385 h 1526927"/>
              <a:gd name="connsiteX2" fmla="*/ 335760 w 1831962"/>
              <a:gd name="connsiteY2" fmla="*/ 1474078 h 1526927"/>
              <a:gd name="connsiteX3" fmla="*/ 460907 w 1831962"/>
              <a:gd name="connsiteY3" fmla="*/ 1414810 h 1526927"/>
              <a:gd name="connsiteX4" fmla="*/ 547160 w 1831962"/>
              <a:gd name="connsiteY4" fmla="*/ 1253943 h 1526927"/>
              <a:gd name="connsiteX5" fmla="*/ 708027 w 1831962"/>
              <a:gd name="connsiteY5" fmla="*/ 635877 h 1526927"/>
              <a:gd name="connsiteX6" fmla="*/ 763060 w 1831962"/>
              <a:gd name="connsiteY6" fmla="*/ 445377 h 1526927"/>
              <a:gd name="connsiteX7" fmla="*/ 815977 w 1831962"/>
              <a:gd name="connsiteY7" fmla="*/ 263344 h 1526927"/>
              <a:gd name="connsiteX8" fmla="*/ 866775 w 1831962"/>
              <a:gd name="connsiteY8" fmla="*/ 123643 h 1526927"/>
              <a:gd name="connsiteX9" fmla="*/ 923928 w 1831962"/>
              <a:gd name="connsiteY9" fmla="*/ 30510 h 1526927"/>
              <a:gd name="connsiteX10" fmla="*/ 1005529 w 1831962"/>
              <a:gd name="connsiteY10" fmla="*/ 27 h 1526927"/>
              <a:gd name="connsiteX11" fmla="*/ 1086911 w 1831962"/>
              <a:gd name="connsiteY11" fmla="*/ 43210 h 1526927"/>
              <a:gd name="connsiteX12" fmla="*/ 1154644 w 1831962"/>
              <a:gd name="connsiteY12" fmla="*/ 185026 h 1526927"/>
              <a:gd name="connsiteX13" fmla="*/ 1211794 w 1831962"/>
              <a:gd name="connsiteY13" fmla="*/ 396694 h 1526927"/>
              <a:gd name="connsiteX14" fmla="*/ 1387478 w 1831962"/>
              <a:gd name="connsiteY14" fmla="*/ 1141760 h 1526927"/>
              <a:gd name="connsiteX15" fmla="*/ 1453094 w 1831962"/>
              <a:gd name="connsiteY15" fmla="*/ 1414810 h 1526927"/>
              <a:gd name="connsiteX16" fmla="*/ 1495427 w 1831962"/>
              <a:gd name="connsiteY16" fmla="*/ 1503710 h 1526927"/>
              <a:gd name="connsiteX17" fmla="*/ 1622427 w 1831962"/>
              <a:gd name="connsiteY17" fmla="*/ 1524877 h 1526927"/>
              <a:gd name="connsiteX18" fmla="*/ 1831962 w 1831962"/>
              <a:gd name="connsiteY18" fmla="*/ 1525181 h 152692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1831962" h="1526927">
                <a:moveTo>
                  <a:pt x="0" y="1516411"/>
                </a:moveTo>
                <a:cubicBezTo>
                  <a:pt x="531" y="1515838"/>
                  <a:pt x="152412" y="1507324"/>
                  <a:pt x="174637" y="1502385"/>
                </a:cubicBezTo>
                <a:cubicBezTo>
                  <a:pt x="196862" y="1497446"/>
                  <a:pt x="288048" y="1488674"/>
                  <a:pt x="335760" y="1474078"/>
                </a:cubicBezTo>
                <a:cubicBezTo>
                  <a:pt x="383472" y="1459482"/>
                  <a:pt x="425674" y="1451499"/>
                  <a:pt x="460907" y="1414810"/>
                </a:cubicBezTo>
                <a:cubicBezTo>
                  <a:pt x="496140" y="1378121"/>
                  <a:pt x="505973" y="1383765"/>
                  <a:pt x="547160" y="1253943"/>
                </a:cubicBezTo>
                <a:cubicBezTo>
                  <a:pt x="588347" y="1124121"/>
                  <a:pt x="672044" y="770638"/>
                  <a:pt x="708027" y="635877"/>
                </a:cubicBezTo>
                <a:cubicBezTo>
                  <a:pt x="744010" y="501116"/>
                  <a:pt x="745068" y="507466"/>
                  <a:pt x="763060" y="445377"/>
                </a:cubicBezTo>
                <a:cubicBezTo>
                  <a:pt x="781052" y="383288"/>
                  <a:pt x="798691" y="316966"/>
                  <a:pt x="815977" y="263344"/>
                </a:cubicBezTo>
                <a:cubicBezTo>
                  <a:pt x="833263" y="209722"/>
                  <a:pt x="848783" y="162449"/>
                  <a:pt x="866775" y="123643"/>
                </a:cubicBezTo>
                <a:cubicBezTo>
                  <a:pt x="884767" y="84837"/>
                  <a:pt x="900802" y="51113"/>
                  <a:pt x="923928" y="30510"/>
                </a:cubicBezTo>
                <a:cubicBezTo>
                  <a:pt x="947054" y="9907"/>
                  <a:pt x="976248" y="732"/>
                  <a:pt x="1005529" y="27"/>
                </a:cubicBezTo>
                <a:cubicBezTo>
                  <a:pt x="1034810" y="-678"/>
                  <a:pt x="1062059" y="12377"/>
                  <a:pt x="1086911" y="43210"/>
                </a:cubicBezTo>
                <a:cubicBezTo>
                  <a:pt x="1111763" y="74043"/>
                  <a:pt x="1133830" y="126112"/>
                  <a:pt x="1154644" y="185026"/>
                </a:cubicBezTo>
                <a:cubicBezTo>
                  <a:pt x="1175458" y="243940"/>
                  <a:pt x="1172988" y="237238"/>
                  <a:pt x="1211794" y="396694"/>
                </a:cubicBezTo>
                <a:cubicBezTo>
                  <a:pt x="1250600" y="556150"/>
                  <a:pt x="1347261" y="972074"/>
                  <a:pt x="1387478" y="1141760"/>
                </a:cubicBezTo>
                <a:cubicBezTo>
                  <a:pt x="1427695" y="1311446"/>
                  <a:pt x="1435103" y="1354485"/>
                  <a:pt x="1453094" y="1414810"/>
                </a:cubicBezTo>
                <a:cubicBezTo>
                  <a:pt x="1471085" y="1475135"/>
                  <a:pt x="1454505" y="1474783"/>
                  <a:pt x="1495427" y="1503710"/>
                </a:cubicBezTo>
                <a:cubicBezTo>
                  <a:pt x="1536349" y="1532637"/>
                  <a:pt x="1566338" y="1521299"/>
                  <a:pt x="1622427" y="1524877"/>
                </a:cubicBezTo>
                <a:cubicBezTo>
                  <a:pt x="1678516" y="1528455"/>
                  <a:pt x="1762117" y="1526541"/>
                  <a:pt x="1831962" y="1525181"/>
                </a:cubicBezTo>
              </a:path>
            </a:pathLst>
          </a:custGeom>
          <a:noFill/>
          <a:ln w="38100">
            <a:solidFill>
              <a:srgbClr val="66FF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2" name="Forma libre 361"/>
          <p:cNvSpPr/>
          <p:nvPr/>
        </p:nvSpPr>
        <p:spPr>
          <a:xfrm flipH="1">
            <a:off x="5876173" y="4609979"/>
            <a:ext cx="1658878" cy="1757337"/>
          </a:xfrm>
          <a:custGeom>
            <a:avLst/>
            <a:gdLst>
              <a:gd name="connsiteX0" fmla="*/ 0 w 1549400"/>
              <a:gd name="connsiteY0" fmla="*/ 1519581 h 1547636"/>
              <a:gd name="connsiteX1" fmla="*/ 169334 w 1549400"/>
              <a:gd name="connsiteY1" fmla="*/ 1443381 h 1547636"/>
              <a:gd name="connsiteX2" fmla="*/ 279400 w 1549400"/>
              <a:gd name="connsiteY2" fmla="*/ 1274047 h 1547636"/>
              <a:gd name="connsiteX3" fmla="*/ 338667 w 1549400"/>
              <a:gd name="connsiteY3" fmla="*/ 1028514 h 1547636"/>
              <a:gd name="connsiteX4" fmla="*/ 389467 w 1549400"/>
              <a:gd name="connsiteY4" fmla="*/ 867647 h 1547636"/>
              <a:gd name="connsiteX5" fmla="*/ 440267 w 1549400"/>
              <a:gd name="connsiteY5" fmla="*/ 655981 h 1547636"/>
              <a:gd name="connsiteX6" fmla="*/ 482600 w 1549400"/>
              <a:gd name="connsiteY6" fmla="*/ 452781 h 1547636"/>
              <a:gd name="connsiteX7" fmla="*/ 524934 w 1549400"/>
              <a:gd name="connsiteY7" fmla="*/ 249581 h 1547636"/>
              <a:gd name="connsiteX8" fmla="*/ 567267 w 1549400"/>
              <a:gd name="connsiteY8" fmla="*/ 139514 h 1547636"/>
              <a:gd name="connsiteX9" fmla="*/ 668867 w 1549400"/>
              <a:gd name="connsiteY9" fmla="*/ 12514 h 1547636"/>
              <a:gd name="connsiteX10" fmla="*/ 829734 w 1549400"/>
              <a:gd name="connsiteY10" fmla="*/ 20981 h 1547636"/>
              <a:gd name="connsiteX11" fmla="*/ 897467 w 1549400"/>
              <a:gd name="connsiteY11" fmla="*/ 156447 h 1547636"/>
              <a:gd name="connsiteX12" fmla="*/ 948267 w 1549400"/>
              <a:gd name="connsiteY12" fmla="*/ 393514 h 1547636"/>
              <a:gd name="connsiteX13" fmla="*/ 1134534 w 1549400"/>
              <a:gd name="connsiteY13" fmla="*/ 1155514 h 1547636"/>
              <a:gd name="connsiteX14" fmla="*/ 1185334 w 1549400"/>
              <a:gd name="connsiteY14" fmla="*/ 1434914 h 1547636"/>
              <a:gd name="connsiteX15" fmla="*/ 1219200 w 1549400"/>
              <a:gd name="connsiteY15" fmla="*/ 1536514 h 1547636"/>
              <a:gd name="connsiteX16" fmla="*/ 1354667 w 1549400"/>
              <a:gd name="connsiteY16" fmla="*/ 1544981 h 1547636"/>
              <a:gd name="connsiteX17" fmla="*/ 1549400 w 1549400"/>
              <a:gd name="connsiteY17" fmla="*/ 1536514 h 1547636"/>
              <a:gd name="connsiteX18" fmla="*/ 1549400 w 1549400"/>
              <a:gd name="connsiteY18" fmla="*/ 1536514 h 1547636"/>
              <a:gd name="connsiteX19" fmla="*/ 1549400 w 1549400"/>
              <a:gd name="connsiteY19" fmla="*/ 1536514 h 1547636"/>
              <a:gd name="connsiteX0" fmla="*/ 0 w 1549400"/>
              <a:gd name="connsiteY0" fmla="*/ 1519581 h 1547636"/>
              <a:gd name="connsiteX1" fmla="*/ 169334 w 1549400"/>
              <a:gd name="connsiteY1" fmla="*/ 1443381 h 1547636"/>
              <a:gd name="connsiteX2" fmla="*/ 279400 w 1549400"/>
              <a:gd name="connsiteY2" fmla="*/ 1274047 h 1547636"/>
              <a:gd name="connsiteX3" fmla="*/ 338667 w 1549400"/>
              <a:gd name="connsiteY3" fmla="*/ 1028514 h 1547636"/>
              <a:gd name="connsiteX4" fmla="*/ 440267 w 1549400"/>
              <a:gd name="connsiteY4" fmla="*/ 655981 h 1547636"/>
              <a:gd name="connsiteX5" fmla="*/ 482600 w 1549400"/>
              <a:gd name="connsiteY5" fmla="*/ 452781 h 1547636"/>
              <a:gd name="connsiteX6" fmla="*/ 524934 w 1549400"/>
              <a:gd name="connsiteY6" fmla="*/ 249581 h 1547636"/>
              <a:gd name="connsiteX7" fmla="*/ 567267 w 1549400"/>
              <a:gd name="connsiteY7" fmla="*/ 139514 h 1547636"/>
              <a:gd name="connsiteX8" fmla="*/ 668867 w 1549400"/>
              <a:gd name="connsiteY8" fmla="*/ 12514 h 1547636"/>
              <a:gd name="connsiteX9" fmla="*/ 829734 w 1549400"/>
              <a:gd name="connsiteY9" fmla="*/ 20981 h 1547636"/>
              <a:gd name="connsiteX10" fmla="*/ 897467 w 1549400"/>
              <a:gd name="connsiteY10" fmla="*/ 156447 h 1547636"/>
              <a:gd name="connsiteX11" fmla="*/ 948267 w 1549400"/>
              <a:gd name="connsiteY11" fmla="*/ 393514 h 1547636"/>
              <a:gd name="connsiteX12" fmla="*/ 1134534 w 1549400"/>
              <a:gd name="connsiteY12" fmla="*/ 1155514 h 1547636"/>
              <a:gd name="connsiteX13" fmla="*/ 1185334 w 1549400"/>
              <a:gd name="connsiteY13" fmla="*/ 1434914 h 1547636"/>
              <a:gd name="connsiteX14" fmla="*/ 1219200 w 1549400"/>
              <a:gd name="connsiteY14" fmla="*/ 1536514 h 1547636"/>
              <a:gd name="connsiteX15" fmla="*/ 1354667 w 1549400"/>
              <a:gd name="connsiteY15" fmla="*/ 1544981 h 1547636"/>
              <a:gd name="connsiteX16" fmla="*/ 1549400 w 1549400"/>
              <a:gd name="connsiteY16" fmla="*/ 1536514 h 1547636"/>
              <a:gd name="connsiteX17" fmla="*/ 1549400 w 1549400"/>
              <a:gd name="connsiteY17" fmla="*/ 1536514 h 1547636"/>
              <a:gd name="connsiteX18" fmla="*/ 1549400 w 1549400"/>
              <a:gd name="connsiteY18" fmla="*/ 1536514 h 1547636"/>
              <a:gd name="connsiteX0" fmla="*/ 0 w 1549400"/>
              <a:gd name="connsiteY0" fmla="*/ 1519581 h 1547636"/>
              <a:gd name="connsiteX1" fmla="*/ 169334 w 1549400"/>
              <a:gd name="connsiteY1" fmla="*/ 1443381 h 1547636"/>
              <a:gd name="connsiteX2" fmla="*/ 279400 w 1549400"/>
              <a:gd name="connsiteY2" fmla="*/ 1274047 h 1547636"/>
              <a:gd name="connsiteX3" fmla="*/ 440267 w 1549400"/>
              <a:gd name="connsiteY3" fmla="*/ 655981 h 1547636"/>
              <a:gd name="connsiteX4" fmla="*/ 482600 w 1549400"/>
              <a:gd name="connsiteY4" fmla="*/ 452781 h 1547636"/>
              <a:gd name="connsiteX5" fmla="*/ 524934 w 1549400"/>
              <a:gd name="connsiteY5" fmla="*/ 249581 h 1547636"/>
              <a:gd name="connsiteX6" fmla="*/ 567267 w 1549400"/>
              <a:gd name="connsiteY6" fmla="*/ 139514 h 1547636"/>
              <a:gd name="connsiteX7" fmla="*/ 668867 w 1549400"/>
              <a:gd name="connsiteY7" fmla="*/ 12514 h 1547636"/>
              <a:gd name="connsiteX8" fmla="*/ 829734 w 1549400"/>
              <a:gd name="connsiteY8" fmla="*/ 20981 h 1547636"/>
              <a:gd name="connsiteX9" fmla="*/ 897467 w 1549400"/>
              <a:gd name="connsiteY9" fmla="*/ 156447 h 1547636"/>
              <a:gd name="connsiteX10" fmla="*/ 948267 w 1549400"/>
              <a:gd name="connsiteY10" fmla="*/ 393514 h 1547636"/>
              <a:gd name="connsiteX11" fmla="*/ 1134534 w 1549400"/>
              <a:gd name="connsiteY11" fmla="*/ 1155514 h 1547636"/>
              <a:gd name="connsiteX12" fmla="*/ 1185334 w 1549400"/>
              <a:gd name="connsiteY12" fmla="*/ 1434914 h 1547636"/>
              <a:gd name="connsiteX13" fmla="*/ 1219200 w 1549400"/>
              <a:gd name="connsiteY13" fmla="*/ 1536514 h 1547636"/>
              <a:gd name="connsiteX14" fmla="*/ 1354667 w 1549400"/>
              <a:gd name="connsiteY14" fmla="*/ 1544981 h 1547636"/>
              <a:gd name="connsiteX15" fmla="*/ 1549400 w 1549400"/>
              <a:gd name="connsiteY15" fmla="*/ 1536514 h 1547636"/>
              <a:gd name="connsiteX16" fmla="*/ 1549400 w 1549400"/>
              <a:gd name="connsiteY16" fmla="*/ 1536514 h 1547636"/>
              <a:gd name="connsiteX17" fmla="*/ 1549400 w 1549400"/>
              <a:gd name="connsiteY17" fmla="*/ 1536514 h 1547636"/>
              <a:gd name="connsiteX0" fmla="*/ 0 w 1617133"/>
              <a:gd name="connsiteY0" fmla="*/ 1519581 h 1547636"/>
              <a:gd name="connsiteX1" fmla="*/ 237067 w 1617133"/>
              <a:gd name="connsiteY1" fmla="*/ 1443381 h 1547636"/>
              <a:gd name="connsiteX2" fmla="*/ 347133 w 1617133"/>
              <a:gd name="connsiteY2" fmla="*/ 1274047 h 1547636"/>
              <a:gd name="connsiteX3" fmla="*/ 508000 w 1617133"/>
              <a:gd name="connsiteY3" fmla="*/ 655981 h 1547636"/>
              <a:gd name="connsiteX4" fmla="*/ 550333 w 1617133"/>
              <a:gd name="connsiteY4" fmla="*/ 452781 h 1547636"/>
              <a:gd name="connsiteX5" fmla="*/ 592667 w 1617133"/>
              <a:gd name="connsiteY5" fmla="*/ 249581 h 1547636"/>
              <a:gd name="connsiteX6" fmla="*/ 635000 w 1617133"/>
              <a:gd name="connsiteY6" fmla="*/ 139514 h 1547636"/>
              <a:gd name="connsiteX7" fmla="*/ 736600 w 1617133"/>
              <a:gd name="connsiteY7" fmla="*/ 12514 h 1547636"/>
              <a:gd name="connsiteX8" fmla="*/ 897467 w 1617133"/>
              <a:gd name="connsiteY8" fmla="*/ 20981 h 1547636"/>
              <a:gd name="connsiteX9" fmla="*/ 965200 w 1617133"/>
              <a:gd name="connsiteY9" fmla="*/ 156447 h 1547636"/>
              <a:gd name="connsiteX10" fmla="*/ 1016000 w 1617133"/>
              <a:gd name="connsiteY10" fmla="*/ 393514 h 1547636"/>
              <a:gd name="connsiteX11" fmla="*/ 1202267 w 1617133"/>
              <a:gd name="connsiteY11" fmla="*/ 1155514 h 1547636"/>
              <a:gd name="connsiteX12" fmla="*/ 1253067 w 1617133"/>
              <a:gd name="connsiteY12" fmla="*/ 1434914 h 1547636"/>
              <a:gd name="connsiteX13" fmla="*/ 1286933 w 1617133"/>
              <a:gd name="connsiteY13" fmla="*/ 1536514 h 1547636"/>
              <a:gd name="connsiteX14" fmla="*/ 1422400 w 1617133"/>
              <a:gd name="connsiteY14" fmla="*/ 1544981 h 1547636"/>
              <a:gd name="connsiteX15" fmla="*/ 1617133 w 1617133"/>
              <a:gd name="connsiteY15" fmla="*/ 1536514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0" fmla="*/ 0 w 1617133"/>
              <a:gd name="connsiteY0" fmla="*/ 1519581 h 1547636"/>
              <a:gd name="connsiteX1" fmla="*/ 127001 w 1617133"/>
              <a:gd name="connsiteY1" fmla="*/ 1485714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2667 w 1617133"/>
              <a:gd name="connsiteY6" fmla="*/ 2495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2667 w 1617133"/>
              <a:gd name="connsiteY6" fmla="*/ 2495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2667 w 1617133"/>
              <a:gd name="connsiteY6" fmla="*/ 2495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6900 w 1617133"/>
              <a:gd name="connsiteY6" fmla="*/ 272864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6900 w 1617133"/>
              <a:gd name="connsiteY6" fmla="*/ 272864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6900 w 1617133"/>
              <a:gd name="connsiteY6" fmla="*/ 272864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609600 w 1617133"/>
              <a:gd name="connsiteY6" fmla="*/ 2749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63033 w 1617133"/>
              <a:gd name="connsiteY5" fmla="*/ 465481 h 1547636"/>
              <a:gd name="connsiteX6" fmla="*/ 609600 w 1617133"/>
              <a:gd name="connsiteY6" fmla="*/ 2749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729 h 1547784"/>
              <a:gd name="connsiteX1" fmla="*/ 133351 w 1617133"/>
              <a:gd name="connsiteY1" fmla="*/ 1490096 h 1547784"/>
              <a:gd name="connsiteX2" fmla="*/ 237067 w 1617133"/>
              <a:gd name="connsiteY2" fmla="*/ 1443529 h 1547784"/>
              <a:gd name="connsiteX3" fmla="*/ 347133 w 1617133"/>
              <a:gd name="connsiteY3" fmla="*/ 1274195 h 1547784"/>
              <a:gd name="connsiteX4" fmla="*/ 508000 w 1617133"/>
              <a:gd name="connsiteY4" fmla="*/ 656129 h 1547784"/>
              <a:gd name="connsiteX5" fmla="*/ 563033 w 1617133"/>
              <a:gd name="connsiteY5" fmla="*/ 465629 h 1547784"/>
              <a:gd name="connsiteX6" fmla="*/ 609600 w 1617133"/>
              <a:gd name="connsiteY6" fmla="*/ 275129 h 1547784"/>
              <a:gd name="connsiteX7" fmla="*/ 647700 w 1617133"/>
              <a:gd name="connsiteY7" fmla="*/ 141778 h 1547784"/>
              <a:gd name="connsiteX8" fmla="*/ 736600 w 1617133"/>
              <a:gd name="connsiteY8" fmla="*/ 12662 h 1547784"/>
              <a:gd name="connsiteX9" fmla="*/ 897467 w 1617133"/>
              <a:gd name="connsiteY9" fmla="*/ 21129 h 1547784"/>
              <a:gd name="connsiteX10" fmla="*/ 965200 w 1617133"/>
              <a:gd name="connsiteY10" fmla="*/ 156595 h 1547784"/>
              <a:gd name="connsiteX11" fmla="*/ 1016000 w 1617133"/>
              <a:gd name="connsiteY11" fmla="*/ 393662 h 1547784"/>
              <a:gd name="connsiteX12" fmla="*/ 1202267 w 1617133"/>
              <a:gd name="connsiteY12" fmla="*/ 1155662 h 1547784"/>
              <a:gd name="connsiteX13" fmla="*/ 1253067 w 1617133"/>
              <a:gd name="connsiteY13" fmla="*/ 1435062 h 1547784"/>
              <a:gd name="connsiteX14" fmla="*/ 1286933 w 1617133"/>
              <a:gd name="connsiteY14" fmla="*/ 1536662 h 1547784"/>
              <a:gd name="connsiteX15" fmla="*/ 1422400 w 1617133"/>
              <a:gd name="connsiteY15" fmla="*/ 1545129 h 1547784"/>
              <a:gd name="connsiteX16" fmla="*/ 1617133 w 1617133"/>
              <a:gd name="connsiteY16" fmla="*/ 1536662 h 1547784"/>
              <a:gd name="connsiteX17" fmla="*/ 1617133 w 1617133"/>
              <a:gd name="connsiteY17" fmla="*/ 1536662 h 1547784"/>
              <a:gd name="connsiteX18" fmla="*/ 1617133 w 1617133"/>
              <a:gd name="connsiteY18" fmla="*/ 1536662 h 1547784"/>
              <a:gd name="connsiteX0" fmla="*/ 0 w 1617133"/>
              <a:gd name="connsiteY0" fmla="*/ 1519582 h 1547637"/>
              <a:gd name="connsiteX1" fmla="*/ 133351 w 1617133"/>
              <a:gd name="connsiteY1" fmla="*/ 1489949 h 1547637"/>
              <a:gd name="connsiteX2" fmla="*/ 237067 w 1617133"/>
              <a:gd name="connsiteY2" fmla="*/ 1443382 h 1547637"/>
              <a:gd name="connsiteX3" fmla="*/ 347133 w 1617133"/>
              <a:gd name="connsiteY3" fmla="*/ 1274048 h 1547637"/>
              <a:gd name="connsiteX4" fmla="*/ 508000 w 1617133"/>
              <a:gd name="connsiteY4" fmla="*/ 655982 h 1547637"/>
              <a:gd name="connsiteX5" fmla="*/ 563033 w 1617133"/>
              <a:gd name="connsiteY5" fmla="*/ 465482 h 1547637"/>
              <a:gd name="connsiteX6" fmla="*/ 609600 w 1617133"/>
              <a:gd name="connsiteY6" fmla="*/ 274982 h 1547637"/>
              <a:gd name="connsiteX7" fmla="*/ 649816 w 1617133"/>
              <a:gd name="connsiteY7" fmla="*/ 139515 h 1547637"/>
              <a:gd name="connsiteX8" fmla="*/ 736600 w 1617133"/>
              <a:gd name="connsiteY8" fmla="*/ 12515 h 1547637"/>
              <a:gd name="connsiteX9" fmla="*/ 897467 w 1617133"/>
              <a:gd name="connsiteY9" fmla="*/ 20982 h 1547637"/>
              <a:gd name="connsiteX10" fmla="*/ 965200 w 1617133"/>
              <a:gd name="connsiteY10" fmla="*/ 156448 h 1547637"/>
              <a:gd name="connsiteX11" fmla="*/ 1016000 w 1617133"/>
              <a:gd name="connsiteY11" fmla="*/ 393515 h 1547637"/>
              <a:gd name="connsiteX12" fmla="*/ 1202267 w 1617133"/>
              <a:gd name="connsiteY12" fmla="*/ 1155515 h 1547637"/>
              <a:gd name="connsiteX13" fmla="*/ 1253067 w 1617133"/>
              <a:gd name="connsiteY13" fmla="*/ 1434915 h 1547637"/>
              <a:gd name="connsiteX14" fmla="*/ 1286933 w 1617133"/>
              <a:gd name="connsiteY14" fmla="*/ 1536515 h 1547637"/>
              <a:gd name="connsiteX15" fmla="*/ 1422400 w 1617133"/>
              <a:gd name="connsiteY15" fmla="*/ 1544982 h 1547637"/>
              <a:gd name="connsiteX16" fmla="*/ 1617133 w 1617133"/>
              <a:gd name="connsiteY16" fmla="*/ 1536515 h 1547637"/>
              <a:gd name="connsiteX17" fmla="*/ 1617133 w 1617133"/>
              <a:gd name="connsiteY17" fmla="*/ 1536515 h 1547637"/>
              <a:gd name="connsiteX18" fmla="*/ 1617133 w 1617133"/>
              <a:gd name="connsiteY18" fmla="*/ 1536515 h 1547637"/>
              <a:gd name="connsiteX0" fmla="*/ 0 w 1617133"/>
              <a:gd name="connsiteY0" fmla="*/ 1519286 h 1547341"/>
              <a:gd name="connsiteX1" fmla="*/ 133351 w 1617133"/>
              <a:gd name="connsiteY1" fmla="*/ 1489653 h 1547341"/>
              <a:gd name="connsiteX2" fmla="*/ 237067 w 1617133"/>
              <a:gd name="connsiteY2" fmla="*/ 1443086 h 1547341"/>
              <a:gd name="connsiteX3" fmla="*/ 347133 w 1617133"/>
              <a:gd name="connsiteY3" fmla="*/ 1273752 h 1547341"/>
              <a:gd name="connsiteX4" fmla="*/ 508000 w 1617133"/>
              <a:gd name="connsiteY4" fmla="*/ 655686 h 1547341"/>
              <a:gd name="connsiteX5" fmla="*/ 563033 w 1617133"/>
              <a:gd name="connsiteY5" fmla="*/ 465186 h 1547341"/>
              <a:gd name="connsiteX6" fmla="*/ 609600 w 1617133"/>
              <a:gd name="connsiteY6" fmla="*/ 274686 h 1547341"/>
              <a:gd name="connsiteX7" fmla="*/ 651932 w 1617133"/>
              <a:gd name="connsiteY7" fmla="*/ 134985 h 1547341"/>
              <a:gd name="connsiteX8" fmla="*/ 736600 w 1617133"/>
              <a:gd name="connsiteY8" fmla="*/ 12219 h 1547341"/>
              <a:gd name="connsiteX9" fmla="*/ 897467 w 1617133"/>
              <a:gd name="connsiteY9" fmla="*/ 20686 h 1547341"/>
              <a:gd name="connsiteX10" fmla="*/ 965200 w 1617133"/>
              <a:gd name="connsiteY10" fmla="*/ 156152 h 1547341"/>
              <a:gd name="connsiteX11" fmla="*/ 1016000 w 1617133"/>
              <a:gd name="connsiteY11" fmla="*/ 393219 h 1547341"/>
              <a:gd name="connsiteX12" fmla="*/ 1202267 w 1617133"/>
              <a:gd name="connsiteY12" fmla="*/ 1155219 h 1547341"/>
              <a:gd name="connsiteX13" fmla="*/ 1253067 w 1617133"/>
              <a:gd name="connsiteY13" fmla="*/ 1434619 h 1547341"/>
              <a:gd name="connsiteX14" fmla="*/ 1286933 w 1617133"/>
              <a:gd name="connsiteY14" fmla="*/ 1536219 h 1547341"/>
              <a:gd name="connsiteX15" fmla="*/ 1422400 w 1617133"/>
              <a:gd name="connsiteY15" fmla="*/ 1544686 h 1547341"/>
              <a:gd name="connsiteX16" fmla="*/ 1617133 w 1617133"/>
              <a:gd name="connsiteY16" fmla="*/ 1536219 h 1547341"/>
              <a:gd name="connsiteX17" fmla="*/ 1617133 w 1617133"/>
              <a:gd name="connsiteY17" fmla="*/ 1536219 h 1547341"/>
              <a:gd name="connsiteX18" fmla="*/ 1617133 w 1617133"/>
              <a:gd name="connsiteY18" fmla="*/ 1536219 h 1547341"/>
              <a:gd name="connsiteX0" fmla="*/ 0 w 1617133"/>
              <a:gd name="connsiteY0" fmla="*/ 1513144 h 1541199"/>
              <a:gd name="connsiteX1" fmla="*/ 133351 w 1617133"/>
              <a:gd name="connsiteY1" fmla="*/ 1483511 h 1541199"/>
              <a:gd name="connsiteX2" fmla="*/ 237067 w 1617133"/>
              <a:gd name="connsiteY2" fmla="*/ 1436944 h 1541199"/>
              <a:gd name="connsiteX3" fmla="*/ 347133 w 1617133"/>
              <a:gd name="connsiteY3" fmla="*/ 1267610 h 1541199"/>
              <a:gd name="connsiteX4" fmla="*/ 508000 w 1617133"/>
              <a:gd name="connsiteY4" fmla="*/ 649544 h 1541199"/>
              <a:gd name="connsiteX5" fmla="*/ 563033 w 1617133"/>
              <a:gd name="connsiteY5" fmla="*/ 459044 h 1541199"/>
              <a:gd name="connsiteX6" fmla="*/ 609600 w 1617133"/>
              <a:gd name="connsiteY6" fmla="*/ 268544 h 1541199"/>
              <a:gd name="connsiteX7" fmla="*/ 651932 w 1617133"/>
              <a:gd name="connsiteY7" fmla="*/ 128843 h 1541199"/>
              <a:gd name="connsiteX8" fmla="*/ 751417 w 1617133"/>
              <a:gd name="connsiteY8" fmla="*/ 16661 h 1541199"/>
              <a:gd name="connsiteX9" fmla="*/ 897467 w 1617133"/>
              <a:gd name="connsiteY9" fmla="*/ 14544 h 1541199"/>
              <a:gd name="connsiteX10" fmla="*/ 965200 w 1617133"/>
              <a:gd name="connsiteY10" fmla="*/ 150010 h 1541199"/>
              <a:gd name="connsiteX11" fmla="*/ 1016000 w 1617133"/>
              <a:gd name="connsiteY11" fmla="*/ 387077 h 1541199"/>
              <a:gd name="connsiteX12" fmla="*/ 1202267 w 1617133"/>
              <a:gd name="connsiteY12" fmla="*/ 1149077 h 1541199"/>
              <a:gd name="connsiteX13" fmla="*/ 1253067 w 1617133"/>
              <a:gd name="connsiteY13" fmla="*/ 1428477 h 1541199"/>
              <a:gd name="connsiteX14" fmla="*/ 1286933 w 1617133"/>
              <a:gd name="connsiteY14" fmla="*/ 1530077 h 1541199"/>
              <a:gd name="connsiteX15" fmla="*/ 1422400 w 1617133"/>
              <a:gd name="connsiteY15" fmla="*/ 1538544 h 1541199"/>
              <a:gd name="connsiteX16" fmla="*/ 1617133 w 1617133"/>
              <a:gd name="connsiteY16" fmla="*/ 1530077 h 1541199"/>
              <a:gd name="connsiteX17" fmla="*/ 1617133 w 1617133"/>
              <a:gd name="connsiteY17" fmla="*/ 1530077 h 1541199"/>
              <a:gd name="connsiteX18" fmla="*/ 1617133 w 1617133"/>
              <a:gd name="connsiteY18" fmla="*/ 1530077 h 1541199"/>
              <a:gd name="connsiteX0" fmla="*/ 0 w 1617133"/>
              <a:gd name="connsiteY0" fmla="*/ 1510639 h 1538694"/>
              <a:gd name="connsiteX1" fmla="*/ 133351 w 1617133"/>
              <a:gd name="connsiteY1" fmla="*/ 1481006 h 1538694"/>
              <a:gd name="connsiteX2" fmla="*/ 237067 w 1617133"/>
              <a:gd name="connsiteY2" fmla="*/ 1434439 h 1538694"/>
              <a:gd name="connsiteX3" fmla="*/ 347133 w 1617133"/>
              <a:gd name="connsiteY3" fmla="*/ 1265105 h 1538694"/>
              <a:gd name="connsiteX4" fmla="*/ 508000 w 1617133"/>
              <a:gd name="connsiteY4" fmla="*/ 647039 h 1538694"/>
              <a:gd name="connsiteX5" fmla="*/ 563033 w 1617133"/>
              <a:gd name="connsiteY5" fmla="*/ 456539 h 1538694"/>
              <a:gd name="connsiteX6" fmla="*/ 609600 w 1617133"/>
              <a:gd name="connsiteY6" fmla="*/ 266039 h 1538694"/>
              <a:gd name="connsiteX7" fmla="*/ 651932 w 1617133"/>
              <a:gd name="connsiteY7" fmla="*/ 126338 h 1538694"/>
              <a:gd name="connsiteX8" fmla="*/ 751417 w 1617133"/>
              <a:gd name="connsiteY8" fmla="*/ 14156 h 1538694"/>
              <a:gd name="connsiteX9" fmla="*/ 895351 w 1617133"/>
              <a:gd name="connsiteY9" fmla="*/ 16272 h 1538694"/>
              <a:gd name="connsiteX10" fmla="*/ 965200 w 1617133"/>
              <a:gd name="connsiteY10" fmla="*/ 147505 h 1538694"/>
              <a:gd name="connsiteX11" fmla="*/ 1016000 w 1617133"/>
              <a:gd name="connsiteY11" fmla="*/ 384572 h 1538694"/>
              <a:gd name="connsiteX12" fmla="*/ 1202267 w 1617133"/>
              <a:gd name="connsiteY12" fmla="*/ 1146572 h 1538694"/>
              <a:gd name="connsiteX13" fmla="*/ 1253067 w 1617133"/>
              <a:gd name="connsiteY13" fmla="*/ 1425972 h 1538694"/>
              <a:gd name="connsiteX14" fmla="*/ 1286933 w 1617133"/>
              <a:gd name="connsiteY14" fmla="*/ 1527572 h 1538694"/>
              <a:gd name="connsiteX15" fmla="*/ 1422400 w 1617133"/>
              <a:gd name="connsiteY15" fmla="*/ 1536039 h 1538694"/>
              <a:gd name="connsiteX16" fmla="*/ 1617133 w 1617133"/>
              <a:gd name="connsiteY16" fmla="*/ 1527572 h 1538694"/>
              <a:gd name="connsiteX17" fmla="*/ 1617133 w 1617133"/>
              <a:gd name="connsiteY17" fmla="*/ 1527572 h 1538694"/>
              <a:gd name="connsiteX18" fmla="*/ 1617133 w 1617133"/>
              <a:gd name="connsiteY18" fmla="*/ 1527572 h 1538694"/>
              <a:gd name="connsiteX0" fmla="*/ 0 w 1617133"/>
              <a:gd name="connsiteY0" fmla="*/ 1512257 h 1540312"/>
              <a:gd name="connsiteX1" fmla="*/ 133351 w 1617133"/>
              <a:gd name="connsiteY1" fmla="*/ 1482624 h 1540312"/>
              <a:gd name="connsiteX2" fmla="*/ 237067 w 1617133"/>
              <a:gd name="connsiteY2" fmla="*/ 1436057 h 1540312"/>
              <a:gd name="connsiteX3" fmla="*/ 347133 w 1617133"/>
              <a:gd name="connsiteY3" fmla="*/ 1266723 h 1540312"/>
              <a:gd name="connsiteX4" fmla="*/ 508000 w 1617133"/>
              <a:gd name="connsiteY4" fmla="*/ 648657 h 1540312"/>
              <a:gd name="connsiteX5" fmla="*/ 563033 w 1617133"/>
              <a:gd name="connsiteY5" fmla="*/ 458157 h 1540312"/>
              <a:gd name="connsiteX6" fmla="*/ 609600 w 1617133"/>
              <a:gd name="connsiteY6" fmla="*/ 267657 h 1540312"/>
              <a:gd name="connsiteX7" fmla="*/ 651932 w 1617133"/>
              <a:gd name="connsiteY7" fmla="*/ 127956 h 1540312"/>
              <a:gd name="connsiteX8" fmla="*/ 751417 w 1617133"/>
              <a:gd name="connsiteY8" fmla="*/ 15774 h 1540312"/>
              <a:gd name="connsiteX9" fmla="*/ 895351 w 1617133"/>
              <a:gd name="connsiteY9" fmla="*/ 17890 h 1540312"/>
              <a:gd name="connsiteX10" fmla="*/ 965200 w 1617133"/>
              <a:gd name="connsiteY10" fmla="*/ 149123 h 1540312"/>
              <a:gd name="connsiteX11" fmla="*/ 1016000 w 1617133"/>
              <a:gd name="connsiteY11" fmla="*/ 386190 h 1540312"/>
              <a:gd name="connsiteX12" fmla="*/ 1202267 w 1617133"/>
              <a:gd name="connsiteY12" fmla="*/ 1148190 h 1540312"/>
              <a:gd name="connsiteX13" fmla="*/ 1253067 w 1617133"/>
              <a:gd name="connsiteY13" fmla="*/ 1427590 h 1540312"/>
              <a:gd name="connsiteX14" fmla="*/ 1286933 w 1617133"/>
              <a:gd name="connsiteY14" fmla="*/ 1529190 h 1540312"/>
              <a:gd name="connsiteX15" fmla="*/ 1422400 w 1617133"/>
              <a:gd name="connsiteY15" fmla="*/ 1537657 h 1540312"/>
              <a:gd name="connsiteX16" fmla="*/ 1617133 w 1617133"/>
              <a:gd name="connsiteY16" fmla="*/ 1529190 h 1540312"/>
              <a:gd name="connsiteX17" fmla="*/ 1617133 w 1617133"/>
              <a:gd name="connsiteY17" fmla="*/ 1529190 h 1540312"/>
              <a:gd name="connsiteX18" fmla="*/ 1617133 w 1617133"/>
              <a:gd name="connsiteY18" fmla="*/ 1529190 h 1540312"/>
              <a:gd name="connsiteX0" fmla="*/ 0 w 1617133"/>
              <a:gd name="connsiteY0" fmla="*/ 1502989 h 1531044"/>
              <a:gd name="connsiteX1" fmla="*/ 133351 w 1617133"/>
              <a:gd name="connsiteY1" fmla="*/ 1473356 h 1531044"/>
              <a:gd name="connsiteX2" fmla="*/ 237067 w 1617133"/>
              <a:gd name="connsiteY2" fmla="*/ 1426789 h 1531044"/>
              <a:gd name="connsiteX3" fmla="*/ 347133 w 1617133"/>
              <a:gd name="connsiteY3" fmla="*/ 1257455 h 1531044"/>
              <a:gd name="connsiteX4" fmla="*/ 508000 w 1617133"/>
              <a:gd name="connsiteY4" fmla="*/ 639389 h 1531044"/>
              <a:gd name="connsiteX5" fmla="*/ 563033 w 1617133"/>
              <a:gd name="connsiteY5" fmla="*/ 448889 h 1531044"/>
              <a:gd name="connsiteX6" fmla="*/ 609600 w 1617133"/>
              <a:gd name="connsiteY6" fmla="*/ 258389 h 1531044"/>
              <a:gd name="connsiteX7" fmla="*/ 651932 w 1617133"/>
              <a:gd name="connsiteY7" fmla="*/ 118688 h 1531044"/>
              <a:gd name="connsiteX8" fmla="*/ 751417 w 1617133"/>
              <a:gd name="connsiteY8" fmla="*/ 6506 h 1531044"/>
              <a:gd name="connsiteX9" fmla="*/ 889001 w 1617133"/>
              <a:gd name="connsiteY9" fmla="*/ 29789 h 1531044"/>
              <a:gd name="connsiteX10" fmla="*/ 965200 w 1617133"/>
              <a:gd name="connsiteY10" fmla="*/ 139855 h 1531044"/>
              <a:gd name="connsiteX11" fmla="*/ 1016000 w 1617133"/>
              <a:gd name="connsiteY11" fmla="*/ 376922 h 1531044"/>
              <a:gd name="connsiteX12" fmla="*/ 1202267 w 1617133"/>
              <a:gd name="connsiteY12" fmla="*/ 1138922 h 1531044"/>
              <a:gd name="connsiteX13" fmla="*/ 1253067 w 1617133"/>
              <a:gd name="connsiteY13" fmla="*/ 1418322 h 1531044"/>
              <a:gd name="connsiteX14" fmla="*/ 1286933 w 1617133"/>
              <a:gd name="connsiteY14" fmla="*/ 1519922 h 1531044"/>
              <a:gd name="connsiteX15" fmla="*/ 1422400 w 1617133"/>
              <a:gd name="connsiteY15" fmla="*/ 1528389 h 1531044"/>
              <a:gd name="connsiteX16" fmla="*/ 1617133 w 1617133"/>
              <a:gd name="connsiteY16" fmla="*/ 1519922 h 1531044"/>
              <a:gd name="connsiteX17" fmla="*/ 1617133 w 1617133"/>
              <a:gd name="connsiteY17" fmla="*/ 1519922 h 1531044"/>
              <a:gd name="connsiteX18" fmla="*/ 1617133 w 1617133"/>
              <a:gd name="connsiteY18" fmla="*/ 1519922 h 1531044"/>
              <a:gd name="connsiteX0" fmla="*/ 0 w 1617133"/>
              <a:gd name="connsiteY0" fmla="*/ 1483612 h 1511667"/>
              <a:gd name="connsiteX1" fmla="*/ 133351 w 1617133"/>
              <a:gd name="connsiteY1" fmla="*/ 1453979 h 1511667"/>
              <a:gd name="connsiteX2" fmla="*/ 237067 w 1617133"/>
              <a:gd name="connsiteY2" fmla="*/ 1407412 h 1511667"/>
              <a:gd name="connsiteX3" fmla="*/ 347133 w 1617133"/>
              <a:gd name="connsiteY3" fmla="*/ 1238078 h 1511667"/>
              <a:gd name="connsiteX4" fmla="*/ 508000 w 1617133"/>
              <a:gd name="connsiteY4" fmla="*/ 620012 h 1511667"/>
              <a:gd name="connsiteX5" fmla="*/ 563033 w 1617133"/>
              <a:gd name="connsiteY5" fmla="*/ 429512 h 1511667"/>
              <a:gd name="connsiteX6" fmla="*/ 609600 w 1617133"/>
              <a:gd name="connsiteY6" fmla="*/ 239012 h 1511667"/>
              <a:gd name="connsiteX7" fmla="*/ 651932 w 1617133"/>
              <a:gd name="connsiteY7" fmla="*/ 99311 h 1511667"/>
              <a:gd name="connsiteX8" fmla="*/ 713317 w 1617133"/>
              <a:gd name="connsiteY8" fmla="*/ 14645 h 1511667"/>
              <a:gd name="connsiteX9" fmla="*/ 889001 w 1617133"/>
              <a:gd name="connsiteY9" fmla="*/ 10412 h 1511667"/>
              <a:gd name="connsiteX10" fmla="*/ 965200 w 1617133"/>
              <a:gd name="connsiteY10" fmla="*/ 120478 h 1511667"/>
              <a:gd name="connsiteX11" fmla="*/ 1016000 w 1617133"/>
              <a:gd name="connsiteY11" fmla="*/ 357545 h 1511667"/>
              <a:gd name="connsiteX12" fmla="*/ 1202267 w 1617133"/>
              <a:gd name="connsiteY12" fmla="*/ 1119545 h 1511667"/>
              <a:gd name="connsiteX13" fmla="*/ 1253067 w 1617133"/>
              <a:gd name="connsiteY13" fmla="*/ 1398945 h 1511667"/>
              <a:gd name="connsiteX14" fmla="*/ 1286933 w 1617133"/>
              <a:gd name="connsiteY14" fmla="*/ 1500545 h 1511667"/>
              <a:gd name="connsiteX15" fmla="*/ 1422400 w 1617133"/>
              <a:gd name="connsiteY15" fmla="*/ 1509012 h 1511667"/>
              <a:gd name="connsiteX16" fmla="*/ 1617133 w 1617133"/>
              <a:gd name="connsiteY16" fmla="*/ 1500545 h 1511667"/>
              <a:gd name="connsiteX17" fmla="*/ 1617133 w 1617133"/>
              <a:gd name="connsiteY17" fmla="*/ 1500545 h 1511667"/>
              <a:gd name="connsiteX18" fmla="*/ 1617133 w 1617133"/>
              <a:gd name="connsiteY18" fmla="*/ 1500545 h 1511667"/>
              <a:gd name="connsiteX0" fmla="*/ 0 w 1617133"/>
              <a:gd name="connsiteY0" fmla="*/ 1499521 h 1527576"/>
              <a:gd name="connsiteX1" fmla="*/ 133351 w 1617133"/>
              <a:gd name="connsiteY1" fmla="*/ 1469888 h 1527576"/>
              <a:gd name="connsiteX2" fmla="*/ 237067 w 1617133"/>
              <a:gd name="connsiteY2" fmla="*/ 1423321 h 1527576"/>
              <a:gd name="connsiteX3" fmla="*/ 347133 w 1617133"/>
              <a:gd name="connsiteY3" fmla="*/ 1253987 h 1527576"/>
              <a:gd name="connsiteX4" fmla="*/ 508000 w 1617133"/>
              <a:gd name="connsiteY4" fmla="*/ 635921 h 1527576"/>
              <a:gd name="connsiteX5" fmla="*/ 563033 w 1617133"/>
              <a:gd name="connsiteY5" fmla="*/ 445421 h 1527576"/>
              <a:gd name="connsiteX6" fmla="*/ 609600 w 1617133"/>
              <a:gd name="connsiteY6" fmla="*/ 254921 h 1527576"/>
              <a:gd name="connsiteX7" fmla="*/ 651932 w 1617133"/>
              <a:gd name="connsiteY7" fmla="*/ 115220 h 1527576"/>
              <a:gd name="connsiteX8" fmla="*/ 713317 w 1617133"/>
              <a:gd name="connsiteY8" fmla="*/ 30554 h 1527576"/>
              <a:gd name="connsiteX9" fmla="*/ 794918 w 1617133"/>
              <a:gd name="connsiteY9" fmla="*/ 71 h 1527576"/>
              <a:gd name="connsiteX10" fmla="*/ 889001 w 1617133"/>
              <a:gd name="connsiteY10" fmla="*/ 26321 h 1527576"/>
              <a:gd name="connsiteX11" fmla="*/ 965200 w 1617133"/>
              <a:gd name="connsiteY11" fmla="*/ 136387 h 1527576"/>
              <a:gd name="connsiteX12" fmla="*/ 1016000 w 1617133"/>
              <a:gd name="connsiteY12" fmla="*/ 373454 h 1527576"/>
              <a:gd name="connsiteX13" fmla="*/ 1202267 w 1617133"/>
              <a:gd name="connsiteY13" fmla="*/ 1135454 h 1527576"/>
              <a:gd name="connsiteX14" fmla="*/ 1253067 w 1617133"/>
              <a:gd name="connsiteY14" fmla="*/ 1414854 h 1527576"/>
              <a:gd name="connsiteX15" fmla="*/ 1286933 w 1617133"/>
              <a:gd name="connsiteY15" fmla="*/ 1516454 h 1527576"/>
              <a:gd name="connsiteX16" fmla="*/ 1422400 w 1617133"/>
              <a:gd name="connsiteY16" fmla="*/ 1524921 h 1527576"/>
              <a:gd name="connsiteX17" fmla="*/ 1617133 w 1617133"/>
              <a:gd name="connsiteY17" fmla="*/ 1516454 h 1527576"/>
              <a:gd name="connsiteX18" fmla="*/ 1617133 w 1617133"/>
              <a:gd name="connsiteY18" fmla="*/ 1516454 h 1527576"/>
              <a:gd name="connsiteX19" fmla="*/ 1617133 w 1617133"/>
              <a:gd name="connsiteY19" fmla="*/ 1516454 h 1527576"/>
              <a:gd name="connsiteX0" fmla="*/ 0 w 1617133"/>
              <a:gd name="connsiteY0" fmla="*/ 1499521 h 1527576"/>
              <a:gd name="connsiteX1" fmla="*/ 133351 w 1617133"/>
              <a:gd name="connsiteY1" fmla="*/ 1469888 h 1527576"/>
              <a:gd name="connsiteX2" fmla="*/ 237067 w 1617133"/>
              <a:gd name="connsiteY2" fmla="*/ 1423321 h 1527576"/>
              <a:gd name="connsiteX3" fmla="*/ 347133 w 1617133"/>
              <a:gd name="connsiteY3" fmla="*/ 1253987 h 1527576"/>
              <a:gd name="connsiteX4" fmla="*/ 508000 w 1617133"/>
              <a:gd name="connsiteY4" fmla="*/ 635921 h 1527576"/>
              <a:gd name="connsiteX5" fmla="*/ 563033 w 1617133"/>
              <a:gd name="connsiteY5" fmla="*/ 445421 h 1527576"/>
              <a:gd name="connsiteX6" fmla="*/ 609600 w 1617133"/>
              <a:gd name="connsiteY6" fmla="*/ 254921 h 1527576"/>
              <a:gd name="connsiteX7" fmla="*/ 658282 w 1617133"/>
              <a:gd name="connsiteY7" fmla="*/ 115220 h 1527576"/>
              <a:gd name="connsiteX8" fmla="*/ 713317 w 1617133"/>
              <a:gd name="connsiteY8" fmla="*/ 30554 h 1527576"/>
              <a:gd name="connsiteX9" fmla="*/ 794918 w 1617133"/>
              <a:gd name="connsiteY9" fmla="*/ 71 h 1527576"/>
              <a:gd name="connsiteX10" fmla="*/ 889001 w 1617133"/>
              <a:gd name="connsiteY10" fmla="*/ 26321 h 1527576"/>
              <a:gd name="connsiteX11" fmla="*/ 965200 w 1617133"/>
              <a:gd name="connsiteY11" fmla="*/ 136387 h 1527576"/>
              <a:gd name="connsiteX12" fmla="*/ 1016000 w 1617133"/>
              <a:gd name="connsiteY12" fmla="*/ 373454 h 1527576"/>
              <a:gd name="connsiteX13" fmla="*/ 1202267 w 1617133"/>
              <a:gd name="connsiteY13" fmla="*/ 1135454 h 1527576"/>
              <a:gd name="connsiteX14" fmla="*/ 1253067 w 1617133"/>
              <a:gd name="connsiteY14" fmla="*/ 1414854 h 1527576"/>
              <a:gd name="connsiteX15" fmla="*/ 1286933 w 1617133"/>
              <a:gd name="connsiteY15" fmla="*/ 1516454 h 1527576"/>
              <a:gd name="connsiteX16" fmla="*/ 1422400 w 1617133"/>
              <a:gd name="connsiteY16" fmla="*/ 1524921 h 1527576"/>
              <a:gd name="connsiteX17" fmla="*/ 1617133 w 1617133"/>
              <a:gd name="connsiteY17" fmla="*/ 1516454 h 1527576"/>
              <a:gd name="connsiteX18" fmla="*/ 1617133 w 1617133"/>
              <a:gd name="connsiteY18" fmla="*/ 1516454 h 1527576"/>
              <a:gd name="connsiteX19" fmla="*/ 1617133 w 1617133"/>
              <a:gd name="connsiteY19" fmla="*/ 1516454 h 1527576"/>
              <a:gd name="connsiteX0" fmla="*/ 0 w 1617133"/>
              <a:gd name="connsiteY0" fmla="*/ 1499521 h 1527576"/>
              <a:gd name="connsiteX1" fmla="*/ 133351 w 1617133"/>
              <a:gd name="connsiteY1" fmla="*/ 1469888 h 1527576"/>
              <a:gd name="connsiteX2" fmla="*/ 237067 w 1617133"/>
              <a:gd name="connsiteY2" fmla="*/ 1423321 h 1527576"/>
              <a:gd name="connsiteX3" fmla="*/ 347133 w 1617133"/>
              <a:gd name="connsiteY3" fmla="*/ 1253987 h 1527576"/>
              <a:gd name="connsiteX4" fmla="*/ 508000 w 1617133"/>
              <a:gd name="connsiteY4" fmla="*/ 635921 h 1527576"/>
              <a:gd name="connsiteX5" fmla="*/ 563033 w 1617133"/>
              <a:gd name="connsiteY5" fmla="*/ 445421 h 1527576"/>
              <a:gd name="connsiteX6" fmla="*/ 609600 w 1617133"/>
              <a:gd name="connsiteY6" fmla="*/ 254921 h 1527576"/>
              <a:gd name="connsiteX7" fmla="*/ 658282 w 1617133"/>
              <a:gd name="connsiteY7" fmla="*/ 115220 h 1527576"/>
              <a:gd name="connsiteX8" fmla="*/ 723901 w 1617133"/>
              <a:gd name="connsiteY8" fmla="*/ 30554 h 1527576"/>
              <a:gd name="connsiteX9" fmla="*/ 794918 w 1617133"/>
              <a:gd name="connsiteY9" fmla="*/ 71 h 1527576"/>
              <a:gd name="connsiteX10" fmla="*/ 889001 w 1617133"/>
              <a:gd name="connsiteY10" fmla="*/ 26321 h 1527576"/>
              <a:gd name="connsiteX11" fmla="*/ 965200 w 1617133"/>
              <a:gd name="connsiteY11" fmla="*/ 136387 h 1527576"/>
              <a:gd name="connsiteX12" fmla="*/ 1016000 w 1617133"/>
              <a:gd name="connsiteY12" fmla="*/ 373454 h 1527576"/>
              <a:gd name="connsiteX13" fmla="*/ 1202267 w 1617133"/>
              <a:gd name="connsiteY13" fmla="*/ 1135454 h 1527576"/>
              <a:gd name="connsiteX14" fmla="*/ 1253067 w 1617133"/>
              <a:gd name="connsiteY14" fmla="*/ 1414854 h 1527576"/>
              <a:gd name="connsiteX15" fmla="*/ 1286933 w 1617133"/>
              <a:gd name="connsiteY15" fmla="*/ 1516454 h 1527576"/>
              <a:gd name="connsiteX16" fmla="*/ 1422400 w 1617133"/>
              <a:gd name="connsiteY16" fmla="*/ 1524921 h 1527576"/>
              <a:gd name="connsiteX17" fmla="*/ 1617133 w 1617133"/>
              <a:gd name="connsiteY17" fmla="*/ 1516454 h 1527576"/>
              <a:gd name="connsiteX18" fmla="*/ 1617133 w 1617133"/>
              <a:gd name="connsiteY18" fmla="*/ 1516454 h 1527576"/>
              <a:gd name="connsiteX19" fmla="*/ 1617133 w 1617133"/>
              <a:gd name="connsiteY19" fmla="*/ 1516454 h 1527576"/>
              <a:gd name="connsiteX0" fmla="*/ 0 w 1617133"/>
              <a:gd name="connsiteY0" fmla="*/ 1499468 h 1527523"/>
              <a:gd name="connsiteX1" fmla="*/ 133351 w 1617133"/>
              <a:gd name="connsiteY1" fmla="*/ 1469835 h 1527523"/>
              <a:gd name="connsiteX2" fmla="*/ 237067 w 1617133"/>
              <a:gd name="connsiteY2" fmla="*/ 1423268 h 1527523"/>
              <a:gd name="connsiteX3" fmla="*/ 347133 w 1617133"/>
              <a:gd name="connsiteY3" fmla="*/ 1253934 h 1527523"/>
              <a:gd name="connsiteX4" fmla="*/ 508000 w 1617133"/>
              <a:gd name="connsiteY4" fmla="*/ 635868 h 1527523"/>
              <a:gd name="connsiteX5" fmla="*/ 563033 w 1617133"/>
              <a:gd name="connsiteY5" fmla="*/ 445368 h 1527523"/>
              <a:gd name="connsiteX6" fmla="*/ 609600 w 1617133"/>
              <a:gd name="connsiteY6" fmla="*/ 254868 h 1527523"/>
              <a:gd name="connsiteX7" fmla="*/ 658282 w 1617133"/>
              <a:gd name="connsiteY7" fmla="*/ 115167 h 1527523"/>
              <a:gd name="connsiteX8" fmla="*/ 723901 w 1617133"/>
              <a:gd name="connsiteY8" fmla="*/ 30501 h 1527523"/>
              <a:gd name="connsiteX9" fmla="*/ 794918 w 1617133"/>
              <a:gd name="connsiteY9" fmla="*/ 18 h 1527523"/>
              <a:gd name="connsiteX10" fmla="*/ 886884 w 1617133"/>
              <a:gd name="connsiteY10" fmla="*/ 43201 h 1527523"/>
              <a:gd name="connsiteX11" fmla="*/ 965200 w 1617133"/>
              <a:gd name="connsiteY11" fmla="*/ 136334 h 1527523"/>
              <a:gd name="connsiteX12" fmla="*/ 1016000 w 1617133"/>
              <a:gd name="connsiteY12" fmla="*/ 373401 h 1527523"/>
              <a:gd name="connsiteX13" fmla="*/ 1202267 w 1617133"/>
              <a:gd name="connsiteY13" fmla="*/ 1135401 h 1527523"/>
              <a:gd name="connsiteX14" fmla="*/ 1253067 w 1617133"/>
              <a:gd name="connsiteY14" fmla="*/ 1414801 h 1527523"/>
              <a:gd name="connsiteX15" fmla="*/ 1286933 w 1617133"/>
              <a:gd name="connsiteY15" fmla="*/ 1516401 h 1527523"/>
              <a:gd name="connsiteX16" fmla="*/ 1422400 w 1617133"/>
              <a:gd name="connsiteY16" fmla="*/ 1524868 h 1527523"/>
              <a:gd name="connsiteX17" fmla="*/ 1617133 w 1617133"/>
              <a:gd name="connsiteY17" fmla="*/ 1516401 h 1527523"/>
              <a:gd name="connsiteX18" fmla="*/ 1617133 w 1617133"/>
              <a:gd name="connsiteY18" fmla="*/ 1516401 h 1527523"/>
              <a:gd name="connsiteX19" fmla="*/ 1617133 w 1617133"/>
              <a:gd name="connsiteY19" fmla="*/ 1516401 h 1527523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09600 w 1617133"/>
              <a:gd name="connsiteY6" fmla="*/ 254873 h 1527528"/>
              <a:gd name="connsiteX7" fmla="*/ 658282 w 1617133"/>
              <a:gd name="connsiteY7" fmla="*/ 115172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09600 w 1617133"/>
              <a:gd name="connsiteY6" fmla="*/ 254873 h 1527528"/>
              <a:gd name="connsiteX7" fmla="*/ 666748 w 1617133"/>
              <a:gd name="connsiteY7" fmla="*/ 123639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09600 w 1617133"/>
              <a:gd name="connsiteY6" fmla="*/ 254873 h 1527528"/>
              <a:gd name="connsiteX7" fmla="*/ 666748 w 1617133"/>
              <a:gd name="connsiteY7" fmla="*/ 123639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15950 w 1617133"/>
              <a:gd name="connsiteY6" fmla="*/ 263340 h 1527528"/>
              <a:gd name="connsiteX7" fmla="*/ 666748 w 1617133"/>
              <a:gd name="connsiteY7" fmla="*/ 123639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73410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73410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73410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94577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4617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805502 w 1617133"/>
              <a:gd name="connsiteY9" fmla="*/ 27 h 1527532"/>
              <a:gd name="connsiteX10" fmla="*/ 886884 w 1617133"/>
              <a:gd name="connsiteY10" fmla="*/ 43210 h 1527532"/>
              <a:gd name="connsiteX11" fmla="*/ 954617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4877"/>
              <a:gd name="connsiteX1" fmla="*/ 133351 w 1617133"/>
              <a:gd name="connsiteY1" fmla="*/ 1469844 h 1524877"/>
              <a:gd name="connsiteX2" fmla="*/ 237067 w 1617133"/>
              <a:gd name="connsiteY2" fmla="*/ 1423277 h 1524877"/>
              <a:gd name="connsiteX3" fmla="*/ 347133 w 1617133"/>
              <a:gd name="connsiteY3" fmla="*/ 1253943 h 1524877"/>
              <a:gd name="connsiteX4" fmla="*/ 508000 w 1617133"/>
              <a:gd name="connsiteY4" fmla="*/ 635877 h 1524877"/>
              <a:gd name="connsiteX5" fmla="*/ 563033 w 1617133"/>
              <a:gd name="connsiteY5" fmla="*/ 445377 h 1524877"/>
              <a:gd name="connsiteX6" fmla="*/ 615950 w 1617133"/>
              <a:gd name="connsiteY6" fmla="*/ 263344 h 1524877"/>
              <a:gd name="connsiteX7" fmla="*/ 666748 w 1617133"/>
              <a:gd name="connsiteY7" fmla="*/ 123643 h 1524877"/>
              <a:gd name="connsiteX8" fmla="*/ 723901 w 1617133"/>
              <a:gd name="connsiteY8" fmla="*/ 30510 h 1524877"/>
              <a:gd name="connsiteX9" fmla="*/ 805502 w 1617133"/>
              <a:gd name="connsiteY9" fmla="*/ 27 h 1524877"/>
              <a:gd name="connsiteX10" fmla="*/ 886884 w 1617133"/>
              <a:gd name="connsiteY10" fmla="*/ 43210 h 1524877"/>
              <a:gd name="connsiteX11" fmla="*/ 954617 w 1617133"/>
              <a:gd name="connsiteY11" fmla="*/ 185026 h 1524877"/>
              <a:gd name="connsiteX12" fmla="*/ 1016000 w 1617133"/>
              <a:gd name="connsiteY12" fmla="*/ 394577 h 1524877"/>
              <a:gd name="connsiteX13" fmla="*/ 1187451 w 1617133"/>
              <a:gd name="connsiteY13" fmla="*/ 1141760 h 1524877"/>
              <a:gd name="connsiteX14" fmla="*/ 1253067 w 1617133"/>
              <a:gd name="connsiteY14" fmla="*/ 1414810 h 1524877"/>
              <a:gd name="connsiteX15" fmla="*/ 1295400 w 1617133"/>
              <a:gd name="connsiteY15" fmla="*/ 1503710 h 1524877"/>
              <a:gd name="connsiteX16" fmla="*/ 1422400 w 1617133"/>
              <a:gd name="connsiteY16" fmla="*/ 1524877 h 1524877"/>
              <a:gd name="connsiteX17" fmla="*/ 1617133 w 1617133"/>
              <a:gd name="connsiteY17" fmla="*/ 1516410 h 1524877"/>
              <a:gd name="connsiteX18" fmla="*/ 1617133 w 1617133"/>
              <a:gd name="connsiteY18" fmla="*/ 1516410 h 1524877"/>
              <a:gd name="connsiteX19" fmla="*/ 1617133 w 1617133"/>
              <a:gd name="connsiteY19" fmla="*/ 1516410 h 1524877"/>
              <a:gd name="connsiteX0" fmla="*/ 0 w 1617133"/>
              <a:gd name="connsiteY0" fmla="*/ 1499477 h 1524877"/>
              <a:gd name="connsiteX1" fmla="*/ 133351 w 1617133"/>
              <a:gd name="connsiteY1" fmla="*/ 1469844 h 1524877"/>
              <a:gd name="connsiteX2" fmla="*/ 237067 w 1617133"/>
              <a:gd name="connsiteY2" fmla="*/ 1423277 h 1524877"/>
              <a:gd name="connsiteX3" fmla="*/ 347133 w 1617133"/>
              <a:gd name="connsiteY3" fmla="*/ 1253943 h 1524877"/>
              <a:gd name="connsiteX4" fmla="*/ 508000 w 1617133"/>
              <a:gd name="connsiteY4" fmla="*/ 635877 h 1524877"/>
              <a:gd name="connsiteX5" fmla="*/ 563033 w 1617133"/>
              <a:gd name="connsiteY5" fmla="*/ 445377 h 1524877"/>
              <a:gd name="connsiteX6" fmla="*/ 615950 w 1617133"/>
              <a:gd name="connsiteY6" fmla="*/ 263344 h 1524877"/>
              <a:gd name="connsiteX7" fmla="*/ 666748 w 1617133"/>
              <a:gd name="connsiteY7" fmla="*/ 123643 h 1524877"/>
              <a:gd name="connsiteX8" fmla="*/ 723901 w 1617133"/>
              <a:gd name="connsiteY8" fmla="*/ 30510 h 1524877"/>
              <a:gd name="connsiteX9" fmla="*/ 805502 w 1617133"/>
              <a:gd name="connsiteY9" fmla="*/ 27 h 1524877"/>
              <a:gd name="connsiteX10" fmla="*/ 886884 w 1617133"/>
              <a:gd name="connsiteY10" fmla="*/ 43210 h 1524877"/>
              <a:gd name="connsiteX11" fmla="*/ 954617 w 1617133"/>
              <a:gd name="connsiteY11" fmla="*/ 185026 h 1524877"/>
              <a:gd name="connsiteX12" fmla="*/ 1016000 w 1617133"/>
              <a:gd name="connsiteY12" fmla="*/ 394577 h 1524877"/>
              <a:gd name="connsiteX13" fmla="*/ 1187451 w 1617133"/>
              <a:gd name="connsiteY13" fmla="*/ 1141760 h 1524877"/>
              <a:gd name="connsiteX14" fmla="*/ 1253067 w 1617133"/>
              <a:gd name="connsiteY14" fmla="*/ 1414810 h 1524877"/>
              <a:gd name="connsiteX15" fmla="*/ 1295400 w 1617133"/>
              <a:gd name="connsiteY15" fmla="*/ 1503710 h 1524877"/>
              <a:gd name="connsiteX16" fmla="*/ 1422400 w 1617133"/>
              <a:gd name="connsiteY16" fmla="*/ 1524877 h 1524877"/>
              <a:gd name="connsiteX17" fmla="*/ 1617133 w 1617133"/>
              <a:gd name="connsiteY17" fmla="*/ 1516410 h 1524877"/>
              <a:gd name="connsiteX18" fmla="*/ 1617133 w 1617133"/>
              <a:gd name="connsiteY18" fmla="*/ 1516410 h 1524877"/>
              <a:gd name="connsiteX19" fmla="*/ 1617133 w 1617133"/>
              <a:gd name="connsiteY19" fmla="*/ 1516410 h 1524877"/>
              <a:gd name="connsiteX0" fmla="*/ 0 w 1617133"/>
              <a:gd name="connsiteY0" fmla="*/ 1499477 h 1524877"/>
              <a:gd name="connsiteX1" fmla="*/ 133351 w 1617133"/>
              <a:gd name="connsiteY1" fmla="*/ 1469844 h 1524877"/>
              <a:gd name="connsiteX2" fmla="*/ 237067 w 1617133"/>
              <a:gd name="connsiteY2" fmla="*/ 1423277 h 1524877"/>
              <a:gd name="connsiteX3" fmla="*/ 347133 w 1617133"/>
              <a:gd name="connsiteY3" fmla="*/ 1253943 h 1524877"/>
              <a:gd name="connsiteX4" fmla="*/ 508000 w 1617133"/>
              <a:gd name="connsiteY4" fmla="*/ 635877 h 1524877"/>
              <a:gd name="connsiteX5" fmla="*/ 563033 w 1617133"/>
              <a:gd name="connsiteY5" fmla="*/ 445377 h 1524877"/>
              <a:gd name="connsiteX6" fmla="*/ 615950 w 1617133"/>
              <a:gd name="connsiteY6" fmla="*/ 263344 h 1524877"/>
              <a:gd name="connsiteX7" fmla="*/ 666748 w 1617133"/>
              <a:gd name="connsiteY7" fmla="*/ 123643 h 1524877"/>
              <a:gd name="connsiteX8" fmla="*/ 723901 w 1617133"/>
              <a:gd name="connsiteY8" fmla="*/ 30510 h 1524877"/>
              <a:gd name="connsiteX9" fmla="*/ 805502 w 1617133"/>
              <a:gd name="connsiteY9" fmla="*/ 27 h 1524877"/>
              <a:gd name="connsiteX10" fmla="*/ 886884 w 1617133"/>
              <a:gd name="connsiteY10" fmla="*/ 43210 h 1524877"/>
              <a:gd name="connsiteX11" fmla="*/ 954617 w 1617133"/>
              <a:gd name="connsiteY11" fmla="*/ 185026 h 1524877"/>
              <a:gd name="connsiteX12" fmla="*/ 1016000 w 1617133"/>
              <a:gd name="connsiteY12" fmla="*/ 394577 h 1524877"/>
              <a:gd name="connsiteX13" fmla="*/ 1187451 w 1617133"/>
              <a:gd name="connsiteY13" fmla="*/ 1141760 h 1524877"/>
              <a:gd name="connsiteX14" fmla="*/ 1253067 w 1617133"/>
              <a:gd name="connsiteY14" fmla="*/ 1414810 h 1524877"/>
              <a:gd name="connsiteX15" fmla="*/ 1295400 w 1617133"/>
              <a:gd name="connsiteY15" fmla="*/ 1503710 h 1524877"/>
              <a:gd name="connsiteX16" fmla="*/ 1422400 w 1617133"/>
              <a:gd name="connsiteY16" fmla="*/ 1524877 h 1524877"/>
              <a:gd name="connsiteX17" fmla="*/ 1617133 w 1617133"/>
              <a:gd name="connsiteY17" fmla="*/ 1516410 h 1524877"/>
              <a:gd name="connsiteX18" fmla="*/ 1617133 w 1617133"/>
              <a:gd name="connsiteY18" fmla="*/ 1516410 h 1524877"/>
              <a:gd name="connsiteX19" fmla="*/ 1617133 w 1617133"/>
              <a:gd name="connsiteY19" fmla="*/ 1516410 h 1524877"/>
              <a:gd name="connsiteX0" fmla="*/ 0 w 1617133"/>
              <a:gd name="connsiteY0" fmla="*/ 1499477 h 1524884"/>
              <a:gd name="connsiteX1" fmla="*/ 133351 w 1617133"/>
              <a:gd name="connsiteY1" fmla="*/ 1469844 h 1524884"/>
              <a:gd name="connsiteX2" fmla="*/ 237067 w 1617133"/>
              <a:gd name="connsiteY2" fmla="*/ 1423277 h 1524884"/>
              <a:gd name="connsiteX3" fmla="*/ 347133 w 1617133"/>
              <a:gd name="connsiteY3" fmla="*/ 1253943 h 1524884"/>
              <a:gd name="connsiteX4" fmla="*/ 508000 w 1617133"/>
              <a:gd name="connsiteY4" fmla="*/ 635877 h 1524884"/>
              <a:gd name="connsiteX5" fmla="*/ 563033 w 1617133"/>
              <a:gd name="connsiteY5" fmla="*/ 445377 h 1524884"/>
              <a:gd name="connsiteX6" fmla="*/ 615950 w 1617133"/>
              <a:gd name="connsiteY6" fmla="*/ 263344 h 1524884"/>
              <a:gd name="connsiteX7" fmla="*/ 666748 w 1617133"/>
              <a:gd name="connsiteY7" fmla="*/ 123643 h 1524884"/>
              <a:gd name="connsiteX8" fmla="*/ 723901 w 1617133"/>
              <a:gd name="connsiteY8" fmla="*/ 30510 h 1524884"/>
              <a:gd name="connsiteX9" fmla="*/ 805502 w 1617133"/>
              <a:gd name="connsiteY9" fmla="*/ 27 h 1524884"/>
              <a:gd name="connsiteX10" fmla="*/ 886884 w 1617133"/>
              <a:gd name="connsiteY10" fmla="*/ 43210 h 1524884"/>
              <a:gd name="connsiteX11" fmla="*/ 954617 w 1617133"/>
              <a:gd name="connsiteY11" fmla="*/ 185026 h 1524884"/>
              <a:gd name="connsiteX12" fmla="*/ 1016000 w 1617133"/>
              <a:gd name="connsiteY12" fmla="*/ 394577 h 1524884"/>
              <a:gd name="connsiteX13" fmla="*/ 1187451 w 1617133"/>
              <a:gd name="connsiteY13" fmla="*/ 1141760 h 1524884"/>
              <a:gd name="connsiteX14" fmla="*/ 1253067 w 1617133"/>
              <a:gd name="connsiteY14" fmla="*/ 1414810 h 1524884"/>
              <a:gd name="connsiteX15" fmla="*/ 1295400 w 1617133"/>
              <a:gd name="connsiteY15" fmla="*/ 1503710 h 1524884"/>
              <a:gd name="connsiteX16" fmla="*/ 1422400 w 1617133"/>
              <a:gd name="connsiteY16" fmla="*/ 1524877 h 1524884"/>
              <a:gd name="connsiteX17" fmla="*/ 1617133 w 1617133"/>
              <a:gd name="connsiteY17" fmla="*/ 1516410 h 1524884"/>
              <a:gd name="connsiteX18" fmla="*/ 1617133 w 1617133"/>
              <a:gd name="connsiteY18" fmla="*/ 1516410 h 1524884"/>
              <a:gd name="connsiteX19" fmla="*/ 1617133 w 1617133"/>
              <a:gd name="connsiteY19" fmla="*/ 1516410 h 1524884"/>
              <a:gd name="connsiteX0" fmla="*/ 0 w 1617133"/>
              <a:gd name="connsiteY0" fmla="*/ 1499477 h 1524884"/>
              <a:gd name="connsiteX1" fmla="*/ 133351 w 1617133"/>
              <a:gd name="connsiteY1" fmla="*/ 1469844 h 1524884"/>
              <a:gd name="connsiteX2" fmla="*/ 237067 w 1617133"/>
              <a:gd name="connsiteY2" fmla="*/ 1423277 h 1524884"/>
              <a:gd name="connsiteX3" fmla="*/ 347133 w 1617133"/>
              <a:gd name="connsiteY3" fmla="*/ 1253943 h 1524884"/>
              <a:gd name="connsiteX4" fmla="*/ 508000 w 1617133"/>
              <a:gd name="connsiteY4" fmla="*/ 635877 h 1524884"/>
              <a:gd name="connsiteX5" fmla="*/ 563033 w 1617133"/>
              <a:gd name="connsiteY5" fmla="*/ 445377 h 1524884"/>
              <a:gd name="connsiteX6" fmla="*/ 615950 w 1617133"/>
              <a:gd name="connsiteY6" fmla="*/ 263344 h 1524884"/>
              <a:gd name="connsiteX7" fmla="*/ 666748 w 1617133"/>
              <a:gd name="connsiteY7" fmla="*/ 123643 h 1524884"/>
              <a:gd name="connsiteX8" fmla="*/ 723901 w 1617133"/>
              <a:gd name="connsiteY8" fmla="*/ 30510 h 1524884"/>
              <a:gd name="connsiteX9" fmla="*/ 805502 w 1617133"/>
              <a:gd name="connsiteY9" fmla="*/ 27 h 1524884"/>
              <a:gd name="connsiteX10" fmla="*/ 886884 w 1617133"/>
              <a:gd name="connsiteY10" fmla="*/ 43210 h 1524884"/>
              <a:gd name="connsiteX11" fmla="*/ 954617 w 1617133"/>
              <a:gd name="connsiteY11" fmla="*/ 185026 h 1524884"/>
              <a:gd name="connsiteX12" fmla="*/ 1011767 w 1617133"/>
              <a:gd name="connsiteY12" fmla="*/ 396694 h 1524884"/>
              <a:gd name="connsiteX13" fmla="*/ 1187451 w 1617133"/>
              <a:gd name="connsiteY13" fmla="*/ 1141760 h 1524884"/>
              <a:gd name="connsiteX14" fmla="*/ 1253067 w 1617133"/>
              <a:gd name="connsiteY14" fmla="*/ 1414810 h 1524884"/>
              <a:gd name="connsiteX15" fmla="*/ 1295400 w 1617133"/>
              <a:gd name="connsiteY15" fmla="*/ 1503710 h 1524884"/>
              <a:gd name="connsiteX16" fmla="*/ 1422400 w 1617133"/>
              <a:gd name="connsiteY16" fmla="*/ 1524877 h 1524884"/>
              <a:gd name="connsiteX17" fmla="*/ 1617133 w 1617133"/>
              <a:gd name="connsiteY17" fmla="*/ 1516410 h 1524884"/>
              <a:gd name="connsiteX18" fmla="*/ 1617133 w 1617133"/>
              <a:gd name="connsiteY18" fmla="*/ 1516410 h 1524884"/>
              <a:gd name="connsiteX19" fmla="*/ 1617133 w 1617133"/>
              <a:gd name="connsiteY19" fmla="*/ 1516410 h 1524884"/>
              <a:gd name="connsiteX0" fmla="*/ 0 w 1617133"/>
              <a:gd name="connsiteY0" fmla="*/ 1499477 h 1524884"/>
              <a:gd name="connsiteX1" fmla="*/ 133351 w 1617133"/>
              <a:gd name="connsiteY1" fmla="*/ 1469844 h 1524884"/>
              <a:gd name="connsiteX2" fmla="*/ 260880 w 1617133"/>
              <a:gd name="connsiteY2" fmla="*/ 1414810 h 1524884"/>
              <a:gd name="connsiteX3" fmla="*/ 347133 w 1617133"/>
              <a:gd name="connsiteY3" fmla="*/ 1253943 h 1524884"/>
              <a:gd name="connsiteX4" fmla="*/ 508000 w 1617133"/>
              <a:gd name="connsiteY4" fmla="*/ 635877 h 1524884"/>
              <a:gd name="connsiteX5" fmla="*/ 563033 w 1617133"/>
              <a:gd name="connsiteY5" fmla="*/ 445377 h 1524884"/>
              <a:gd name="connsiteX6" fmla="*/ 615950 w 1617133"/>
              <a:gd name="connsiteY6" fmla="*/ 263344 h 1524884"/>
              <a:gd name="connsiteX7" fmla="*/ 666748 w 1617133"/>
              <a:gd name="connsiteY7" fmla="*/ 123643 h 1524884"/>
              <a:gd name="connsiteX8" fmla="*/ 723901 w 1617133"/>
              <a:gd name="connsiteY8" fmla="*/ 30510 h 1524884"/>
              <a:gd name="connsiteX9" fmla="*/ 805502 w 1617133"/>
              <a:gd name="connsiteY9" fmla="*/ 27 h 1524884"/>
              <a:gd name="connsiteX10" fmla="*/ 886884 w 1617133"/>
              <a:gd name="connsiteY10" fmla="*/ 43210 h 1524884"/>
              <a:gd name="connsiteX11" fmla="*/ 954617 w 1617133"/>
              <a:gd name="connsiteY11" fmla="*/ 185026 h 1524884"/>
              <a:gd name="connsiteX12" fmla="*/ 1011767 w 1617133"/>
              <a:gd name="connsiteY12" fmla="*/ 396694 h 1524884"/>
              <a:gd name="connsiteX13" fmla="*/ 1187451 w 1617133"/>
              <a:gd name="connsiteY13" fmla="*/ 1141760 h 1524884"/>
              <a:gd name="connsiteX14" fmla="*/ 1253067 w 1617133"/>
              <a:gd name="connsiteY14" fmla="*/ 1414810 h 1524884"/>
              <a:gd name="connsiteX15" fmla="*/ 1295400 w 1617133"/>
              <a:gd name="connsiteY15" fmla="*/ 1503710 h 1524884"/>
              <a:gd name="connsiteX16" fmla="*/ 1422400 w 1617133"/>
              <a:gd name="connsiteY16" fmla="*/ 1524877 h 1524884"/>
              <a:gd name="connsiteX17" fmla="*/ 1617133 w 1617133"/>
              <a:gd name="connsiteY17" fmla="*/ 1516410 h 1524884"/>
              <a:gd name="connsiteX18" fmla="*/ 1617133 w 1617133"/>
              <a:gd name="connsiteY18" fmla="*/ 1516410 h 1524884"/>
              <a:gd name="connsiteX19" fmla="*/ 1617133 w 1617133"/>
              <a:gd name="connsiteY19" fmla="*/ 1516410 h 1524884"/>
              <a:gd name="connsiteX0" fmla="*/ 7455 w 1624588"/>
              <a:gd name="connsiteY0" fmla="*/ 1499477 h 1524884"/>
              <a:gd name="connsiteX1" fmla="*/ 10640 w 1624588"/>
              <a:gd name="connsiteY1" fmla="*/ 1496036 h 1524884"/>
              <a:gd name="connsiteX2" fmla="*/ 140806 w 1624588"/>
              <a:gd name="connsiteY2" fmla="*/ 1469844 h 1524884"/>
              <a:gd name="connsiteX3" fmla="*/ 268335 w 1624588"/>
              <a:gd name="connsiteY3" fmla="*/ 1414810 h 1524884"/>
              <a:gd name="connsiteX4" fmla="*/ 354588 w 1624588"/>
              <a:gd name="connsiteY4" fmla="*/ 1253943 h 1524884"/>
              <a:gd name="connsiteX5" fmla="*/ 515455 w 1624588"/>
              <a:gd name="connsiteY5" fmla="*/ 635877 h 1524884"/>
              <a:gd name="connsiteX6" fmla="*/ 570488 w 1624588"/>
              <a:gd name="connsiteY6" fmla="*/ 445377 h 1524884"/>
              <a:gd name="connsiteX7" fmla="*/ 623405 w 1624588"/>
              <a:gd name="connsiteY7" fmla="*/ 263344 h 1524884"/>
              <a:gd name="connsiteX8" fmla="*/ 674203 w 1624588"/>
              <a:gd name="connsiteY8" fmla="*/ 123643 h 1524884"/>
              <a:gd name="connsiteX9" fmla="*/ 731356 w 1624588"/>
              <a:gd name="connsiteY9" fmla="*/ 30510 h 1524884"/>
              <a:gd name="connsiteX10" fmla="*/ 812957 w 1624588"/>
              <a:gd name="connsiteY10" fmla="*/ 27 h 1524884"/>
              <a:gd name="connsiteX11" fmla="*/ 894339 w 1624588"/>
              <a:gd name="connsiteY11" fmla="*/ 43210 h 1524884"/>
              <a:gd name="connsiteX12" fmla="*/ 962072 w 1624588"/>
              <a:gd name="connsiteY12" fmla="*/ 185026 h 1524884"/>
              <a:gd name="connsiteX13" fmla="*/ 1019222 w 1624588"/>
              <a:gd name="connsiteY13" fmla="*/ 396694 h 1524884"/>
              <a:gd name="connsiteX14" fmla="*/ 1194906 w 1624588"/>
              <a:gd name="connsiteY14" fmla="*/ 1141760 h 1524884"/>
              <a:gd name="connsiteX15" fmla="*/ 1260522 w 1624588"/>
              <a:gd name="connsiteY15" fmla="*/ 1414810 h 1524884"/>
              <a:gd name="connsiteX16" fmla="*/ 1302855 w 1624588"/>
              <a:gd name="connsiteY16" fmla="*/ 1503710 h 1524884"/>
              <a:gd name="connsiteX17" fmla="*/ 1429855 w 1624588"/>
              <a:gd name="connsiteY17" fmla="*/ 1524877 h 1524884"/>
              <a:gd name="connsiteX18" fmla="*/ 1624588 w 1624588"/>
              <a:gd name="connsiteY18" fmla="*/ 1516410 h 1524884"/>
              <a:gd name="connsiteX19" fmla="*/ 1624588 w 1624588"/>
              <a:gd name="connsiteY19" fmla="*/ 1516410 h 1524884"/>
              <a:gd name="connsiteX20" fmla="*/ 1624588 w 1624588"/>
              <a:gd name="connsiteY20" fmla="*/ 1516410 h 1524884"/>
              <a:gd name="connsiteX0" fmla="*/ 160627 w 1777760"/>
              <a:gd name="connsiteY0" fmla="*/ 1499477 h 1524884"/>
              <a:gd name="connsiteX1" fmla="*/ 1886 w 1777760"/>
              <a:gd name="connsiteY1" fmla="*/ 1510852 h 1524884"/>
              <a:gd name="connsiteX2" fmla="*/ 293978 w 1777760"/>
              <a:gd name="connsiteY2" fmla="*/ 1469844 h 1524884"/>
              <a:gd name="connsiteX3" fmla="*/ 421507 w 1777760"/>
              <a:gd name="connsiteY3" fmla="*/ 1414810 h 1524884"/>
              <a:gd name="connsiteX4" fmla="*/ 507760 w 1777760"/>
              <a:gd name="connsiteY4" fmla="*/ 1253943 h 1524884"/>
              <a:gd name="connsiteX5" fmla="*/ 668627 w 1777760"/>
              <a:gd name="connsiteY5" fmla="*/ 635877 h 1524884"/>
              <a:gd name="connsiteX6" fmla="*/ 723660 w 1777760"/>
              <a:gd name="connsiteY6" fmla="*/ 445377 h 1524884"/>
              <a:gd name="connsiteX7" fmla="*/ 776577 w 1777760"/>
              <a:gd name="connsiteY7" fmla="*/ 263344 h 1524884"/>
              <a:gd name="connsiteX8" fmla="*/ 827375 w 1777760"/>
              <a:gd name="connsiteY8" fmla="*/ 123643 h 1524884"/>
              <a:gd name="connsiteX9" fmla="*/ 884528 w 1777760"/>
              <a:gd name="connsiteY9" fmla="*/ 30510 h 1524884"/>
              <a:gd name="connsiteX10" fmla="*/ 966129 w 1777760"/>
              <a:gd name="connsiteY10" fmla="*/ 27 h 1524884"/>
              <a:gd name="connsiteX11" fmla="*/ 1047511 w 1777760"/>
              <a:gd name="connsiteY11" fmla="*/ 43210 h 1524884"/>
              <a:gd name="connsiteX12" fmla="*/ 1115244 w 1777760"/>
              <a:gd name="connsiteY12" fmla="*/ 185026 h 1524884"/>
              <a:gd name="connsiteX13" fmla="*/ 1172394 w 1777760"/>
              <a:gd name="connsiteY13" fmla="*/ 396694 h 1524884"/>
              <a:gd name="connsiteX14" fmla="*/ 1348078 w 1777760"/>
              <a:gd name="connsiteY14" fmla="*/ 1141760 h 1524884"/>
              <a:gd name="connsiteX15" fmla="*/ 1413694 w 1777760"/>
              <a:gd name="connsiteY15" fmla="*/ 1414810 h 1524884"/>
              <a:gd name="connsiteX16" fmla="*/ 1456027 w 1777760"/>
              <a:gd name="connsiteY16" fmla="*/ 1503710 h 1524884"/>
              <a:gd name="connsiteX17" fmla="*/ 1583027 w 1777760"/>
              <a:gd name="connsiteY17" fmla="*/ 1524877 h 1524884"/>
              <a:gd name="connsiteX18" fmla="*/ 1777760 w 1777760"/>
              <a:gd name="connsiteY18" fmla="*/ 1516410 h 1524884"/>
              <a:gd name="connsiteX19" fmla="*/ 1777760 w 1777760"/>
              <a:gd name="connsiteY19" fmla="*/ 1516410 h 1524884"/>
              <a:gd name="connsiteX20" fmla="*/ 1777760 w 1777760"/>
              <a:gd name="connsiteY20" fmla="*/ 1516410 h 1524884"/>
              <a:gd name="connsiteX0" fmla="*/ 10952 w 1785249"/>
              <a:gd name="connsiteY0" fmla="*/ 1586261 h 1586261"/>
              <a:gd name="connsiteX1" fmla="*/ 9375 w 1785249"/>
              <a:gd name="connsiteY1" fmla="*/ 1510852 h 1586261"/>
              <a:gd name="connsiteX2" fmla="*/ 301467 w 1785249"/>
              <a:gd name="connsiteY2" fmla="*/ 1469844 h 1586261"/>
              <a:gd name="connsiteX3" fmla="*/ 428996 w 1785249"/>
              <a:gd name="connsiteY3" fmla="*/ 1414810 h 1586261"/>
              <a:gd name="connsiteX4" fmla="*/ 515249 w 1785249"/>
              <a:gd name="connsiteY4" fmla="*/ 1253943 h 1586261"/>
              <a:gd name="connsiteX5" fmla="*/ 676116 w 1785249"/>
              <a:gd name="connsiteY5" fmla="*/ 635877 h 1586261"/>
              <a:gd name="connsiteX6" fmla="*/ 731149 w 1785249"/>
              <a:gd name="connsiteY6" fmla="*/ 445377 h 1586261"/>
              <a:gd name="connsiteX7" fmla="*/ 784066 w 1785249"/>
              <a:gd name="connsiteY7" fmla="*/ 263344 h 1586261"/>
              <a:gd name="connsiteX8" fmla="*/ 834864 w 1785249"/>
              <a:gd name="connsiteY8" fmla="*/ 123643 h 1586261"/>
              <a:gd name="connsiteX9" fmla="*/ 892017 w 1785249"/>
              <a:gd name="connsiteY9" fmla="*/ 30510 h 1586261"/>
              <a:gd name="connsiteX10" fmla="*/ 973618 w 1785249"/>
              <a:gd name="connsiteY10" fmla="*/ 27 h 1586261"/>
              <a:gd name="connsiteX11" fmla="*/ 1055000 w 1785249"/>
              <a:gd name="connsiteY11" fmla="*/ 43210 h 1586261"/>
              <a:gd name="connsiteX12" fmla="*/ 1122733 w 1785249"/>
              <a:gd name="connsiteY12" fmla="*/ 185026 h 1586261"/>
              <a:gd name="connsiteX13" fmla="*/ 1179883 w 1785249"/>
              <a:gd name="connsiteY13" fmla="*/ 396694 h 1586261"/>
              <a:gd name="connsiteX14" fmla="*/ 1355567 w 1785249"/>
              <a:gd name="connsiteY14" fmla="*/ 1141760 h 1586261"/>
              <a:gd name="connsiteX15" fmla="*/ 1421183 w 1785249"/>
              <a:gd name="connsiteY15" fmla="*/ 1414810 h 1586261"/>
              <a:gd name="connsiteX16" fmla="*/ 1463516 w 1785249"/>
              <a:gd name="connsiteY16" fmla="*/ 1503710 h 1586261"/>
              <a:gd name="connsiteX17" fmla="*/ 1590516 w 1785249"/>
              <a:gd name="connsiteY17" fmla="*/ 1524877 h 1586261"/>
              <a:gd name="connsiteX18" fmla="*/ 1785249 w 1785249"/>
              <a:gd name="connsiteY18" fmla="*/ 1516410 h 1586261"/>
              <a:gd name="connsiteX19" fmla="*/ 1785249 w 1785249"/>
              <a:gd name="connsiteY19" fmla="*/ 1516410 h 1586261"/>
              <a:gd name="connsiteX20" fmla="*/ 1785249 w 1785249"/>
              <a:gd name="connsiteY20" fmla="*/ 1516410 h 1586261"/>
              <a:gd name="connsiteX0" fmla="*/ 0 w 1774297"/>
              <a:gd name="connsiteY0" fmla="*/ 1586261 h 1586261"/>
              <a:gd name="connsiteX1" fmla="*/ 131774 w 1774297"/>
              <a:gd name="connsiteY1" fmla="*/ 1502385 h 1586261"/>
              <a:gd name="connsiteX2" fmla="*/ 290515 w 1774297"/>
              <a:gd name="connsiteY2" fmla="*/ 1469844 h 1586261"/>
              <a:gd name="connsiteX3" fmla="*/ 418044 w 1774297"/>
              <a:gd name="connsiteY3" fmla="*/ 1414810 h 1586261"/>
              <a:gd name="connsiteX4" fmla="*/ 504297 w 1774297"/>
              <a:gd name="connsiteY4" fmla="*/ 1253943 h 1586261"/>
              <a:gd name="connsiteX5" fmla="*/ 665164 w 1774297"/>
              <a:gd name="connsiteY5" fmla="*/ 635877 h 1586261"/>
              <a:gd name="connsiteX6" fmla="*/ 720197 w 1774297"/>
              <a:gd name="connsiteY6" fmla="*/ 445377 h 1586261"/>
              <a:gd name="connsiteX7" fmla="*/ 773114 w 1774297"/>
              <a:gd name="connsiteY7" fmla="*/ 263344 h 1586261"/>
              <a:gd name="connsiteX8" fmla="*/ 823912 w 1774297"/>
              <a:gd name="connsiteY8" fmla="*/ 123643 h 1586261"/>
              <a:gd name="connsiteX9" fmla="*/ 881065 w 1774297"/>
              <a:gd name="connsiteY9" fmla="*/ 30510 h 1586261"/>
              <a:gd name="connsiteX10" fmla="*/ 962666 w 1774297"/>
              <a:gd name="connsiteY10" fmla="*/ 27 h 1586261"/>
              <a:gd name="connsiteX11" fmla="*/ 1044048 w 1774297"/>
              <a:gd name="connsiteY11" fmla="*/ 43210 h 1586261"/>
              <a:gd name="connsiteX12" fmla="*/ 1111781 w 1774297"/>
              <a:gd name="connsiteY12" fmla="*/ 185026 h 1586261"/>
              <a:gd name="connsiteX13" fmla="*/ 1168931 w 1774297"/>
              <a:gd name="connsiteY13" fmla="*/ 396694 h 1586261"/>
              <a:gd name="connsiteX14" fmla="*/ 1344615 w 1774297"/>
              <a:gd name="connsiteY14" fmla="*/ 1141760 h 1586261"/>
              <a:gd name="connsiteX15" fmla="*/ 1410231 w 1774297"/>
              <a:gd name="connsiteY15" fmla="*/ 1414810 h 1586261"/>
              <a:gd name="connsiteX16" fmla="*/ 1452564 w 1774297"/>
              <a:gd name="connsiteY16" fmla="*/ 1503710 h 1586261"/>
              <a:gd name="connsiteX17" fmla="*/ 1579564 w 1774297"/>
              <a:gd name="connsiteY17" fmla="*/ 1524877 h 1586261"/>
              <a:gd name="connsiteX18" fmla="*/ 1774297 w 1774297"/>
              <a:gd name="connsiteY18" fmla="*/ 1516410 h 1586261"/>
              <a:gd name="connsiteX19" fmla="*/ 1774297 w 1774297"/>
              <a:gd name="connsiteY19" fmla="*/ 1516410 h 1586261"/>
              <a:gd name="connsiteX20" fmla="*/ 1774297 w 1774297"/>
              <a:gd name="connsiteY20" fmla="*/ 1516410 h 1586261"/>
              <a:gd name="connsiteX0" fmla="*/ 0 w 1817160"/>
              <a:gd name="connsiteY0" fmla="*/ 1516411 h 1524884"/>
              <a:gd name="connsiteX1" fmla="*/ 174637 w 1817160"/>
              <a:gd name="connsiteY1" fmla="*/ 1502385 h 1524884"/>
              <a:gd name="connsiteX2" fmla="*/ 333378 w 1817160"/>
              <a:gd name="connsiteY2" fmla="*/ 1469844 h 1524884"/>
              <a:gd name="connsiteX3" fmla="*/ 460907 w 1817160"/>
              <a:gd name="connsiteY3" fmla="*/ 1414810 h 1524884"/>
              <a:gd name="connsiteX4" fmla="*/ 547160 w 1817160"/>
              <a:gd name="connsiteY4" fmla="*/ 1253943 h 1524884"/>
              <a:gd name="connsiteX5" fmla="*/ 708027 w 1817160"/>
              <a:gd name="connsiteY5" fmla="*/ 635877 h 1524884"/>
              <a:gd name="connsiteX6" fmla="*/ 763060 w 1817160"/>
              <a:gd name="connsiteY6" fmla="*/ 445377 h 1524884"/>
              <a:gd name="connsiteX7" fmla="*/ 815977 w 1817160"/>
              <a:gd name="connsiteY7" fmla="*/ 263344 h 1524884"/>
              <a:gd name="connsiteX8" fmla="*/ 866775 w 1817160"/>
              <a:gd name="connsiteY8" fmla="*/ 123643 h 1524884"/>
              <a:gd name="connsiteX9" fmla="*/ 923928 w 1817160"/>
              <a:gd name="connsiteY9" fmla="*/ 30510 h 1524884"/>
              <a:gd name="connsiteX10" fmla="*/ 1005529 w 1817160"/>
              <a:gd name="connsiteY10" fmla="*/ 27 h 1524884"/>
              <a:gd name="connsiteX11" fmla="*/ 1086911 w 1817160"/>
              <a:gd name="connsiteY11" fmla="*/ 43210 h 1524884"/>
              <a:gd name="connsiteX12" fmla="*/ 1154644 w 1817160"/>
              <a:gd name="connsiteY12" fmla="*/ 185026 h 1524884"/>
              <a:gd name="connsiteX13" fmla="*/ 1211794 w 1817160"/>
              <a:gd name="connsiteY13" fmla="*/ 396694 h 1524884"/>
              <a:gd name="connsiteX14" fmla="*/ 1387478 w 1817160"/>
              <a:gd name="connsiteY14" fmla="*/ 1141760 h 1524884"/>
              <a:gd name="connsiteX15" fmla="*/ 1453094 w 1817160"/>
              <a:gd name="connsiteY15" fmla="*/ 1414810 h 1524884"/>
              <a:gd name="connsiteX16" fmla="*/ 1495427 w 1817160"/>
              <a:gd name="connsiteY16" fmla="*/ 1503710 h 1524884"/>
              <a:gd name="connsiteX17" fmla="*/ 1622427 w 1817160"/>
              <a:gd name="connsiteY17" fmla="*/ 1524877 h 1524884"/>
              <a:gd name="connsiteX18" fmla="*/ 1817160 w 1817160"/>
              <a:gd name="connsiteY18" fmla="*/ 1516410 h 1524884"/>
              <a:gd name="connsiteX19" fmla="*/ 1817160 w 1817160"/>
              <a:gd name="connsiteY19" fmla="*/ 1516410 h 1524884"/>
              <a:gd name="connsiteX20" fmla="*/ 1817160 w 1817160"/>
              <a:gd name="connsiteY20" fmla="*/ 1516410 h 1524884"/>
              <a:gd name="connsiteX0" fmla="*/ 0 w 1817160"/>
              <a:gd name="connsiteY0" fmla="*/ 1516411 h 1524884"/>
              <a:gd name="connsiteX1" fmla="*/ 174637 w 1817160"/>
              <a:gd name="connsiteY1" fmla="*/ 1502385 h 1524884"/>
              <a:gd name="connsiteX2" fmla="*/ 333378 w 1817160"/>
              <a:gd name="connsiteY2" fmla="*/ 1469844 h 1524884"/>
              <a:gd name="connsiteX3" fmla="*/ 460907 w 1817160"/>
              <a:gd name="connsiteY3" fmla="*/ 1414810 h 1524884"/>
              <a:gd name="connsiteX4" fmla="*/ 547160 w 1817160"/>
              <a:gd name="connsiteY4" fmla="*/ 1253943 h 1524884"/>
              <a:gd name="connsiteX5" fmla="*/ 708027 w 1817160"/>
              <a:gd name="connsiteY5" fmla="*/ 635877 h 1524884"/>
              <a:gd name="connsiteX6" fmla="*/ 763060 w 1817160"/>
              <a:gd name="connsiteY6" fmla="*/ 445377 h 1524884"/>
              <a:gd name="connsiteX7" fmla="*/ 815977 w 1817160"/>
              <a:gd name="connsiteY7" fmla="*/ 263344 h 1524884"/>
              <a:gd name="connsiteX8" fmla="*/ 866775 w 1817160"/>
              <a:gd name="connsiteY8" fmla="*/ 123643 h 1524884"/>
              <a:gd name="connsiteX9" fmla="*/ 923928 w 1817160"/>
              <a:gd name="connsiteY9" fmla="*/ 30510 h 1524884"/>
              <a:gd name="connsiteX10" fmla="*/ 1005529 w 1817160"/>
              <a:gd name="connsiteY10" fmla="*/ 27 h 1524884"/>
              <a:gd name="connsiteX11" fmla="*/ 1086911 w 1817160"/>
              <a:gd name="connsiteY11" fmla="*/ 43210 h 1524884"/>
              <a:gd name="connsiteX12" fmla="*/ 1154644 w 1817160"/>
              <a:gd name="connsiteY12" fmla="*/ 185026 h 1524884"/>
              <a:gd name="connsiteX13" fmla="*/ 1211794 w 1817160"/>
              <a:gd name="connsiteY13" fmla="*/ 396694 h 1524884"/>
              <a:gd name="connsiteX14" fmla="*/ 1387478 w 1817160"/>
              <a:gd name="connsiteY14" fmla="*/ 1141760 h 1524884"/>
              <a:gd name="connsiteX15" fmla="*/ 1453094 w 1817160"/>
              <a:gd name="connsiteY15" fmla="*/ 1414810 h 1524884"/>
              <a:gd name="connsiteX16" fmla="*/ 1495427 w 1817160"/>
              <a:gd name="connsiteY16" fmla="*/ 1503710 h 1524884"/>
              <a:gd name="connsiteX17" fmla="*/ 1622427 w 1817160"/>
              <a:gd name="connsiteY17" fmla="*/ 1524877 h 1524884"/>
              <a:gd name="connsiteX18" fmla="*/ 1817160 w 1817160"/>
              <a:gd name="connsiteY18" fmla="*/ 1516410 h 1524884"/>
              <a:gd name="connsiteX19" fmla="*/ 1817160 w 1817160"/>
              <a:gd name="connsiteY19" fmla="*/ 1516410 h 1524884"/>
              <a:gd name="connsiteX20" fmla="*/ 1817160 w 1817160"/>
              <a:gd name="connsiteY20" fmla="*/ 1516410 h 1524884"/>
              <a:gd name="connsiteX0" fmla="*/ 0 w 1817160"/>
              <a:gd name="connsiteY0" fmla="*/ 1516411 h 1524884"/>
              <a:gd name="connsiteX1" fmla="*/ 174637 w 1817160"/>
              <a:gd name="connsiteY1" fmla="*/ 1502385 h 1524884"/>
              <a:gd name="connsiteX2" fmla="*/ 335760 w 1817160"/>
              <a:gd name="connsiteY2" fmla="*/ 1474078 h 1524884"/>
              <a:gd name="connsiteX3" fmla="*/ 460907 w 1817160"/>
              <a:gd name="connsiteY3" fmla="*/ 1414810 h 1524884"/>
              <a:gd name="connsiteX4" fmla="*/ 547160 w 1817160"/>
              <a:gd name="connsiteY4" fmla="*/ 1253943 h 1524884"/>
              <a:gd name="connsiteX5" fmla="*/ 708027 w 1817160"/>
              <a:gd name="connsiteY5" fmla="*/ 635877 h 1524884"/>
              <a:gd name="connsiteX6" fmla="*/ 763060 w 1817160"/>
              <a:gd name="connsiteY6" fmla="*/ 445377 h 1524884"/>
              <a:gd name="connsiteX7" fmla="*/ 815977 w 1817160"/>
              <a:gd name="connsiteY7" fmla="*/ 263344 h 1524884"/>
              <a:gd name="connsiteX8" fmla="*/ 866775 w 1817160"/>
              <a:gd name="connsiteY8" fmla="*/ 123643 h 1524884"/>
              <a:gd name="connsiteX9" fmla="*/ 923928 w 1817160"/>
              <a:gd name="connsiteY9" fmla="*/ 30510 h 1524884"/>
              <a:gd name="connsiteX10" fmla="*/ 1005529 w 1817160"/>
              <a:gd name="connsiteY10" fmla="*/ 27 h 1524884"/>
              <a:gd name="connsiteX11" fmla="*/ 1086911 w 1817160"/>
              <a:gd name="connsiteY11" fmla="*/ 43210 h 1524884"/>
              <a:gd name="connsiteX12" fmla="*/ 1154644 w 1817160"/>
              <a:gd name="connsiteY12" fmla="*/ 185026 h 1524884"/>
              <a:gd name="connsiteX13" fmla="*/ 1211794 w 1817160"/>
              <a:gd name="connsiteY13" fmla="*/ 396694 h 1524884"/>
              <a:gd name="connsiteX14" fmla="*/ 1387478 w 1817160"/>
              <a:gd name="connsiteY14" fmla="*/ 1141760 h 1524884"/>
              <a:gd name="connsiteX15" fmla="*/ 1453094 w 1817160"/>
              <a:gd name="connsiteY15" fmla="*/ 1414810 h 1524884"/>
              <a:gd name="connsiteX16" fmla="*/ 1495427 w 1817160"/>
              <a:gd name="connsiteY16" fmla="*/ 1503710 h 1524884"/>
              <a:gd name="connsiteX17" fmla="*/ 1622427 w 1817160"/>
              <a:gd name="connsiteY17" fmla="*/ 1524877 h 1524884"/>
              <a:gd name="connsiteX18" fmla="*/ 1817160 w 1817160"/>
              <a:gd name="connsiteY18" fmla="*/ 1516410 h 1524884"/>
              <a:gd name="connsiteX19" fmla="*/ 1817160 w 1817160"/>
              <a:gd name="connsiteY19" fmla="*/ 1516410 h 1524884"/>
              <a:gd name="connsiteX20" fmla="*/ 1817160 w 1817160"/>
              <a:gd name="connsiteY20" fmla="*/ 1516410 h 1524884"/>
              <a:gd name="connsiteX0" fmla="*/ 0 w 1817160"/>
              <a:gd name="connsiteY0" fmla="*/ 1516411 h 1525690"/>
              <a:gd name="connsiteX1" fmla="*/ 174637 w 1817160"/>
              <a:gd name="connsiteY1" fmla="*/ 1502385 h 1525690"/>
              <a:gd name="connsiteX2" fmla="*/ 335760 w 1817160"/>
              <a:gd name="connsiteY2" fmla="*/ 1474078 h 1525690"/>
              <a:gd name="connsiteX3" fmla="*/ 460907 w 1817160"/>
              <a:gd name="connsiteY3" fmla="*/ 1414810 h 1525690"/>
              <a:gd name="connsiteX4" fmla="*/ 547160 w 1817160"/>
              <a:gd name="connsiteY4" fmla="*/ 1253943 h 1525690"/>
              <a:gd name="connsiteX5" fmla="*/ 708027 w 1817160"/>
              <a:gd name="connsiteY5" fmla="*/ 635877 h 1525690"/>
              <a:gd name="connsiteX6" fmla="*/ 763060 w 1817160"/>
              <a:gd name="connsiteY6" fmla="*/ 445377 h 1525690"/>
              <a:gd name="connsiteX7" fmla="*/ 815977 w 1817160"/>
              <a:gd name="connsiteY7" fmla="*/ 263344 h 1525690"/>
              <a:gd name="connsiteX8" fmla="*/ 866775 w 1817160"/>
              <a:gd name="connsiteY8" fmla="*/ 123643 h 1525690"/>
              <a:gd name="connsiteX9" fmla="*/ 923928 w 1817160"/>
              <a:gd name="connsiteY9" fmla="*/ 30510 h 1525690"/>
              <a:gd name="connsiteX10" fmla="*/ 1005529 w 1817160"/>
              <a:gd name="connsiteY10" fmla="*/ 27 h 1525690"/>
              <a:gd name="connsiteX11" fmla="*/ 1086911 w 1817160"/>
              <a:gd name="connsiteY11" fmla="*/ 43210 h 1525690"/>
              <a:gd name="connsiteX12" fmla="*/ 1154644 w 1817160"/>
              <a:gd name="connsiteY12" fmla="*/ 185026 h 1525690"/>
              <a:gd name="connsiteX13" fmla="*/ 1211794 w 1817160"/>
              <a:gd name="connsiteY13" fmla="*/ 396694 h 1525690"/>
              <a:gd name="connsiteX14" fmla="*/ 1387478 w 1817160"/>
              <a:gd name="connsiteY14" fmla="*/ 1141760 h 1525690"/>
              <a:gd name="connsiteX15" fmla="*/ 1453094 w 1817160"/>
              <a:gd name="connsiteY15" fmla="*/ 1414810 h 1525690"/>
              <a:gd name="connsiteX16" fmla="*/ 1504297 w 1817160"/>
              <a:gd name="connsiteY16" fmla="*/ 1494938 h 1525690"/>
              <a:gd name="connsiteX17" fmla="*/ 1622427 w 1817160"/>
              <a:gd name="connsiteY17" fmla="*/ 1524877 h 1525690"/>
              <a:gd name="connsiteX18" fmla="*/ 1817160 w 1817160"/>
              <a:gd name="connsiteY18" fmla="*/ 1516410 h 1525690"/>
              <a:gd name="connsiteX19" fmla="*/ 1817160 w 1817160"/>
              <a:gd name="connsiteY19" fmla="*/ 1516410 h 1525690"/>
              <a:gd name="connsiteX20" fmla="*/ 1817160 w 1817160"/>
              <a:gd name="connsiteY20" fmla="*/ 1516410 h 1525690"/>
              <a:gd name="connsiteX0" fmla="*/ 0 w 1817160"/>
              <a:gd name="connsiteY0" fmla="*/ 1516411 h 1526345"/>
              <a:gd name="connsiteX1" fmla="*/ 174637 w 1817160"/>
              <a:gd name="connsiteY1" fmla="*/ 1502385 h 1526345"/>
              <a:gd name="connsiteX2" fmla="*/ 335760 w 1817160"/>
              <a:gd name="connsiteY2" fmla="*/ 1474078 h 1526345"/>
              <a:gd name="connsiteX3" fmla="*/ 460907 w 1817160"/>
              <a:gd name="connsiteY3" fmla="*/ 1414810 h 1526345"/>
              <a:gd name="connsiteX4" fmla="*/ 547160 w 1817160"/>
              <a:gd name="connsiteY4" fmla="*/ 1253943 h 1526345"/>
              <a:gd name="connsiteX5" fmla="*/ 708027 w 1817160"/>
              <a:gd name="connsiteY5" fmla="*/ 635877 h 1526345"/>
              <a:gd name="connsiteX6" fmla="*/ 763060 w 1817160"/>
              <a:gd name="connsiteY6" fmla="*/ 445377 h 1526345"/>
              <a:gd name="connsiteX7" fmla="*/ 815977 w 1817160"/>
              <a:gd name="connsiteY7" fmla="*/ 263344 h 1526345"/>
              <a:gd name="connsiteX8" fmla="*/ 866775 w 1817160"/>
              <a:gd name="connsiteY8" fmla="*/ 123643 h 1526345"/>
              <a:gd name="connsiteX9" fmla="*/ 923928 w 1817160"/>
              <a:gd name="connsiteY9" fmla="*/ 30510 h 1526345"/>
              <a:gd name="connsiteX10" fmla="*/ 1005529 w 1817160"/>
              <a:gd name="connsiteY10" fmla="*/ 27 h 1526345"/>
              <a:gd name="connsiteX11" fmla="*/ 1086911 w 1817160"/>
              <a:gd name="connsiteY11" fmla="*/ 43210 h 1526345"/>
              <a:gd name="connsiteX12" fmla="*/ 1154644 w 1817160"/>
              <a:gd name="connsiteY12" fmla="*/ 185026 h 1526345"/>
              <a:gd name="connsiteX13" fmla="*/ 1211794 w 1817160"/>
              <a:gd name="connsiteY13" fmla="*/ 396694 h 1526345"/>
              <a:gd name="connsiteX14" fmla="*/ 1387478 w 1817160"/>
              <a:gd name="connsiteY14" fmla="*/ 1141760 h 1526345"/>
              <a:gd name="connsiteX15" fmla="*/ 1453094 w 1817160"/>
              <a:gd name="connsiteY15" fmla="*/ 1414810 h 1526345"/>
              <a:gd name="connsiteX16" fmla="*/ 1510948 w 1817160"/>
              <a:gd name="connsiteY16" fmla="*/ 1483974 h 1526345"/>
              <a:gd name="connsiteX17" fmla="*/ 1622427 w 1817160"/>
              <a:gd name="connsiteY17" fmla="*/ 1524877 h 1526345"/>
              <a:gd name="connsiteX18" fmla="*/ 1817160 w 1817160"/>
              <a:gd name="connsiteY18" fmla="*/ 1516410 h 1526345"/>
              <a:gd name="connsiteX19" fmla="*/ 1817160 w 1817160"/>
              <a:gd name="connsiteY19" fmla="*/ 1516410 h 1526345"/>
              <a:gd name="connsiteX20" fmla="*/ 1817160 w 1817160"/>
              <a:gd name="connsiteY20" fmla="*/ 1516410 h 1526345"/>
              <a:gd name="connsiteX0" fmla="*/ 0 w 1817160"/>
              <a:gd name="connsiteY0" fmla="*/ 1516411 h 1526345"/>
              <a:gd name="connsiteX1" fmla="*/ 174637 w 1817160"/>
              <a:gd name="connsiteY1" fmla="*/ 1502385 h 1526345"/>
              <a:gd name="connsiteX2" fmla="*/ 335760 w 1817160"/>
              <a:gd name="connsiteY2" fmla="*/ 1474078 h 1526345"/>
              <a:gd name="connsiteX3" fmla="*/ 460907 w 1817160"/>
              <a:gd name="connsiteY3" fmla="*/ 1414810 h 1526345"/>
              <a:gd name="connsiteX4" fmla="*/ 547160 w 1817160"/>
              <a:gd name="connsiteY4" fmla="*/ 1253943 h 1526345"/>
              <a:gd name="connsiteX5" fmla="*/ 708027 w 1817160"/>
              <a:gd name="connsiteY5" fmla="*/ 635877 h 1526345"/>
              <a:gd name="connsiteX6" fmla="*/ 763060 w 1817160"/>
              <a:gd name="connsiteY6" fmla="*/ 445377 h 1526345"/>
              <a:gd name="connsiteX7" fmla="*/ 815977 w 1817160"/>
              <a:gd name="connsiteY7" fmla="*/ 263344 h 1526345"/>
              <a:gd name="connsiteX8" fmla="*/ 866775 w 1817160"/>
              <a:gd name="connsiteY8" fmla="*/ 123643 h 1526345"/>
              <a:gd name="connsiteX9" fmla="*/ 923928 w 1817160"/>
              <a:gd name="connsiteY9" fmla="*/ 30510 h 1526345"/>
              <a:gd name="connsiteX10" fmla="*/ 1005529 w 1817160"/>
              <a:gd name="connsiteY10" fmla="*/ 27 h 1526345"/>
              <a:gd name="connsiteX11" fmla="*/ 1086911 w 1817160"/>
              <a:gd name="connsiteY11" fmla="*/ 43210 h 1526345"/>
              <a:gd name="connsiteX12" fmla="*/ 1154644 w 1817160"/>
              <a:gd name="connsiteY12" fmla="*/ 185026 h 1526345"/>
              <a:gd name="connsiteX13" fmla="*/ 1211794 w 1817160"/>
              <a:gd name="connsiteY13" fmla="*/ 396694 h 1526345"/>
              <a:gd name="connsiteX14" fmla="*/ 1387478 w 1817160"/>
              <a:gd name="connsiteY14" fmla="*/ 1141760 h 1526345"/>
              <a:gd name="connsiteX15" fmla="*/ 1453094 w 1817160"/>
              <a:gd name="connsiteY15" fmla="*/ 1414810 h 1526345"/>
              <a:gd name="connsiteX16" fmla="*/ 1510948 w 1817160"/>
              <a:gd name="connsiteY16" fmla="*/ 1483974 h 1526345"/>
              <a:gd name="connsiteX17" fmla="*/ 1622427 w 1817160"/>
              <a:gd name="connsiteY17" fmla="*/ 1524877 h 1526345"/>
              <a:gd name="connsiteX18" fmla="*/ 1817160 w 1817160"/>
              <a:gd name="connsiteY18" fmla="*/ 1516410 h 1526345"/>
              <a:gd name="connsiteX19" fmla="*/ 1817160 w 1817160"/>
              <a:gd name="connsiteY19" fmla="*/ 1516410 h 1526345"/>
              <a:gd name="connsiteX20" fmla="*/ 1817160 w 1817160"/>
              <a:gd name="connsiteY20" fmla="*/ 1516410 h 1526345"/>
              <a:gd name="connsiteX0" fmla="*/ 0 w 1817160"/>
              <a:gd name="connsiteY0" fmla="*/ 1516411 h 1526345"/>
              <a:gd name="connsiteX1" fmla="*/ 174637 w 1817160"/>
              <a:gd name="connsiteY1" fmla="*/ 1502385 h 1526345"/>
              <a:gd name="connsiteX2" fmla="*/ 335760 w 1817160"/>
              <a:gd name="connsiteY2" fmla="*/ 1474078 h 1526345"/>
              <a:gd name="connsiteX3" fmla="*/ 460907 w 1817160"/>
              <a:gd name="connsiteY3" fmla="*/ 1414810 h 1526345"/>
              <a:gd name="connsiteX4" fmla="*/ 547160 w 1817160"/>
              <a:gd name="connsiteY4" fmla="*/ 1253943 h 1526345"/>
              <a:gd name="connsiteX5" fmla="*/ 708027 w 1817160"/>
              <a:gd name="connsiteY5" fmla="*/ 635877 h 1526345"/>
              <a:gd name="connsiteX6" fmla="*/ 763060 w 1817160"/>
              <a:gd name="connsiteY6" fmla="*/ 445377 h 1526345"/>
              <a:gd name="connsiteX7" fmla="*/ 815977 w 1817160"/>
              <a:gd name="connsiteY7" fmla="*/ 263344 h 1526345"/>
              <a:gd name="connsiteX8" fmla="*/ 866775 w 1817160"/>
              <a:gd name="connsiteY8" fmla="*/ 123643 h 1526345"/>
              <a:gd name="connsiteX9" fmla="*/ 923928 w 1817160"/>
              <a:gd name="connsiteY9" fmla="*/ 30510 h 1526345"/>
              <a:gd name="connsiteX10" fmla="*/ 1005529 w 1817160"/>
              <a:gd name="connsiteY10" fmla="*/ 27 h 1526345"/>
              <a:gd name="connsiteX11" fmla="*/ 1086911 w 1817160"/>
              <a:gd name="connsiteY11" fmla="*/ 43210 h 1526345"/>
              <a:gd name="connsiteX12" fmla="*/ 1154644 w 1817160"/>
              <a:gd name="connsiteY12" fmla="*/ 185026 h 1526345"/>
              <a:gd name="connsiteX13" fmla="*/ 1211794 w 1817160"/>
              <a:gd name="connsiteY13" fmla="*/ 396694 h 1526345"/>
              <a:gd name="connsiteX14" fmla="*/ 1387478 w 1817160"/>
              <a:gd name="connsiteY14" fmla="*/ 1141760 h 1526345"/>
              <a:gd name="connsiteX15" fmla="*/ 1453094 w 1817160"/>
              <a:gd name="connsiteY15" fmla="*/ 1414810 h 1526345"/>
              <a:gd name="connsiteX16" fmla="*/ 1510948 w 1817160"/>
              <a:gd name="connsiteY16" fmla="*/ 1483974 h 1526345"/>
              <a:gd name="connsiteX17" fmla="*/ 1622427 w 1817160"/>
              <a:gd name="connsiteY17" fmla="*/ 1524877 h 1526345"/>
              <a:gd name="connsiteX18" fmla="*/ 1817160 w 1817160"/>
              <a:gd name="connsiteY18" fmla="*/ 1516410 h 1526345"/>
              <a:gd name="connsiteX19" fmla="*/ 1817160 w 1817160"/>
              <a:gd name="connsiteY19" fmla="*/ 1516410 h 1526345"/>
              <a:gd name="connsiteX20" fmla="*/ 1817160 w 1817160"/>
              <a:gd name="connsiteY20" fmla="*/ 1516410 h 1526345"/>
              <a:gd name="connsiteX0" fmla="*/ 0 w 1817160"/>
              <a:gd name="connsiteY0" fmla="*/ 1516411 h 1526345"/>
              <a:gd name="connsiteX1" fmla="*/ 174637 w 1817160"/>
              <a:gd name="connsiteY1" fmla="*/ 1502385 h 1526345"/>
              <a:gd name="connsiteX2" fmla="*/ 335760 w 1817160"/>
              <a:gd name="connsiteY2" fmla="*/ 1474078 h 1526345"/>
              <a:gd name="connsiteX3" fmla="*/ 460907 w 1817160"/>
              <a:gd name="connsiteY3" fmla="*/ 1414810 h 1526345"/>
              <a:gd name="connsiteX4" fmla="*/ 547160 w 1817160"/>
              <a:gd name="connsiteY4" fmla="*/ 1253943 h 1526345"/>
              <a:gd name="connsiteX5" fmla="*/ 708027 w 1817160"/>
              <a:gd name="connsiteY5" fmla="*/ 635877 h 1526345"/>
              <a:gd name="connsiteX6" fmla="*/ 763060 w 1817160"/>
              <a:gd name="connsiteY6" fmla="*/ 445377 h 1526345"/>
              <a:gd name="connsiteX7" fmla="*/ 815977 w 1817160"/>
              <a:gd name="connsiteY7" fmla="*/ 263344 h 1526345"/>
              <a:gd name="connsiteX8" fmla="*/ 866775 w 1817160"/>
              <a:gd name="connsiteY8" fmla="*/ 123643 h 1526345"/>
              <a:gd name="connsiteX9" fmla="*/ 923928 w 1817160"/>
              <a:gd name="connsiteY9" fmla="*/ 30510 h 1526345"/>
              <a:gd name="connsiteX10" fmla="*/ 1005529 w 1817160"/>
              <a:gd name="connsiteY10" fmla="*/ 27 h 1526345"/>
              <a:gd name="connsiteX11" fmla="*/ 1086911 w 1817160"/>
              <a:gd name="connsiteY11" fmla="*/ 43210 h 1526345"/>
              <a:gd name="connsiteX12" fmla="*/ 1154644 w 1817160"/>
              <a:gd name="connsiteY12" fmla="*/ 185026 h 1526345"/>
              <a:gd name="connsiteX13" fmla="*/ 1211794 w 1817160"/>
              <a:gd name="connsiteY13" fmla="*/ 396694 h 1526345"/>
              <a:gd name="connsiteX14" fmla="*/ 1387478 w 1817160"/>
              <a:gd name="connsiteY14" fmla="*/ 1141760 h 1526345"/>
              <a:gd name="connsiteX15" fmla="*/ 1442007 w 1817160"/>
              <a:gd name="connsiteY15" fmla="*/ 1373147 h 1526345"/>
              <a:gd name="connsiteX16" fmla="*/ 1510948 w 1817160"/>
              <a:gd name="connsiteY16" fmla="*/ 1483974 h 1526345"/>
              <a:gd name="connsiteX17" fmla="*/ 1622427 w 1817160"/>
              <a:gd name="connsiteY17" fmla="*/ 1524877 h 1526345"/>
              <a:gd name="connsiteX18" fmla="*/ 1817160 w 1817160"/>
              <a:gd name="connsiteY18" fmla="*/ 1516410 h 1526345"/>
              <a:gd name="connsiteX19" fmla="*/ 1817160 w 1817160"/>
              <a:gd name="connsiteY19" fmla="*/ 1516410 h 1526345"/>
              <a:gd name="connsiteX20" fmla="*/ 1817160 w 1817160"/>
              <a:gd name="connsiteY20" fmla="*/ 1516410 h 1526345"/>
              <a:gd name="connsiteX0" fmla="*/ 0 w 1832682"/>
              <a:gd name="connsiteY0" fmla="*/ 1516411 h 1529567"/>
              <a:gd name="connsiteX1" fmla="*/ 174637 w 1832682"/>
              <a:gd name="connsiteY1" fmla="*/ 1502385 h 1529567"/>
              <a:gd name="connsiteX2" fmla="*/ 335760 w 1832682"/>
              <a:gd name="connsiteY2" fmla="*/ 1474078 h 1529567"/>
              <a:gd name="connsiteX3" fmla="*/ 460907 w 1832682"/>
              <a:gd name="connsiteY3" fmla="*/ 1414810 h 1529567"/>
              <a:gd name="connsiteX4" fmla="*/ 547160 w 1832682"/>
              <a:gd name="connsiteY4" fmla="*/ 1253943 h 1529567"/>
              <a:gd name="connsiteX5" fmla="*/ 708027 w 1832682"/>
              <a:gd name="connsiteY5" fmla="*/ 635877 h 1529567"/>
              <a:gd name="connsiteX6" fmla="*/ 763060 w 1832682"/>
              <a:gd name="connsiteY6" fmla="*/ 445377 h 1529567"/>
              <a:gd name="connsiteX7" fmla="*/ 815977 w 1832682"/>
              <a:gd name="connsiteY7" fmla="*/ 263344 h 1529567"/>
              <a:gd name="connsiteX8" fmla="*/ 866775 w 1832682"/>
              <a:gd name="connsiteY8" fmla="*/ 123643 h 1529567"/>
              <a:gd name="connsiteX9" fmla="*/ 923928 w 1832682"/>
              <a:gd name="connsiteY9" fmla="*/ 30510 h 1529567"/>
              <a:gd name="connsiteX10" fmla="*/ 1005529 w 1832682"/>
              <a:gd name="connsiteY10" fmla="*/ 27 h 1529567"/>
              <a:gd name="connsiteX11" fmla="*/ 1086911 w 1832682"/>
              <a:gd name="connsiteY11" fmla="*/ 43210 h 1529567"/>
              <a:gd name="connsiteX12" fmla="*/ 1154644 w 1832682"/>
              <a:gd name="connsiteY12" fmla="*/ 185026 h 1529567"/>
              <a:gd name="connsiteX13" fmla="*/ 1211794 w 1832682"/>
              <a:gd name="connsiteY13" fmla="*/ 396694 h 1529567"/>
              <a:gd name="connsiteX14" fmla="*/ 1387478 w 1832682"/>
              <a:gd name="connsiteY14" fmla="*/ 1141760 h 1529567"/>
              <a:gd name="connsiteX15" fmla="*/ 1442007 w 1832682"/>
              <a:gd name="connsiteY15" fmla="*/ 1373147 h 1529567"/>
              <a:gd name="connsiteX16" fmla="*/ 1510948 w 1832682"/>
              <a:gd name="connsiteY16" fmla="*/ 1483974 h 1529567"/>
              <a:gd name="connsiteX17" fmla="*/ 1622427 w 1832682"/>
              <a:gd name="connsiteY17" fmla="*/ 1524877 h 1529567"/>
              <a:gd name="connsiteX18" fmla="*/ 1817160 w 1832682"/>
              <a:gd name="connsiteY18" fmla="*/ 1516410 h 1529567"/>
              <a:gd name="connsiteX19" fmla="*/ 1817160 w 1832682"/>
              <a:gd name="connsiteY19" fmla="*/ 1516410 h 1529567"/>
              <a:gd name="connsiteX20" fmla="*/ 1832682 w 1832682"/>
              <a:gd name="connsiteY20" fmla="*/ 1529567 h 1529567"/>
              <a:gd name="connsiteX0" fmla="*/ 0 w 1817160"/>
              <a:gd name="connsiteY0" fmla="*/ 1516411 h 1529567"/>
              <a:gd name="connsiteX1" fmla="*/ 174637 w 1817160"/>
              <a:gd name="connsiteY1" fmla="*/ 1502385 h 1529567"/>
              <a:gd name="connsiteX2" fmla="*/ 335760 w 1817160"/>
              <a:gd name="connsiteY2" fmla="*/ 1474078 h 1529567"/>
              <a:gd name="connsiteX3" fmla="*/ 460907 w 1817160"/>
              <a:gd name="connsiteY3" fmla="*/ 1414810 h 1529567"/>
              <a:gd name="connsiteX4" fmla="*/ 547160 w 1817160"/>
              <a:gd name="connsiteY4" fmla="*/ 1253943 h 1529567"/>
              <a:gd name="connsiteX5" fmla="*/ 708027 w 1817160"/>
              <a:gd name="connsiteY5" fmla="*/ 635877 h 1529567"/>
              <a:gd name="connsiteX6" fmla="*/ 763060 w 1817160"/>
              <a:gd name="connsiteY6" fmla="*/ 445377 h 1529567"/>
              <a:gd name="connsiteX7" fmla="*/ 815977 w 1817160"/>
              <a:gd name="connsiteY7" fmla="*/ 263344 h 1529567"/>
              <a:gd name="connsiteX8" fmla="*/ 866775 w 1817160"/>
              <a:gd name="connsiteY8" fmla="*/ 123643 h 1529567"/>
              <a:gd name="connsiteX9" fmla="*/ 923928 w 1817160"/>
              <a:gd name="connsiteY9" fmla="*/ 30510 h 1529567"/>
              <a:gd name="connsiteX10" fmla="*/ 1005529 w 1817160"/>
              <a:gd name="connsiteY10" fmla="*/ 27 h 1529567"/>
              <a:gd name="connsiteX11" fmla="*/ 1086911 w 1817160"/>
              <a:gd name="connsiteY11" fmla="*/ 43210 h 1529567"/>
              <a:gd name="connsiteX12" fmla="*/ 1154644 w 1817160"/>
              <a:gd name="connsiteY12" fmla="*/ 185026 h 1529567"/>
              <a:gd name="connsiteX13" fmla="*/ 1211794 w 1817160"/>
              <a:gd name="connsiteY13" fmla="*/ 396694 h 1529567"/>
              <a:gd name="connsiteX14" fmla="*/ 1387478 w 1817160"/>
              <a:gd name="connsiteY14" fmla="*/ 1141760 h 1529567"/>
              <a:gd name="connsiteX15" fmla="*/ 1442007 w 1817160"/>
              <a:gd name="connsiteY15" fmla="*/ 1373147 h 1529567"/>
              <a:gd name="connsiteX16" fmla="*/ 1510948 w 1817160"/>
              <a:gd name="connsiteY16" fmla="*/ 1483974 h 1529567"/>
              <a:gd name="connsiteX17" fmla="*/ 1622427 w 1817160"/>
              <a:gd name="connsiteY17" fmla="*/ 1524877 h 1529567"/>
              <a:gd name="connsiteX18" fmla="*/ 1817160 w 1817160"/>
              <a:gd name="connsiteY18" fmla="*/ 1516410 h 1529567"/>
              <a:gd name="connsiteX19" fmla="*/ 1817160 w 1817160"/>
              <a:gd name="connsiteY19" fmla="*/ 1516410 h 1529567"/>
              <a:gd name="connsiteX20" fmla="*/ 1781684 w 1817160"/>
              <a:gd name="connsiteY20" fmla="*/ 1529567 h 1529567"/>
              <a:gd name="connsiteX0" fmla="*/ 0 w 1865942"/>
              <a:gd name="connsiteY0" fmla="*/ 1516411 h 1654557"/>
              <a:gd name="connsiteX1" fmla="*/ 174637 w 1865942"/>
              <a:gd name="connsiteY1" fmla="*/ 1502385 h 1654557"/>
              <a:gd name="connsiteX2" fmla="*/ 335760 w 1865942"/>
              <a:gd name="connsiteY2" fmla="*/ 1474078 h 1654557"/>
              <a:gd name="connsiteX3" fmla="*/ 460907 w 1865942"/>
              <a:gd name="connsiteY3" fmla="*/ 1414810 h 1654557"/>
              <a:gd name="connsiteX4" fmla="*/ 547160 w 1865942"/>
              <a:gd name="connsiteY4" fmla="*/ 1253943 h 1654557"/>
              <a:gd name="connsiteX5" fmla="*/ 708027 w 1865942"/>
              <a:gd name="connsiteY5" fmla="*/ 635877 h 1654557"/>
              <a:gd name="connsiteX6" fmla="*/ 763060 w 1865942"/>
              <a:gd name="connsiteY6" fmla="*/ 445377 h 1654557"/>
              <a:gd name="connsiteX7" fmla="*/ 815977 w 1865942"/>
              <a:gd name="connsiteY7" fmla="*/ 263344 h 1654557"/>
              <a:gd name="connsiteX8" fmla="*/ 866775 w 1865942"/>
              <a:gd name="connsiteY8" fmla="*/ 123643 h 1654557"/>
              <a:gd name="connsiteX9" fmla="*/ 923928 w 1865942"/>
              <a:gd name="connsiteY9" fmla="*/ 30510 h 1654557"/>
              <a:gd name="connsiteX10" fmla="*/ 1005529 w 1865942"/>
              <a:gd name="connsiteY10" fmla="*/ 27 h 1654557"/>
              <a:gd name="connsiteX11" fmla="*/ 1086911 w 1865942"/>
              <a:gd name="connsiteY11" fmla="*/ 43210 h 1654557"/>
              <a:gd name="connsiteX12" fmla="*/ 1154644 w 1865942"/>
              <a:gd name="connsiteY12" fmla="*/ 185026 h 1654557"/>
              <a:gd name="connsiteX13" fmla="*/ 1211794 w 1865942"/>
              <a:gd name="connsiteY13" fmla="*/ 396694 h 1654557"/>
              <a:gd name="connsiteX14" fmla="*/ 1387478 w 1865942"/>
              <a:gd name="connsiteY14" fmla="*/ 1141760 h 1654557"/>
              <a:gd name="connsiteX15" fmla="*/ 1442007 w 1865942"/>
              <a:gd name="connsiteY15" fmla="*/ 1373147 h 1654557"/>
              <a:gd name="connsiteX16" fmla="*/ 1510948 w 1865942"/>
              <a:gd name="connsiteY16" fmla="*/ 1483974 h 1654557"/>
              <a:gd name="connsiteX17" fmla="*/ 1622427 w 1865942"/>
              <a:gd name="connsiteY17" fmla="*/ 1524877 h 1654557"/>
              <a:gd name="connsiteX18" fmla="*/ 1817160 w 1865942"/>
              <a:gd name="connsiteY18" fmla="*/ 1516410 h 1654557"/>
              <a:gd name="connsiteX19" fmla="*/ 1817160 w 1865942"/>
              <a:gd name="connsiteY19" fmla="*/ 1516410 h 1654557"/>
              <a:gd name="connsiteX20" fmla="*/ 1865942 w 1865942"/>
              <a:gd name="connsiteY20" fmla="*/ 1654557 h 1654557"/>
              <a:gd name="connsiteX0" fmla="*/ 0 w 1865942"/>
              <a:gd name="connsiteY0" fmla="*/ 1516411 h 1654557"/>
              <a:gd name="connsiteX1" fmla="*/ 174637 w 1865942"/>
              <a:gd name="connsiteY1" fmla="*/ 1502385 h 1654557"/>
              <a:gd name="connsiteX2" fmla="*/ 335760 w 1865942"/>
              <a:gd name="connsiteY2" fmla="*/ 1474078 h 1654557"/>
              <a:gd name="connsiteX3" fmla="*/ 460907 w 1865942"/>
              <a:gd name="connsiteY3" fmla="*/ 1414810 h 1654557"/>
              <a:gd name="connsiteX4" fmla="*/ 547160 w 1865942"/>
              <a:gd name="connsiteY4" fmla="*/ 1253943 h 1654557"/>
              <a:gd name="connsiteX5" fmla="*/ 708027 w 1865942"/>
              <a:gd name="connsiteY5" fmla="*/ 635877 h 1654557"/>
              <a:gd name="connsiteX6" fmla="*/ 763060 w 1865942"/>
              <a:gd name="connsiteY6" fmla="*/ 445377 h 1654557"/>
              <a:gd name="connsiteX7" fmla="*/ 815977 w 1865942"/>
              <a:gd name="connsiteY7" fmla="*/ 263344 h 1654557"/>
              <a:gd name="connsiteX8" fmla="*/ 866775 w 1865942"/>
              <a:gd name="connsiteY8" fmla="*/ 123643 h 1654557"/>
              <a:gd name="connsiteX9" fmla="*/ 923928 w 1865942"/>
              <a:gd name="connsiteY9" fmla="*/ 30510 h 1654557"/>
              <a:gd name="connsiteX10" fmla="*/ 1005529 w 1865942"/>
              <a:gd name="connsiteY10" fmla="*/ 27 h 1654557"/>
              <a:gd name="connsiteX11" fmla="*/ 1086911 w 1865942"/>
              <a:gd name="connsiteY11" fmla="*/ 43210 h 1654557"/>
              <a:gd name="connsiteX12" fmla="*/ 1154644 w 1865942"/>
              <a:gd name="connsiteY12" fmla="*/ 185026 h 1654557"/>
              <a:gd name="connsiteX13" fmla="*/ 1211794 w 1865942"/>
              <a:gd name="connsiteY13" fmla="*/ 396694 h 1654557"/>
              <a:gd name="connsiteX14" fmla="*/ 1387478 w 1865942"/>
              <a:gd name="connsiteY14" fmla="*/ 1141760 h 1654557"/>
              <a:gd name="connsiteX15" fmla="*/ 1442007 w 1865942"/>
              <a:gd name="connsiteY15" fmla="*/ 1373147 h 1654557"/>
              <a:gd name="connsiteX16" fmla="*/ 1510948 w 1865942"/>
              <a:gd name="connsiteY16" fmla="*/ 1483974 h 1654557"/>
              <a:gd name="connsiteX17" fmla="*/ 1622427 w 1865942"/>
              <a:gd name="connsiteY17" fmla="*/ 1524877 h 1654557"/>
              <a:gd name="connsiteX18" fmla="*/ 1817160 w 1865942"/>
              <a:gd name="connsiteY18" fmla="*/ 1516410 h 1654557"/>
              <a:gd name="connsiteX19" fmla="*/ 1814942 w 1865942"/>
              <a:gd name="connsiteY19" fmla="*/ 1522989 h 1654557"/>
              <a:gd name="connsiteX20" fmla="*/ 1865942 w 1865942"/>
              <a:gd name="connsiteY20" fmla="*/ 1654557 h 1654557"/>
              <a:gd name="connsiteX0" fmla="*/ 0 w 1865942"/>
              <a:gd name="connsiteY0" fmla="*/ 1516411 h 1654557"/>
              <a:gd name="connsiteX1" fmla="*/ 174637 w 1865942"/>
              <a:gd name="connsiteY1" fmla="*/ 1502385 h 1654557"/>
              <a:gd name="connsiteX2" fmla="*/ 335760 w 1865942"/>
              <a:gd name="connsiteY2" fmla="*/ 1474078 h 1654557"/>
              <a:gd name="connsiteX3" fmla="*/ 460907 w 1865942"/>
              <a:gd name="connsiteY3" fmla="*/ 1414810 h 1654557"/>
              <a:gd name="connsiteX4" fmla="*/ 547160 w 1865942"/>
              <a:gd name="connsiteY4" fmla="*/ 1253943 h 1654557"/>
              <a:gd name="connsiteX5" fmla="*/ 708027 w 1865942"/>
              <a:gd name="connsiteY5" fmla="*/ 635877 h 1654557"/>
              <a:gd name="connsiteX6" fmla="*/ 763060 w 1865942"/>
              <a:gd name="connsiteY6" fmla="*/ 445377 h 1654557"/>
              <a:gd name="connsiteX7" fmla="*/ 815977 w 1865942"/>
              <a:gd name="connsiteY7" fmla="*/ 263344 h 1654557"/>
              <a:gd name="connsiteX8" fmla="*/ 866775 w 1865942"/>
              <a:gd name="connsiteY8" fmla="*/ 123643 h 1654557"/>
              <a:gd name="connsiteX9" fmla="*/ 923928 w 1865942"/>
              <a:gd name="connsiteY9" fmla="*/ 30510 h 1654557"/>
              <a:gd name="connsiteX10" fmla="*/ 1005529 w 1865942"/>
              <a:gd name="connsiteY10" fmla="*/ 27 h 1654557"/>
              <a:gd name="connsiteX11" fmla="*/ 1086911 w 1865942"/>
              <a:gd name="connsiteY11" fmla="*/ 43210 h 1654557"/>
              <a:gd name="connsiteX12" fmla="*/ 1154644 w 1865942"/>
              <a:gd name="connsiteY12" fmla="*/ 185026 h 1654557"/>
              <a:gd name="connsiteX13" fmla="*/ 1211794 w 1865942"/>
              <a:gd name="connsiteY13" fmla="*/ 396694 h 1654557"/>
              <a:gd name="connsiteX14" fmla="*/ 1387478 w 1865942"/>
              <a:gd name="connsiteY14" fmla="*/ 1141760 h 1654557"/>
              <a:gd name="connsiteX15" fmla="*/ 1442007 w 1865942"/>
              <a:gd name="connsiteY15" fmla="*/ 1373147 h 1654557"/>
              <a:gd name="connsiteX16" fmla="*/ 1510948 w 1865942"/>
              <a:gd name="connsiteY16" fmla="*/ 1483974 h 1654557"/>
              <a:gd name="connsiteX17" fmla="*/ 1622427 w 1865942"/>
              <a:gd name="connsiteY17" fmla="*/ 1524877 h 1654557"/>
              <a:gd name="connsiteX18" fmla="*/ 1817160 w 1865942"/>
              <a:gd name="connsiteY18" fmla="*/ 1516410 h 1654557"/>
              <a:gd name="connsiteX19" fmla="*/ 1865942 w 1865942"/>
              <a:gd name="connsiteY19" fmla="*/ 1654557 h 1654557"/>
              <a:gd name="connsiteX0" fmla="*/ 0 w 1865942"/>
              <a:gd name="connsiteY0" fmla="*/ 1516411 h 1654557"/>
              <a:gd name="connsiteX1" fmla="*/ 174637 w 1865942"/>
              <a:gd name="connsiteY1" fmla="*/ 1502385 h 1654557"/>
              <a:gd name="connsiteX2" fmla="*/ 335760 w 1865942"/>
              <a:gd name="connsiteY2" fmla="*/ 1474078 h 1654557"/>
              <a:gd name="connsiteX3" fmla="*/ 460907 w 1865942"/>
              <a:gd name="connsiteY3" fmla="*/ 1414810 h 1654557"/>
              <a:gd name="connsiteX4" fmla="*/ 547160 w 1865942"/>
              <a:gd name="connsiteY4" fmla="*/ 1253943 h 1654557"/>
              <a:gd name="connsiteX5" fmla="*/ 708027 w 1865942"/>
              <a:gd name="connsiteY5" fmla="*/ 635877 h 1654557"/>
              <a:gd name="connsiteX6" fmla="*/ 763060 w 1865942"/>
              <a:gd name="connsiteY6" fmla="*/ 445377 h 1654557"/>
              <a:gd name="connsiteX7" fmla="*/ 815977 w 1865942"/>
              <a:gd name="connsiteY7" fmla="*/ 263344 h 1654557"/>
              <a:gd name="connsiteX8" fmla="*/ 866775 w 1865942"/>
              <a:gd name="connsiteY8" fmla="*/ 123643 h 1654557"/>
              <a:gd name="connsiteX9" fmla="*/ 923928 w 1865942"/>
              <a:gd name="connsiteY9" fmla="*/ 30510 h 1654557"/>
              <a:gd name="connsiteX10" fmla="*/ 1005529 w 1865942"/>
              <a:gd name="connsiteY10" fmla="*/ 27 h 1654557"/>
              <a:gd name="connsiteX11" fmla="*/ 1086911 w 1865942"/>
              <a:gd name="connsiteY11" fmla="*/ 43210 h 1654557"/>
              <a:gd name="connsiteX12" fmla="*/ 1154644 w 1865942"/>
              <a:gd name="connsiteY12" fmla="*/ 185026 h 1654557"/>
              <a:gd name="connsiteX13" fmla="*/ 1211794 w 1865942"/>
              <a:gd name="connsiteY13" fmla="*/ 396694 h 1654557"/>
              <a:gd name="connsiteX14" fmla="*/ 1387478 w 1865942"/>
              <a:gd name="connsiteY14" fmla="*/ 1141760 h 1654557"/>
              <a:gd name="connsiteX15" fmla="*/ 1442007 w 1865942"/>
              <a:gd name="connsiteY15" fmla="*/ 1373147 h 1654557"/>
              <a:gd name="connsiteX16" fmla="*/ 1510948 w 1865942"/>
              <a:gd name="connsiteY16" fmla="*/ 1483974 h 1654557"/>
              <a:gd name="connsiteX17" fmla="*/ 1622427 w 1865942"/>
              <a:gd name="connsiteY17" fmla="*/ 1524877 h 1654557"/>
              <a:gd name="connsiteX18" fmla="*/ 1748423 w 1865942"/>
              <a:gd name="connsiteY18" fmla="*/ 1520796 h 1654557"/>
              <a:gd name="connsiteX19" fmla="*/ 1865942 w 1865942"/>
              <a:gd name="connsiteY19" fmla="*/ 1654557 h 1654557"/>
              <a:gd name="connsiteX0" fmla="*/ 0 w 1896984"/>
              <a:gd name="connsiteY0" fmla="*/ 1516411 h 1547110"/>
              <a:gd name="connsiteX1" fmla="*/ 174637 w 1896984"/>
              <a:gd name="connsiteY1" fmla="*/ 1502385 h 1547110"/>
              <a:gd name="connsiteX2" fmla="*/ 335760 w 1896984"/>
              <a:gd name="connsiteY2" fmla="*/ 1474078 h 1547110"/>
              <a:gd name="connsiteX3" fmla="*/ 460907 w 1896984"/>
              <a:gd name="connsiteY3" fmla="*/ 1414810 h 1547110"/>
              <a:gd name="connsiteX4" fmla="*/ 547160 w 1896984"/>
              <a:gd name="connsiteY4" fmla="*/ 1253943 h 1547110"/>
              <a:gd name="connsiteX5" fmla="*/ 708027 w 1896984"/>
              <a:gd name="connsiteY5" fmla="*/ 635877 h 1547110"/>
              <a:gd name="connsiteX6" fmla="*/ 763060 w 1896984"/>
              <a:gd name="connsiteY6" fmla="*/ 445377 h 1547110"/>
              <a:gd name="connsiteX7" fmla="*/ 815977 w 1896984"/>
              <a:gd name="connsiteY7" fmla="*/ 263344 h 1547110"/>
              <a:gd name="connsiteX8" fmla="*/ 866775 w 1896984"/>
              <a:gd name="connsiteY8" fmla="*/ 123643 h 1547110"/>
              <a:gd name="connsiteX9" fmla="*/ 923928 w 1896984"/>
              <a:gd name="connsiteY9" fmla="*/ 30510 h 1547110"/>
              <a:gd name="connsiteX10" fmla="*/ 1005529 w 1896984"/>
              <a:gd name="connsiteY10" fmla="*/ 27 h 1547110"/>
              <a:gd name="connsiteX11" fmla="*/ 1086911 w 1896984"/>
              <a:gd name="connsiteY11" fmla="*/ 43210 h 1547110"/>
              <a:gd name="connsiteX12" fmla="*/ 1154644 w 1896984"/>
              <a:gd name="connsiteY12" fmla="*/ 185026 h 1547110"/>
              <a:gd name="connsiteX13" fmla="*/ 1211794 w 1896984"/>
              <a:gd name="connsiteY13" fmla="*/ 396694 h 1547110"/>
              <a:gd name="connsiteX14" fmla="*/ 1387478 w 1896984"/>
              <a:gd name="connsiteY14" fmla="*/ 1141760 h 1547110"/>
              <a:gd name="connsiteX15" fmla="*/ 1442007 w 1896984"/>
              <a:gd name="connsiteY15" fmla="*/ 1373147 h 1547110"/>
              <a:gd name="connsiteX16" fmla="*/ 1510948 w 1896984"/>
              <a:gd name="connsiteY16" fmla="*/ 1483974 h 1547110"/>
              <a:gd name="connsiteX17" fmla="*/ 1622427 w 1896984"/>
              <a:gd name="connsiteY17" fmla="*/ 1524877 h 1547110"/>
              <a:gd name="connsiteX18" fmla="*/ 1748423 w 1896984"/>
              <a:gd name="connsiteY18" fmla="*/ 1520796 h 1547110"/>
              <a:gd name="connsiteX19" fmla="*/ 1896984 w 1896984"/>
              <a:gd name="connsiteY19" fmla="*/ 1547110 h 1547110"/>
              <a:gd name="connsiteX0" fmla="*/ 0 w 1896984"/>
              <a:gd name="connsiteY0" fmla="*/ 1516411 h 1547110"/>
              <a:gd name="connsiteX1" fmla="*/ 174637 w 1896984"/>
              <a:gd name="connsiteY1" fmla="*/ 1502385 h 1547110"/>
              <a:gd name="connsiteX2" fmla="*/ 335760 w 1896984"/>
              <a:gd name="connsiteY2" fmla="*/ 1474078 h 1547110"/>
              <a:gd name="connsiteX3" fmla="*/ 460907 w 1896984"/>
              <a:gd name="connsiteY3" fmla="*/ 1414810 h 1547110"/>
              <a:gd name="connsiteX4" fmla="*/ 547160 w 1896984"/>
              <a:gd name="connsiteY4" fmla="*/ 1253943 h 1547110"/>
              <a:gd name="connsiteX5" fmla="*/ 708027 w 1896984"/>
              <a:gd name="connsiteY5" fmla="*/ 635877 h 1547110"/>
              <a:gd name="connsiteX6" fmla="*/ 763060 w 1896984"/>
              <a:gd name="connsiteY6" fmla="*/ 445377 h 1547110"/>
              <a:gd name="connsiteX7" fmla="*/ 815977 w 1896984"/>
              <a:gd name="connsiteY7" fmla="*/ 263344 h 1547110"/>
              <a:gd name="connsiteX8" fmla="*/ 866775 w 1896984"/>
              <a:gd name="connsiteY8" fmla="*/ 123643 h 1547110"/>
              <a:gd name="connsiteX9" fmla="*/ 923928 w 1896984"/>
              <a:gd name="connsiteY9" fmla="*/ 30510 h 1547110"/>
              <a:gd name="connsiteX10" fmla="*/ 1005529 w 1896984"/>
              <a:gd name="connsiteY10" fmla="*/ 27 h 1547110"/>
              <a:gd name="connsiteX11" fmla="*/ 1086911 w 1896984"/>
              <a:gd name="connsiteY11" fmla="*/ 43210 h 1547110"/>
              <a:gd name="connsiteX12" fmla="*/ 1154644 w 1896984"/>
              <a:gd name="connsiteY12" fmla="*/ 185026 h 1547110"/>
              <a:gd name="connsiteX13" fmla="*/ 1211794 w 1896984"/>
              <a:gd name="connsiteY13" fmla="*/ 396694 h 1547110"/>
              <a:gd name="connsiteX14" fmla="*/ 1387478 w 1896984"/>
              <a:gd name="connsiteY14" fmla="*/ 1141760 h 1547110"/>
              <a:gd name="connsiteX15" fmla="*/ 1442007 w 1896984"/>
              <a:gd name="connsiteY15" fmla="*/ 1373147 h 1547110"/>
              <a:gd name="connsiteX16" fmla="*/ 1510948 w 1896984"/>
              <a:gd name="connsiteY16" fmla="*/ 1483974 h 1547110"/>
              <a:gd name="connsiteX17" fmla="*/ 1622427 w 1896984"/>
              <a:gd name="connsiteY17" fmla="*/ 1524877 h 1547110"/>
              <a:gd name="connsiteX18" fmla="*/ 1757292 w 1896984"/>
              <a:gd name="connsiteY18" fmla="*/ 1529567 h 1547110"/>
              <a:gd name="connsiteX19" fmla="*/ 1896984 w 1896984"/>
              <a:gd name="connsiteY19" fmla="*/ 1547110 h 1547110"/>
              <a:gd name="connsiteX0" fmla="*/ 0 w 1896984"/>
              <a:gd name="connsiteY0" fmla="*/ 1516411 h 1538339"/>
              <a:gd name="connsiteX1" fmla="*/ 174637 w 1896984"/>
              <a:gd name="connsiteY1" fmla="*/ 1502385 h 1538339"/>
              <a:gd name="connsiteX2" fmla="*/ 335760 w 1896984"/>
              <a:gd name="connsiteY2" fmla="*/ 1474078 h 1538339"/>
              <a:gd name="connsiteX3" fmla="*/ 460907 w 1896984"/>
              <a:gd name="connsiteY3" fmla="*/ 1414810 h 1538339"/>
              <a:gd name="connsiteX4" fmla="*/ 547160 w 1896984"/>
              <a:gd name="connsiteY4" fmla="*/ 1253943 h 1538339"/>
              <a:gd name="connsiteX5" fmla="*/ 708027 w 1896984"/>
              <a:gd name="connsiteY5" fmla="*/ 635877 h 1538339"/>
              <a:gd name="connsiteX6" fmla="*/ 763060 w 1896984"/>
              <a:gd name="connsiteY6" fmla="*/ 445377 h 1538339"/>
              <a:gd name="connsiteX7" fmla="*/ 815977 w 1896984"/>
              <a:gd name="connsiteY7" fmla="*/ 263344 h 1538339"/>
              <a:gd name="connsiteX8" fmla="*/ 866775 w 1896984"/>
              <a:gd name="connsiteY8" fmla="*/ 123643 h 1538339"/>
              <a:gd name="connsiteX9" fmla="*/ 923928 w 1896984"/>
              <a:gd name="connsiteY9" fmla="*/ 30510 h 1538339"/>
              <a:gd name="connsiteX10" fmla="*/ 1005529 w 1896984"/>
              <a:gd name="connsiteY10" fmla="*/ 27 h 1538339"/>
              <a:gd name="connsiteX11" fmla="*/ 1086911 w 1896984"/>
              <a:gd name="connsiteY11" fmla="*/ 43210 h 1538339"/>
              <a:gd name="connsiteX12" fmla="*/ 1154644 w 1896984"/>
              <a:gd name="connsiteY12" fmla="*/ 185026 h 1538339"/>
              <a:gd name="connsiteX13" fmla="*/ 1211794 w 1896984"/>
              <a:gd name="connsiteY13" fmla="*/ 396694 h 1538339"/>
              <a:gd name="connsiteX14" fmla="*/ 1387478 w 1896984"/>
              <a:gd name="connsiteY14" fmla="*/ 1141760 h 1538339"/>
              <a:gd name="connsiteX15" fmla="*/ 1442007 w 1896984"/>
              <a:gd name="connsiteY15" fmla="*/ 1373147 h 1538339"/>
              <a:gd name="connsiteX16" fmla="*/ 1510948 w 1896984"/>
              <a:gd name="connsiteY16" fmla="*/ 1483974 h 1538339"/>
              <a:gd name="connsiteX17" fmla="*/ 1622427 w 1896984"/>
              <a:gd name="connsiteY17" fmla="*/ 1524877 h 1538339"/>
              <a:gd name="connsiteX18" fmla="*/ 1757292 w 1896984"/>
              <a:gd name="connsiteY18" fmla="*/ 1529567 h 1538339"/>
              <a:gd name="connsiteX19" fmla="*/ 1896984 w 1896984"/>
              <a:gd name="connsiteY19" fmla="*/ 1538339 h 1538339"/>
              <a:gd name="connsiteX0" fmla="*/ 0 w 1896984"/>
              <a:gd name="connsiteY0" fmla="*/ 1516411 h 1538339"/>
              <a:gd name="connsiteX1" fmla="*/ 174637 w 1896984"/>
              <a:gd name="connsiteY1" fmla="*/ 1502385 h 1538339"/>
              <a:gd name="connsiteX2" fmla="*/ 335760 w 1896984"/>
              <a:gd name="connsiteY2" fmla="*/ 1474078 h 1538339"/>
              <a:gd name="connsiteX3" fmla="*/ 460907 w 1896984"/>
              <a:gd name="connsiteY3" fmla="*/ 1414810 h 1538339"/>
              <a:gd name="connsiteX4" fmla="*/ 547160 w 1896984"/>
              <a:gd name="connsiteY4" fmla="*/ 1253943 h 1538339"/>
              <a:gd name="connsiteX5" fmla="*/ 708027 w 1896984"/>
              <a:gd name="connsiteY5" fmla="*/ 635877 h 1538339"/>
              <a:gd name="connsiteX6" fmla="*/ 763060 w 1896984"/>
              <a:gd name="connsiteY6" fmla="*/ 445377 h 1538339"/>
              <a:gd name="connsiteX7" fmla="*/ 815977 w 1896984"/>
              <a:gd name="connsiteY7" fmla="*/ 263344 h 1538339"/>
              <a:gd name="connsiteX8" fmla="*/ 866775 w 1896984"/>
              <a:gd name="connsiteY8" fmla="*/ 123643 h 1538339"/>
              <a:gd name="connsiteX9" fmla="*/ 923928 w 1896984"/>
              <a:gd name="connsiteY9" fmla="*/ 30510 h 1538339"/>
              <a:gd name="connsiteX10" fmla="*/ 1005529 w 1896984"/>
              <a:gd name="connsiteY10" fmla="*/ 27 h 1538339"/>
              <a:gd name="connsiteX11" fmla="*/ 1086911 w 1896984"/>
              <a:gd name="connsiteY11" fmla="*/ 43210 h 1538339"/>
              <a:gd name="connsiteX12" fmla="*/ 1154644 w 1896984"/>
              <a:gd name="connsiteY12" fmla="*/ 185026 h 1538339"/>
              <a:gd name="connsiteX13" fmla="*/ 1211794 w 1896984"/>
              <a:gd name="connsiteY13" fmla="*/ 396694 h 1538339"/>
              <a:gd name="connsiteX14" fmla="*/ 1387478 w 1896984"/>
              <a:gd name="connsiteY14" fmla="*/ 1141760 h 1538339"/>
              <a:gd name="connsiteX15" fmla="*/ 1442007 w 1896984"/>
              <a:gd name="connsiteY15" fmla="*/ 1373147 h 1538339"/>
              <a:gd name="connsiteX16" fmla="*/ 1510948 w 1896984"/>
              <a:gd name="connsiteY16" fmla="*/ 1483974 h 1538339"/>
              <a:gd name="connsiteX17" fmla="*/ 1622427 w 1896984"/>
              <a:gd name="connsiteY17" fmla="*/ 1524877 h 1538339"/>
              <a:gd name="connsiteX18" fmla="*/ 1757292 w 1896984"/>
              <a:gd name="connsiteY18" fmla="*/ 1529567 h 1538339"/>
              <a:gd name="connsiteX19" fmla="*/ 1896984 w 1896984"/>
              <a:gd name="connsiteY19" fmla="*/ 1538339 h 1538339"/>
              <a:gd name="connsiteX0" fmla="*/ 0 w 1896984"/>
              <a:gd name="connsiteY0" fmla="*/ 1516411 h 1538339"/>
              <a:gd name="connsiteX1" fmla="*/ 174637 w 1896984"/>
              <a:gd name="connsiteY1" fmla="*/ 1502385 h 1538339"/>
              <a:gd name="connsiteX2" fmla="*/ 335760 w 1896984"/>
              <a:gd name="connsiteY2" fmla="*/ 1474078 h 1538339"/>
              <a:gd name="connsiteX3" fmla="*/ 460907 w 1896984"/>
              <a:gd name="connsiteY3" fmla="*/ 1414810 h 1538339"/>
              <a:gd name="connsiteX4" fmla="*/ 547160 w 1896984"/>
              <a:gd name="connsiteY4" fmla="*/ 1253943 h 1538339"/>
              <a:gd name="connsiteX5" fmla="*/ 708027 w 1896984"/>
              <a:gd name="connsiteY5" fmla="*/ 635877 h 1538339"/>
              <a:gd name="connsiteX6" fmla="*/ 763060 w 1896984"/>
              <a:gd name="connsiteY6" fmla="*/ 445377 h 1538339"/>
              <a:gd name="connsiteX7" fmla="*/ 815977 w 1896984"/>
              <a:gd name="connsiteY7" fmla="*/ 263344 h 1538339"/>
              <a:gd name="connsiteX8" fmla="*/ 866775 w 1896984"/>
              <a:gd name="connsiteY8" fmla="*/ 123643 h 1538339"/>
              <a:gd name="connsiteX9" fmla="*/ 923928 w 1896984"/>
              <a:gd name="connsiteY9" fmla="*/ 30510 h 1538339"/>
              <a:gd name="connsiteX10" fmla="*/ 1005529 w 1896984"/>
              <a:gd name="connsiteY10" fmla="*/ 27 h 1538339"/>
              <a:gd name="connsiteX11" fmla="*/ 1086911 w 1896984"/>
              <a:gd name="connsiteY11" fmla="*/ 43210 h 1538339"/>
              <a:gd name="connsiteX12" fmla="*/ 1154644 w 1896984"/>
              <a:gd name="connsiteY12" fmla="*/ 185026 h 1538339"/>
              <a:gd name="connsiteX13" fmla="*/ 1211794 w 1896984"/>
              <a:gd name="connsiteY13" fmla="*/ 396694 h 1538339"/>
              <a:gd name="connsiteX14" fmla="*/ 1387478 w 1896984"/>
              <a:gd name="connsiteY14" fmla="*/ 1141760 h 1538339"/>
              <a:gd name="connsiteX15" fmla="*/ 1442007 w 1896984"/>
              <a:gd name="connsiteY15" fmla="*/ 1373147 h 1538339"/>
              <a:gd name="connsiteX16" fmla="*/ 1510948 w 1896984"/>
              <a:gd name="connsiteY16" fmla="*/ 1483974 h 1538339"/>
              <a:gd name="connsiteX17" fmla="*/ 1622427 w 1896984"/>
              <a:gd name="connsiteY17" fmla="*/ 1524877 h 1538339"/>
              <a:gd name="connsiteX18" fmla="*/ 1757292 w 1896984"/>
              <a:gd name="connsiteY18" fmla="*/ 1529567 h 1538339"/>
              <a:gd name="connsiteX19" fmla="*/ 1896984 w 1896984"/>
              <a:gd name="connsiteY19" fmla="*/ 1538339 h 1538339"/>
              <a:gd name="connsiteX0" fmla="*/ 0 w 1896984"/>
              <a:gd name="connsiteY0" fmla="*/ 1516411 h 1538339"/>
              <a:gd name="connsiteX1" fmla="*/ 174637 w 1896984"/>
              <a:gd name="connsiteY1" fmla="*/ 1502385 h 1538339"/>
              <a:gd name="connsiteX2" fmla="*/ 335760 w 1896984"/>
              <a:gd name="connsiteY2" fmla="*/ 1474078 h 1538339"/>
              <a:gd name="connsiteX3" fmla="*/ 460907 w 1896984"/>
              <a:gd name="connsiteY3" fmla="*/ 1414810 h 1538339"/>
              <a:gd name="connsiteX4" fmla="*/ 547160 w 1896984"/>
              <a:gd name="connsiteY4" fmla="*/ 1253943 h 1538339"/>
              <a:gd name="connsiteX5" fmla="*/ 708027 w 1896984"/>
              <a:gd name="connsiteY5" fmla="*/ 635877 h 1538339"/>
              <a:gd name="connsiteX6" fmla="*/ 763060 w 1896984"/>
              <a:gd name="connsiteY6" fmla="*/ 445377 h 1538339"/>
              <a:gd name="connsiteX7" fmla="*/ 815977 w 1896984"/>
              <a:gd name="connsiteY7" fmla="*/ 263344 h 1538339"/>
              <a:gd name="connsiteX8" fmla="*/ 866775 w 1896984"/>
              <a:gd name="connsiteY8" fmla="*/ 123643 h 1538339"/>
              <a:gd name="connsiteX9" fmla="*/ 923928 w 1896984"/>
              <a:gd name="connsiteY9" fmla="*/ 30510 h 1538339"/>
              <a:gd name="connsiteX10" fmla="*/ 1005529 w 1896984"/>
              <a:gd name="connsiteY10" fmla="*/ 27 h 1538339"/>
              <a:gd name="connsiteX11" fmla="*/ 1086911 w 1896984"/>
              <a:gd name="connsiteY11" fmla="*/ 43210 h 1538339"/>
              <a:gd name="connsiteX12" fmla="*/ 1154644 w 1896984"/>
              <a:gd name="connsiteY12" fmla="*/ 185026 h 1538339"/>
              <a:gd name="connsiteX13" fmla="*/ 1211794 w 1896984"/>
              <a:gd name="connsiteY13" fmla="*/ 396694 h 1538339"/>
              <a:gd name="connsiteX14" fmla="*/ 1387478 w 1896984"/>
              <a:gd name="connsiteY14" fmla="*/ 1141760 h 1538339"/>
              <a:gd name="connsiteX15" fmla="*/ 1442007 w 1896984"/>
              <a:gd name="connsiteY15" fmla="*/ 1373147 h 1538339"/>
              <a:gd name="connsiteX16" fmla="*/ 1510948 w 1896984"/>
              <a:gd name="connsiteY16" fmla="*/ 1483974 h 1538339"/>
              <a:gd name="connsiteX17" fmla="*/ 1622427 w 1896984"/>
              <a:gd name="connsiteY17" fmla="*/ 1524877 h 1538339"/>
              <a:gd name="connsiteX18" fmla="*/ 1757292 w 1896984"/>
              <a:gd name="connsiteY18" fmla="*/ 1529567 h 1538339"/>
              <a:gd name="connsiteX19" fmla="*/ 1896984 w 1896984"/>
              <a:gd name="connsiteY19" fmla="*/ 1538339 h 1538339"/>
              <a:gd name="connsiteX0" fmla="*/ 0 w 1899202"/>
              <a:gd name="connsiteY0" fmla="*/ 1516411 h 1529941"/>
              <a:gd name="connsiteX1" fmla="*/ 174637 w 1899202"/>
              <a:gd name="connsiteY1" fmla="*/ 1502385 h 1529941"/>
              <a:gd name="connsiteX2" fmla="*/ 335760 w 1899202"/>
              <a:gd name="connsiteY2" fmla="*/ 1474078 h 1529941"/>
              <a:gd name="connsiteX3" fmla="*/ 460907 w 1899202"/>
              <a:gd name="connsiteY3" fmla="*/ 1414810 h 1529941"/>
              <a:gd name="connsiteX4" fmla="*/ 547160 w 1899202"/>
              <a:gd name="connsiteY4" fmla="*/ 1253943 h 1529941"/>
              <a:gd name="connsiteX5" fmla="*/ 708027 w 1899202"/>
              <a:gd name="connsiteY5" fmla="*/ 635877 h 1529941"/>
              <a:gd name="connsiteX6" fmla="*/ 763060 w 1899202"/>
              <a:gd name="connsiteY6" fmla="*/ 445377 h 1529941"/>
              <a:gd name="connsiteX7" fmla="*/ 815977 w 1899202"/>
              <a:gd name="connsiteY7" fmla="*/ 263344 h 1529941"/>
              <a:gd name="connsiteX8" fmla="*/ 866775 w 1899202"/>
              <a:gd name="connsiteY8" fmla="*/ 123643 h 1529941"/>
              <a:gd name="connsiteX9" fmla="*/ 923928 w 1899202"/>
              <a:gd name="connsiteY9" fmla="*/ 30510 h 1529941"/>
              <a:gd name="connsiteX10" fmla="*/ 1005529 w 1899202"/>
              <a:gd name="connsiteY10" fmla="*/ 27 h 1529941"/>
              <a:gd name="connsiteX11" fmla="*/ 1086911 w 1899202"/>
              <a:gd name="connsiteY11" fmla="*/ 43210 h 1529941"/>
              <a:gd name="connsiteX12" fmla="*/ 1154644 w 1899202"/>
              <a:gd name="connsiteY12" fmla="*/ 185026 h 1529941"/>
              <a:gd name="connsiteX13" fmla="*/ 1211794 w 1899202"/>
              <a:gd name="connsiteY13" fmla="*/ 396694 h 1529941"/>
              <a:gd name="connsiteX14" fmla="*/ 1387478 w 1899202"/>
              <a:gd name="connsiteY14" fmla="*/ 1141760 h 1529941"/>
              <a:gd name="connsiteX15" fmla="*/ 1442007 w 1899202"/>
              <a:gd name="connsiteY15" fmla="*/ 1373147 h 1529941"/>
              <a:gd name="connsiteX16" fmla="*/ 1510948 w 1899202"/>
              <a:gd name="connsiteY16" fmla="*/ 1483974 h 1529941"/>
              <a:gd name="connsiteX17" fmla="*/ 1622427 w 1899202"/>
              <a:gd name="connsiteY17" fmla="*/ 1524877 h 1529941"/>
              <a:gd name="connsiteX18" fmla="*/ 1757292 w 1899202"/>
              <a:gd name="connsiteY18" fmla="*/ 1529567 h 1529941"/>
              <a:gd name="connsiteX19" fmla="*/ 1899202 w 1899202"/>
              <a:gd name="connsiteY19" fmla="*/ 1527375 h 152994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</a:cxnLst>
            <a:rect l="l" t="t" r="r" b="b"/>
            <a:pathLst>
              <a:path w="1899202" h="1529941">
                <a:moveTo>
                  <a:pt x="0" y="1516411"/>
                </a:moveTo>
                <a:cubicBezTo>
                  <a:pt x="531" y="1515838"/>
                  <a:pt x="152412" y="1507324"/>
                  <a:pt x="174637" y="1502385"/>
                </a:cubicBezTo>
                <a:cubicBezTo>
                  <a:pt x="196862" y="1497446"/>
                  <a:pt x="288048" y="1488674"/>
                  <a:pt x="335760" y="1474078"/>
                </a:cubicBezTo>
                <a:cubicBezTo>
                  <a:pt x="383472" y="1459482"/>
                  <a:pt x="425674" y="1451499"/>
                  <a:pt x="460907" y="1414810"/>
                </a:cubicBezTo>
                <a:cubicBezTo>
                  <a:pt x="496140" y="1378121"/>
                  <a:pt x="505973" y="1383765"/>
                  <a:pt x="547160" y="1253943"/>
                </a:cubicBezTo>
                <a:cubicBezTo>
                  <a:pt x="588347" y="1124121"/>
                  <a:pt x="672044" y="770638"/>
                  <a:pt x="708027" y="635877"/>
                </a:cubicBezTo>
                <a:cubicBezTo>
                  <a:pt x="744010" y="501116"/>
                  <a:pt x="745068" y="507466"/>
                  <a:pt x="763060" y="445377"/>
                </a:cubicBezTo>
                <a:cubicBezTo>
                  <a:pt x="781052" y="383288"/>
                  <a:pt x="798691" y="316966"/>
                  <a:pt x="815977" y="263344"/>
                </a:cubicBezTo>
                <a:cubicBezTo>
                  <a:pt x="833263" y="209722"/>
                  <a:pt x="848783" y="162449"/>
                  <a:pt x="866775" y="123643"/>
                </a:cubicBezTo>
                <a:cubicBezTo>
                  <a:pt x="884767" y="84837"/>
                  <a:pt x="900802" y="51113"/>
                  <a:pt x="923928" y="30510"/>
                </a:cubicBezTo>
                <a:cubicBezTo>
                  <a:pt x="947054" y="9907"/>
                  <a:pt x="976248" y="732"/>
                  <a:pt x="1005529" y="27"/>
                </a:cubicBezTo>
                <a:cubicBezTo>
                  <a:pt x="1034810" y="-678"/>
                  <a:pt x="1062059" y="12377"/>
                  <a:pt x="1086911" y="43210"/>
                </a:cubicBezTo>
                <a:cubicBezTo>
                  <a:pt x="1111763" y="74043"/>
                  <a:pt x="1133830" y="126112"/>
                  <a:pt x="1154644" y="185026"/>
                </a:cubicBezTo>
                <a:cubicBezTo>
                  <a:pt x="1175458" y="243940"/>
                  <a:pt x="1172988" y="237238"/>
                  <a:pt x="1211794" y="396694"/>
                </a:cubicBezTo>
                <a:cubicBezTo>
                  <a:pt x="1250600" y="556150"/>
                  <a:pt x="1349109" y="979018"/>
                  <a:pt x="1387478" y="1141760"/>
                </a:cubicBezTo>
                <a:cubicBezTo>
                  <a:pt x="1425847" y="1304502"/>
                  <a:pt x="1421429" y="1316111"/>
                  <a:pt x="1442007" y="1373147"/>
                </a:cubicBezTo>
                <a:cubicBezTo>
                  <a:pt x="1462585" y="1430183"/>
                  <a:pt x="1480878" y="1458686"/>
                  <a:pt x="1510948" y="1483974"/>
                </a:cubicBezTo>
                <a:cubicBezTo>
                  <a:pt x="1541018" y="1509262"/>
                  <a:pt x="1581370" y="1517278"/>
                  <a:pt x="1622427" y="1524877"/>
                </a:cubicBezTo>
                <a:cubicBezTo>
                  <a:pt x="1663484" y="1532476"/>
                  <a:pt x="1711163" y="1529151"/>
                  <a:pt x="1757292" y="1529567"/>
                </a:cubicBezTo>
                <a:cubicBezTo>
                  <a:pt x="1803421" y="1529983"/>
                  <a:pt x="1831389" y="1527101"/>
                  <a:pt x="1899202" y="1527375"/>
                </a:cubicBezTo>
              </a:path>
            </a:pathLst>
          </a:cu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3" name="Forma libre 362"/>
          <p:cNvSpPr/>
          <p:nvPr/>
        </p:nvSpPr>
        <p:spPr>
          <a:xfrm flipH="1">
            <a:off x="7046338" y="4600112"/>
            <a:ext cx="1658878" cy="1757337"/>
          </a:xfrm>
          <a:custGeom>
            <a:avLst/>
            <a:gdLst>
              <a:gd name="connsiteX0" fmla="*/ 0 w 1549400"/>
              <a:gd name="connsiteY0" fmla="*/ 1519581 h 1547636"/>
              <a:gd name="connsiteX1" fmla="*/ 169334 w 1549400"/>
              <a:gd name="connsiteY1" fmla="*/ 1443381 h 1547636"/>
              <a:gd name="connsiteX2" fmla="*/ 279400 w 1549400"/>
              <a:gd name="connsiteY2" fmla="*/ 1274047 h 1547636"/>
              <a:gd name="connsiteX3" fmla="*/ 338667 w 1549400"/>
              <a:gd name="connsiteY3" fmla="*/ 1028514 h 1547636"/>
              <a:gd name="connsiteX4" fmla="*/ 389467 w 1549400"/>
              <a:gd name="connsiteY4" fmla="*/ 867647 h 1547636"/>
              <a:gd name="connsiteX5" fmla="*/ 440267 w 1549400"/>
              <a:gd name="connsiteY5" fmla="*/ 655981 h 1547636"/>
              <a:gd name="connsiteX6" fmla="*/ 482600 w 1549400"/>
              <a:gd name="connsiteY6" fmla="*/ 452781 h 1547636"/>
              <a:gd name="connsiteX7" fmla="*/ 524934 w 1549400"/>
              <a:gd name="connsiteY7" fmla="*/ 249581 h 1547636"/>
              <a:gd name="connsiteX8" fmla="*/ 567267 w 1549400"/>
              <a:gd name="connsiteY8" fmla="*/ 139514 h 1547636"/>
              <a:gd name="connsiteX9" fmla="*/ 668867 w 1549400"/>
              <a:gd name="connsiteY9" fmla="*/ 12514 h 1547636"/>
              <a:gd name="connsiteX10" fmla="*/ 829734 w 1549400"/>
              <a:gd name="connsiteY10" fmla="*/ 20981 h 1547636"/>
              <a:gd name="connsiteX11" fmla="*/ 897467 w 1549400"/>
              <a:gd name="connsiteY11" fmla="*/ 156447 h 1547636"/>
              <a:gd name="connsiteX12" fmla="*/ 948267 w 1549400"/>
              <a:gd name="connsiteY12" fmla="*/ 393514 h 1547636"/>
              <a:gd name="connsiteX13" fmla="*/ 1134534 w 1549400"/>
              <a:gd name="connsiteY13" fmla="*/ 1155514 h 1547636"/>
              <a:gd name="connsiteX14" fmla="*/ 1185334 w 1549400"/>
              <a:gd name="connsiteY14" fmla="*/ 1434914 h 1547636"/>
              <a:gd name="connsiteX15" fmla="*/ 1219200 w 1549400"/>
              <a:gd name="connsiteY15" fmla="*/ 1536514 h 1547636"/>
              <a:gd name="connsiteX16" fmla="*/ 1354667 w 1549400"/>
              <a:gd name="connsiteY16" fmla="*/ 1544981 h 1547636"/>
              <a:gd name="connsiteX17" fmla="*/ 1549400 w 1549400"/>
              <a:gd name="connsiteY17" fmla="*/ 1536514 h 1547636"/>
              <a:gd name="connsiteX18" fmla="*/ 1549400 w 1549400"/>
              <a:gd name="connsiteY18" fmla="*/ 1536514 h 1547636"/>
              <a:gd name="connsiteX19" fmla="*/ 1549400 w 1549400"/>
              <a:gd name="connsiteY19" fmla="*/ 1536514 h 1547636"/>
              <a:gd name="connsiteX0" fmla="*/ 0 w 1549400"/>
              <a:gd name="connsiteY0" fmla="*/ 1519581 h 1547636"/>
              <a:gd name="connsiteX1" fmla="*/ 169334 w 1549400"/>
              <a:gd name="connsiteY1" fmla="*/ 1443381 h 1547636"/>
              <a:gd name="connsiteX2" fmla="*/ 279400 w 1549400"/>
              <a:gd name="connsiteY2" fmla="*/ 1274047 h 1547636"/>
              <a:gd name="connsiteX3" fmla="*/ 338667 w 1549400"/>
              <a:gd name="connsiteY3" fmla="*/ 1028514 h 1547636"/>
              <a:gd name="connsiteX4" fmla="*/ 440267 w 1549400"/>
              <a:gd name="connsiteY4" fmla="*/ 655981 h 1547636"/>
              <a:gd name="connsiteX5" fmla="*/ 482600 w 1549400"/>
              <a:gd name="connsiteY5" fmla="*/ 452781 h 1547636"/>
              <a:gd name="connsiteX6" fmla="*/ 524934 w 1549400"/>
              <a:gd name="connsiteY6" fmla="*/ 249581 h 1547636"/>
              <a:gd name="connsiteX7" fmla="*/ 567267 w 1549400"/>
              <a:gd name="connsiteY7" fmla="*/ 139514 h 1547636"/>
              <a:gd name="connsiteX8" fmla="*/ 668867 w 1549400"/>
              <a:gd name="connsiteY8" fmla="*/ 12514 h 1547636"/>
              <a:gd name="connsiteX9" fmla="*/ 829734 w 1549400"/>
              <a:gd name="connsiteY9" fmla="*/ 20981 h 1547636"/>
              <a:gd name="connsiteX10" fmla="*/ 897467 w 1549400"/>
              <a:gd name="connsiteY10" fmla="*/ 156447 h 1547636"/>
              <a:gd name="connsiteX11" fmla="*/ 948267 w 1549400"/>
              <a:gd name="connsiteY11" fmla="*/ 393514 h 1547636"/>
              <a:gd name="connsiteX12" fmla="*/ 1134534 w 1549400"/>
              <a:gd name="connsiteY12" fmla="*/ 1155514 h 1547636"/>
              <a:gd name="connsiteX13" fmla="*/ 1185334 w 1549400"/>
              <a:gd name="connsiteY13" fmla="*/ 1434914 h 1547636"/>
              <a:gd name="connsiteX14" fmla="*/ 1219200 w 1549400"/>
              <a:gd name="connsiteY14" fmla="*/ 1536514 h 1547636"/>
              <a:gd name="connsiteX15" fmla="*/ 1354667 w 1549400"/>
              <a:gd name="connsiteY15" fmla="*/ 1544981 h 1547636"/>
              <a:gd name="connsiteX16" fmla="*/ 1549400 w 1549400"/>
              <a:gd name="connsiteY16" fmla="*/ 1536514 h 1547636"/>
              <a:gd name="connsiteX17" fmla="*/ 1549400 w 1549400"/>
              <a:gd name="connsiteY17" fmla="*/ 1536514 h 1547636"/>
              <a:gd name="connsiteX18" fmla="*/ 1549400 w 1549400"/>
              <a:gd name="connsiteY18" fmla="*/ 1536514 h 1547636"/>
              <a:gd name="connsiteX0" fmla="*/ 0 w 1549400"/>
              <a:gd name="connsiteY0" fmla="*/ 1519581 h 1547636"/>
              <a:gd name="connsiteX1" fmla="*/ 169334 w 1549400"/>
              <a:gd name="connsiteY1" fmla="*/ 1443381 h 1547636"/>
              <a:gd name="connsiteX2" fmla="*/ 279400 w 1549400"/>
              <a:gd name="connsiteY2" fmla="*/ 1274047 h 1547636"/>
              <a:gd name="connsiteX3" fmla="*/ 440267 w 1549400"/>
              <a:gd name="connsiteY3" fmla="*/ 655981 h 1547636"/>
              <a:gd name="connsiteX4" fmla="*/ 482600 w 1549400"/>
              <a:gd name="connsiteY4" fmla="*/ 452781 h 1547636"/>
              <a:gd name="connsiteX5" fmla="*/ 524934 w 1549400"/>
              <a:gd name="connsiteY5" fmla="*/ 249581 h 1547636"/>
              <a:gd name="connsiteX6" fmla="*/ 567267 w 1549400"/>
              <a:gd name="connsiteY6" fmla="*/ 139514 h 1547636"/>
              <a:gd name="connsiteX7" fmla="*/ 668867 w 1549400"/>
              <a:gd name="connsiteY7" fmla="*/ 12514 h 1547636"/>
              <a:gd name="connsiteX8" fmla="*/ 829734 w 1549400"/>
              <a:gd name="connsiteY8" fmla="*/ 20981 h 1547636"/>
              <a:gd name="connsiteX9" fmla="*/ 897467 w 1549400"/>
              <a:gd name="connsiteY9" fmla="*/ 156447 h 1547636"/>
              <a:gd name="connsiteX10" fmla="*/ 948267 w 1549400"/>
              <a:gd name="connsiteY10" fmla="*/ 393514 h 1547636"/>
              <a:gd name="connsiteX11" fmla="*/ 1134534 w 1549400"/>
              <a:gd name="connsiteY11" fmla="*/ 1155514 h 1547636"/>
              <a:gd name="connsiteX12" fmla="*/ 1185334 w 1549400"/>
              <a:gd name="connsiteY12" fmla="*/ 1434914 h 1547636"/>
              <a:gd name="connsiteX13" fmla="*/ 1219200 w 1549400"/>
              <a:gd name="connsiteY13" fmla="*/ 1536514 h 1547636"/>
              <a:gd name="connsiteX14" fmla="*/ 1354667 w 1549400"/>
              <a:gd name="connsiteY14" fmla="*/ 1544981 h 1547636"/>
              <a:gd name="connsiteX15" fmla="*/ 1549400 w 1549400"/>
              <a:gd name="connsiteY15" fmla="*/ 1536514 h 1547636"/>
              <a:gd name="connsiteX16" fmla="*/ 1549400 w 1549400"/>
              <a:gd name="connsiteY16" fmla="*/ 1536514 h 1547636"/>
              <a:gd name="connsiteX17" fmla="*/ 1549400 w 1549400"/>
              <a:gd name="connsiteY17" fmla="*/ 1536514 h 1547636"/>
              <a:gd name="connsiteX0" fmla="*/ 0 w 1617133"/>
              <a:gd name="connsiteY0" fmla="*/ 1519581 h 1547636"/>
              <a:gd name="connsiteX1" fmla="*/ 237067 w 1617133"/>
              <a:gd name="connsiteY1" fmla="*/ 1443381 h 1547636"/>
              <a:gd name="connsiteX2" fmla="*/ 347133 w 1617133"/>
              <a:gd name="connsiteY2" fmla="*/ 1274047 h 1547636"/>
              <a:gd name="connsiteX3" fmla="*/ 508000 w 1617133"/>
              <a:gd name="connsiteY3" fmla="*/ 655981 h 1547636"/>
              <a:gd name="connsiteX4" fmla="*/ 550333 w 1617133"/>
              <a:gd name="connsiteY4" fmla="*/ 452781 h 1547636"/>
              <a:gd name="connsiteX5" fmla="*/ 592667 w 1617133"/>
              <a:gd name="connsiteY5" fmla="*/ 249581 h 1547636"/>
              <a:gd name="connsiteX6" fmla="*/ 635000 w 1617133"/>
              <a:gd name="connsiteY6" fmla="*/ 139514 h 1547636"/>
              <a:gd name="connsiteX7" fmla="*/ 736600 w 1617133"/>
              <a:gd name="connsiteY7" fmla="*/ 12514 h 1547636"/>
              <a:gd name="connsiteX8" fmla="*/ 897467 w 1617133"/>
              <a:gd name="connsiteY8" fmla="*/ 20981 h 1547636"/>
              <a:gd name="connsiteX9" fmla="*/ 965200 w 1617133"/>
              <a:gd name="connsiteY9" fmla="*/ 156447 h 1547636"/>
              <a:gd name="connsiteX10" fmla="*/ 1016000 w 1617133"/>
              <a:gd name="connsiteY10" fmla="*/ 393514 h 1547636"/>
              <a:gd name="connsiteX11" fmla="*/ 1202267 w 1617133"/>
              <a:gd name="connsiteY11" fmla="*/ 1155514 h 1547636"/>
              <a:gd name="connsiteX12" fmla="*/ 1253067 w 1617133"/>
              <a:gd name="connsiteY12" fmla="*/ 1434914 h 1547636"/>
              <a:gd name="connsiteX13" fmla="*/ 1286933 w 1617133"/>
              <a:gd name="connsiteY13" fmla="*/ 1536514 h 1547636"/>
              <a:gd name="connsiteX14" fmla="*/ 1422400 w 1617133"/>
              <a:gd name="connsiteY14" fmla="*/ 1544981 h 1547636"/>
              <a:gd name="connsiteX15" fmla="*/ 1617133 w 1617133"/>
              <a:gd name="connsiteY15" fmla="*/ 1536514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0" fmla="*/ 0 w 1617133"/>
              <a:gd name="connsiteY0" fmla="*/ 1519581 h 1547636"/>
              <a:gd name="connsiteX1" fmla="*/ 127001 w 1617133"/>
              <a:gd name="connsiteY1" fmla="*/ 1485714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2667 w 1617133"/>
              <a:gd name="connsiteY6" fmla="*/ 2495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2667 w 1617133"/>
              <a:gd name="connsiteY6" fmla="*/ 2495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2667 w 1617133"/>
              <a:gd name="connsiteY6" fmla="*/ 2495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6900 w 1617133"/>
              <a:gd name="connsiteY6" fmla="*/ 272864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6900 w 1617133"/>
              <a:gd name="connsiteY6" fmla="*/ 272864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596900 w 1617133"/>
              <a:gd name="connsiteY6" fmla="*/ 272864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50333 w 1617133"/>
              <a:gd name="connsiteY5" fmla="*/ 452781 h 1547636"/>
              <a:gd name="connsiteX6" fmla="*/ 609600 w 1617133"/>
              <a:gd name="connsiteY6" fmla="*/ 2749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581 h 1547636"/>
              <a:gd name="connsiteX1" fmla="*/ 133351 w 1617133"/>
              <a:gd name="connsiteY1" fmla="*/ 1489948 h 1547636"/>
              <a:gd name="connsiteX2" fmla="*/ 237067 w 1617133"/>
              <a:gd name="connsiteY2" fmla="*/ 1443381 h 1547636"/>
              <a:gd name="connsiteX3" fmla="*/ 347133 w 1617133"/>
              <a:gd name="connsiteY3" fmla="*/ 1274047 h 1547636"/>
              <a:gd name="connsiteX4" fmla="*/ 508000 w 1617133"/>
              <a:gd name="connsiteY4" fmla="*/ 655981 h 1547636"/>
              <a:gd name="connsiteX5" fmla="*/ 563033 w 1617133"/>
              <a:gd name="connsiteY5" fmla="*/ 465481 h 1547636"/>
              <a:gd name="connsiteX6" fmla="*/ 609600 w 1617133"/>
              <a:gd name="connsiteY6" fmla="*/ 274981 h 1547636"/>
              <a:gd name="connsiteX7" fmla="*/ 635000 w 1617133"/>
              <a:gd name="connsiteY7" fmla="*/ 139514 h 1547636"/>
              <a:gd name="connsiteX8" fmla="*/ 736600 w 1617133"/>
              <a:gd name="connsiteY8" fmla="*/ 12514 h 1547636"/>
              <a:gd name="connsiteX9" fmla="*/ 897467 w 1617133"/>
              <a:gd name="connsiteY9" fmla="*/ 20981 h 1547636"/>
              <a:gd name="connsiteX10" fmla="*/ 965200 w 1617133"/>
              <a:gd name="connsiteY10" fmla="*/ 156447 h 1547636"/>
              <a:gd name="connsiteX11" fmla="*/ 1016000 w 1617133"/>
              <a:gd name="connsiteY11" fmla="*/ 393514 h 1547636"/>
              <a:gd name="connsiteX12" fmla="*/ 1202267 w 1617133"/>
              <a:gd name="connsiteY12" fmla="*/ 1155514 h 1547636"/>
              <a:gd name="connsiteX13" fmla="*/ 1253067 w 1617133"/>
              <a:gd name="connsiteY13" fmla="*/ 1434914 h 1547636"/>
              <a:gd name="connsiteX14" fmla="*/ 1286933 w 1617133"/>
              <a:gd name="connsiteY14" fmla="*/ 1536514 h 1547636"/>
              <a:gd name="connsiteX15" fmla="*/ 1422400 w 1617133"/>
              <a:gd name="connsiteY15" fmla="*/ 1544981 h 1547636"/>
              <a:gd name="connsiteX16" fmla="*/ 1617133 w 1617133"/>
              <a:gd name="connsiteY16" fmla="*/ 1536514 h 1547636"/>
              <a:gd name="connsiteX17" fmla="*/ 1617133 w 1617133"/>
              <a:gd name="connsiteY17" fmla="*/ 1536514 h 1547636"/>
              <a:gd name="connsiteX18" fmla="*/ 1617133 w 1617133"/>
              <a:gd name="connsiteY18" fmla="*/ 1536514 h 1547636"/>
              <a:gd name="connsiteX0" fmla="*/ 0 w 1617133"/>
              <a:gd name="connsiteY0" fmla="*/ 1519729 h 1547784"/>
              <a:gd name="connsiteX1" fmla="*/ 133351 w 1617133"/>
              <a:gd name="connsiteY1" fmla="*/ 1490096 h 1547784"/>
              <a:gd name="connsiteX2" fmla="*/ 237067 w 1617133"/>
              <a:gd name="connsiteY2" fmla="*/ 1443529 h 1547784"/>
              <a:gd name="connsiteX3" fmla="*/ 347133 w 1617133"/>
              <a:gd name="connsiteY3" fmla="*/ 1274195 h 1547784"/>
              <a:gd name="connsiteX4" fmla="*/ 508000 w 1617133"/>
              <a:gd name="connsiteY4" fmla="*/ 656129 h 1547784"/>
              <a:gd name="connsiteX5" fmla="*/ 563033 w 1617133"/>
              <a:gd name="connsiteY5" fmla="*/ 465629 h 1547784"/>
              <a:gd name="connsiteX6" fmla="*/ 609600 w 1617133"/>
              <a:gd name="connsiteY6" fmla="*/ 275129 h 1547784"/>
              <a:gd name="connsiteX7" fmla="*/ 647700 w 1617133"/>
              <a:gd name="connsiteY7" fmla="*/ 141778 h 1547784"/>
              <a:gd name="connsiteX8" fmla="*/ 736600 w 1617133"/>
              <a:gd name="connsiteY8" fmla="*/ 12662 h 1547784"/>
              <a:gd name="connsiteX9" fmla="*/ 897467 w 1617133"/>
              <a:gd name="connsiteY9" fmla="*/ 21129 h 1547784"/>
              <a:gd name="connsiteX10" fmla="*/ 965200 w 1617133"/>
              <a:gd name="connsiteY10" fmla="*/ 156595 h 1547784"/>
              <a:gd name="connsiteX11" fmla="*/ 1016000 w 1617133"/>
              <a:gd name="connsiteY11" fmla="*/ 393662 h 1547784"/>
              <a:gd name="connsiteX12" fmla="*/ 1202267 w 1617133"/>
              <a:gd name="connsiteY12" fmla="*/ 1155662 h 1547784"/>
              <a:gd name="connsiteX13" fmla="*/ 1253067 w 1617133"/>
              <a:gd name="connsiteY13" fmla="*/ 1435062 h 1547784"/>
              <a:gd name="connsiteX14" fmla="*/ 1286933 w 1617133"/>
              <a:gd name="connsiteY14" fmla="*/ 1536662 h 1547784"/>
              <a:gd name="connsiteX15" fmla="*/ 1422400 w 1617133"/>
              <a:gd name="connsiteY15" fmla="*/ 1545129 h 1547784"/>
              <a:gd name="connsiteX16" fmla="*/ 1617133 w 1617133"/>
              <a:gd name="connsiteY16" fmla="*/ 1536662 h 1547784"/>
              <a:gd name="connsiteX17" fmla="*/ 1617133 w 1617133"/>
              <a:gd name="connsiteY17" fmla="*/ 1536662 h 1547784"/>
              <a:gd name="connsiteX18" fmla="*/ 1617133 w 1617133"/>
              <a:gd name="connsiteY18" fmla="*/ 1536662 h 1547784"/>
              <a:gd name="connsiteX0" fmla="*/ 0 w 1617133"/>
              <a:gd name="connsiteY0" fmla="*/ 1519582 h 1547637"/>
              <a:gd name="connsiteX1" fmla="*/ 133351 w 1617133"/>
              <a:gd name="connsiteY1" fmla="*/ 1489949 h 1547637"/>
              <a:gd name="connsiteX2" fmla="*/ 237067 w 1617133"/>
              <a:gd name="connsiteY2" fmla="*/ 1443382 h 1547637"/>
              <a:gd name="connsiteX3" fmla="*/ 347133 w 1617133"/>
              <a:gd name="connsiteY3" fmla="*/ 1274048 h 1547637"/>
              <a:gd name="connsiteX4" fmla="*/ 508000 w 1617133"/>
              <a:gd name="connsiteY4" fmla="*/ 655982 h 1547637"/>
              <a:gd name="connsiteX5" fmla="*/ 563033 w 1617133"/>
              <a:gd name="connsiteY5" fmla="*/ 465482 h 1547637"/>
              <a:gd name="connsiteX6" fmla="*/ 609600 w 1617133"/>
              <a:gd name="connsiteY6" fmla="*/ 274982 h 1547637"/>
              <a:gd name="connsiteX7" fmla="*/ 649816 w 1617133"/>
              <a:gd name="connsiteY7" fmla="*/ 139515 h 1547637"/>
              <a:gd name="connsiteX8" fmla="*/ 736600 w 1617133"/>
              <a:gd name="connsiteY8" fmla="*/ 12515 h 1547637"/>
              <a:gd name="connsiteX9" fmla="*/ 897467 w 1617133"/>
              <a:gd name="connsiteY9" fmla="*/ 20982 h 1547637"/>
              <a:gd name="connsiteX10" fmla="*/ 965200 w 1617133"/>
              <a:gd name="connsiteY10" fmla="*/ 156448 h 1547637"/>
              <a:gd name="connsiteX11" fmla="*/ 1016000 w 1617133"/>
              <a:gd name="connsiteY11" fmla="*/ 393515 h 1547637"/>
              <a:gd name="connsiteX12" fmla="*/ 1202267 w 1617133"/>
              <a:gd name="connsiteY12" fmla="*/ 1155515 h 1547637"/>
              <a:gd name="connsiteX13" fmla="*/ 1253067 w 1617133"/>
              <a:gd name="connsiteY13" fmla="*/ 1434915 h 1547637"/>
              <a:gd name="connsiteX14" fmla="*/ 1286933 w 1617133"/>
              <a:gd name="connsiteY14" fmla="*/ 1536515 h 1547637"/>
              <a:gd name="connsiteX15" fmla="*/ 1422400 w 1617133"/>
              <a:gd name="connsiteY15" fmla="*/ 1544982 h 1547637"/>
              <a:gd name="connsiteX16" fmla="*/ 1617133 w 1617133"/>
              <a:gd name="connsiteY16" fmla="*/ 1536515 h 1547637"/>
              <a:gd name="connsiteX17" fmla="*/ 1617133 w 1617133"/>
              <a:gd name="connsiteY17" fmla="*/ 1536515 h 1547637"/>
              <a:gd name="connsiteX18" fmla="*/ 1617133 w 1617133"/>
              <a:gd name="connsiteY18" fmla="*/ 1536515 h 1547637"/>
              <a:gd name="connsiteX0" fmla="*/ 0 w 1617133"/>
              <a:gd name="connsiteY0" fmla="*/ 1519286 h 1547341"/>
              <a:gd name="connsiteX1" fmla="*/ 133351 w 1617133"/>
              <a:gd name="connsiteY1" fmla="*/ 1489653 h 1547341"/>
              <a:gd name="connsiteX2" fmla="*/ 237067 w 1617133"/>
              <a:gd name="connsiteY2" fmla="*/ 1443086 h 1547341"/>
              <a:gd name="connsiteX3" fmla="*/ 347133 w 1617133"/>
              <a:gd name="connsiteY3" fmla="*/ 1273752 h 1547341"/>
              <a:gd name="connsiteX4" fmla="*/ 508000 w 1617133"/>
              <a:gd name="connsiteY4" fmla="*/ 655686 h 1547341"/>
              <a:gd name="connsiteX5" fmla="*/ 563033 w 1617133"/>
              <a:gd name="connsiteY5" fmla="*/ 465186 h 1547341"/>
              <a:gd name="connsiteX6" fmla="*/ 609600 w 1617133"/>
              <a:gd name="connsiteY6" fmla="*/ 274686 h 1547341"/>
              <a:gd name="connsiteX7" fmla="*/ 651932 w 1617133"/>
              <a:gd name="connsiteY7" fmla="*/ 134985 h 1547341"/>
              <a:gd name="connsiteX8" fmla="*/ 736600 w 1617133"/>
              <a:gd name="connsiteY8" fmla="*/ 12219 h 1547341"/>
              <a:gd name="connsiteX9" fmla="*/ 897467 w 1617133"/>
              <a:gd name="connsiteY9" fmla="*/ 20686 h 1547341"/>
              <a:gd name="connsiteX10" fmla="*/ 965200 w 1617133"/>
              <a:gd name="connsiteY10" fmla="*/ 156152 h 1547341"/>
              <a:gd name="connsiteX11" fmla="*/ 1016000 w 1617133"/>
              <a:gd name="connsiteY11" fmla="*/ 393219 h 1547341"/>
              <a:gd name="connsiteX12" fmla="*/ 1202267 w 1617133"/>
              <a:gd name="connsiteY12" fmla="*/ 1155219 h 1547341"/>
              <a:gd name="connsiteX13" fmla="*/ 1253067 w 1617133"/>
              <a:gd name="connsiteY13" fmla="*/ 1434619 h 1547341"/>
              <a:gd name="connsiteX14" fmla="*/ 1286933 w 1617133"/>
              <a:gd name="connsiteY14" fmla="*/ 1536219 h 1547341"/>
              <a:gd name="connsiteX15" fmla="*/ 1422400 w 1617133"/>
              <a:gd name="connsiteY15" fmla="*/ 1544686 h 1547341"/>
              <a:gd name="connsiteX16" fmla="*/ 1617133 w 1617133"/>
              <a:gd name="connsiteY16" fmla="*/ 1536219 h 1547341"/>
              <a:gd name="connsiteX17" fmla="*/ 1617133 w 1617133"/>
              <a:gd name="connsiteY17" fmla="*/ 1536219 h 1547341"/>
              <a:gd name="connsiteX18" fmla="*/ 1617133 w 1617133"/>
              <a:gd name="connsiteY18" fmla="*/ 1536219 h 1547341"/>
              <a:gd name="connsiteX0" fmla="*/ 0 w 1617133"/>
              <a:gd name="connsiteY0" fmla="*/ 1513144 h 1541199"/>
              <a:gd name="connsiteX1" fmla="*/ 133351 w 1617133"/>
              <a:gd name="connsiteY1" fmla="*/ 1483511 h 1541199"/>
              <a:gd name="connsiteX2" fmla="*/ 237067 w 1617133"/>
              <a:gd name="connsiteY2" fmla="*/ 1436944 h 1541199"/>
              <a:gd name="connsiteX3" fmla="*/ 347133 w 1617133"/>
              <a:gd name="connsiteY3" fmla="*/ 1267610 h 1541199"/>
              <a:gd name="connsiteX4" fmla="*/ 508000 w 1617133"/>
              <a:gd name="connsiteY4" fmla="*/ 649544 h 1541199"/>
              <a:gd name="connsiteX5" fmla="*/ 563033 w 1617133"/>
              <a:gd name="connsiteY5" fmla="*/ 459044 h 1541199"/>
              <a:gd name="connsiteX6" fmla="*/ 609600 w 1617133"/>
              <a:gd name="connsiteY6" fmla="*/ 268544 h 1541199"/>
              <a:gd name="connsiteX7" fmla="*/ 651932 w 1617133"/>
              <a:gd name="connsiteY7" fmla="*/ 128843 h 1541199"/>
              <a:gd name="connsiteX8" fmla="*/ 751417 w 1617133"/>
              <a:gd name="connsiteY8" fmla="*/ 16661 h 1541199"/>
              <a:gd name="connsiteX9" fmla="*/ 897467 w 1617133"/>
              <a:gd name="connsiteY9" fmla="*/ 14544 h 1541199"/>
              <a:gd name="connsiteX10" fmla="*/ 965200 w 1617133"/>
              <a:gd name="connsiteY10" fmla="*/ 150010 h 1541199"/>
              <a:gd name="connsiteX11" fmla="*/ 1016000 w 1617133"/>
              <a:gd name="connsiteY11" fmla="*/ 387077 h 1541199"/>
              <a:gd name="connsiteX12" fmla="*/ 1202267 w 1617133"/>
              <a:gd name="connsiteY12" fmla="*/ 1149077 h 1541199"/>
              <a:gd name="connsiteX13" fmla="*/ 1253067 w 1617133"/>
              <a:gd name="connsiteY13" fmla="*/ 1428477 h 1541199"/>
              <a:gd name="connsiteX14" fmla="*/ 1286933 w 1617133"/>
              <a:gd name="connsiteY14" fmla="*/ 1530077 h 1541199"/>
              <a:gd name="connsiteX15" fmla="*/ 1422400 w 1617133"/>
              <a:gd name="connsiteY15" fmla="*/ 1538544 h 1541199"/>
              <a:gd name="connsiteX16" fmla="*/ 1617133 w 1617133"/>
              <a:gd name="connsiteY16" fmla="*/ 1530077 h 1541199"/>
              <a:gd name="connsiteX17" fmla="*/ 1617133 w 1617133"/>
              <a:gd name="connsiteY17" fmla="*/ 1530077 h 1541199"/>
              <a:gd name="connsiteX18" fmla="*/ 1617133 w 1617133"/>
              <a:gd name="connsiteY18" fmla="*/ 1530077 h 1541199"/>
              <a:gd name="connsiteX0" fmla="*/ 0 w 1617133"/>
              <a:gd name="connsiteY0" fmla="*/ 1510639 h 1538694"/>
              <a:gd name="connsiteX1" fmla="*/ 133351 w 1617133"/>
              <a:gd name="connsiteY1" fmla="*/ 1481006 h 1538694"/>
              <a:gd name="connsiteX2" fmla="*/ 237067 w 1617133"/>
              <a:gd name="connsiteY2" fmla="*/ 1434439 h 1538694"/>
              <a:gd name="connsiteX3" fmla="*/ 347133 w 1617133"/>
              <a:gd name="connsiteY3" fmla="*/ 1265105 h 1538694"/>
              <a:gd name="connsiteX4" fmla="*/ 508000 w 1617133"/>
              <a:gd name="connsiteY4" fmla="*/ 647039 h 1538694"/>
              <a:gd name="connsiteX5" fmla="*/ 563033 w 1617133"/>
              <a:gd name="connsiteY5" fmla="*/ 456539 h 1538694"/>
              <a:gd name="connsiteX6" fmla="*/ 609600 w 1617133"/>
              <a:gd name="connsiteY6" fmla="*/ 266039 h 1538694"/>
              <a:gd name="connsiteX7" fmla="*/ 651932 w 1617133"/>
              <a:gd name="connsiteY7" fmla="*/ 126338 h 1538694"/>
              <a:gd name="connsiteX8" fmla="*/ 751417 w 1617133"/>
              <a:gd name="connsiteY8" fmla="*/ 14156 h 1538694"/>
              <a:gd name="connsiteX9" fmla="*/ 895351 w 1617133"/>
              <a:gd name="connsiteY9" fmla="*/ 16272 h 1538694"/>
              <a:gd name="connsiteX10" fmla="*/ 965200 w 1617133"/>
              <a:gd name="connsiteY10" fmla="*/ 147505 h 1538694"/>
              <a:gd name="connsiteX11" fmla="*/ 1016000 w 1617133"/>
              <a:gd name="connsiteY11" fmla="*/ 384572 h 1538694"/>
              <a:gd name="connsiteX12" fmla="*/ 1202267 w 1617133"/>
              <a:gd name="connsiteY12" fmla="*/ 1146572 h 1538694"/>
              <a:gd name="connsiteX13" fmla="*/ 1253067 w 1617133"/>
              <a:gd name="connsiteY13" fmla="*/ 1425972 h 1538694"/>
              <a:gd name="connsiteX14" fmla="*/ 1286933 w 1617133"/>
              <a:gd name="connsiteY14" fmla="*/ 1527572 h 1538694"/>
              <a:gd name="connsiteX15" fmla="*/ 1422400 w 1617133"/>
              <a:gd name="connsiteY15" fmla="*/ 1536039 h 1538694"/>
              <a:gd name="connsiteX16" fmla="*/ 1617133 w 1617133"/>
              <a:gd name="connsiteY16" fmla="*/ 1527572 h 1538694"/>
              <a:gd name="connsiteX17" fmla="*/ 1617133 w 1617133"/>
              <a:gd name="connsiteY17" fmla="*/ 1527572 h 1538694"/>
              <a:gd name="connsiteX18" fmla="*/ 1617133 w 1617133"/>
              <a:gd name="connsiteY18" fmla="*/ 1527572 h 1538694"/>
              <a:gd name="connsiteX0" fmla="*/ 0 w 1617133"/>
              <a:gd name="connsiteY0" fmla="*/ 1512257 h 1540312"/>
              <a:gd name="connsiteX1" fmla="*/ 133351 w 1617133"/>
              <a:gd name="connsiteY1" fmla="*/ 1482624 h 1540312"/>
              <a:gd name="connsiteX2" fmla="*/ 237067 w 1617133"/>
              <a:gd name="connsiteY2" fmla="*/ 1436057 h 1540312"/>
              <a:gd name="connsiteX3" fmla="*/ 347133 w 1617133"/>
              <a:gd name="connsiteY3" fmla="*/ 1266723 h 1540312"/>
              <a:gd name="connsiteX4" fmla="*/ 508000 w 1617133"/>
              <a:gd name="connsiteY4" fmla="*/ 648657 h 1540312"/>
              <a:gd name="connsiteX5" fmla="*/ 563033 w 1617133"/>
              <a:gd name="connsiteY5" fmla="*/ 458157 h 1540312"/>
              <a:gd name="connsiteX6" fmla="*/ 609600 w 1617133"/>
              <a:gd name="connsiteY6" fmla="*/ 267657 h 1540312"/>
              <a:gd name="connsiteX7" fmla="*/ 651932 w 1617133"/>
              <a:gd name="connsiteY7" fmla="*/ 127956 h 1540312"/>
              <a:gd name="connsiteX8" fmla="*/ 751417 w 1617133"/>
              <a:gd name="connsiteY8" fmla="*/ 15774 h 1540312"/>
              <a:gd name="connsiteX9" fmla="*/ 895351 w 1617133"/>
              <a:gd name="connsiteY9" fmla="*/ 17890 h 1540312"/>
              <a:gd name="connsiteX10" fmla="*/ 965200 w 1617133"/>
              <a:gd name="connsiteY10" fmla="*/ 149123 h 1540312"/>
              <a:gd name="connsiteX11" fmla="*/ 1016000 w 1617133"/>
              <a:gd name="connsiteY11" fmla="*/ 386190 h 1540312"/>
              <a:gd name="connsiteX12" fmla="*/ 1202267 w 1617133"/>
              <a:gd name="connsiteY12" fmla="*/ 1148190 h 1540312"/>
              <a:gd name="connsiteX13" fmla="*/ 1253067 w 1617133"/>
              <a:gd name="connsiteY13" fmla="*/ 1427590 h 1540312"/>
              <a:gd name="connsiteX14" fmla="*/ 1286933 w 1617133"/>
              <a:gd name="connsiteY14" fmla="*/ 1529190 h 1540312"/>
              <a:gd name="connsiteX15" fmla="*/ 1422400 w 1617133"/>
              <a:gd name="connsiteY15" fmla="*/ 1537657 h 1540312"/>
              <a:gd name="connsiteX16" fmla="*/ 1617133 w 1617133"/>
              <a:gd name="connsiteY16" fmla="*/ 1529190 h 1540312"/>
              <a:gd name="connsiteX17" fmla="*/ 1617133 w 1617133"/>
              <a:gd name="connsiteY17" fmla="*/ 1529190 h 1540312"/>
              <a:gd name="connsiteX18" fmla="*/ 1617133 w 1617133"/>
              <a:gd name="connsiteY18" fmla="*/ 1529190 h 1540312"/>
              <a:gd name="connsiteX0" fmla="*/ 0 w 1617133"/>
              <a:gd name="connsiteY0" fmla="*/ 1502989 h 1531044"/>
              <a:gd name="connsiteX1" fmla="*/ 133351 w 1617133"/>
              <a:gd name="connsiteY1" fmla="*/ 1473356 h 1531044"/>
              <a:gd name="connsiteX2" fmla="*/ 237067 w 1617133"/>
              <a:gd name="connsiteY2" fmla="*/ 1426789 h 1531044"/>
              <a:gd name="connsiteX3" fmla="*/ 347133 w 1617133"/>
              <a:gd name="connsiteY3" fmla="*/ 1257455 h 1531044"/>
              <a:gd name="connsiteX4" fmla="*/ 508000 w 1617133"/>
              <a:gd name="connsiteY4" fmla="*/ 639389 h 1531044"/>
              <a:gd name="connsiteX5" fmla="*/ 563033 w 1617133"/>
              <a:gd name="connsiteY5" fmla="*/ 448889 h 1531044"/>
              <a:gd name="connsiteX6" fmla="*/ 609600 w 1617133"/>
              <a:gd name="connsiteY6" fmla="*/ 258389 h 1531044"/>
              <a:gd name="connsiteX7" fmla="*/ 651932 w 1617133"/>
              <a:gd name="connsiteY7" fmla="*/ 118688 h 1531044"/>
              <a:gd name="connsiteX8" fmla="*/ 751417 w 1617133"/>
              <a:gd name="connsiteY8" fmla="*/ 6506 h 1531044"/>
              <a:gd name="connsiteX9" fmla="*/ 889001 w 1617133"/>
              <a:gd name="connsiteY9" fmla="*/ 29789 h 1531044"/>
              <a:gd name="connsiteX10" fmla="*/ 965200 w 1617133"/>
              <a:gd name="connsiteY10" fmla="*/ 139855 h 1531044"/>
              <a:gd name="connsiteX11" fmla="*/ 1016000 w 1617133"/>
              <a:gd name="connsiteY11" fmla="*/ 376922 h 1531044"/>
              <a:gd name="connsiteX12" fmla="*/ 1202267 w 1617133"/>
              <a:gd name="connsiteY12" fmla="*/ 1138922 h 1531044"/>
              <a:gd name="connsiteX13" fmla="*/ 1253067 w 1617133"/>
              <a:gd name="connsiteY13" fmla="*/ 1418322 h 1531044"/>
              <a:gd name="connsiteX14" fmla="*/ 1286933 w 1617133"/>
              <a:gd name="connsiteY14" fmla="*/ 1519922 h 1531044"/>
              <a:gd name="connsiteX15" fmla="*/ 1422400 w 1617133"/>
              <a:gd name="connsiteY15" fmla="*/ 1528389 h 1531044"/>
              <a:gd name="connsiteX16" fmla="*/ 1617133 w 1617133"/>
              <a:gd name="connsiteY16" fmla="*/ 1519922 h 1531044"/>
              <a:gd name="connsiteX17" fmla="*/ 1617133 w 1617133"/>
              <a:gd name="connsiteY17" fmla="*/ 1519922 h 1531044"/>
              <a:gd name="connsiteX18" fmla="*/ 1617133 w 1617133"/>
              <a:gd name="connsiteY18" fmla="*/ 1519922 h 1531044"/>
              <a:gd name="connsiteX0" fmla="*/ 0 w 1617133"/>
              <a:gd name="connsiteY0" fmla="*/ 1483612 h 1511667"/>
              <a:gd name="connsiteX1" fmla="*/ 133351 w 1617133"/>
              <a:gd name="connsiteY1" fmla="*/ 1453979 h 1511667"/>
              <a:gd name="connsiteX2" fmla="*/ 237067 w 1617133"/>
              <a:gd name="connsiteY2" fmla="*/ 1407412 h 1511667"/>
              <a:gd name="connsiteX3" fmla="*/ 347133 w 1617133"/>
              <a:gd name="connsiteY3" fmla="*/ 1238078 h 1511667"/>
              <a:gd name="connsiteX4" fmla="*/ 508000 w 1617133"/>
              <a:gd name="connsiteY4" fmla="*/ 620012 h 1511667"/>
              <a:gd name="connsiteX5" fmla="*/ 563033 w 1617133"/>
              <a:gd name="connsiteY5" fmla="*/ 429512 h 1511667"/>
              <a:gd name="connsiteX6" fmla="*/ 609600 w 1617133"/>
              <a:gd name="connsiteY6" fmla="*/ 239012 h 1511667"/>
              <a:gd name="connsiteX7" fmla="*/ 651932 w 1617133"/>
              <a:gd name="connsiteY7" fmla="*/ 99311 h 1511667"/>
              <a:gd name="connsiteX8" fmla="*/ 713317 w 1617133"/>
              <a:gd name="connsiteY8" fmla="*/ 14645 h 1511667"/>
              <a:gd name="connsiteX9" fmla="*/ 889001 w 1617133"/>
              <a:gd name="connsiteY9" fmla="*/ 10412 h 1511667"/>
              <a:gd name="connsiteX10" fmla="*/ 965200 w 1617133"/>
              <a:gd name="connsiteY10" fmla="*/ 120478 h 1511667"/>
              <a:gd name="connsiteX11" fmla="*/ 1016000 w 1617133"/>
              <a:gd name="connsiteY11" fmla="*/ 357545 h 1511667"/>
              <a:gd name="connsiteX12" fmla="*/ 1202267 w 1617133"/>
              <a:gd name="connsiteY12" fmla="*/ 1119545 h 1511667"/>
              <a:gd name="connsiteX13" fmla="*/ 1253067 w 1617133"/>
              <a:gd name="connsiteY13" fmla="*/ 1398945 h 1511667"/>
              <a:gd name="connsiteX14" fmla="*/ 1286933 w 1617133"/>
              <a:gd name="connsiteY14" fmla="*/ 1500545 h 1511667"/>
              <a:gd name="connsiteX15" fmla="*/ 1422400 w 1617133"/>
              <a:gd name="connsiteY15" fmla="*/ 1509012 h 1511667"/>
              <a:gd name="connsiteX16" fmla="*/ 1617133 w 1617133"/>
              <a:gd name="connsiteY16" fmla="*/ 1500545 h 1511667"/>
              <a:gd name="connsiteX17" fmla="*/ 1617133 w 1617133"/>
              <a:gd name="connsiteY17" fmla="*/ 1500545 h 1511667"/>
              <a:gd name="connsiteX18" fmla="*/ 1617133 w 1617133"/>
              <a:gd name="connsiteY18" fmla="*/ 1500545 h 1511667"/>
              <a:gd name="connsiteX0" fmla="*/ 0 w 1617133"/>
              <a:gd name="connsiteY0" fmla="*/ 1499521 h 1527576"/>
              <a:gd name="connsiteX1" fmla="*/ 133351 w 1617133"/>
              <a:gd name="connsiteY1" fmla="*/ 1469888 h 1527576"/>
              <a:gd name="connsiteX2" fmla="*/ 237067 w 1617133"/>
              <a:gd name="connsiteY2" fmla="*/ 1423321 h 1527576"/>
              <a:gd name="connsiteX3" fmla="*/ 347133 w 1617133"/>
              <a:gd name="connsiteY3" fmla="*/ 1253987 h 1527576"/>
              <a:gd name="connsiteX4" fmla="*/ 508000 w 1617133"/>
              <a:gd name="connsiteY4" fmla="*/ 635921 h 1527576"/>
              <a:gd name="connsiteX5" fmla="*/ 563033 w 1617133"/>
              <a:gd name="connsiteY5" fmla="*/ 445421 h 1527576"/>
              <a:gd name="connsiteX6" fmla="*/ 609600 w 1617133"/>
              <a:gd name="connsiteY6" fmla="*/ 254921 h 1527576"/>
              <a:gd name="connsiteX7" fmla="*/ 651932 w 1617133"/>
              <a:gd name="connsiteY7" fmla="*/ 115220 h 1527576"/>
              <a:gd name="connsiteX8" fmla="*/ 713317 w 1617133"/>
              <a:gd name="connsiteY8" fmla="*/ 30554 h 1527576"/>
              <a:gd name="connsiteX9" fmla="*/ 794918 w 1617133"/>
              <a:gd name="connsiteY9" fmla="*/ 71 h 1527576"/>
              <a:gd name="connsiteX10" fmla="*/ 889001 w 1617133"/>
              <a:gd name="connsiteY10" fmla="*/ 26321 h 1527576"/>
              <a:gd name="connsiteX11" fmla="*/ 965200 w 1617133"/>
              <a:gd name="connsiteY11" fmla="*/ 136387 h 1527576"/>
              <a:gd name="connsiteX12" fmla="*/ 1016000 w 1617133"/>
              <a:gd name="connsiteY12" fmla="*/ 373454 h 1527576"/>
              <a:gd name="connsiteX13" fmla="*/ 1202267 w 1617133"/>
              <a:gd name="connsiteY13" fmla="*/ 1135454 h 1527576"/>
              <a:gd name="connsiteX14" fmla="*/ 1253067 w 1617133"/>
              <a:gd name="connsiteY14" fmla="*/ 1414854 h 1527576"/>
              <a:gd name="connsiteX15" fmla="*/ 1286933 w 1617133"/>
              <a:gd name="connsiteY15" fmla="*/ 1516454 h 1527576"/>
              <a:gd name="connsiteX16" fmla="*/ 1422400 w 1617133"/>
              <a:gd name="connsiteY16" fmla="*/ 1524921 h 1527576"/>
              <a:gd name="connsiteX17" fmla="*/ 1617133 w 1617133"/>
              <a:gd name="connsiteY17" fmla="*/ 1516454 h 1527576"/>
              <a:gd name="connsiteX18" fmla="*/ 1617133 w 1617133"/>
              <a:gd name="connsiteY18" fmla="*/ 1516454 h 1527576"/>
              <a:gd name="connsiteX19" fmla="*/ 1617133 w 1617133"/>
              <a:gd name="connsiteY19" fmla="*/ 1516454 h 1527576"/>
              <a:gd name="connsiteX0" fmla="*/ 0 w 1617133"/>
              <a:gd name="connsiteY0" fmla="*/ 1499521 h 1527576"/>
              <a:gd name="connsiteX1" fmla="*/ 133351 w 1617133"/>
              <a:gd name="connsiteY1" fmla="*/ 1469888 h 1527576"/>
              <a:gd name="connsiteX2" fmla="*/ 237067 w 1617133"/>
              <a:gd name="connsiteY2" fmla="*/ 1423321 h 1527576"/>
              <a:gd name="connsiteX3" fmla="*/ 347133 w 1617133"/>
              <a:gd name="connsiteY3" fmla="*/ 1253987 h 1527576"/>
              <a:gd name="connsiteX4" fmla="*/ 508000 w 1617133"/>
              <a:gd name="connsiteY4" fmla="*/ 635921 h 1527576"/>
              <a:gd name="connsiteX5" fmla="*/ 563033 w 1617133"/>
              <a:gd name="connsiteY5" fmla="*/ 445421 h 1527576"/>
              <a:gd name="connsiteX6" fmla="*/ 609600 w 1617133"/>
              <a:gd name="connsiteY6" fmla="*/ 254921 h 1527576"/>
              <a:gd name="connsiteX7" fmla="*/ 658282 w 1617133"/>
              <a:gd name="connsiteY7" fmla="*/ 115220 h 1527576"/>
              <a:gd name="connsiteX8" fmla="*/ 713317 w 1617133"/>
              <a:gd name="connsiteY8" fmla="*/ 30554 h 1527576"/>
              <a:gd name="connsiteX9" fmla="*/ 794918 w 1617133"/>
              <a:gd name="connsiteY9" fmla="*/ 71 h 1527576"/>
              <a:gd name="connsiteX10" fmla="*/ 889001 w 1617133"/>
              <a:gd name="connsiteY10" fmla="*/ 26321 h 1527576"/>
              <a:gd name="connsiteX11" fmla="*/ 965200 w 1617133"/>
              <a:gd name="connsiteY11" fmla="*/ 136387 h 1527576"/>
              <a:gd name="connsiteX12" fmla="*/ 1016000 w 1617133"/>
              <a:gd name="connsiteY12" fmla="*/ 373454 h 1527576"/>
              <a:gd name="connsiteX13" fmla="*/ 1202267 w 1617133"/>
              <a:gd name="connsiteY13" fmla="*/ 1135454 h 1527576"/>
              <a:gd name="connsiteX14" fmla="*/ 1253067 w 1617133"/>
              <a:gd name="connsiteY14" fmla="*/ 1414854 h 1527576"/>
              <a:gd name="connsiteX15" fmla="*/ 1286933 w 1617133"/>
              <a:gd name="connsiteY15" fmla="*/ 1516454 h 1527576"/>
              <a:gd name="connsiteX16" fmla="*/ 1422400 w 1617133"/>
              <a:gd name="connsiteY16" fmla="*/ 1524921 h 1527576"/>
              <a:gd name="connsiteX17" fmla="*/ 1617133 w 1617133"/>
              <a:gd name="connsiteY17" fmla="*/ 1516454 h 1527576"/>
              <a:gd name="connsiteX18" fmla="*/ 1617133 w 1617133"/>
              <a:gd name="connsiteY18" fmla="*/ 1516454 h 1527576"/>
              <a:gd name="connsiteX19" fmla="*/ 1617133 w 1617133"/>
              <a:gd name="connsiteY19" fmla="*/ 1516454 h 1527576"/>
              <a:gd name="connsiteX0" fmla="*/ 0 w 1617133"/>
              <a:gd name="connsiteY0" fmla="*/ 1499521 h 1527576"/>
              <a:gd name="connsiteX1" fmla="*/ 133351 w 1617133"/>
              <a:gd name="connsiteY1" fmla="*/ 1469888 h 1527576"/>
              <a:gd name="connsiteX2" fmla="*/ 237067 w 1617133"/>
              <a:gd name="connsiteY2" fmla="*/ 1423321 h 1527576"/>
              <a:gd name="connsiteX3" fmla="*/ 347133 w 1617133"/>
              <a:gd name="connsiteY3" fmla="*/ 1253987 h 1527576"/>
              <a:gd name="connsiteX4" fmla="*/ 508000 w 1617133"/>
              <a:gd name="connsiteY4" fmla="*/ 635921 h 1527576"/>
              <a:gd name="connsiteX5" fmla="*/ 563033 w 1617133"/>
              <a:gd name="connsiteY5" fmla="*/ 445421 h 1527576"/>
              <a:gd name="connsiteX6" fmla="*/ 609600 w 1617133"/>
              <a:gd name="connsiteY6" fmla="*/ 254921 h 1527576"/>
              <a:gd name="connsiteX7" fmla="*/ 658282 w 1617133"/>
              <a:gd name="connsiteY7" fmla="*/ 115220 h 1527576"/>
              <a:gd name="connsiteX8" fmla="*/ 723901 w 1617133"/>
              <a:gd name="connsiteY8" fmla="*/ 30554 h 1527576"/>
              <a:gd name="connsiteX9" fmla="*/ 794918 w 1617133"/>
              <a:gd name="connsiteY9" fmla="*/ 71 h 1527576"/>
              <a:gd name="connsiteX10" fmla="*/ 889001 w 1617133"/>
              <a:gd name="connsiteY10" fmla="*/ 26321 h 1527576"/>
              <a:gd name="connsiteX11" fmla="*/ 965200 w 1617133"/>
              <a:gd name="connsiteY11" fmla="*/ 136387 h 1527576"/>
              <a:gd name="connsiteX12" fmla="*/ 1016000 w 1617133"/>
              <a:gd name="connsiteY12" fmla="*/ 373454 h 1527576"/>
              <a:gd name="connsiteX13" fmla="*/ 1202267 w 1617133"/>
              <a:gd name="connsiteY13" fmla="*/ 1135454 h 1527576"/>
              <a:gd name="connsiteX14" fmla="*/ 1253067 w 1617133"/>
              <a:gd name="connsiteY14" fmla="*/ 1414854 h 1527576"/>
              <a:gd name="connsiteX15" fmla="*/ 1286933 w 1617133"/>
              <a:gd name="connsiteY15" fmla="*/ 1516454 h 1527576"/>
              <a:gd name="connsiteX16" fmla="*/ 1422400 w 1617133"/>
              <a:gd name="connsiteY16" fmla="*/ 1524921 h 1527576"/>
              <a:gd name="connsiteX17" fmla="*/ 1617133 w 1617133"/>
              <a:gd name="connsiteY17" fmla="*/ 1516454 h 1527576"/>
              <a:gd name="connsiteX18" fmla="*/ 1617133 w 1617133"/>
              <a:gd name="connsiteY18" fmla="*/ 1516454 h 1527576"/>
              <a:gd name="connsiteX19" fmla="*/ 1617133 w 1617133"/>
              <a:gd name="connsiteY19" fmla="*/ 1516454 h 1527576"/>
              <a:gd name="connsiteX0" fmla="*/ 0 w 1617133"/>
              <a:gd name="connsiteY0" fmla="*/ 1499468 h 1527523"/>
              <a:gd name="connsiteX1" fmla="*/ 133351 w 1617133"/>
              <a:gd name="connsiteY1" fmla="*/ 1469835 h 1527523"/>
              <a:gd name="connsiteX2" fmla="*/ 237067 w 1617133"/>
              <a:gd name="connsiteY2" fmla="*/ 1423268 h 1527523"/>
              <a:gd name="connsiteX3" fmla="*/ 347133 w 1617133"/>
              <a:gd name="connsiteY3" fmla="*/ 1253934 h 1527523"/>
              <a:gd name="connsiteX4" fmla="*/ 508000 w 1617133"/>
              <a:gd name="connsiteY4" fmla="*/ 635868 h 1527523"/>
              <a:gd name="connsiteX5" fmla="*/ 563033 w 1617133"/>
              <a:gd name="connsiteY5" fmla="*/ 445368 h 1527523"/>
              <a:gd name="connsiteX6" fmla="*/ 609600 w 1617133"/>
              <a:gd name="connsiteY6" fmla="*/ 254868 h 1527523"/>
              <a:gd name="connsiteX7" fmla="*/ 658282 w 1617133"/>
              <a:gd name="connsiteY7" fmla="*/ 115167 h 1527523"/>
              <a:gd name="connsiteX8" fmla="*/ 723901 w 1617133"/>
              <a:gd name="connsiteY8" fmla="*/ 30501 h 1527523"/>
              <a:gd name="connsiteX9" fmla="*/ 794918 w 1617133"/>
              <a:gd name="connsiteY9" fmla="*/ 18 h 1527523"/>
              <a:gd name="connsiteX10" fmla="*/ 886884 w 1617133"/>
              <a:gd name="connsiteY10" fmla="*/ 43201 h 1527523"/>
              <a:gd name="connsiteX11" fmla="*/ 965200 w 1617133"/>
              <a:gd name="connsiteY11" fmla="*/ 136334 h 1527523"/>
              <a:gd name="connsiteX12" fmla="*/ 1016000 w 1617133"/>
              <a:gd name="connsiteY12" fmla="*/ 373401 h 1527523"/>
              <a:gd name="connsiteX13" fmla="*/ 1202267 w 1617133"/>
              <a:gd name="connsiteY13" fmla="*/ 1135401 h 1527523"/>
              <a:gd name="connsiteX14" fmla="*/ 1253067 w 1617133"/>
              <a:gd name="connsiteY14" fmla="*/ 1414801 h 1527523"/>
              <a:gd name="connsiteX15" fmla="*/ 1286933 w 1617133"/>
              <a:gd name="connsiteY15" fmla="*/ 1516401 h 1527523"/>
              <a:gd name="connsiteX16" fmla="*/ 1422400 w 1617133"/>
              <a:gd name="connsiteY16" fmla="*/ 1524868 h 1527523"/>
              <a:gd name="connsiteX17" fmla="*/ 1617133 w 1617133"/>
              <a:gd name="connsiteY17" fmla="*/ 1516401 h 1527523"/>
              <a:gd name="connsiteX18" fmla="*/ 1617133 w 1617133"/>
              <a:gd name="connsiteY18" fmla="*/ 1516401 h 1527523"/>
              <a:gd name="connsiteX19" fmla="*/ 1617133 w 1617133"/>
              <a:gd name="connsiteY19" fmla="*/ 1516401 h 1527523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09600 w 1617133"/>
              <a:gd name="connsiteY6" fmla="*/ 254873 h 1527528"/>
              <a:gd name="connsiteX7" fmla="*/ 658282 w 1617133"/>
              <a:gd name="connsiteY7" fmla="*/ 115172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09600 w 1617133"/>
              <a:gd name="connsiteY6" fmla="*/ 254873 h 1527528"/>
              <a:gd name="connsiteX7" fmla="*/ 666748 w 1617133"/>
              <a:gd name="connsiteY7" fmla="*/ 123639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09600 w 1617133"/>
              <a:gd name="connsiteY6" fmla="*/ 254873 h 1527528"/>
              <a:gd name="connsiteX7" fmla="*/ 666748 w 1617133"/>
              <a:gd name="connsiteY7" fmla="*/ 123639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3 h 1527528"/>
              <a:gd name="connsiteX1" fmla="*/ 133351 w 1617133"/>
              <a:gd name="connsiteY1" fmla="*/ 1469840 h 1527528"/>
              <a:gd name="connsiteX2" fmla="*/ 237067 w 1617133"/>
              <a:gd name="connsiteY2" fmla="*/ 1423273 h 1527528"/>
              <a:gd name="connsiteX3" fmla="*/ 347133 w 1617133"/>
              <a:gd name="connsiteY3" fmla="*/ 1253939 h 1527528"/>
              <a:gd name="connsiteX4" fmla="*/ 508000 w 1617133"/>
              <a:gd name="connsiteY4" fmla="*/ 635873 h 1527528"/>
              <a:gd name="connsiteX5" fmla="*/ 563033 w 1617133"/>
              <a:gd name="connsiteY5" fmla="*/ 445373 h 1527528"/>
              <a:gd name="connsiteX6" fmla="*/ 615950 w 1617133"/>
              <a:gd name="connsiteY6" fmla="*/ 263340 h 1527528"/>
              <a:gd name="connsiteX7" fmla="*/ 666748 w 1617133"/>
              <a:gd name="connsiteY7" fmla="*/ 123639 h 1527528"/>
              <a:gd name="connsiteX8" fmla="*/ 723901 w 1617133"/>
              <a:gd name="connsiteY8" fmla="*/ 30506 h 1527528"/>
              <a:gd name="connsiteX9" fmla="*/ 794918 w 1617133"/>
              <a:gd name="connsiteY9" fmla="*/ 23 h 1527528"/>
              <a:gd name="connsiteX10" fmla="*/ 886884 w 1617133"/>
              <a:gd name="connsiteY10" fmla="*/ 43206 h 1527528"/>
              <a:gd name="connsiteX11" fmla="*/ 956734 w 1617133"/>
              <a:gd name="connsiteY11" fmla="*/ 170206 h 1527528"/>
              <a:gd name="connsiteX12" fmla="*/ 1016000 w 1617133"/>
              <a:gd name="connsiteY12" fmla="*/ 373406 h 1527528"/>
              <a:gd name="connsiteX13" fmla="*/ 1202267 w 1617133"/>
              <a:gd name="connsiteY13" fmla="*/ 1135406 h 1527528"/>
              <a:gd name="connsiteX14" fmla="*/ 1253067 w 1617133"/>
              <a:gd name="connsiteY14" fmla="*/ 1414806 h 1527528"/>
              <a:gd name="connsiteX15" fmla="*/ 1286933 w 1617133"/>
              <a:gd name="connsiteY15" fmla="*/ 1516406 h 1527528"/>
              <a:gd name="connsiteX16" fmla="*/ 1422400 w 1617133"/>
              <a:gd name="connsiteY16" fmla="*/ 1524873 h 1527528"/>
              <a:gd name="connsiteX17" fmla="*/ 1617133 w 1617133"/>
              <a:gd name="connsiteY17" fmla="*/ 1516406 h 1527528"/>
              <a:gd name="connsiteX18" fmla="*/ 1617133 w 1617133"/>
              <a:gd name="connsiteY18" fmla="*/ 1516406 h 1527528"/>
              <a:gd name="connsiteX19" fmla="*/ 1617133 w 1617133"/>
              <a:gd name="connsiteY19" fmla="*/ 1516406 h 1527528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73410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73410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73410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94577 h 1527532"/>
              <a:gd name="connsiteX13" fmla="*/ 1202267 w 1617133"/>
              <a:gd name="connsiteY13" fmla="*/ 113541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0384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794918 w 1617133"/>
              <a:gd name="connsiteY9" fmla="*/ 27 h 1527532"/>
              <a:gd name="connsiteX10" fmla="*/ 886884 w 1617133"/>
              <a:gd name="connsiteY10" fmla="*/ 43210 h 1527532"/>
              <a:gd name="connsiteX11" fmla="*/ 954617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7532"/>
              <a:gd name="connsiteX1" fmla="*/ 133351 w 1617133"/>
              <a:gd name="connsiteY1" fmla="*/ 1469844 h 1527532"/>
              <a:gd name="connsiteX2" fmla="*/ 237067 w 1617133"/>
              <a:gd name="connsiteY2" fmla="*/ 1423277 h 1527532"/>
              <a:gd name="connsiteX3" fmla="*/ 347133 w 1617133"/>
              <a:gd name="connsiteY3" fmla="*/ 1253943 h 1527532"/>
              <a:gd name="connsiteX4" fmla="*/ 508000 w 1617133"/>
              <a:gd name="connsiteY4" fmla="*/ 635877 h 1527532"/>
              <a:gd name="connsiteX5" fmla="*/ 563033 w 1617133"/>
              <a:gd name="connsiteY5" fmla="*/ 445377 h 1527532"/>
              <a:gd name="connsiteX6" fmla="*/ 615950 w 1617133"/>
              <a:gd name="connsiteY6" fmla="*/ 263344 h 1527532"/>
              <a:gd name="connsiteX7" fmla="*/ 666748 w 1617133"/>
              <a:gd name="connsiteY7" fmla="*/ 123643 h 1527532"/>
              <a:gd name="connsiteX8" fmla="*/ 723901 w 1617133"/>
              <a:gd name="connsiteY8" fmla="*/ 30510 h 1527532"/>
              <a:gd name="connsiteX9" fmla="*/ 805502 w 1617133"/>
              <a:gd name="connsiteY9" fmla="*/ 27 h 1527532"/>
              <a:gd name="connsiteX10" fmla="*/ 886884 w 1617133"/>
              <a:gd name="connsiteY10" fmla="*/ 43210 h 1527532"/>
              <a:gd name="connsiteX11" fmla="*/ 954617 w 1617133"/>
              <a:gd name="connsiteY11" fmla="*/ 185026 h 1527532"/>
              <a:gd name="connsiteX12" fmla="*/ 1016000 w 1617133"/>
              <a:gd name="connsiteY12" fmla="*/ 394577 h 1527532"/>
              <a:gd name="connsiteX13" fmla="*/ 1187451 w 1617133"/>
              <a:gd name="connsiteY13" fmla="*/ 1141760 h 1527532"/>
              <a:gd name="connsiteX14" fmla="*/ 1253067 w 1617133"/>
              <a:gd name="connsiteY14" fmla="*/ 1414810 h 1527532"/>
              <a:gd name="connsiteX15" fmla="*/ 1286933 w 1617133"/>
              <a:gd name="connsiteY15" fmla="*/ 1516410 h 1527532"/>
              <a:gd name="connsiteX16" fmla="*/ 1422400 w 1617133"/>
              <a:gd name="connsiteY16" fmla="*/ 1524877 h 1527532"/>
              <a:gd name="connsiteX17" fmla="*/ 1617133 w 1617133"/>
              <a:gd name="connsiteY17" fmla="*/ 1516410 h 1527532"/>
              <a:gd name="connsiteX18" fmla="*/ 1617133 w 1617133"/>
              <a:gd name="connsiteY18" fmla="*/ 1516410 h 1527532"/>
              <a:gd name="connsiteX19" fmla="*/ 1617133 w 1617133"/>
              <a:gd name="connsiteY19" fmla="*/ 1516410 h 1527532"/>
              <a:gd name="connsiteX0" fmla="*/ 0 w 1617133"/>
              <a:gd name="connsiteY0" fmla="*/ 1499477 h 1524877"/>
              <a:gd name="connsiteX1" fmla="*/ 133351 w 1617133"/>
              <a:gd name="connsiteY1" fmla="*/ 1469844 h 1524877"/>
              <a:gd name="connsiteX2" fmla="*/ 237067 w 1617133"/>
              <a:gd name="connsiteY2" fmla="*/ 1423277 h 1524877"/>
              <a:gd name="connsiteX3" fmla="*/ 347133 w 1617133"/>
              <a:gd name="connsiteY3" fmla="*/ 1253943 h 1524877"/>
              <a:gd name="connsiteX4" fmla="*/ 508000 w 1617133"/>
              <a:gd name="connsiteY4" fmla="*/ 635877 h 1524877"/>
              <a:gd name="connsiteX5" fmla="*/ 563033 w 1617133"/>
              <a:gd name="connsiteY5" fmla="*/ 445377 h 1524877"/>
              <a:gd name="connsiteX6" fmla="*/ 615950 w 1617133"/>
              <a:gd name="connsiteY6" fmla="*/ 263344 h 1524877"/>
              <a:gd name="connsiteX7" fmla="*/ 666748 w 1617133"/>
              <a:gd name="connsiteY7" fmla="*/ 123643 h 1524877"/>
              <a:gd name="connsiteX8" fmla="*/ 723901 w 1617133"/>
              <a:gd name="connsiteY8" fmla="*/ 30510 h 1524877"/>
              <a:gd name="connsiteX9" fmla="*/ 805502 w 1617133"/>
              <a:gd name="connsiteY9" fmla="*/ 27 h 1524877"/>
              <a:gd name="connsiteX10" fmla="*/ 886884 w 1617133"/>
              <a:gd name="connsiteY10" fmla="*/ 43210 h 1524877"/>
              <a:gd name="connsiteX11" fmla="*/ 954617 w 1617133"/>
              <a:gd name="connsiteY11" fmla="*/ 185026 h 1524877"/>
              <a:gd name="connsiteX12" fmla="*/ 1016000 w 1617133"/>
              <a:gd name="connsiteY12" fmla="*/ 394577 h 1524877"/>
              <a:gd name="connsiteX13" fmla="*/ 1187451 w 1617133"/>
              <a:gd name="connsiteY13" fmla="*/ 1141760 h 1524877"/>
              <a:gd name="connsiteX14" fmla="*/ 1253067 w 1617133"/>
              <a:gd name="connsiteY14" fmla="*/ 1414810 h 1524877"/>
              <a:gd name="connsiteX15" fmla="*/ 1295400 w 1617133"/>
              <a:gd name="connsiteY15" fmla="*/ 1503710 h 1524877"/>
              <a:gd name="connsiteX16" fmla="*/ 1422400 w 1617133"/>
              <a:gd name="connsiteY16" fmla="*/ 1524877 h 1524877"/>
              <a:gd name="connsiteX17" fmla="*/ 1617133 w 1617133"/>
              <a:gd name="connsiteY17" fmla="*/ 1516410 h 1524877"/>
              <a:gd name="connsiteX18" fmla="*/ 1617133 w 1617133"/>
              <a:gd name="connsiteY18" fmla="*/ 1516410 h 1524877"/>
              <a:gd name="connsiteX19" fmla="*/ 1617133 w 1617133"/>
              <a:gd name="connsiteY19" fmla="*/ 1516410 h 1524877"/>
              <a:gd name="connsiteX0" fmla="*/ 0 w 1617133"/>
              <a:gd name="connsiteY0" fmla="*/ 1499477 h 1524877"/>
              <a:gd name="connsiteX1" fmla="*/ 133351 w 1617133"/>
              <a:gd name="connsiteY1" fmla="*/ 1469844 h 1524877"/>
              <a:gd name="connsiteX2" fmla="*/ 237067 w 1617133"/>
              <a:gd name="connsiteY2" fmla="*/ 1423277 h 1524877"/>
              <a:gd name="connsiteX3" fmla="*/ 347133 w 1617133"/>
              <a:gd name="connsiteY3" fmla="*/ 1253943 h 1524877"/>
              <a:gd name="connsiteX4" fmla="*/ 508000 w 1617133"/>
              <a:gd name="connsiteY4" fmla="*/ 635877 h 1524877"/>
              <a:gd name="connsiteX5" fmla="*/ 563033 w 1617133"/>
              <a:gd name="connsiteY5" fmla="*/ 445377 h 1524877"/>
              <a:gd name="connsiteX6" fmla="*/ 615950 w 1617133"/>
              <a:gd name="connsiteY6" fmla="*/ 263344 h 1524877"/>
              <a:gd name="connsiteX7" fmla="*/ 666748 w 1617133"/>
              <a:gd name="connsiteY7" fmla="*/ 123643 h 1524877"/>
              <a:gd name="connsiteX8" fmla="*/ 723901 w 1617133"/>
              <a:gd name="connsiteY8" fmla="*/ 30510 h 1524877"/>
              <a:gd name="connsiteX9" fmla="*/ 805502 w 1617133"/>
              <a:gd name="connsiteY9" fmla="*/ 27 h 1524877"/>
              <a:gd name="connsiteX10" fmla="*/ 886884 w 1617133"/>
              <a:gd name="connsiteY10" fmla="*/ 43210 h 1524877"/>
              <a:gd name="connsiteX11" fmla="*/ 954617 w 1617133"/>
              <a:gd name="connsiteY11" fmla="*/ 185026 h 1524877"/>
              <a:gd name="connsiteX12" fmla="*/ 1016000 w 1617133"/>
              <a:gd name="connsiteY12" fmla="*/ 394577 h 1524877"/>
              <a:gd name="connsiteX13" fmla="*/ 1187451 w 1617133"/>
              <a:gd name="connsiteY13" fmla="*/ 1141760 h 1524877"/>
              <a:gd name="connsiteX14" fmla="*/ 1253067 w 1617133"/>
              <a:gd name="connsiteY14" fmla="*/ 1414810 h 1524877"/>
              <a:gd name="connsiteX15" fmla="*/ 1295400 w 1617133"/>
              <a:gd name="connsiteY15" fmla="*/ 1503710 h 1524877"/>
              <a:gd name="connsiteX16" fmla="*/ 1422400 w 1617133"/>
              <a:gd name="connsiteY16" fmla="*/ 1524877 h 1524877"/>
              <a:gd name="connsiteX17" fmla="*/ 1617133 w 1617133"/>
              <a:gd name="connsiteY17" fmla="*/ 1516410 h 1524877"/>
              <a:gd name="connsiteX18" fmla="*/ 1617133 w 1617133"/>
              <a:gd name="connsiteY18" fmla="*/ 1516410 h 1524877"/>
              <a:gd name="connsiteX19" fmla="*/ 1617133 w 1617133"/>
              <a:gd name="connsiteY19" fmla="*/ 1516410 h 1524877"/>
              <a:gd name="connsiteX0" fmla="*/ 0 w 1617133"/>
              <a:gd name="connsiteY0" fmla="*/ 1499477 h 1524877"/>
              <a:gd name="connsiteX1" fmla="*/ 133351 w 1617133"/>
              <a:gd name="connsiteY1" fmla="*/ 1469844 h 1524877"/>
              <a:gd name="connsiteX2" fmla="*/ 237067 w 1617133"/>
              <a:gd name="connsiteY2" fmla="*/ 1423277 h 1524877"/>
              <a:gd name="connsiteX3" fmla="*/ 347133 w 1617133"/>
              <a:gd name="connsiteY3" fmla="*/ 1253943 h 1524877"/>
              <a:gd name="connsiteX4" fmla="*/ 508000 w 1617133"/>
              <a:gd name="connsiteY4" fmla="*/ 635877 h 1524877"/>
              <a:gd name="connsiteX5" fmla="*/ 563033 w 1617133"/>
              <a:gd name="connsiteY5" fmla="*/ 445377 h 1524877"/>
              <a:gd name="connsiteX6" fmla="*/ 615950 w 1617133"/>
              <a:gd name="connsiteY6" fmla="*/ 263344 h 1524877"/>
              <a:gd name="connsiteX7" fmla="*/ 666748 w 1617133"/>
              <a:gd name="connsiteY7" fmla="*/ 123643 h 1524877"/>
              <a:gd name="connsiteX8" fmla="*/ 723901 w 1617133"/>
              <a:gd name="connsiteY8" fmla="*/ 30510 h 1524877"/>
              <a:gd name="connsiteX9" fmla="*/ 805502 w 1617133"/>
              <a:gd name="connsiteY9" fmla="*/ 27 h 1524877"/>
              <a:gd name="connsiteX10" fmla="*/ 886884 w 1617133"/>
              <a:gd name="connsiteY10" fmla="*/ 43210 h 1524877"/>
              <a:gd name="connsiteX11" fmla="*/ 954617 w 1617133"/>
              <a:gd name="connsiteY11" fmla="*/ 185026 h 1524877"/>
              <a:gd name="connsiteX12" fmla="*/ 1016000 w 1617133"/>
              <a:gd name="connsiteY12" fmla="*/ 394577 h 1524877"/>
              <a:gd name="connsiteX13" fmla="*/ 1187451 w 1617133"/>
              <a:gd name="connsiteY13" fmla="*/ 1141760 h 1524877"/>
              <a:gd name="connsiteX14" fmla="*/ 1253067 w 1617133"/>
              <a:gd name="connsiteY14" fmla="*/ 1414810 h 1524877"/>
              <a:gd name="connsiteX15" fmla="*/ 1295400 w 1617133"/>
              <a:gd name="connsiteY15" fmla="*/ 1503710 h 1524877"/>
              <a:gd name="connsiteX16" fmla="*/ 1422400 w 1617133"/>
              <a:gd name="connsiteY16" fmla="*/ 1524877 h 1524877"/>
              <a:gd name="connsiteX17" fmla="*/ 1617133 w 1617133"/>
              <a:gd name="connsiteY17" fmla="*/ 1516410 h 1524877"/>
              <a:gd name="connsiteX18" fmla="*/ 1617133 w 1617133"/>
              <a:gd name="connsiteY18" fmla="*/ 1516410 h 1524877"/>
              <a:gd name="connsiteX19" fmla="*/ 1617133 w 1617133"/>
              <a:gd name="connsiteY19" fmla="*/ 1516410 h 1524877"/>
              <a:gd name="connsiteX0" fmla="*/ 0 w 1617133"/>
              <a:gd name="connsiteY0" fmla="*/ 1499477 h 1524884"/>
              <a:gd name="connsiteX1" fmla="*/ 133351 w 1617133"/>
              <a:gd name="connsiteY1" fmla="*/ 1469844 h 1524884"/>
              <a:gd name="connsiteX2" fmla="*/ 237067 w 1617133"/>
              <a:gd name="connsiteY2" fmla="*/ 1423277 h 1524884"/>
              <a:gd name="connsiteX3" fmla="*/ 347133 w 1617133"/>
              <a:gd name="connsiteY3" fmla="*/ 1253943 h 1524884"/>
              <a:gd name="connsiteX4" fmla="*/ 508000 w 1617133"/>
              <a:gd name="connsiteY4" fmla="*/ 635877 h 1524884"/>
              <a:gd name="connsiteX5" fmla="*/ 563033 w 1617133"/>
              <a:gd name="connsiteY5" fmla="*/ 445377 h 1524884"/>
              <a:gd name="connsiteX6" fmla="*/ 615950 w 1617133"/>
              <a:gd name="connsiteY6" fmla="*/ 263344 h 1524884"/>
              <a:gd name="connsiteX7" fmla="*/ 666748 w 1617133"/>
              <a:gd name="connsiteY7" fmla="*/ 123643 h 1524884"/>
              <a:gd name="connsiteX8" fmla="*/ 723901 w 1617133"/>
              <a:gd name="connsiteY8" fmla="*/ 30510 h 1524884"/>
              <a:gd name="connsiteX9" fmla="*/ 805502 w 1617133"/>
              <a:gd name="connsiteY9" fmla="*/ 27 h 1524884"/>
              <a:gd name="connsiteX10" fmla="*/ 886884 w 1617133"/>
              <a:gd name="connsiteY10" fmla="*/ 43210 h 1524884"/>
              <a:gd name="connsiteX11" fmla="*/ 954617 w 1617133"/>
              <a:gd name="connsiteY11" fmla="*/ 185026 h 1524884"/>
              <a:gd name="connsiteX12" fmla="*/ 1016000 w 1617133"/>
              <a:gd name="connsiteY12" fmla="*/ 394577 h 1524884"/>
              <a:gd name="connsiteX13" fmla="*/ 1187451 w 1617133"/>
              <a:gd name="connsiteY13" fmla="*/ 1141760 h 1524884"/>
              <a:gd name="connsiteX14" fmla="*/ 1253067 w 1617133"/>
              <a:gd name="connsiteY14" fmla="*/ 1414810 h 1524884"/>
              <a:gd name="connsiteX15" fmla="*/ 1295400 w 1617133"/>
              <a:gd name="connsiteY15" fmla="*/ 1503710 h 1524884"/>
              <a:gd name="connsiteX16" fmla="*/ 1422400 w 1617133"/>
              <a:gd name="connsiteY16" fmla="*/ 1524877 h 1524884"/>
              <a:gd name="connsiteX17" fmla="*/ 1617133 w 1617133"/>
              <a:gd name="connsiteY17" fmla="*/ 1516410 h 1524884"/>
              <a:gd name="connsiteX18" fmla="*/ 1617133 w 1617133"/>
              <a:gd name="connsiteY18" fmla="*/ 1516410 h 1524884"/>
              <a:gd name="connsiteX19" fmla="*/ 1617133 w 1617133"/>
              <a:gd name="connsiteY19" fmla="*/ 1516410 h 1524884"/>
              <a:gd name="connsiteX0" fmla="*/ 0 w 1617133"/>
              <a:gd name="connsiteY0" fmla="*/ 1499477 h 1524884"/>
              <a:gd name="connsiteX1" fmla="*/ 133351 w 1617133"/>
              <a:gd name="connsiteY1" fmla="*/ 1469844 h 1524884"/>
              <a:gd name="connsiteX2" fmla="*/ 237067 w 1617133"/>
              <a:gd name="connsiteY2" fmla="*/ 1423277 h 1524884"/>
              <a:gd name="connsiteX3" fmla="*/ 347133 w 1617133"/>
              <a:gd name="connsiteY3" fmla="*/ 1253943 h 1524884"/>
              <a:gd name="connsiteX4" fmla="*/ 508000 w 1617133"/>
              <a:gd name="connsiteY4" fmla="*/ 635877 h 1524884"/>
              <a:gd name="connsiteX5" fmla="*/ 563033 w 1617133"/>
              <a:gd name="connsiteY5" fmla="*/ 445377 h 1524884"/>
              <a:gd name="connsiteX6" fmla="*/ 615950 w 1617133"/>
              <a:gd name="connsiteY6" fmla="*/ 263344 h 1524884"/>
              <a:gd name="connsiteX7" fmla="*/ 666748 w 1617133"/>
              <a:gd name="connsiteY7" fmla="*/ 123643 h 1524884"/>
              <a:gd name="connsiteX8" fmla="*/ 723901 w 1617133"/>
              <a:gd name="connsiteY8" fmla="*/ 30510 h 1524884"/>
              <a:gd name="connsiteX9" fmla="*/ 805502 w 1617133"/>
              <a:gd name="connsiteY9" fmla="*/ 27 h 1524884"/>
              <a:gd name="connsiteX10" fmla="*/ 886884 w 1617133"/>
              <a:gd name="connsiteY10" fmla="*/ 43210 h 1524884"/>
              <a:gd name="connsiteX11" fmla="*/ 954617 w 1617133"/>
              <a:gd name="connsiteY11" fmla="*/ 185026 h 1524884"/>
              <a:gd name="connsiteX12" fmla="*/ 1011767 w 1617133"/>
              <a:gd name="connsiteY12" fmla="*/ 396694 h 1524884"/>
              <a:gd name="connsiteX13" fmla="*/ 1187451 w 1617133"/>
              <a:gd name="connsiteY13" fmla="*/ 1141760 h 1524884"/>
              <a:gd name="connsiteX14" fmla="*/ 1253067 w 1617133"/>
              <a:gd name="connsiteY14" fmla="*/ 1414810 h 1524884"/>
              <a:gd name="connsiteX15" fmla="*/ 1295400 w 1617133"/>
              <a:gd name="connsiteY15" fmla="*/ 1503710 h 1524884"/>
              <a:gd name="connsiteX16" fmla="*/ 1422400 w 1617133"/>
              <a:gd name="connsiteY16" fmla="*/ 1524877 h 1524884"/>
              <a:gd name="connsiteX17" fmla="*/ 1617133 w 1617133"/>
              <a:gd name="connsiteY17" fmla="*/ 1516410 h 1524884"/>
              <a:gd name="connsiteX18" fmla="*/ 1617133 w 1617133"/>
              <a:gd name="connsiteY18" fmla="*/ 1516410 h 1524884"/>
              <a:gd name="connsiteX19" fmla="*/ 1617133 w 1617133"/>
              <a:gd name="connsiteY19" fmla="*/ 1516410 h 1524884"/>
              <a:gd name="connsiteX0" fmla="*/ 0 w 1617133"/>
              <a:gd name="connsiteY0" fmla="*/ 1499477 h 1524884"/>
              <a:gd name="connsiteX1" fmla="*/ 133351 w 1617133"/>
              <a:gd name="connsiteY1" fmla="*/ 1469844 h 1524884"/>
              <a:gd name="connsiteX2" fmla="*/ 260880 w 1617133"/>
              <a:gd name="connsiteY2" fmla="*/ 1414810 h 1524884"/>
              <a:gd name="connsiteX3" fmla="*/ 347133 w 1617133"/>
              <a:gd name="connsiteY3" fmla="*/ 1253943 h 1524884"/>
              <a:gd name="connsiteX4" fmla="*/ 508000 w 1617133"/>
              <a:gd name="connsiteY4" fmla="*/ 635877 h 1524884"/>
              <a:gd name="connsiteX5" fmla="*/ 563033 w 1617133"/>
              <a:gd name="connsiteY5" fmla="*/ 445377 h 1524884"/>
              <a:gd name="connsiteX6" fmla="*/ 615950 w 1617133"/>
              <a:gd name="connsiteY6" fmla="*/ 263344 h 1524884"/>
              <a:gd name="connsiteX7" fmla="*/ 666748 w 1617133"/>
              <a:gd name="connsiteY7" fmla="*/ 123643 h 1524884"/>
              <a:gd name="connsiteX8" fmla="*/ 723901 w 1617133"/>
              <a:gd name="connsiteY8" fmla="*/ 30510 h 1524884"/>
              <a:gd name="connsiteX9" fmla="*/ 805502 w 1617133"/>
              <a:gd name="connsiteY9" fmla="*/ 27 h 1524884"/>
              <a:gd name="connsiteX10" fmla="*/ 886884 w 1617133"/>
              <a:gd name="connsiteY10" fmla="*/ 43210 h 1524884"/>
              <a:gd name="connsiteX11" fmla="*/ 954617 w 1617133"/>
              <a:gd name="connsiteY11" fmla="*/ 185026 h 1524884"/>
              <a:gd name="connsiteX12" fmla="*/ 1011767 w 1617133"/>
              <a:gd name="connsiteY12" fmla="*/ 396694 h 1524884"/>
              <a:gd name="connsiteX13" fmla="*/ 1187451 w 1617133"/>
              <a:gd name="connsiteY13" fmla="*/ 1141760 h 1524884"/>
              <a:gd name="connsiteX14" fmla="*/ 1253067 w 1617133"/>
              <a:gd name="connsiteY14" fmla="*/ 1414810 h 1524884"/>
              <a:gd name="connsiteX15" fmla="*/ 1295400 w 1617133"/>
              <a:gd name="connsiteY15" fmla="*/ 1503710 h 1524884"/>
              <a:gd name="connsiteX16" fmla="*/ 1422400 w 1617133"/>
              <a:gd name="connsiteY16" fmla="*/ 1524877 h 1524884"/>
              <a:gd name="connsiteX17" fmla="*/ 1617133 w 1617133"/>
              <a:gd name="connsiteY17" fmla="*/ 1516410 h 1524884"/>
              <a:gd name="connsiteX18" fmla="*/ 1617133 w 1617133"/>
              <a:gd name="connsiteY18" fmla="*/ 1516410 h 1524884"/>
              <a:gd name="connsiteX19" fmla="*/ 1617133 w 1617133"/>
              <a:gd name="connsiteY19" fmla="*/ 1516410 h 1524884"/>
              <a:gd name="connsiteX0" fmla="*/ 7455 w 1624588"/>
              <a:gd name="connsiteY0" fmla="*/ 1499477 h 1524884"/>
              <a:gd name="connsiteX1" fmla="*/ 10640 w 1624588"/>
              <a:gd name="connsiteY1" fmla="*/ 1496036 h 1524884"/>
              <a:gd name="connsiteX2" fmla="*/ 140806 w 1624588"/>
              <a:gd name="connsiteY2" fmla="*/ 1469844 h 1524884"/>
              <a:gd name="connsiteX3" fmla="*/ 268335 w 1624588"/>
              <a:gd name="connsiteY3" fmla="*/ 1414810 h 1524884"/>
              <a:gd name="connsiteX4" fmla="*/ 354588 w 1624588"/>
              <a:gd name="connsiteY4" fmla="*/ 1253943 h 1524884"/>
              <a:gd name="connsiteX5" fmla="*/ 515455 w 1624588"/>
              <a:gd name="connsiteY5" fmla="*/ 635877 h 1524884"/>
              <a:gd name="connsiteX6" fmla="*/ 570488 w 1624588"/>
              <a:gd name="connsiteY6" fmla="*/ 445377 h 1524884"/>
              <a:gd name="connsiteX7" fmla="*/ 623405 w 1624588"/>
              <a:gd name="connsiteY7" fmla="*/ 263344 h 1524884"/>
              <a:gd name="connsiteX8" fmla="*/ 674203 w 1624588"/>
              <a:gd name="connsiteY8" fmla="*/ 123643 h 1524884"/>
              <a:gd name="connsiteX9" fmla="*/ 731356 w 1624588"/>
              <a:gd name="connsiteY9" fmla="*/ 30510 h 1524884"/>
              <a:gd name="connsiteX10" fmla="*/ 812957 w 1624588"/>
              <a:gd name="connsiteY10" fmla="*/ 27 h 1524884"/>
              <a:gd name="connsiteX11" fmla="*/ 894339 w 1624588"/>
              <a:gd name="connsiteY11" fmla="*/ 43210 h 1524884"/>
              <a:gd name="connsiteX12" fmla="*/ 962072 w 1624588"/>
              <a:gd name="connsiteY12" fmla="*/ 185026 h 1524884"/>
              <a:gd name="connsiteX13" fmla="*/ 1019222 w 1624588"/>
              <a:gd name="connsiteY13" fmla="*/ 396694 h 1524884"/>
              <a:gd name="connsiteX14" fmla="*/ 1194906 w 1624588"/>
              <a:gd name="connsiteY14" fmla="*/ 1141760 h 1524884"/>
              <a:gd name="connsiteX15" fmla="*/ 1260522 w 1624588"/>
              <a:gd name="connsiteY15" fmla="*/ 1414810 h 1524884"/>
              <a:gd name="connsiteX16" fmla="*/ 1302855 w 1624588"/>
              <a:gd name="connsiteY16" fmla="*/ 1503710 h 1524884"/>
              <a:gd name="connsiteX17" fmla="*/ 1429855 w 1624588"/>
              <a:gd name="connsiteY17" fmla="*/ 1524877 h 1524884"/>
              <a:gd name="connsiteX18" fmla="*/ 1624588 w 1624588"/>
              <a:gd name="connsiteY18" fmla="*/ 1516410 h 1524884"/>
              <a:gd name="connsiteX19" fmla="*/ 1624588 w 1624588"/>
              <a:gd name="connsiteY19" fmla="*/ 1516410 h 1524884"/>
              <a:gd name="connsiteX20" fmla="*/ 1624588 w 1624588"/>
              <a:gd name="connsiteY20" fmla="*/ 1516410 h 1524884"/>
              <a:gd name="connsiteX0" fmla="*/ 160627 w 1777760"/>
              <a:gd name="connsiteY0" fmla="*/ 1499477 h 1524884"/>
              <a:gd name="connsiteX1" fmla="*/ 1886 w 1777760"/>
              <a:gd name="connsiteY1" fmla="*/ 1510852 h 1524884"/>
              <a:gd name="connsiteX2" fmla="*/ 293978 w 1777760"/>
              <a:gd name="connsiteY2" fmla="*/ 1469844 h 1524884"/>
              <a:gd name="connsiteX3" fmla="*/ 421507 w 1777760"/>
              <a:gd name="connsiteY3" fmla="*/ 1414810 h 1524884"/>
              <a:gd name="connsiteX4" fmla="*/ 507760 w 1777760"/>
              <a:gd name="connsiteY4" fmla="*/ 1253943 h 1524884"/>
              <a:gd name="connsiteX5" fmla="*/ 668627 w 1777760"/>
              <a:gd name="connsiteY5" fmla="*/ 635877 h 1524884"/>
              <a:gd name="connsiteX6" fmla="*/ 723660 w 1777760"/>
              <a:gd name="connsiteY6" fmla="*/ 445377 h 1524884"/>
              <a:gd name="connsiteX7" fmla="*/ 776577 w 1777760"/>
              <a:gd name="connsiteY7" fmla="*/ 263344 h 1524884"/>
              <a:gd name="connsiteX8" fmla="*/ 827375 w 1777760"/>
              <a:gd name="connsiteY8" fmla="*/ 123643 h 1524884"/>
              <a:gd name="connsiteX9" fmla="*/ 884528 w 1777760"/>
              <a:gd name="connsiteY9" fmla="*/ 30510 h 1524884"/>
              <a:gd name="connsiteX10" fmla="*/ 966129 w 1777760"/>
              <a:gd name="connsiteY10" fmla="*/ 27 h 1524884"/>
              <a:gd name="connsiteX11" fmla="*/ 1047511 w 1777760"/>
              <a:gd name="connsiteY11" fmla="*/ 43210 h 1524884"/>
              <a:gd name="connsiteX12" fmla="*/ 1115244 w 1777760"/>
              <a:gd name="connsiteY12" fmla="*/ 185026 h 1524884"/>
              <a:gd name="connsiteX13" fmla="*/ 1172394 w 1777760"/>
              <a:gd name="connsiteY13" fmla="*/ 396694 h 1524884"/>
              <a:gd name="connsiteX14" fmla="*/ 1348078 w 1777760"/>
              <a:gd name="connsiteY14" fmla="*/ 1141760 h 1524884"/>
              <a:gd name="connsiteX15" fmla="*/ 1413694 w 1777760"/>
              <a:gd name="connsiteY15" fmla="*/ 1414810 h 1524884"/>
              <a:gd name="connsiteX16" fmla="*/ 1456027 w 1777760"/>
              <a:gd name="connsiteY16" fmla="*/ 1503710 h 1524884"/>
              <a:gd name="connsiteX17" fmla="*/ 1583027 w 1777760"/>
              <a:gd name="connsiteY17" fmla="*/ 1524877 h 1524884"/>
              <a:gd name="connsiteX18" fmla="*/ 1777760 w 1777760"/>
              <a:gd name="connsiteY18" fmla="*/ 1516410 h 1524884"/>
              <a:gd name="connsiteX19" fmla="*/ 1777760 w 1777760"/>
              <a:gd name="connsiteY19" fmla="*/ 1516410 h 1524884"/>
              <a:gd name="connsiteX20" fmla="*/ 1777760 w 1777760"/>
              <a:gd name="connsiteY20" fmla="*/ 1516410 h 1524884"/>
              <a:gd name="connsiteX0" fmla="*/ 10952 w 1785249"/>
              <a:gd name="connsiteY0" fmla="*/ 1586261 h 1586261"/>
              <a:gd name="connsiteX1" fmla="*/ 9375 w 1785249"/>
              <a:gd name="connsiteY1" fmla="*/ 1510852 h 1586261"/>
              <a:gd name="connsiteX2" fmla="*/ 301467 w 1785249"/>
              <a:gd name="connsiteY2" fmla="*/ 1469844 h 1586261"/>
              <a:gd name="connsiteX3" fmla="*/ 428996 w 1785249"/>
              <a:gd name="connsiteY3" fmla="*/ 1414810 h 1586261"/>
              <a:gd name="connsiteX4" fmla="*/ 515249 w 1785249"/>
              <a:gd name="connsiteY4" fmla="*/ 1253943 h 1586261"/>
              <a:gd name="connsiteX5" fmla="*/ 676116 w 1785249"/>
              <a:gd name="connsiteY5" fmla="*/ 635877 h 1586261"/>
              <a:gd name="connsiteX6" fmla="*/ 731149 w 1785249"/>
              <a:gd name="connsiteY6" fmla="*/ 445377 h 1586261"/>
              <a:gd name="connsiteX7" fmla="*/ 784066 w 1785249"/>
              <a:gd name="connsiteY7" fmla="*/ 263344 h 1586261"/>
              <a:gd name="connsiteX8" fmla="*/ 834864 w 1785249"/>
              <a:gd name="connsiteY8" fmla="*/ 123643 h 1586261"/>
              <a:gd name="connsiteX9" fmla="*/ 892017 w 1785249"/>
              <a:gd name="connsiteY9" fmla="*/ 30510 h 1586261"/>
              <a:gd name="connsiteX10" fmla="*/ 973618 w 1785249"/>
              <a:gd name="connsiteY10" fmla="*/ 27 h 1586261"/>
              <a:gd name="connsiteX11" fmla="*/ 1055000 w 1785249"/>
              <a:gd name="connsiteY11" fmla="*/ 43210 h 1586261"/>
              <a:gd name="connsiteX12" fmla="*/ 1122733 w 1785249"/>
              <a:gd name="connsiteY12" fmla="*/ 185026 h 1586261"/>
              <a:gd name="connsiteX13" fmla="*/ 1179883 w 1785249"/>
              <a:gd name="connsiteY13" fmla="*/ 396694 h 1586261"/>
              <a:gd name="connsiteX14" fmla="*/ 1355567 w 1785249"/>
              <a:gd name="connsiteY14" fmla="*/ 1141760 h 1586261"/>
              <a:gd name="connsiteX15" fmla="*/ 1421183 w 1785249"/>
              <a:gd name="connsiteY15" fmla="*/ 1414810 h 1586261"/>
              <a:gd name="connsiteX16" fmla="*/ 1463516 w 1785249"/>
              <a:gd name="connsiteY16" fmla="*/ 1503710 h 1586261"/>
              <a:gd name="connsiteX17" fmla="*/ 1590516 w 1785249"/>
              <a:gd name="connsiteY17" fmla="*/ 1524877 h 1586261"/>
              <a:gd name="connsiteX18" fmla="*/ 1785249 w 1785249"/>
              <a:gd name="connsiteY18" fmla="*/ 1516410 h 1586261"/>
              <a:gd name="connsiteX19" fmla="*/ 1785249 w 1785249"/>
              <a:gd name="connsiteY19" fmla="*/ 1516410 h 1586261"/>
              <a:gd name="connsiteX20" fmla="*/ 1785249 w 1785249"/>
              <a:gd name="connsiteY20" fmla="*/ 1516410 h 1586261"/>
              <a:gd name="connsiteX0" fmla="*/ 0 w 1774297"/>
              <a:gd name="connsiteY0" fmla="*/ 1586261 h 1586261"/>
              <a:gd name="connsiteX1" fmla="*/ 131774 w 1774297"/>
              <a:gd name="connsiteY1" fmla="*/ 1502385 h 1586261"/>
              <a:gd name="connsiteX2" fmla="*/ 290515 w 1774297"/>
              <a:gd name="connsiteY2" fmla="*/ 1469844 h 1586261"/>
              <a:gd name="connsiteX3" fmla="*/ 418044 w 1774297"/>
              <a:gd name="connsiteY3" fmla="*/ 1414810 h 1586261"/>
              <a:gd name="connsiteX4" fmla="*/ 504297 w 1774297"/>
              <a:gd name="connsiteY4" fmla="*/ 1253943 h 1586261"/>
              <a:gd name="connsiteX5" fmla="*/ 665164 w 1774297"/>
              <a:gd name="connsiteY5" fmla="*/ 635877 h 1586261"/>
              <a:gd name="connsiteX6" fmla="*/ 720197 w 1774297"/>
              <a:gd name="connsiteY6" fmla="*/ 445377 h 1586261"/>
              <a:gd name="connsiteX7" fmla="*/ 773114 w 1774297"/>
              <a:gd name="connsiteY7" fmla="*/ 263344 h 1586261"/>
              <a:gd name="connsiteX8" fmla="*/ 823912 w 1774297"/>
              <a:gd name="connsiteY8" fmla="*/ 123643 h 1586261"/>
              <a:gd name="connsiteX9" fmla="*/ 881065 w 1774297"/>
              <a:gd name="connsiteY9" fmla="*/ 30510 h 1586261"/>
              <a:gd name="connsiteX10" fmla="*/ 962666 w 1774297"/>
              <a:gd name="connsiteY10" fmla="*/ 27 h 1586261"/>
              <a:gd name="connsiteX11" fmla="*/ 1044048 w 1774297"/>
              <a:gd name="connsiteY11" fmla="*/ 43210 h 1586261"/>
              <a:gd name="connsiteX12" fmla="*/ 1111781 w 1774297"/>
              <a:gd name="connsiteY12" fmla="*/ 185026 h 1586261"/>
              <a:gd name="connsiteX13" fmla="*/ 1168931 w 1774297"/>
              <a:gd name="connsiteY13" fmla="*/ 396694 h 1586261"/>
              <a:gd name="connsiteX14" fmla="*/ 1344615 w 1774297"/>
              <a:gd name="connsiteY14" fmla="*/ 1141760 h 1586261"/>
              <a:gd name="connsiteX15" fmla="*/ 1410231 w 1774297"/>
              <a:gd name="connsiteY15" fmla="*/ 1414810 h 1586261"/>
              <a:gd name="connsiteX16" fmla="*/ 1452564 w 1774297"/>
              <a:gd name="connsiteY16" fmla="*/ 1503710 h 1586261"/>
              <a:gd name="connsiteX17" fmla="*/ 1579564 w 1774297"/>
              <a:gd name="connsiteY17" fmla="*/ 1524877 h 1586261"/>
              <a:gd name="connsiteX18" fmla="*/ 1774297 w 1774297"/>
              <a:gd name="connsiteY18" fmla="*/ 1516410 h 1586261"/>
              <a:gd name="connsiteX19" fmla="*/ 1774297 w 1774297"/>
              <a:gd name="connsiteY19" fmla="*/ 1516410 h 1586261"/>
              <a:gd name="connsiteX20" fmla="*/ 1774297 w 1774297"/>
              <a:gd name="connsiteY20" fmla="*/ 1516410 h 1586261"/>
              <a:gd name="connsiteX0" fmla="*/ 0 w 1817160"/>
              <a:gd name="connsiteY0" fmla="*/ 1516411 h 1524884"/>
              <a:gd name="connsiteX1" fmla="*/ 174637 w 1817160"/>
              <a:gd name="connsiteY1" fmla="*/ 1502385 h 1524884"/>
              <a:gd name="connsiteX2" fmla="*/ 333378 w 1817160"/>
              <a:gd name="connsiteY2" fmla="*/ 1469844 h 1524884"/>
              <a:gd name="connsiteX3" fmla="*/ 460907 w 1817160"/>
              <a:gd name="connsiteY3" fmla="*/ 1414810 h 1524884"/>
              <a:gd name="connsiteX4" fmla="*/ 547160 w 1817160"/>
              <a:gd name="connsiteY4" fmla="*/ 1253943 h 1524884"/>
              <a:gd name="connsiteX5" fmla="*/ 708027 w 1817160"/>
              <a:gd name="connsiteY5" fmla="*/ 635877 h 1524884"/>
              <a:gd name="connsiteX6" fmla="*/ 763060 w 1817160"/>
              <a:gd name="connsiteY6" fmla="*/ 445377 h 1524884"/>
              <a:gd name="connsiteX7" fmla="*/ 815977 w 1817160"/>
              <a:gd name="connsiteY7" fmla="*/ 263344 h 1524884"/>
              <a:gd name="connsiteX8" fmla="*/ 866775 w 1817160"/>
              <a:gd name="connsiteY8" fmla="*/ 123643 h 1524884"/>
              <a:gd name="connsiteX9" fmla="*/ 923928 w 1817160"/>
              <a:gd name="connsiteY9" fmla="*/ 30510 h 1524884"/>
              <a:gd name="connsiteX10" fmla="*/ 1005529 w 1817160"/>
              <a:gd name="connsiteY10" fmla="*/ 27 h 1524884"/>
              <a:gd name="connsiteX11" fmla="*/ 1086911 w 1817160"/>
              <a:gd name="connsiteY11" fmla="*/ 43210 h 1524884"/>
              <a:gd name="connsiteX12" fmla="*/ 1154644 w 1817160"/>
              <a:gd name="connsiteY12" fmla="*/ 185026 h 1524884"/>
              <a:gd name="connsiteX13" fmla="*/ 1211794 w 1817160"/>
              <a:gd name="connsiteY13" fmla="*/ 396694 h 1524884"/>
              <a:gd name="connsiteX14" fmla="*/ 1387478 w 1817160"/>
              <a:gd name="connsiteY14" fmla="*/ 1141760 h 1524884"/>
              <a:gd name="connsiteX15" fmla="*/ 1453094 w 1817160"/>
              <a:gd name="connsiteY15" fmla="*/ 1414810 h 1524884"/>
              <a:gd name="connsiteX16" fmla="*/ 1495427 w 1817160"/>
              <a:gd name="connsiteY16" fmla="*/ 1503710 h 1524884"/>
              <a:gd name="connsiteX17" fmla="*/ 1622427 w 1817160"/>
              <a:gd name="connsiteY17" fmla="*/ 1524877 h 1524884"/>
              <a:gd name="connsiteX18" fmla="*/ 1817160 w 1817160"/>
              <a:gd name="connsiteY18" fmla="*/ 1516410 h 1524884"/>
              <a:gd name="connsiteX19" fmla="*/ 1817160 w 1817160"/>
              <a:gd name="connsiteY19" fmla="*/ 1516410 h 1524884"/>
              <a:gd name="connsiteX20" fmla="*/ 1817160 w 1817160"/>
              <a:gd name="connsiteY20" fmla="*/ 1516410 h 1524884"/>
              <a:gd name="connsiteX0" fmla="*/ 0 w 1817160"/>
              <a:gd name="connsiteY0" fmla="*/ 1516411 h 1524884"/>
              <a:gd name="connsiteX1" fmla="*/ 174637 w 1817160"/>
              <a:gd name="connsiteY1" fmla="*/ 1502385 h 1524884"/>
              <a:gd name="connsiteX2" fmla="*/ 333378 w 1817160"/>
              <a:gd name="connsiteY2" fmla="*/ 1469844 h 1524884"/>
              <a:gd name="connsiteX3" fmla="*/ 460907 w 1817160"/>
              <a:gd name="connsiteY3" fmla="*/ 1414810 h 1524884"/>
              <a:gd name="connsiteX4" fmla="*/ 547160 w 1817160"/>
              <a:gd name="connsiteY4" fmla="*/ 1253943 h 1524884"/>
              <a:gd name="connsiteX5" fmla="*/ 708027 w 1817160"/>
              <a:gd name="connsiteY5" fmla="*/ 635877 h 1524884"/>
              <a:gd name="connsiteX6" fmla="*/ 763060 w 1817160"/>
              <a:gd name="connsiteY6" fmla="*/ 445377 h 1524884"/>
              <a:gd name="connsiteX7" fmla="*/ 815977 w 1817160"/>
              <a:gd name="connsiteY7" fmla="*/ 263344 h 1524884"/>
              <a:gd name="connsiteX8" fmla="*/ 866775 w 1817160"/>
              <a:gd name="connsiteY8" fmla="*/ 123643 h 1524884"/>
              <a:gd name="connsiteX9" fmla="*/ 923928 w 1817160"/>
              <a:gd name="connsiteY9" fmla="*/ 30510 h 1524884"/>
              <a:gd name="connsiteX10" fmla="*/ 1005529 w 1817160"/>
              <a:gd name="connsiteY10" fmla="*/ 27 h 1524884"/>
              <a:gd name="connsiteX11" fmla="*/ 1086911 w 1817160"/>
              <a:gd name="connsiteY11" fmla="*/ 43210 h 1524884"/>
              <a:gd name="connsiteX12" fmla="*/ 1154644 w 1817160"/>
              <a:gd name="connsiteY12" fmla="*/ 185026 h 1524884"/>
              <a:gd name="connsiteX13" fmla="*/ 1211794 w 1817160"/>
              <a:gd name="connsiteY13" fmla="*/ 396694 h 1524884"/>
              <a:gd name="connsiteX14" fmla="*/ 1387478 w 1817160"/>
              <a:gd name="connsiteY14" fmla="*/ 1141760 h 1524884"/>
              <a:gd name="connsiteX15" fmla="*/ 1453094 w 1817160"/>
              <a:gd name="connsiteY15" fmla="*/ 1414810 h 1524884"/>
              <a:gd name="connsiteX16" fmla="*/ 1495427 w 1817160"/>
              <a:gd name="connsiteY16" fmla="*/ 1503710 h 1524884"/>
              <a:gd name="connsiteX17" fmla="*/ 1622427 w 1817160"/>
              <a:gd name="connsiteY17" fmla="*/ 1524877 h 1524884"/>
              <a:gd name="connsiteX18" fmla="*/ 1817160 w 1817160"/>
              <a:gd name="connsiteY18" fmla="*/ 1516410 h 1524884"/>
              <a:gd name="connsiteX19" fmla="*/ 1817160 w 1817160"/>
              <a:gd name="connsiteY19" fmla="*/ 1516410 h 1524884"/>
              <a:gd name="connsiteX20" fmla="*/ 1817160 w 1817160"/>
              <a:gd name="connsiteY20" fmla="*/ 1516410 h 1524884"/>
              <a:gd name="connsiteX0" fmla="*/ 0 w 1817160"/>
              <a:gd name="connsiteY0" fmla="*/ 1516411 h 1524884"/>
              <a:gd name="connsiteX1" fmla="*/ 174637 w 1817160"/>
              <a:gd name="connsiteY1" fmla="*/ 1502385 h 1524884"/>
              <a:gd name="connsiteX2" fmla="*/ 335760 w 1817160"/>
              <a:gd name="connsiteY2" fmla="*/ 1474078 h 1524884"/>
              <a:gd name="connsiteX3" fmla="*/ 460907 w 1817160"/>
              <a:gd name="connsiteY3" fmla="*/ 1414810 h 1524884"/>
              <a:gd name="connsiteX4" fmla="*/ 547160 w 1817160"/>
              <a:gd name="connsiteY4" fmla="*/ 1253943 h 1524884"/>
              <a:gd name="connsiteX5" fmla="*/ 708027 w 1817160"/>
              <a:gd name="connsiteY5" fmla="*/ 635877 h 1524884"/>
              <a:gd name="connsiteX6" fmla="*/ 763060 w 1817160"/>
              <a:gd name="connsiteY6" fmla="*/ 445377 h 1524884"/>
              <a:gd name="connsiteX7" fmla="*/ 815977 w 1817160"/>
              <a:gd name="connsiteY7" fmla="*/ 263344 h 1524884"/>
              <a:gd name="connsiteX8" fmla="*/ 866775 w 1817160"/>
              <a:gd name="connsiteY8" fmla="*/ 123643 h 1524884"/>
              <a:gd name="connsiteX9" fmla="*/ 923928 w 1817160"/>
              <a:gd name="connsiteY9" fmla="*/ 30510 h 1524884"/>
              <a:gd name="connsiteX10" fmla="*/ 1005529 w 1817160"/>
              <a:gd name="connsiteY10" fmla="*/ 27 h 1524884"/>
              <a:gd name="connsiteX11" fmla="*/ 1086911 w 1817160"/>
              <a:gd name="connsiteY11" fmla="*/ 43210 h 1524884"/>
              <a:gd name="connsiteX12" fmla="*/ 1154644 w 1817160"/>
              <a:gd name="connsiteY12" fmla="*/ 185026 h 1524884"/>
              <a:gd name="connsiteX13" fmla="*/ 1211794 w 1817160"/>
              <a:gd name="connsiteY13" fmla="*/ 396694 h 1524884"/>
              <a:gd name="connsiteX14" fmla="*/ 1387478 w 1817160"/>
              <a:gd name="connsiteY14" fmla="*/ 1141760 h 1524884"/>
              <a:gd name="connsiteX15" fmla="*/ 1453094 w 1817160"/>
              <a:gd name="connsiteY15" fmla="*/ 1414810 h 1524884"/>
              <a:gd name="connsiteX16" fmla="*/ 1495427 w 1817160"/>
              <a:gd name="connsiteY16" fmla="*/ 1503710 h 1524884"/>
              <a:gd name="connsiteX17" fmla="*/ 1622427 w 1817160"/>
              <a:gd name="connsiteY17" fmla="*/ 1524877 h 1524884"/>
              <a:gd name="connsiteX18" fmla="*/ 1817160 w 1817160"/>
              <a:gd name="connsiteY18" fmla="*/ 1516410 h 1524884"/>
              <a:gd name="connsiteX19" fmla="*/ 1817160 w 1817160"/>
              <a:gd name="connsiteY19" fmla="*/ 1516410 h 1524884"/>
              <a:gd name="connsiteX20" fmla="*/ 1817160 w 1817160"/>
              <a:gd name="connsiteY20" fmla="*/ 1516410 h 1524884"/>
              <a:gd name="connsiteX0" fmla="*/ 0 w 1817160"/>
              <a:gd name="connsiteY0" fmla="*/ 1516411 h 1525690"/>
              <a:gd name="connsiteX1" fmla="*/ 174637 w 1817160"/>
              <a:gd name="connsiteY1" fmla="*/ 1502385 h 1525690"/>
              <a:gd name="connsiteX2" fmla="*/ 335760 w 1817160"/>
              <a:gd name="connsiteY2" fmla="*/ 1474078 h 1525690"/>
              <a:gd name="connsiteX3" fmla="*/ 460907 w 1817160"/>
              <a:gd name="connsiteY3" fmla="*/ 1414810 h 1525690"/>
              <a:gd name="connsiteX4" fmla="*/ 547160 w 1817160"/>
              <a:gd name="connsiteY4" fmla="*/ 1253943 h 1525690"/>
              <a:gd name="connsiteX5" fmla="*/ 708027 w 1817160"/>
              <a:gd name="connsiteY5" fmla="*/ 635877 h 1525690"/>
              <a:gd name="connsiteX6" fmla="*/ 763060 w 1817160"/>
              <a:gd name="connsiteY6" fmla="*/ 445377 h 1525690"/>
              <a:gd name="connsiteX7" fmla="*/ 815977 w 1817160"/>
              <a:gd name="connsiteY7" fmla="*/ 263344 h 1525690"/>
              <a:gd name="connsiteX8" fmla="*/ 866775 w 1817160"/>
              <a:gd name="connsiteY8" fmla="*/ 123643 h 1525690"/>
              <a:gd name="connsiteX9" fmla="*/ 923928 w 1817160"/>
              <a:gd name="connsiteY9" fmla="*/ 30510 h 1525690"/>
              <a:gd name="connsiteX10" fmla="*/ 1005529 w 1817160"/>
              <a:gd name="connsiteY10" fmla="*/ 27 h 1525690"/>
              <a:gd name="connsiteX11" fmla="*/ 1086911 w 1817160"/>
              <a:gd name="connsiteY11" fmla="*/ 43210 h 1525690"/>
              <a:gd name="connsiteX12" fmla="*/ 1154644 w 1817160"/>
              <a:gd name="connsiteY12" fmla="*/ 185026 h 1525690"/>
              <a:gd name="connsiteX13" fmla="*/ 1211794 w 1817160"/>
              <a:gd name="connsiteY13" fmla="*/ 396694 h 1525690"/>
              <a:gd name="connsiteX14" fmla="*/ 1387478 w 1817160"/>
              <a:gd name="connsiteY14" fmla="*/ 1141760 h 1525690"/>
              <a:gd name="connsiteX15" fmla="*/ 1453094 w 1817160"/>
              <a:gd name="connsiteY15" fmla="*/ 1414810 h 1525690"/>
              <a:gd name="connsiteX16" fmla="*/ 1504297 w 1817160"/>
              <a:gd name="connsiteY16" fmla="*/ 1494938 h 1525690"/>
              <a:gd name="connsiteX17" fmla="*/ 1622427 w 1817160"/>
              <a:gd name="connsiteY17" fmla="*/ 1524877 h 1525690"/>
              <a:gd name="connsiteX18" fmla="*/ 1817160 w 1817160"/>
              <a:gd name="connsiteY18" fmla="*/ 1516410 h 1525690"/>
              <a:gd name="connsiteX19" fmla="*/ 1817160 w 1817160"/>
              <a:gd name="connsiteY19" fmla="*/ 1516410 h 1525690"/>
              <a:gd name="connsiteX20" fmla="*/ 1817160 w 1817160"/>
              <a:gd name="connsiteY20" fmla="*/ 1516410 h 1525690"/>
              <a:gd name="connsiteX0" fmla="*/ 0 w 1817160"/>
              <a:gd name="connsiteY0" fmla="*/ 1516411 h 1526345"/>
              <a:gd name="connsiteX1" fmla="*/ 174637 w 1817160"/>
              <a:gd name="connsiteY1" fmla="*/ 1502385 h 1526345"/>
              <a:gd name="connsiteX2" fmla="*/ 335760 w 1817160"/>
              <a:gd name="connsiteY2" fmla="*/ 1474078 h 1526345"/>
              <a:gd name="connsiteX3" fmla="*/ 460907 w 1817160"/>
              <a:gd name="connsiteY3" fmla="*/ 1414810 h 1526345"/>
              <a:gd name="connsiteX4" fmla="*/ 547160 w 1817160"/>
              <a:gd name="connsiteY4" fmla="*/ 1253943 h 1526345"/>
              <a:gd name="connsiteX5" fmla="*/ 708027 w 1817160"/>
              <a:gd name="connsiteY5" fmla="*/ 635877 h 1526345"/>
              <a:gd name="connsiteX6" fmla="*/ 763060 w 1817160"/>
              <a:gd name="connsiteY6" fmla="*/ 445377 h 1526345"/>
              <a:gd name="connsiteX7" fmla="*/ 815977 w 1817160"/>
              <a:gd name="connsiteY7" fmla="*/ 263344 h 1526345"/>
              <a:gd name="connsiteX8" fmla="*/ 866775 w 1817160"/>
              <a:gd name="connsiteY8" fmla="*/ 123643 h 1526345"/>
              <a:gd name="connsiteX9" fmla="*/ 923928 w 1817160"/>
              <a:gd name="connsiteY9" fmla="*/ 30510 h 1526345"/>
              <a:gd name="connsiteX10" fmla="*/ 1005529 w 1817160"/>
              <a:gd name="connsiteY10" fmla="*/ 27 h 1526345"/>
              <a:gd name="connsiteX11" fmla="*/ 1086911 w 1817160"/>
              <a:gd name="connsiteY11" fmla="*/ 43210 h 1526345"/>
              <a:gd name="connsiteX12" fmla="*/ 1154644 w 1817160"/>
              <a:gd name="connsiteY12" fmla="*/ 185026 h 1526345"/>
              <a:gd name="connsiteX13" fmla="*/ 1211794 w 1817160"/>
              <a:gd name="connsiteY13" fmla="*/ 396694 h 1526345"/>
              <a:gd name="connsiteX14" fmla="*/ 1387478 w 1817160"/>
              <a:gd name="connsiteY14" fmla="*/ 1141760 h 1526345"/>
              <a:gd name="connsiteX15" fmla="*/ 1453094 w 1817160"/>
              <a:gd name="connsiteY15" fmla="*/ 1414810 h 1526345"/>
              <a:gd name="connsiteX16" fmla="*/ 1510948 w 1817160"/>
              <a:gd name="connsiteY16" fmla="*/ 1483974 h 1526345"/>
              <a:gd name="connsiteX17" fmla="*/ 1622427 w 1817160"/>
              <a:gd name="connsiteY17" fmla="*/ 1524877 h 1526345"/>
              <a:gd name="connsiteX18" fmla="*/ 1817160 w 1817160"/>
              <a:gd name="connsiteY18" fmla="*/ 1516410 h 1526345"/>
              <a:gd name="connsiteX19" fmla="*/ 1817160 w 1817160"/>
              <a:gd name="connsiteY19" fmla="*/ 1516410 h 1526345"/>
              <a:gd name="connsiteX20" fmla="*/ 1817160 w 1817160"/>
              <a:gd name="connsiteY20" fmla="*/ 1516410 h 1526345"/>
              <a:gd name="connsiteX0" fmla="*/ 0 w 1817160"/>
              <a:gd name="connsiteY0" fmla="*/ 1516411 h 1526345"/>
              <a:gd name="connsiteX1" fmla="*/ 174637 w 1817160"/>
              <a:gd name="connsiteY1" fmla="*/ 1502385 h 1526345"/>
              <a:gd name="connsiteX2" fmla="*/ 335760 w 1817160"/>
              <a:gd name="connsiteY2" fmla="*/ 1474078 h 1526345"/>
              <a:gd name="connsiteX3" fmla="*/ 460907 w 1817160"/>
              <a:gd name="connsiteY3" fmla="*/ 1414810 h 1526345"/>
              <a:gd name="connsiteX4" fmla="*/ 547160 w 1817160"/>
              <a:gd name="connsiteY4" fmla="*/ 1253943 h 1526345"/>
              <a:gd name="connsiteX5" fmla="*/ 708027 w 1817160"/>
              <a:gd name="connsiteY5" fmla="*/ 635877 h 1526345"/>
              <a:gd name="connsiteX6" fmla="*/ 763060 w 1817160"/>
              <a:gd name="connsiteY6" fmla="*/ 445377 h 1526345"/>
              <a:gd name="connsiteX7" fmla="*/ 815977 w 1817160"/>
              <a:gd name="connsiteY7" fmla="*/ 263344 h 1526345"/>
              <a:gd name="connsiteX8" fmla="*/ 866775 w 1817160"/>
              <a:gd name="connsiteY8" fmla="*/ 123643 h 1526345"/>
              <a:gd name="connsiteX9" fmla="*/ 923928 w 1817160"/>
              <a:gd name="connsiteY9" fmla="*/ 30510 h 1526345"/>
              <a:gd name="connsiteX10" fmla="*/ 1005529 w 1817160"/>
              <a:gd name="connsiteY10" fmla="*/ 27 h 1526345"/>
              <a:gd name="connsiteX11" fmla="*/ 1086911 w 1817160"/>
              <a:gd name="connsiteY11" fmla="*/ 43210 h 1526345"/>
              <a:gd name="connsiteX12" fmla="*/ 1154644 w 1817160"/>
              <a:gd name="connsiteY12" fmla="*/ 185026 h 1526345"/>
              <a:gd name="connsiteX13" fmla="*/ 1211794 w 1817160"/>
              <a:gd name="connsiteY13" fmla="*/ 396694 h 1526345"/>
              <a:gd name="connsiteX14" fmla="*/ 1387478 w 1817160"/>
              <a:gd name="connsiteY14" fmla="*/ 1141760 h 1526345"/>
              <a:gd name="connsiteX15" fmla="*/ 1453094 w 1817160"/>
              <a:gd name="connsiteY15" fmla="*/ 1414810 h 1526345"/>
              <a:gd name="connsiteX16" fmla="*/ 1510948 w 1817160"/>
              <a:gd name="connsiteY16" fmla="*/ 1483974 h 1526345"/>
              <a:gd name="connsiteX17" fmla="*/ 1622427 w 1817160"/>
              <a:gd name="connsiteY17" fmla="*/ 1524877 h 1526345"/>
              <a:gd name="connsiteX18" fmla="*/ 1817160 w 1817160"/>
              <a:gd name="connsiteY18" fmla="*/ 1516410 h 1526345"/>
              <a:gd name="connsiteX19" fmla="*/ 1817160 w 1817160"/>
              <a:gd name="connsiteY19" fmla="*/ 1516410 h 1526345"/>
              <a:gd name="connsiteX20" fmla="*/ 1817160 w 1817160"/>
              <a:gd name="connsiteY20" fmla="*/ 1516410 h 1526345"/>
              <a:gd name="connsiteX0" fmla="*/ 0 w 1817160"/>
              <a:gd name="connsiteY0" fmla="*/ 1516411 h 1526345"/>
              <a:gd name="connsiteX1" fmla="*/ 174637 w 1817160"/>
              <a:gd name="connsiteY1" fmla="*/ 1502385 h 1526345"/>
              <a:gd name="connsiteX2" fmla="*/ 335760 w 1817160"/>
              <a:gd name="connsiteY2" fmla="*/ 1474078 h 1526345"/>
              <a:gd name="connsiteX3" fmla="*/ 460907 w 1817160"/>
              <a:gd name="connsiteY3" fmla="*/ 1414810 h 1526345"/>
              <a:gd name="connsiteX4" fmla="*/ 547160 w 1817160"/>
              <a:gd name="connsiteY4" fmla="*/ 1253943 h 1526345"/>
              <a:gd name="connsiteX5" fmla="*/ 708027 w 1817160"/>
              <a:gd name="connsiteY5" fmla="*/ 635877 h 1526345"/>
              <a:gd name="connsiteX6" fmla="*/ 763060 w 1817160"/>
              <a:gd name="connsiteY6" fmla="*/ 445377 h 1526345"/>
              <a:gd name="connsiteX7" fmla="*/ 815977 w 1817160"/>
              <a:gd name="connsiteY7" fmla="*/ 263344 h 1526345"/>
              <a:gd name="connsiteX8" fmla="*/ 866775 w 1817160"/>
              <a:gd name="connsiteY8" fmla="*/ 123643 h 1526345"/>
              <a:gd name="connsiteX9" fmla="*/ 923928 w 1817160"/>
              <a:gd name="connsiteY9" fmla="*/ 30510 h 1526345"/>
              <a:gd name="connsiteX10" fmla="*/ 1005529 w 1817160"/>
              <a:gd name="connsiteY10" fmla="*/ 27 h 1526345"/>
              <a:gd name="connsiteX11" fmla="*/ 1086911 w 1817160"/>
              <a:gd name="connsiteY11" fmla="*/ 43210 h 1526345"/>
              <a:gd name="connsiteX12" fmla="*/ 1154644 w 1817160"/>
              <a:gd name="connsiteY12" fmla="*/ 185026 h 1526345"/>
              <a:gd name="connsiteX13" fmla="*/ 1211794 w 1817160"/>
              <a:gd name="connsiteY13" fmla="*/ 396694 h 1526345"/>
              <a:gd name="connsiteX14" fmla="*/ 1387478 w 1817160"/>
              <a:gd name="connsiteY14" fmla="*/ 1141760 h 1526345"/>
              <a:gd name="connsiteX15" fmla="*/ 1453094 w 1817160"/>
              <a:gd name="connsiteY15" fmla="*/ 1414810 h 1526345"/>
              <a:gd name="connsiteX16" fmla="*/ 1510948 w 1817160"/>
              <a:gd name="connsiteY16" fmla="*/ 1483974 h 1526345"/>
              <a:gd name="connsiteX17" fmla="*/ 1622427 w 1817160"/>
              <a:gd name="connsiteY17" fmla="*/ 1524877 h 1526345"/>
              <a:gd name="connsiteX18" fmla="*/ 1817160 w 1817160"/>
              <a:gd name="connsiteY18" fmla="*/ 1516410 h 1526345"/>
              <a:gd name="connsiteX19" fmla="*/ 1817160 w 1817160"/>
              <a:gd name="connsiteY19" fmla="*/ 1516410 h 1526345"/>
              <a:gd name="connsiteX20" fmla="*/ 1817160 w 1817160"/>
              <a:gd name="connsiteY20" fmla="*/ 1516410 h 1526345"/>
              <a:gd name="connsiteX0" fmla="*/ 0 w 1817160"/>
              <a:gd name="connsiteY0" fmla="*/ 1516411 h 1526345"/>
              <a:gd name="connsiteX1" fmla="*/ 174637 w 1817160"/>
              <a:gd name="connsiteY1" fmla="*/ 1502385 h 1526345"/>
              <a:gd name="connsiteX2" fmla="*/ 335760 w 1817160"/>
              <a:gd name="connsiteY2" fmla="*/ 1474078 h 1526345"/>
              <a:gd name="connsiteX3" fmla="*/ 460907 w 1817160"/>
              <a:gd name="connsiteY3" fmla="*/ 1414810 h 1526345"/>
              <a:gd name="connsiteX4" fmla="*/ 547160 w 1817160"/>
              <a:gd name="connsiteY4" fmla="*/ 1253943 h 1526345"/>
              <a:gd name="connsiteX5" fmla="*/ 708027 w 1817160"/>
              <a:gd name="connsiteY5" fmla="*/ 635877 h 1526345"/>
              <a:gd name="connsiteX6" fmla="*/ 763060 w 1817160"/>
              <a:gd name="connsiteY6" fmla="*/ 445377 h 1526345"/>
              <a:gd name="connsiteX7" fmla="*/ 815977 w 1817160"/>
              <a:gd name="connsiteY7" fmla="*/ 263344 h 1526345"/>
              <a:gd name="connsiteX8" fmla="*/ 866775 w 1817160"/>
              <a:gd name="connsiteY8" fmla="*/ 123643 h 1526345"/>
              <a:gd name="connsiteX9" fmla="*/ 923928 w 1817160"/>
              <a:gd name="connsiteY9" fmla="*/ 30510 h 1526345"/>
              <a:gd name="connsiteX10" fmla="*/ 1005529 w 1817160"/>
              <a:gd name="connsiteY10" fmla="*/ 27 h 1526345"/>
              <a:gd name="connsiteX11" fmla="*/ 1086911 w 1817160"/>
              <a:gd name="connsiteY11" fmla="*/ 43210 h 1526345"/>
              <a:gd name="connsiteX12" fmla="*/ 1154644 w 1817160"/>
              <a:gd name="connsiteY12" fmla="*/ 185026 h 1526345"/>
              <a:gd name="connsiteX13" fmla="*/ 1211794 w 1817160"/>
              <a:gd name="connsiteY13" fmla="*/ 396694 h 1526345"/>
              <a:gd name="connsiteX14" fmla="*/ 1387478 w 1817160"/>
              <a:gd name="connsiteY14" fmla="*/ 1141760 h 1526345"/>
              <a:gd name="connsiteX15" fmla="*/ 1442007 w 1817160"/>
              <a:gd name="connsiteY15" fmla="*/ 1373147 h 1526345"/>
              <a:gd name="connsiteX16" fmla="*/ 1510948 w 1817160"/>
              <a:gd name="connsiteY16" fmla="*/ 1483974 h 1526345"/>
              <a:gd name="connsiteX17" fmla="*/ 1622427 w 1817160"/>
              <a:gd name="connsiteY17" fmla="*/ 1524877 h 1526345"/>
              <a:gd name="connsiteX18" fmla="*/ 1817160 w 1817160"/>
              <a:gd name="connsiteY18" fmla="*/ 1516410 h 1526345"/>
              <a:gd name="connsiteX19" fmla="*/ 1817160 w 1817160"/>
              <a:gd name="connsiteY19" fmla="*/ 1516410 h 1526345"/>
              <a:gd name="connsiteX20" fmla="*/ 1817160 w 1817160"/>
              <a:gd name="connsiteY20" fmla="*/ 1516410 h 1526345"/>
              <a:gd name="connsiteX0" fmla="*/ 0 w 1832682"/>
              <a:gd name="connsiteY0" fmla="*/ 1516411 h 1529567"/>
              <a:gd name="connsiteX1" fmla="*/ 174637 w 1832682"/>
              <a:gd name="connsiteY1" fmla="*/ 1502385 h 1529567"/>
              <a:gd name="connsiteX2" fmla="*/ 335760 w 1832682"/>
              <a:gd name="connsiteY2" fmla="*/ 1474078 h 1529567"/>
              <a:gd name="connsiteX3" fmla="*/ 460907 w 1832682"/>
              <a:gd name="connsiteY3" fmla="*/ 1414810 h 1529567"/>
              <a:gd name="connsiteX4" fmla="*/ 547160 w 1832682"/>
              <a:gd name="connsiteY4" fmla="*/ 1253943 h 1529567"/>
              <a:gd name="connsiteX5" fmla="*/ 708027 w 1832682"/>
              <a:gd name="connsiteY5" fmla="*/ 635877 h 1529567"/>
              <a:gd name="connsiteX6" fmla="*/ 763060 w 1832682"/>
              <a:gd name="connsiteY6" fmla="*/ 445377 h 1529567"/>
              <a:gd name="connsiteX7" fmla="*/ 815977 w 1832682"/>
              <a:gd name="connsiteY7" fmla="*/ 263344 h 1529567"/>
              <a:gd name="connsiteX8" fmla="*/ 866775 w 1832682"/>
              <a:gd name="connsiteY8" fmla="*/ 123643 h 1529567"/>
              <a:gd name="connsiteX9" fmla="*/ 923928 w 1832682"/>
              <a:gd name="connsiteY9" fmla="*/ 30510 h 1529567"/>
              <a:gd name="connsiteX10" fmla="*/ 1005529 w 1832682"/>
              <a:gd name="connsiteY10" fmla="*/ 27 h 1529567"/>
              <a:gd name="connsiteX11" fmla="*/ 1086911 w 1832682"/>
              <a:gd name="connsiteY11" fmla="*/ 43210 h 1529567"/>
              <a:gd name="connsiteX12" fmla="*/ 1154644 w 1832682"/>
              <a:gd name="connsiteY12" fmla="*/ 185026 h 1529567"/>
              <a:gd name="connsiteX13" fmla="*/ 1211794 w 1832682"/>
              <a:gd name="connsiteY13" fmla="*/ 396694 h 1529567"/>
              <a:gd name="connsiteX14" fmla="*/ 1387478 w 1832682"/>
              <a:gd name="connsiteY14" fmla="*/ 1141760 h 1529567"/>
              <a:gd name="connsiteX15" fmla="*/ 1442007 w 1832682"/>
              <a:gd name="connsiteY15" fmla="*/ 1373147 h 1529567"/>
              <a:gd name="connsiteX16" fmla="*/ 1510948 w 1832682"/>
              <a:gd name="connsiteY16" fmla="*/ 1483974 h 1529567"/>
              <a:gd name="connsiteX17" fmla="*/ 1622427 w 1832682"/>
              <a:gd name="connsiteY17" fmla="*/ 1524877 h 1529567"/>
              <a:gd name="connsiteX18" fmla="*/ 1817160 w 1832682"/>
              <a:gd name="connsiteY18" fmla="*/ 1516410 h 1529567"/>
              <a:gd name="connsiteX19" fmla="*/ 1817160 w 1832682"/>
              <a:gd name="connsiteY19" fmla="*/ 1516410 h 1529567"/>
              <a:gd name="connsiteX20" fmla="*/ 1832682 w 1832682"/>
              <a:gd name="connsiteY20" fmla="*/ 1529567 h 1529567"/>
              <a:gd name="connsiteX0" fmla="*/ 0 w 1817160"/>
              <a:gd name="connsiteY0" fmla="*/ 1516411 h 1529567"/>
              <a:gd name="connsiteX1" fmla="*/ 174637 w 1817160"/>
              <a:gd name="connsiteY1" fmla="*/ 1502385 h 1529567"/>
              <a:gd name="connsiteX2" fmla="*/ 335760 w 1817160"/>
              <a:gd name="connsiteY2" fmla="*/ 1474078 h 1529567"/>
              <a:gd name="connsiteX3" fmla="*/ 460907 w 1817160"/>
              <a:gd name="connsiteY3" fmla="*/ 1414810 h 1529567"/>
              <a:gd name="connsiteX4" fmla="*/ 547160 w 1817160"/>
              <a:gd name="connsiteY4" fmla="*/ 1253943 h 1529567"/>
              <a:gd name="connsiteX5" fmla="*/ 708027 w 1817160"/>
              <a:gd name="connsiteY5" fmla="*/ 635877 h 1529567"/>
              <a:gd name="connsiteX6" fmla="*/ 763060 w 1817160"/>
              <a:gd name="connsiteY6" fmla="*/ 445377 h 1529567"/>
              <a:gd name="connsiteX7" fmla="*/ 815977 w 1817160"/>
              <a:gd name="connsiteY7" fmla="*/ 263344 h 1529567"/>
              <a:gd name="connsiteX8" fmla="*/ 866775 w 1817160"/>
              <a:gd name="connsiteY8" fmla="*/ 123643 h 1529567"/>
              <a:gd name="connsiteX9" fmla="*/ 923928 w 1817160"/>
              <a:gd name="connsiteY9" fmla="*/ 30510 h 1529567"/>
              <a:gd name="connsiteX10" fmla="*/ 1005529 w 1817160"/>
              <a:gd name="connsiteY10" fmla="*/ 27 h 1529567"/>
              <a:gd name="connsiteX11" fmla="*/ 1086911 w 1817160"/>
              <a:gd name="connsiteY11" fmla="*/ 43210 h 1529567"/>
              <a:gd name="connsiteX12" fmla="*/ 1154644 w 1817160"/>
              <a:gd name="connsiteY12" fmla="*/ 185026 h 1529567"/>
              <a:gd name="connsiteX13" fmla="*/ 1211794 w 1817160"/>
              <a:gd name="connsiteY13" fmla="*/ 396694 h 1529567"/>
              <a:gd name="connsiteX14" fmla="*/ 1387478 w 1817160"/>
              <a:gd name="connsiteY14" fmla="*/ 1141760 h 1529567"/>
              <a:gd name="connsiteX15" fmla="*/ 1442007 w 1817160"/>
              <a:gd name="connsiteY15" fmla="*/ 1373147 h 1529567"/>
              <a:gd name="connsiteX16" fmla="*/ 1510948 w 1817160"/>
              <a:gd name="connsiteY16" fmla="*/ 1483974 h 1529567"/>
              <a:gd name="connsiteX17" fmla="*/ 1622427 w 1817160"/>
              <a:gd name="connsiteY17" fmla="*/ 1524877 h 1529567"/>
              <a:gd name="connsiteX18" fmla="*/ 1817160 w 1817160"/>
              <a:gd name="connsiteY18" fmla="*/ 1516410 h 1529567"/>
              <a:gd name="connsiteX19" fmla="*/ 1817160 w 1817160"/>
              <a:gd name="connsiteY19" fmla="*/ 1516410 h 1529567"/>
              <a:gd name="connsiteX20" fmla="*/ 1781684 w 1817160"/>
              <a:gd name="connsiteY20" fmla="*/ 1529567 h 1529567"/>
              <a:gd name="connsiteX0" fmla="*/ 0 w 1865942"/>
              <a:gd name="connsiteY0" fmla="*/ 1516411 h 1654557"/>
              <a:gd name="connsiteX1" fmla="*/ 174637 w 1865942"/>
              <a:gd name="connsiteY1" fmla="*/ 1502385 h 1654557"/>
              <a:gd name="connsiteX2" fmla="*/ 335760 w 1865942"/>
              <a:gd name="connsiteY2" fmla="*/ 1474078 h 1654557"/>
              <a:gd name="connsiteX3" fmla="*/ 460907 w 1865942"/>
              <a:gd name="connsiteY3" fmla="*/ 1414810 h 1654557"/>
              <a:gd name="connsiteX4" fmla="*/ 547160 w 1865942"/>
              <a:gd name="connsiteY4" fmla="*/ 1253943 h 1654557"/>
              <a:gd name="connsiteX5" fmla="*/ 708027 w 1865942"/>
              <a:gd name="connsiteY5" fmla="*/ 635877 h 1654557"/>
              <a:gd name="connsiteX6" fmla="*/ 763060 w 1865942"/>
              <a:gd name="connsiteY6" fmla="*/ 445377 h 1654557"/>
              <a:gd name="connsiteX7" fmla="*/ 815977 w 1865942"/>
              <a:gd name="connsiteY7" fmla="*/ 263344 h 1654557"/>
              <a:gd name="connsiteX8" fmla="*/ 866775 w 1865942"/>
              <a:gd name="connsiteY8" fmla="*/ 123643 h 1654557"/>
              <a:gd name="connsiteX9" fmla="*/ 923928 w 1865942"/>
              <a:gd name="connsiteY9" fmla="*/ 30510 h 1654557"/>
              <a:gd name="connsiteX10" fmla="*/ 1005529 w 1865942"/>
              <a:gd name="connsiteY10" fmla="*/ 27 h 1654557"/>
              <a:gd name="connsiteX11" fmla="*/ 1086911 w 1865942"/>
              <a:gd name="connsiteY11" fmla="*/ 43210 h 1654557"/>
              <a:gd name="connsiteX12" fmla="*/ 1154644 w 1865942"/>
              <a:gd name="connsiteY12" fmla="*/ 185026 h 1654557"/>
              <a:gd name="connsiteX13" fmla="*/ 1211794 w 1865942"/>
              <a:gd name="connsiteY13" fmla="*/ 396694 h 1654557"/>
              <a:gd name="connsiteX14" fmla="*/ 1387478 w 1865942"/>
              <a:gd name="connsiteY14" fmla="*/ 1141760 h 1654557"/>
              <a:gd name="connsiteX15" fmla="*/ 1442007 w 1865942"/>
              <a:gd name="connsiteY15" fmla="*/ 1373147 h 1654557"/>
              <a:gd name="connsiteX16" fmla="*/ 1510948 w 1865942"/>
              <a:gd name="connsiteY16" fmla="*/ 1483974 h 1654557"/>
              <a:gd name="connsiteX17" fmla="*/ 1622427 w 1865942"/>
              <a:gd name="connsiteY17" fmla="*/ 1524877 h 1654557"/>
              <a:gd name="connsiteX18" fmla="*/ 1817160 w 1865942"/>
              <a:gd name="connsiteY18" fmla="*/ 1516410 h 1654557"/>
              <a:gd name="connsiteX19" fmla="*/ 1817160 w 1865942"/>
              <a:gd name="connsiteY19" fmla="*/ 1516410 h 1654557"/>
              <a:gd name="connsiteX20" fmla="*/ 1865942 w 1865942"/>
              <a:gd name="connsiteY20" fmla="*/ 1654557 h 1654557"/>
              <a:gd name="connsiteX0" fmla="*/ 0 w 1865942"/>
              <a:gd name="connsiteY0" fmla="*/ 1516411 h 1654557"/>
              <a:gd name="connsiteX1" fmla="*/ 174637 w 1865942"/>
              <a:gd name="connsiteY1" fmla="*/ 1502385 h 1654557"/>
              <a:gd name="connsiteX2" fmla="*/ 335760 w 1865942"/>
              <a:gd name="connsiteY2" fmla="*/ 1474078 h 1654557"/>
              <a:gd name="connsiteX3" fmla="*/ 460907 w 1865942"/>
              <a:gd name="connsiteY3" fmla="*/ 1414810 h 1654557"/>
              <a:gd name="connsiteX4" fmla="*/ 547160 w 1865942"/>
              <a:gd name="connsiteY4" fmla="*/ 1253943 h 1654557"/>
              <a:gd name="connsiteX5" fmla="*/ 708027 w 1865942"/>
              <a:gd name="connsiteY5" fmla="*/ 635877 h 1654557"/>
              <a:gd name="connsiteX6" fmla="*/ 763060 w 1865942"/>
              <a:gd name="connsiteY6" fmla="*/ 445377 h 1654557"/>
              <a:gd name="connsiteX7" fmla="*/ 815977 w 1865942"/>
              <a:gd name="connsiteY7" fmla="*/ 263344 h 1654557"/>
              <a:gd name="connsiteX8" fmla="*/ 866775 w 1865942"/>
              <a:gd name="connsiteY8" fmla="*/ 123643 h 1654557"/>
              <a:gd name="connsiteX9" fmla="*/ 923928 w 1865942"/>
              <a:gd name="connsiteY9" fmla="*/ 30510 h 1654557"/>
              <a:gd name="connsiteX10" fmla="*/ 1005529 w 1865942"/>
              <a:gd name="connsiteY10" fmla="*/ 27 h 1654557"/>
              <a:gd name="connsiteX11" fmla="*/ 1086911 w 1865942"/>
              <a:gd name="connsiteY11" fmla="*/ 43210 h 1654557"/>
              <a:gd name="connsiteX12" fmla="*/ 1154644 w 1865942"/>
              <a:gd name="connsiteY12" fmla="*/ 185026 h 1654557"/>
              <a:gd name="connsiteX13" fmla="*/ 1211794 w 1865942"/>
              <a:gd name="connsiteY13" fmla="*/ 396694 h 1654557"/>
              <a:gd name="connsiteX14" fmla="*/ 1387478 w 1865942"/>
              <a:gd name="connsiteY14" fmla="*/ 1141760 h 1654557"/>
              <a:gd name="connsiteX15" fmla="*/ 1442007 w 1865942"/>
              <a:gd name="connsiteY15" fmla="*/ 1373147 h 1654557"/>
              <a:gd name="connsiteX16" fmla="*/ 1510948 w 1865942"/>
              <a:gd name="connsiteY16" fmla="*/ 1483974 h 1654557"/>
              <a:gd name="connsiteX17" fmla="*/ 1622427 w 1865942"/>
              <a:gd name="connsiteY17" fmla="*/ 1524877 h 1654557"/>
              <a:gd name="connsiteX18" fmla="*/ 1817160 w 1865942"/>
              <a:gd name="connsiteY18" fmla="*/ 1516410 h 1654557"/>
              <a:gd name="connsiteX19" fmla="*/ 1814942 w 1865942"/>
              <a:gd name="connsiteY19" fmla="*/ 1522989 h 1654557"/>
              <a:gd name="connsiteX20" fmla="*/ 1865942 w 1865942"/>
              <a:gd name="connsiteY20" fmla="*/ 1654557 h 1654557"/>
              <a:gd name="connsiteX0" fmla="*/ 0 w 1865942"/>
              <a:gd name="connsiteY0" fmla="*/ 1516411 h 1654557"/>
              <a:gd name="connsiteX1" fmla="*/ 174637 w 1865942"/>
              <a:gd name="connsiteY1" fmla="*/ 1502385 h 1654557"/>
              <a:gd name="connsiteX2" fmla="*/ 335760 w 1865942"/>
              <a:gd name="connsiteY2" fmla="*/ 1474078 h 1654557"/>
              <a:gd name="connsiteX3" fmla="*/ 460907 w 1865942"/>
              <a:gd name="connsiteY3" fmla="*/ 1414810 h 1654557"/>
              <a:gd name="connsiteX4" fmla="*/ 547160 w 1865942"/>
              <a:gd name="connsiteY4" fmla="*/ 1253943 h 1654557"/>
              <a:gd name="connsiteX5" fmla="*/ 708027 w 1865942"/>
              <a:gd name="connsiteY5" fmla="*/ 635877 h 1654557"/>
              <a:gd name="connsiteX6" fmla="*/ 763060 w 1865942"/>
              <a:gd name="connsiteY6" fmla="*/ 445377 h 1654557"/>
              <a:gd name="connsiteX7" fmla="*/ 815977 w 1865942"/>
              <a:gd name="connsiteY7" fmla="*/ 263344 h 1654557"/>
              <a:gd name="connsiteX8" fmla="*/ 866775 w 1865942"/>
              <a:gd name="connsiteY8" fmla="*/ 123643 h 1654557"/>
              <a:gd name="connsiteX9" fmla="*/ 923928 w 1865942"/>
              <a:gd name="connsiteY9" fmla="*/ 30510 h 1654557"/>
              <a:gd name="connsiteX10" fmla="*/ 1005529 w 1865942"/>
              <a:gd name="connsiteY10" fmla="*/ 27 h 1654557"/>
              <a:gd name="connsiteX11" fmla="*/ 1086911 w 1865942"/>
              <a:gd name="connsiteY11" fmla="*/ 43210 h 1654557"/>
              <a:gd name="connsiteX12" fmla="*/ 1154644 w 1865942"/>
              <a:gd name="connsiteY12" fmla="*/ 185026 h 1654557"/>
              <a:gd name="connsiteX13" fmla="*/ 1211794 w 1865942"/>
              <a:gd name="connsiteY13" fmla="*/ 396694 h 1654557"/>
              <a:gd name="connsiteX14" fmla="*/ 1387478 w 1865942"/>
              <a:gd name="connsiteY14" fmla="*/ 1141760 h 1654557"/>
              <a:gd name="connsiteX15" fmla="*/ 1442007 w 1865942"/>
              <a:gd name="connsiteY15" fmla="*/ 1373147 h 1654557"/>
              <a:gd name="connsiteX16" fmla="*/ 1510948 w 1865942"/>
              <a:gd name="connsiteY16" fmla="*/ 1483974 h 1654557"/>
              <a:gd name="connsiteX17" fmla="*/ 1622427 w 1865942"/>
              <a:gd name="connsiteY17" fmla="*/ 1524877 h 1654557"/>
              <a:gd name="connsiteX18" fmla="*/ 1817160 w 1865942"/>
              <a:gd name="connsiteY18" fmla="*/ 1516410 h 1654557"/>
              <a:gd name="connsiteX19" fmla="*/ 1865942 w 1865942"/>
              <a:gd name="connsiteY19" fmla="*/ 1654557 h 1654557"/>
              <a:gd name="connsiteX0" fmla="*/ 0 w 1865942"/>
              <a:gd name="connsiteY0" fmla="*/ 1516411 h 1654557"/>
              <a:gd name="connsiteX1" fmla="*/ 174637 w 1865942"/>
              <a:gd name="connsiteY1" fmla="*/ 1502385 h 1654557"/>
              <a:gd name="connsiteX2" fmla="*/ 335760 w 1865942"/>
              <a:gd name="connsiteY2" fmla="*/ 1474078 h 1654557"/>
              <a:gd name="connsiteX3" fmla="*/ 460907 w 1865942"/>
              <a:gd name="connsiteY3" fmla="*/ 1414810 h 1654557"/>
              <a:gd name="connsiteX4" fmla="*/ 547160 w 1865942"/>
              <a:gd name="connsiteY4" fmla="*/ 1253943 h 1654557"/>
              <a:gd name="connsiteX5" fmla="*/ 708027 w 1865942"/>
              <a:gd name="connsiteY5" fmla="*/ 635877 h 1654557"/>
              <a:gd name="connsiteX6" fmla="*/ 763060 w 1865942"/>
              <a:gd name="connsiteY6" fmla="*/ 445377 h 1654557"/>
              <a:gd name="connsiteX7" fmla="*/ 815977 w 1865942"/>
              <a:gd name="connsiteY7" fmla="*/ 263344 h 1654557"/>
              <a:gd name="connsiteX8" fmla="*/ 866775 w 1865942"/>
              <a:gd name="connsiteY8" fmla="*/ 123643 h 1654557"/>
              <a:gd name="connsiteX9" fmla="*/ 923928 w 1865942"/>
              <a:gd name="connsiteY9" fmla="*/ 30510 h 1654557"/>
              <a:gd name="connsiteX10" fmla="*/ 1005529 w 1865942"/>
              <a:gd name="connsiteY10" fmla="*/ 27 h 1654557"/>
              <a:gd name="connsiteX11" fmla="*/ 1086911 w 1865942"/>
              <a:gd name="connsiteY11" fmla="*/ 43210 h 1654557"/>
              <a:gd name="connsiteX12" fmla="*/ 1154644 w 1865942"/>
              <a:gd name="connsiteY12" fmla="*/ 185026 h 1654557"/>
              <a:gd name="connsiteX13" fmla="*/ 1211794 w 1865942"/>
              <a:gd name="connsiteY13" fmla="*/ 396694 h 1654557"/>
              <a:gd name="connsiteX14" fmla="*/ 1387478 w 1865942"/>
              <a:gd name="connsiteY14" fmla="*/ 1141760 h 1654557"/>
              <a:gd name="connsiteX15" fmla="*/ 1442007 w 1865942"/>
              <a:gd name="connsiteY15" fmla="*/ 1373147 h 1654557"/>
              <a:gd name="connsiteX16" fmla="*/ 1510948 w 1865942"/>
              <a:gd name="connsiteY16" fmla="*/ 1483974 h 1654557"/>
              <a:gd name="connsiteX17" fmla="*/ 1622427 w 1865942"/>
              <a:gd name="connsiteY17" fmla="*/ 1524877 h 1654557"/>
              <a:gd name="connsiteX18" fmla="*/ 1748423 w 1865942"/>
              <a:gd name="connsiteY18" fmla="*/ 1520796 h 1654557"/>
              <a:gd name="connsiteX19" fmla="*/ 1865942 w 1865942"/>
              <a:gd name="connsiteY19" fmla="*/ 1654557 h 1654557"/>
              <a:gd name="connsiteX0" fmla="*/ 0 w 1896984"/>
              <a:gd name="connsiteY0" fmla="*/ 1516411 h 1547110"/>
              <a:gd name="connsiteX1" fmla="*/ 174637 w 1896984"/>
              <a:gd name="connsiteY1" fmla="*/ 1502385 h 1547110"/>
              <a:gd name="connsiteX2" fmla="*/ 335760 w 1896984"/>
              <a:gd name="connsiteY2" fmla="*/ 1474078 h 1547110"/>
              <a:gd name="connsiteX3" fmla="*/ 460907 w 1896984"/>
              <a:gd name="connsiteY3" fmla="*/ 1414810 h 1547110"/>
              <a:gd name="connsiteX4" fmla="*/ 547160 w 1896984"/>
              <a:gd name="connsiteY4" fmla="*/ 1253943 h 1547110"/>
              <a:gd name="connsiteX5" fmla="*/ 708027 w 1896984"/>
              <a:gd name="connsiteY5" fmla="*/ 635877 h 1547110"/>
              <a:gd name="connsiteX6" fmla="*/ 763060 w 1896984"/>
              <a:gd name="connsiteY6" fmla="*/ 445377 h 1547110"/>
              <a:gd name="connsiteX7" fmla="*/ 815977 w 1896984"/>
              <a:gd name="connsiteY7" fmla="*/ 263344 h 1547110"/>
              <a:gd name="connsiteX8" fmla="*/ 866775 w 1896984"/>
              <a:gd name="connsiteY8" fmla="*/ 123643 h 1547110"/>
              <a:gd name="connsiteX9" fmla="*/ 923928 w 1896984"/>
              <a:gd name="connsiteY9" fmla="*/ 30510 h 1547110"/>
              <a:gd name="connsiteX10" fmla="*/ 1005529 w 1896984"/>
              <a:gd name="connsiteY10" fmla="*/ 27 h 1547110"/>
              <a:gd name="connsiteX11" fmla="*/ 1086911 w 1896984"/>
              <a:gd name="connsiteY11" fmla="*/ 43210 h 1547110"/>
              <a:gd name="connsiteX12" fmla="*/ 1154644 w 1896984"/>
              <a:gd name="connsiteY12" fmla="*/ 185026 h 1547110"/>
              <a:gd name="connsiteX13" fmla="*/ 1211794 w 1896984"/>
              <a:gd name="connsiteY13" fmla="*/ 396694 h 1547110"/>
              <a:gd name="connsiteX14" fmla="*/ 1387478 w 1896984"/>
              <a:gd name="connsiteY14" fmla="*/ 1141760 h 1547110"/>
              <a:gd name="connsiteX15" fmla="*/ 1442007 w 1896984"/>
              <a:gd name="connsiteY15" fmla="*/ 1373147 h 1547110"/>
              <a:gd name="connsiteX16" fmla="*/ 1510948 w 1896984"/>
              <a:gd name="connsiteY16" fmla="*/ 1483974 h 1547110"/>
              <a:gd name="connsiteX17" fmla="*/ 1622427 w 1896984"/>
              <a:gd name="connsiteY17" fmla="*/ 1524877 h 1547110"/>
              <a:gd name="connsiteX18" fmla="*/ 1748423 w 1896984"/>
              <a:gd name="connsiteY18" fmla="*/ 1520796 h 1547110"/>
              <a:gd name="connsiteX19" fmla="*/ 1896984 w 1896984"/>
              <a:gd name="connsiteY19" fmla="*/ 1547110 h 1547110"/>
              <a:gd name="connsiteX0" fmla="*/ 0 w 1896984"/>
              <a:gd name="connsiteY0" fmla="*/ 1516411 h 1547110"/>
              <a:gd name="connsiteX1" fmla="*/ 174637 w 1896984"/>
              <a:gd name="connsiteY1" fmla="*/ 1502385 h 1547110"/>
              <a:gd name="connsiteX2" fmla="*/ 335760 w 1896984"/>
              <a:gd name="connsiteY2" fmla="*/ 1474078 h 1547110"/>
              <a:gd name="connsiteX3" fmla="*/ 460907 w 1896984"/>
              <a:gd name="connsiteY3" fmla="*/ 1414810 h 1547110"/>
              <a:gd name="connsiteX4" fmla="*/ 547160 w 1896984"/>
              <a:gd name="connsiteY4" fmla="*/ 1253943 h 1547110"/>
              <a:gd name="connsiteX5" fmla="*/ 708027 w 1896984"/>
              <a:gd name="connsiteY5" fmla="*/ 635877 h 1547110"/>
              <a:gd name="connsiteX6" fmla="*/ 763060 w 1896984"/>
              <a:gd name="connsiteY6" fmla="*/ 445377 h 1547110"/>
              <a:gd name="connsiteX7" fmla="*/ 815977 w 1896984"/>
              <a:gd name="connsiteY7" fmla="*/ 263344 h 1547110"/>
              <a:gd name="connsiteX8" fmla="*/ 866775 w 1896984"/>
              <a:gd name="connsiteY8" fmla="*/ 123643 h 1547110"/>
              <a:gd name="connsiteX9" fmla="*/ 923928 w 1896984"/>
              <a:gd name="connsiteY9" fmla="*/ 30510 h 1547110"/>
              <a:gd name="connsiteX10" fmla="*/ 1005529 w 1896984"/>
              <a:gd name="connsiteY10" fmla="*/ 27 h 1547110"/>
              <a:gd name="connsiteX11" fmla="*/ 1086911 w 1896984"/>
              <a:gd name="connsiteY11" fmla="*/ 43210 h 1547110"/>
              <a:gd name="connsiteX12" fmla="*/ 1154644 w 1896984"/>
              <a:gd name="connsiteY12" fmla="*/ 185026 h 1547110"/>
              <a:gd name="connsiteX13" fmla="*/ 1211794 w 1896984"/>
              <a:gd name="connsiteY13" fmla="*/ 396694 h 1547110"/>
              <a:gd name="connsiteX14" fmla="*/ 1387478 w 1896984"/>
              <a:gd name="connsiteY14" fmla="*/ 1141760 h 1547110"/>
              <a:gd name="connsiteX15" fmla="*/ 1442007 w 1896984"/>
              <a:gd name="connsiteY15" fmla="*/ 1373147 h 1547110"/>
              <a:gd name="connsiteX16" fmla="*/ 1510948 w 1896984"/>
              <a:gd name="connsiteY16" fmla="*/ 1483974 h 1547110"/>
              <a:gd name="connsiteX17" fmla="*/ 1622427 w 1896984"/>
              <a:gd name="connsiteY17" fmla="*/ 1524877 h 1547110"/>
              <a:gd name="connsiteX18" fmla="*/ 1757292 w 1896984"/>
              <a:gd name="connsiteY18" fmla="*/ 1529567 h 1547110"/>
              <a:gd name="connsiteX19" fmla="*/ 1896984 w 1896984"/>
              <a:gd name="connsiteY19" fmla="*/ 1547110 h 1547110"/>
              <a:gd name="connsiteX0" fmla="*/ 0 w 1896984"/>
              <a:gd name="connsiteY0" fmla="*/ 1516411 h 1538339"/>
              <a:gd name="connsiteX1" fmla="*/ 174637 w 1896984"/>
              <a:gd name="connsiteY1" fmla="*/ 1502385 h 1538339"/>
              <a:gd name="connsiteX2" fmla="*/ 335760 w 1896984"/>
              <a:gd name="connsiteY2" fmla="*/ 1474078 h 1538339"/>
              <a:gd name="connsiteX3" fmla="*/ 460907 w 1896984"/>
              <a:gd name="connsiteY3" fmla="*/ 1414810 h 1538339"/>
              <a:gd name="connsiteX4" fmla="*/ 547160 w 1896984"/>
              <a:gd name="connsiteY4" fmla="*/ 1253943 h 1538339"/>
              <a:gd name="connsiteX5" fmla="*/ 708027 w 1896984"/>
              <a:gd name="connsiteY5" fmla="*/ 635877 h 1538339"/>
              <a:gd name="connsiteX6" fmla="*/ 763060 w 1896984"/>
              <a:gd name="connsiteY6" fmla="*/ 445377 h 1538339"/>
              <a:gd name="connsiteX7" fmla="*/ 815977 w 1896984"/>
              <a:gd name="connsiteY7" fmla="*/ 263344 h 1538339"/>
              <a:gd name="connsiteX8" fmla="*/ 866775 w 1896984"/>
              <a:gd name="connsiteY8" fmla="*/ 123643 h 1538339"/>
              <a:gd name="connsiteX9" fmla="*/ 923928 w 1896984"/>
              <a:gd name="connsiteY9" fmla="*/ 30510 h 1538339"/>
              <a:gd name="connsiteX10" fmla="*/ 1005529 w 1896984"/>
              <a:gd name="connsiteY10" fmla="*/ 27 h 1538339"/>
              <a:gd name="connsiteX11" fmla="*/ 1086911 w 1896984"/>
              <a:gd name="connsiteY11" fmla="*/ 43210 h 1538339"/>
              <a:gd name="connsiteX12" fmla="*/ 1154644 w 1896984"/>
              <a:gd name="connsiteY12" fmla="*/ 185026 h 1538339"/>
              <a:gd name="connsiteX13" fmla="*/ 1211794 w 1896984"/>
              <a:gd name="connsiteY13" fmla="*/ 396694 h 1538339"/>
              <a:gd name="connsiteX14" fmla="*/ 1387478 w 1896984"/>
              <a:gd name="connsiteY14" fmla="*/ 1141760 h 1538339"/>
              <a:gd name="connsiteX15" fmla="*/ 1442007 w 1896984"/>
              <a:gd name="connsiteY15" fmla="*/ 1373147 h 1538339"/>
              <a:gd name="connsiteX16" fmla="*/ 1510948 w 1896984"/>
              <a:gd name="connsiteY16" fmla="*/ 1483974 h 1538339"/>
              <a:gd name="connsiteX17" fmla="*/ 1622427 w 1896984"/>
              <a:gd name="connsiteY17" fmla="*/ 1524877 h 1538339"/>
              <a:gd name="connsiteX18" fmla="*/ 1757292 w 1896984"/>
              <a:gd name="connsiteY18" fmla="*/ 1529567 h 1538339"/>
              <a:gd name="connsiteX19" fmla="*/ 1896984 w 1896984"/>
              <a:gd name="connsiteY19" fmla="*/ 1538339 h 1538339"/>
              <a:gd name="connsiteX0" fmla="*/ 0 w 1896984"/>
              <a:gd name="connsiteY0" fmla="*/ 1516411 h 1538339"/>
              <a:gd name="connsiteX1" fmla="*/ 174637 w 1896984"/>
              <a:gd name="connsiteY1" fmla="*/ 1502385 h 1538339"/>
              <a:gd name="connsiteX2" fmla="*/ 335760 w 1896984"/>
              <a:gd name="connsiteY2" fmla="*/ 1474078 h 1538339"/>
              <a:gd name="connsiteX3" fmla="*/ 460907 w 1896984"/>
              <a:gd name="connsiteY3" fmla="*/ 1414810 h 1538339"/>
              <a:gd name="connsiteX4" fmla="*/ 547160 w 1896984"/>
              <a:gd name="connsiteY4" fmla="*/ 1253943 h 1538339"/>
              <a:gd name="connsiteX5" fmla="*/ 708027 w 1896984"/>
              <a:gd name="connsiteY5" fmla="*/ 635877 h 1538339"/>
              <a:gd name="connsiteX6" fmla="*/ 763060 w 1896984"/>
              <a:gd name="connsiteY6" fmla="*/ 445377 h 1538339"/>
              <a:gd name="connsiteX7" fmla="*/ 815977 w 1896984"/>
              <a:gd name="connsiteY7" fmla="*/ 263344 h 1538339"/>
              <a:gd name="connsiteX8" fmla="*/ 866775 w 1896984"/>
              <a:gd name="connsiteY8" fmla="*/ 123643 h 1538339"/>
              <a:gd name="connsiteX9" fmla="*/ 923928 w 1896984"/>
              <a:gd name="connsiteY9" fmla="*/ 30510 h 1538339"/>
              <a:gd name="connsiteX10" fmla="*/ 1005529 w 1896984"/>
              <a:gd name="connsiteY10" fmla="*/ 27 h 1538339"/>
              <a:gd name="connsiteX11" fmla="*/ 1086911 w 1896984"/>
              <a:gd name="connsiteY11" fmla="*/ 43210 h 1538339"/>
              <a:gd name="connsiteX12" fmla="*/ 1154644 w 1896984"/>
              <a:gd name="connsiteY12" fmla="*/ 185026 h 1538339"/>
              <a:gd name="connsiteX13" fmla="*/ 1211794 w 1896984"/>
              <a:gd name="connsiteY13" fmla="*/ 396694 h 1538339"/>
              <a:gd name="connsiteX14" fmla="*/ 1387478 w 1896984"/>
              <a:gd name="connsiteY14" fmla="*/ 1141760 h 1538339"/>
              <a:gd name="connsiteX15" fmla="*/ 1442007 w 1896984"/>
              <a:gd name="connsiteY15" fmla="*/ 1373147 h 1538339"/>
              <a:gd name="connsiteX16" fmla="*/ 1510948 w 1896984"/>
              <a:gd name="connsiteY16" fmla="*/ 1483974 h 1538339"/>
              <a:gd name="connsiteX17" fmla="*/ 1622427 w 1896984"/>
              <a:gd name="connsiteY17" fmla="*/ 1524877 h 1538339"/>
              <a:gd name="connsiteX18" fmla="*/ 1757292 w 1896984"/>
              <a:gd name="connsiteY18" fmla="*/ 1529567 h 1538339"/>
              <a:gd name="connsiteX19" fmla="*/ 1896984 w 1896984"/>
              <a:gd name="connsiteY19" fmla="*/ 1538339 h 1538339"/>
              <a:gd name="connsiteX0" fmla="*/ 0 w 1896984"/>
              <a:gd name="connsiteY0" fmla="*/ 1516411 h 1538339"/>
              <a:gd name="connsiteX1" fmla="*/ 174637 w 1896984"/>
              <a:gd name="connsiteY1" fmla="*/ 1502385 h 1538339"/>
              <a:gd name="connsiteX2" fmla="*/ 335760 w 1896984"/>
              <a:gd name="connsiteY2" fmla="*/ 1474078 h 1538339"/>
              <a:gd name="connsiteX3" fmla="*/ 460907 w 1896984"/>
              <a:gd name="connsiteY3" fmla="*/ 1414810 h 1538339"/>
              <a:gd name="connsiteX4" fmla="*/ 547160 w 1896984"/>
              <a:gd name="connsiteY4" fmla="*/ 1253943 h 1538339"/>
              <a:gd name="connsiteX5" fmla="*/ 708027 w 1896984"/>
              <a:gd name="connsiteY5" fmla="*/ 635877 h 1538339"/>
              <a:gd name="connsiteX6" fmla="*/ 763060 w 1896984"/>
              <a:gd name="connsiteY6" fmla="*/ 445377 h 1538339"/>
              <a:gd name="connsiteX7" fmla="*/ 815977 w 1896984"/>
              <a:gd name="connsiteY7" fmla="*/ 263344 h 1538339"/>
              <a:gd name="connsiteX8" fmla="*/ 866775 w 1896984"/>
              <a:gd name="connsiteY8" fmla="*/ 123643 h 1538339"/>
              <a:gd name="connsiteX9" fmla="*/ 923928 w 1896984"/>
              <a:gd name="connsiteY9" fmla="*/ 30510 h 1538339"/>
              <a:gd name="connsiteX10" fmla="*/ 1005529 w 1896984"/>
              <a:gd name="connsiteY10" fmla="*/ 27 h 1538339"/>
              <a:gd name="connsiteX11" fmla="*/ 1086911 w 1896984"/>
              <a:gd name="connsiteY11" fmla="*/ 43210 h 1538339"/>
              <a:gd name="connsiteX12" fmla="*/ 1154644 w 1896984"/>
              <a:gd name="connsiteY12" fmla="*/ 185026 h 1538339"/>
              <a:gd name="connsiteX13" fmla="*/ 1211794 w 1896984"/>
              <a:gd name="connsiteY13" fmla="*/ 396694 h 1538339"/>
              <a:gd name="connsiteX14" fmla="*/ 1387478 w 1896984"/>
              <a:gd name="connsiteY14" fmla="*/ 1141760 h 1538339"/>
              <a:gd name="connsiteX15" fmla="*/ 1442007 w 1896984"/>
              <a:gd name="connsiteY15" fmla="*/ 1373147 h 1538339"/>
              <a:gd name="connsiteX16" fmla="*/ 1510948 w 1896984"/>
              <a:gd name="connsiteY16" fmla="*/ 1483974 h 1538339"/>
              <a:gd name="connsiteX17" fmla="*/ 1622427 w 1896984"/>
              <a:gd name="connsiteY17" fmla="*/ 1524877 h 1538339"/>
              <a:gd name="connsiteX18" fmla="*/ 1757292 w 1896984"/>
              <a:gd name="connsiteY18" fmla="*/ 1529567 h 1538339"/>
              <a:gd name="connsiteX19" fmla="*/ 1896984 w 1896984"/>
              <a:gd name="connsiteY19" fmla="*/ 1538339 h 1538339"/>
              <a:gd name="connsiteX0" fmla="*/ 0 w 1896984"/>
              <a:gd name="connsiteY0" fmla="*/ 1516411 h 1538339"/>
              <a:gd name="connsiteX1" fmla="*/ 174637 w 1896984"/>
              <a:gd name="connsiteY1" fmla="*/ 1502385 h 1538339"/>
              <a:gd name="connsiteX2" fmla="*/ 335760 w 1896984"/>
              <a:gd name="connsiteY2" fmla="*/ 1474078 h 1538339"/>
              <a:gd name="connsiteX3" fmla="*/ 460907 w 1896984"/>
              <a:gd name="connsiteY3" fmla="*/ 1414810 h 1538339"/>
              <a:gd name="connsiteX4" fmla="*/ 547160 w 1896984"/>
              <a:gd name="connsiteY4" fmla="*/ 1253943 h 1538339"/>
              <a:gd name="connsiteX5" fmla="*/ 708027 w 1896984"/>
              <a:gd name="connsiteY5" fmla="*/ 635877 h 1538339"/>
              <a:gd name="connsiteX6" fmla="*/ 763060 w 1896984"/>
              <a:gd name="connsiteY6" fmla="*/ 445377 h 1538339"/>
              <a:gd name="connsiteX7" fmla="*/ 815977 w 1896984"/>
              <a:gd name="connsiteY7" fmla="*/ 263344 h 1538339"/>
              <a:gd name="connsiteX8" fmla="*/ 866775 w 1896984"/>
              <a:gd name="connsiteY8" fmla="*/ 123643 h 1538339"/>
              <a:gd name="connsiteX9" fmla="*/ 923928 w 1896984"/>
              <a:gd name="connsiteY9" fmla="*/ 30510 h 1538339"/>
              <a:gd name="connsiteX10" fmla="*/ 1005529 w 1896984"/>
              <a:gd name="connsiteY10" fmla="*/ 27 h 1538339"/>
              <a:gd name="connsiteX11" fmla="*/ 1086911 w 1896984"/>
              <a:gd name="connsiteY11" fmla="*/ 43210 h 1538339"/>
              <a:gd name="connsiteX12" fmla="*/ 1154644 w 1896984"/>
              <a:gd name="connsiteY12" fmla="*/ 185026 h 1538339"/>
              <a:gd name="connsiteX13" fmla="*/ 1211794 w 1896984"/>
              <a:gd name="connsiteY13" fmla="*/ 396694 h 1538339"/>
              <a:gd name="connsiteX14" fmla="*/ 1387478 w 1896984"/>
              <a:gd name="connsiteY14" fmla="*/ 1141760 h 1538339"/>
              <a:gd name="connsiteX15" fmla="*/ 1442007 w 1896984"/>
              <a:gd name="connsiteY15" fmla="*/ 1373147 h 1538339"/>
              <a:gd name="connsiteX16" fmla="*/ 1510948 w 1896984"/>
              <a:gd name="connsiteY16" fmla="*/ 1483974 h 1538339"/>
              <a:gd name="connsiteX17" fmla="*/ 1622427 w 1896984"/>
              <a:gd name="connsiteY17" fmla="*/ 1524877 h 1538339"/>
              <a:gd name="connsiteX18" fmla="*/ 1757292 w 1896984"/>
              <a:gd name="connsiteY18" fmla="*/ 1529567 h 1538339"/>
              <a:gd name="connsiteX19" fmla="*/ 1896984 w 1896984"/>
              <a:gd name="connsiteY19" fmla="*/ 1538339 h 1538339"/>
              <a:gd name="connsiteX0" fmla="*/ 0 w 1899202"/>
              <a:gd name="connsiteY0" fmla="*/ 1516411 h 1529941"/>
              <a:gd name="connsiteX1" fmla="*/ 174637 w 1899202"/>
              <a:gd name="connsiteY1" fmla="*/ 1502385 h 1529941"/>
              <a:gd name="connsiteX2" fmla="*/ 335760 w 1899202"/>
              <a:gd name="connsiteY2" fmla="*/ 1474078 h 1529941"/>
              <a:gd name="connsiteX3" fmla="*/ 460907 w 1899202"/>
              <a:gd name="connsiteY3" fmla="*/ 1414810 h 1529941"/>
              <a:gd name="connsiteX4" fmla="*/ 547160 w 1899202"/>
              <a:gd name="connsiteY4" fmla="*/ 1253943 h 1529941"/>
              <a:gd name="connsiteX5" fmla="*/ 708027 w 1899202"/>
              <a:gd name="connsiteY5" fmla="*/ 635877 h 1529941"/>
              <a:gd name="connsiteX6" fmla="*/ 763060 w 1899202"/>
              <a:gd name="connsiteY6" fmla="*/ 445377 h 1529941"/>
              <a:gd name="connsiteX7" fmla="*/ 815977 w 1899202"/>
              <a:gd name="connsiteY7" fmla="*/ 263344 h 1529941"/>
              <a:gd name="connsiteX8" fmla="*/ 866775 w 1899202"/>
              <a:gd name="connsiteY8" fmla="*/ 123643 h 1529941"/>
              <a:gd name="connsiteX9" fmla="*/ 923928 w 1899202"/>
              <a:gd name="connsiteY9" fmla="*/ 30510 h 1529941"/>
              <a:gd name="connsiteX10" fmla="*/ 1005529 w 1899202"/>
              <a:gd name="connsiteY10" fmla="*/ 27 h 1529941"/>
              <a:gd name="connsiteX11" fmla="*/ 1086911 w 1899202"/>
              <a:gd name="connsiteY11" fmla="*/ 43210 h 1529941"/>
              <a:gd name="connsiteX12" fmla="*/ 1154644 w 1899202"/>
              <a:gd name="connsiteY12" fmla="*/ 185026 h 1529941"/>
              <a:gd name="connsiteX13" fmla="*/ 1211794 w 1899202"/>
              <a:gd name="connsiteY13" fmla="*/ 396694 h 1529941"/>
              <a:gd name="connsiteX14" fmla="*/ 1387478 w 1899202"/>
              <a:gd name="connsiteY14" fmla="*/ 1141760 h 1529941"/>
              <a:gd name="connsiteX15" fmla="*/ 1442007 w 1899202"/>
              <a:gd name="connsiteY15" fmla="*/ 1373147 h 1529941"/>
              <a:gd name="connsiteX16" fmla="*/ 1510948 w 1899202"/>
              <a:gd name="connsiteY16" fmla="*/ 1483974 h 1529941"/>
              <a:gd name="connsiteX17" fmla="*/ 1622427 w 1899202"/>
              <a:gd name="connsiteY17" fmla="*/ 1524877 h 1529941"/>
              <a:gd name="connsiteX18" fmla="*/ 1757292 w 1899202"/>
              <a:gd name="connsiteY18" fmla="*/ 1529567 h 1529941"/>
              <a:gd name="connsiteX19" fmla="*/ 1899202 w 1899202"/>
              <a:gd name="connsiteY19" fmla="*/ 1527375 h 152994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</a:cxnLst>
            <a:rect l="l" t="t" r="r" b="b"/>
            <a:pathLst>
              <a:path w="1899202" h="1529941">
                <a:moveTo>
                  <a:pt x="0" y="1516411"/>
                </a:moveTo>
                <a:cubicBezTo>
                  <a:pt x="531" y="1515838"/>
                  <a:pt x="152412" y="1507324"/>
                  <a:pt x="174637" y="1502385"/>
                </a:cubicBezTo>
                <a:cubicBezTo>
                  <a:pt x="196862" y="1497446"/>
                  <a:pt x="288048" y="1488674"/>
                  <a:pt x="335760" y="1474078"/>
                </a:cubicBezTo>
                <a:cubicBezTo>
                  <a:pt x="383472" y="1459482"/>
                  <a:pt x="425674" y="1451499"/>
                  <a:pt x="460907" y="1414810"/>
                </a:cubicBezTo>
                <a:cubicBezTo>
                  <a:pt x="496140" y="1378121"/>
                  <a:pt x="505973" y="1383765"/>
                  <a:pt x="547160" y="1253943"/>
                </a:cubicBezTo>
                <a:cubicBezTo>
                  <a:pt x="588347" y="1124121"/>
                  <a:pt x="672044" y="770638"/>
                  <a:pt x="708027" y="635877"/>
                </a:cubicBezTo>
                <a:cubicBezTo>
                  <a:pt x="744010" y="501116"/>
                  <a:pt x="745068" y="507466"/>
                  <a:pt x="763060" y="445377"/>
                </a:cubicBezTo>
                <a:cubicBezTo>
                  <a:pt x="781052" y="383288"/>
                  <a:pt x="798691" y="316966"/>
                  <a:pt x="815977" y="263344"/>
                </a:cubicBezTo>
                <a:cubicBezTo>
                  <a:pt x="833263" y="209722"/>
                  <a:pt x="848783" y="162449"/>
                  <a:pt x="866775" y="123643"/>
                </a:cubicBezTo>
                <a:cubicBezTo>
                  <a:pt x="884767" y="84837"/>
                  <a:pt x="900802" y="51113"/>
                  <a:pt x="923928" y="30510"/>
                </a:cubicBezTo>
                <a:cubicBezTo>
                  <a:pt x="947054" y="9907"/>
                  <a:pt x="976248" y="732"/>
                  <a:pt x="1005529" y="27"/>
                </a:cubicBezTo>
                <a:cubicBezTo>
                  <a:pt x="1034810" y="-678"/>
                  <a:pt x="1062059" y="12377"/>
                  <a:pt x="1086911" y="43210"/>
                </a:cubicBezTo>
                <a:cubicBezTo>
                  <a:pt x="1111763" y="74043"/>
                  <a:pt x="1133830" y="126112"/>
                  <a:pt x="1154644" y="185026"/>
                </a:cubicBezTo>
                <a:cubicBezTo>
                  <a:pt x="1175458" y="243940"/>
                  <a:pt x="1172988" y="237238"/>
                  <a:pt x="1211794" y="396694"/>
                </a:cubicBezTo>
                <a:cubicBezTo>
                  <a:pt x="1250600" y="556150"/>
                  <a:pt x="1349109" y="979018"/>
                  <a:pt x="1387478" y="1141760"/>
                </a:cubicBezTo>
                <a:cubicBezTo>
                  <a:pt x="1425847" y="1304502"/>
                  <a:pt x="1421429" y="1316111"/>
                  <a:pt x="1442007" y="1373147"/>
                </a:cubicBezTo>
                <a:cubicBezTo>
                  <a:pt x="1462585" y="1430183"/>
                  <a:pt x="1480878" y="1458686"/>
                  <a:pt x="1510948" y="1483974"/>
                </a:cubicBezTo>
                <a:cubicBezTo>
                  <a:pt x="1541018" y="1509262"/>
                  <a:pt x="1581370" y="1517278"/>
                  <a:pt x="1622427" y="1524877"/>
                </a:cubicBezTo>
                <a:cubicBezTo>
                  <a:pt x="1663484" y="1532476"/>
                  <a:pt x="1711163" y="1529151"/>
                  <a:pt x="1757292" y="1529567"/>
                </a:cubicBezTo>
                <a:cubicBezTo>
                  <a:pt x="1803421" y="1529983"/>
                  <a:pt x="1831389" y="1527101"/>
                  <a:pt x="1899202" y="1527375"/>
                </a:cubicBezTo>
              </a:path>
            </a:pathLst>
          </a:custGeom>
          <a:noFill/>
          <a:ln w="28575">
            <a:solidFill>
              <a:srgbClr val="FF33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4" name="CuadroTexto 363"/>
          <p:cNvSpPr txBox="1"/>
          <p:nvPr/>
        </p:nvSpPr>
        <p:spPr>
          <a:xfrm>
            <a:off x="4988462" y="4426193"/>
            <a:ext cx="1086612" cy="220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s-CO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citatio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CuadroTexto 364"/>
          <p:cNvSpPr txBox="1"/>
          <p:nvPr/>
        </p:nvSpPr>
        <p:spPr>
          <a:xfrm>
            <a:off x="5866844" y="4411559"/>
            <a:ext cx="880014" cy="220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s-CO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missio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6" name="CuadroTexto 365"/>
          <p:cNvSpPr txBox="1"/>
          <p:nvPr/>
        </p:nvSpPr>
        <p:spPr>
          <a:xfrm>
            <a:off x="6162305" y="6464011"/>
            <a:ext cx="1372745" cy="220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velenght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nm)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7" name="CuadroTexto 366"/>
          <p:cNvSpPr txBox="1"/>
          <p:nvPr/>
        </p:nvSpPr>
        <p:spPr>
          <a:xfrm rot="16200000">
            <a:off x="3871604" y="5325909"/>
            <a:ext cx="1416135" cy="220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s-CO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8" name="CuadroTexto 367"/>
          <p:cNvSpPr txBox="1"/>
          <p:nvPr/>
        </p:nvSpPr>
        <p:spPr>
          <a:xfrm>
            <a:off x="6538628" y="4608929"/>
            <a:ext cx="1086612" cy="220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s-CO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citatio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9" name="CuadroTexto 368"/>
          <p:cNvSpPr txBox="1"/>
          <p:nvPr/>
        </p:nvSpPr>
        <p:spPr>
          <a:xfrm>
            <a:off x="7385239" y="4400266"/>
            <a:ext cx="880014" cy="220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missio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3" name="Estrella de 7 puntas 372"/>
          <p:cNvSpPr/>
          <p:nvPr/>
        </p:nvSpPr>
        <p:spPr>
          <a:xfrm rot="1218321">
            <a:off x="5946781" y="3717772"/>
            <a:ext cx="711776" cy="686202"/>
          </a:xfrm>
          <a:prstGeom prst="star7">
            <a:avLst>
              <a:gd name="adj" fmla="val 23070"/>
              <a:gd name="hf" fmla="val 102572"/>
              <a:gd name="vf" fmla="val 105210"/>
            </a:avLst>
          </a:prstGeom>
          <a:solidFill>
            <a:srgbClr val="66FF33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4" name="CuadroTexto 373"/>
          <p:cNvSpPr txBox="1"/>
          <p:nvPr/>
        </p:nvSpPr>
        <p:spPr>
          <a:xfrm>
            <a:off x="6107409" y="3847308"/>
            <a:ext cx="38501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2200" b="1" dirty="0" smtClean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sz="2200" b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7" name="Lágrima 376"/>
          <p:cNvSpPr/>
          <p:nvPr/>
        </p:nvSpPr>
        <p:spPr>
          <a:xfrm rot="11328590">
            <a:off x="6833814" y="4178030"/>
            <a:ext cx="468030" cy="459801"/>
          </a:xfrm>
          <a:prstGeom prst="teardrop">
            <a:avLst/>
          </a:prstGeom>
          <a:solidFill>
            <a:srgbClr val="9999FF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8" name="CuadroTexto 377"/>
          <p:cNvSpPr txBox="1"/>
          <p:nvPr/>
        </p:nvSpPr>
        <p:spPr>
          <a:xfrm>
            <a:off x="6874751" y="4197850"/>
            <a:ext cx="34160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2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en-US" sz="2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9" name="Lágrima 378"/>
          <p:cNvSpPr/>
          <p:nvPr/>
        </p:nvSpPr>
        <p:spPr>
          <a:xfrm rot="11328590">
            <a:off x="7604763" y="3959710"/>
            <a:ext cx="516054" cy="447921"/>
          </a:xfrm>
          <a:prstGeom prst="teardrop">
            <a:avLst/>
          </a:prstGeom>
          <a:solidFill>
            <a:srgbClr val="FF33CC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0" name="CuadroTexto 379"/>
          <p:cNvSpPr txBox="1"/>
          <p:nvPr/>
        </p:nvSpPr>
        <p:spPr>
          <a:xfrm>
            <a:off x="7651125" y="3978231"/>
            <a:ext cx="35420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2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en-US" sz="2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1" name="Rectángulo 380"/>
          <p:cNvSpPr/>
          <p:nvPr/>
        </p:nvSpPr>
        <p:spPr>
          <a:xfrm>
            <a:off x="9559149" y="5388555"/>
            <a:ext cx="2340000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382" name="Conector recto 381"/>
          <p:cNvCxnSpPr/>
          <p:nvPr/>
        </p:nvCxnSpPr>
        <p:spPr>
          <a:xfrm flipV="1">
            <a:off x="9570359" y="5506516"/>
            <a:ext cx="23400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3" name="Imagen 38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>
            <a:off x="9472591" y="5333750"/>
            <a:ext cx="91418" cy="88266"/>
          </a:xfrm>
          <a:prstGeom prst="rect">
            <a:avLst/>
          </a:prstGeom>
        </p:spPr>
      </p:pic>
      <p:pic>
        <p:nvPicPr>
          <p:cNvPr id="384" name="Imagen 38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>
            <a:off x="11894916" y="5300290"/>
            <a:ext cx="90629" cy="88265"/>
          </a:xfrm>
          <a:prstGeom prst="rect">
            <a:avLst/>
          </a:prstGeom>
        </p:spPr>
      </p:pic>
      <p:sp>
        <p:nvSpPr>
          <p:cNvPr id="385" name="Rectángulo 384"/>
          <p:cNvSpPr/>
          <p:nvPr/>
        </p:nvSpPr>
        <p:spPr>
          <a:xfrm>
            <a:off x="9554916" y="4725865"/>
            <a:ext cx="2340000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386" name="Conector recto 385"/>
          <p:cNvCxnSpPr/>
          <p:nvPr/>
        </p:nvCxnSpPr>
        <p:spPr>
          <a:xfrm flipV="1">
            <a:off x="9546330" y="4683053"/>
            <a:ext cx="23400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9" name="Rectángulo 388"/>
          <p:cNvSpPr/>
          <p:nvPr/>
        </p:nvSpPr>
        <p:spPr>
          <a:xfrm>
            <a:off x="9595760" y="6283729"/>
            <a:ext cx="2340000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390" name="Conector recto 389"/>
          <p:cNvCxnSpPr/>
          <p:nvPr/>
        </p:nvCxnSpPr>
        <p:spPr>
          <a:xfrm flipV="1">
            <a:off x="9587174" y="6240917"/>
            <a:ext cx="23400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91" name="Imagen 39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 rot="10800000">
            <a:off x="11894916" y="4789202"/>
            <a:ext cx="91418" cy="88266"/>
          </a:xfrm>
          <a:prstGeom prst="rect">
            <a:avLst/>
          </a:prstGeom>
        </p:spPr>
      </p:pic>
      <p:pic>
        <p:nvPicPr>
          <p:cNvPr id="392" name="Imagen 39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 rot="10800000">
            <a:off x="9455410" y="4796073"/>
            <a:ext cx="90629" cy="88265"/>
          </a:xfrm>
          <a:prstGeom prst="rect">
            <a:avLst/>
          </a:prstGeom>
        </p:spPr>
      </p:pic>
      <p:pic>
        <p:nvPicPr>
          <p:cNvPr id="393" name="Imagen 39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 rot="10800000">
            <a:off x="11944637" y="6331672"/>
            <a:ext cx="91418" cy="88266"/>
          </a:xfrm>
          <a:prstGeom prst="rect">
            <a:avLst/>
          </a:prstGeom>
        </p:spPr>
      </p:pic>
      <p:pic>
        <p:nvPicPr>
          <p:cNvPr id="394" name="Imagen 39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 rot="10800000">
            <a:off x="9505131" y="6321611"/>
            <a:ext cx="90629" cy="88265"/>
          </a:xfrm>
          <a:prstGeom prst="rect">
            <a:avLst/>
          </a:prstGeom>
        </p:spPr>
      </p:pic>
      <p:sp>
        <p:nvSpPr>
          <p:cNvPr id="395" name="Rectángulo 394"/>
          <p:cNvSpPr/>
          <p:nvPr/>
        </p:nvSpPr>
        <p:spPr>
          <a:xfrm>
            <a:off x="10611875" y="4499411"/>
            <a:ext cx="637200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397" name="Estrella de 7 puntas 396"/>
          <p:cNvSpPr/>
          <p:nvPr/>
        </p:nvSpPr>
        <p:spPr>
          <a:xfrm rot="1218321">
            <a:off x="10369800" y="4268198"/>
            <a:ext cx="317808" cy="285615"/>
          </a:xfrm>
          <a:prstGeom prst="star7">
            <a:avLst>
              <a:gd name="adj" fmla="val 33068"/>
              <a:gd name="hf" fmla="val 102572"/>
              <a:gd name="vf" fmla="val 105210"/>
            </a:avLst>
          </a:prstGeom>
          <a:solidFill>
            <a:srgbClr val="92D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8" name="CuadroTexto 397"/>
          <p:cNvSpPr txBox="1"/>
          <p:nvPr/>
        </p:nvSpPr>
        <p:spPr>
          <a:xfrm>
            <a:off x="10367674" y="4263735"/>
            <a:ext cx="385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b="1" dirty="0" smtClean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sz="1400" b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1" name="Estrella de 7 puntas 400"/>
          <p:cNvSpPr/>
          <p:nvPr/>
        </p:nvSpPr>
        <p:spPr>
          <a:xfrm rot="390206">
            <a:off x="5030164" y="3896337"/>
            <a:ext cx="629335" cy="565585"/>
          </a:xfrm>
          <a:prstGeom prst="star7">
            <a:avLst>
              <a:gd name="adj" fmla="val 33068"/>
              <a:gd name="hf" fmla="val 102572"/>
              <a:gd name="vf" fmla="val 105210"/>
            </a:avLst>
          </a:prstGeom>
          <a:solidFill>
            <a:srgbClr val="92D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2" name="CuadroTexto 401"/>
          <p:cNvSpPr txBox="1"/>
          <p:nvPr/>
        </p:nvSpPr>
        <p:spPr>
          <a:xfrm>
            <a:off x="5132486" y="3970534"/>
            <a:ext cx="38501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2200" b="1" dirty="0" smtClean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sz="2200" b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3" name="Lágrima 402"/>
          <p:cNvSpPr/>
          <p:nvPr/>
        </p:nvSpPr>
        <p:spPr>
          <a:xfrm rot="11328590">
            <a:off x="11180437" y="4274848"/>
            <a:ext cx="241100" cy="245672"/>
          </a:xfrm>
          <a:prstGeom prst="teardrop">
            <a:avLst/>
          </a:prstGeom>
          <a:solidFill>
            <a:srgbClr val="FF33CC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4" name="CuadroTexto 403"/>
          <p:cNvSpPr txBox="1"/>
          <p:nvPr/>
        </p:nvSpPr>
        <p:spPr>
          <a:xfrm>
            <a:off x="11137201" y="4244755"/>
            <a:ext cx="385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b="1" dirty="0" smtClean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en-US" sz="1400" b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5" name="Conector recto de flecha 404"/>
          <p:cNvCxnSpPr/>
          <p:nvPr/>
        </p:nvCxnSpPr>
        <p:spPr>
          <a:xfrm>
            <a:off x="10675569" y="4414575"/>
            <a:ext cx="468000" cy="5044"/>
          </a:xfrm>
          <a:prstGeom prst="straightConnector1">
            <a:avLst/>
          </a:prstGeom>
          <a:ln w="28575">
            <a:solidFill>
              <a:srgbClr val="C0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6" name="Conector recto 415"/>
          <p:cNvCxnSpPr/>
          <p:nvPr/>
        </p:nvCxnSpPr>
        <p:spPr>
          <a:xfrm flipV="1">
            <a:off x="11052409" y="6179297"/>
            <a:ext cx="3240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7" name="Rectángulo 416"/>
          <p:cNvSpPr/>
          <p:nvPr/>
        </p:nvSpPr>
        <p:spPr>
          <a:xfrm>
            <a:off x="11052774" y="6060158"/>
            <a:ext cx="324000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420" name="Lágrima 419"/>
          <p:cNvSpPr/>
          <p:nvPr/>
        </p:nvSpPr>
        <p:spPr>
          <a:xfrm rot="11328590">
            <a:off x="11306561" y="5835288"/>
            <a:ext cx="241100" cy="245672"/>
          </a:xfrm>
          <a:prstGeom prst="teardrop">
            <a:avLst/>
          </a:prstGeom>
          <a:solidFill>
            <a:srgbClr val="9999FF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1" name="CuadroTexto 420"/>
          <p:cNvSpPr txBox="1"/>
          <p:nvPr/>
        </p:nvSpPr>
        <p:spPr>
          <a:xfrm>
            <a:off x="11258975" y="5809197"/>
            <a:ext cx="385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b="1" dirty="0" smtClean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en-US" sz="1400" b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23" name="Grupo 422"/>
          <p:cNvGrpSpPr/>
          <p:nvPr/>
        </p:nvGrpSpPr>
        <p:grpSpPr>
          <a:xfrm rot="960000">
            <a:off x="10560537" y="5842237"/>
            <a:ext cx="62100" cy="106542"/>
            <a:chOff x="4953375" y="7221921"/>
            <a:chExt cx="82800" cy="142056"/>
          </a:xfrm>
        </p:grpSpPr>
        <p:sp>
          <p:nvSpPr>
            <p:cNvPr id="424" name="Rectángulo 423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25" name="Conector recto 424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6" name="Grupo 425"/>
          <p:cNvGrpSpPr/>
          <p:nvPr/>
        </p:nvGrpSpPr>
        <p:grpSpPr>
          <a:xfrm rot="-120000">
            <a:off x="10429157" y="5867060"/>
            <a:ext cx="62100" cy="106542"/>
            <a:chOff x="4953375" y="7221921"/>
            <a:chExt cx="82800" cy="142056"/>
          </a:xfrm>
        </p:grpSpPr>
        <p:sp>
          <p:nvSpPr>
            <p:cNvPr id="427" name="Rectángulo 42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28" name="Conector recto 42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9" name="Circular 131"/>
          <p:cNvSpPr/>
          <p:nvPr/>
        </p:nvSpPr>
        <p:spPr>
          <a:xfrm rot="1475539">
            <a:off x="10684463" y="6070612"/>
            <a:ext cx="175841" cy="13620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grpSp>
        <p:nvGrpSpPr>
          <p:cNvPr id="430" name="Grupo 429"/>
          <p:cNvGrpSpPr/>
          <p:nvPr/>
        </p:nvGrpSpPr>
        <p:grpSpPr>
          <a:xfrm flipH="1" flipV="1">
            <a:off x="9600246" y="6063361"/>
            <a:ext cx="189000" cy="130469"/>
            <a:chOff x="4079020" y="6879809"/>
            <a:chExt cx="252000" cy="173958"/>
          </a:xfrm>
        </p:grpSpPr>
        <p:sp>
          <p:nvSpPr>
            <p:cNvPr id="431" name="Forma libre 430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32" name="Conector recto 431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3" name="Grupo 432"/>
          <p:cNvGrpSpPr/>
          <p:nvPr/>
        </p:nvGrpSpPr>
        <p:grpSpPr>
          <a:xfrm rot="21540000">
            <a:off x="10016161" y="6087473"/>
            <a:ext cx="62100" cy="106542"/>
            <a:chOff x="4953375" y="7221921"/>
            <a:chExt cx="82800" cy="142056"/>
          </a:xfrm>
        </p:grpSpPr>
        <p:sp>
          <p:nvSpPr>
            <p:cNvPr id="434" name="Rectángulo 433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35" name="Conector recto 434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6" name="Grupo 435"/>
          <p:cNvGrpSpPr/>
          <p:nvPr/>
        </p:nvGrpSpPr>
        <p:grpSpPr>
          <a:xfrm rot="60000" flipH="1">
            <a:off x="10089734" y="6087343"/>
            <a:ext cx="62100" cy="106542"/>
            <a:chOff x="4953375" y="7221921"/>
            <a:chExt cx="82800" cy="142056"/>
          </a:xfrm>
        </p:grpSpPr>
        <p:sp>
          <p:nvSpPr>
            <p:cNvPr id="437" name="Rectángulo 43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38" name="Conector recto 43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9" name="Grupo 438"/>
          <p:cNvGrpSpPr/>
          <p:nvPr/>
        </p:nvGrpSpPr>
        <p:grpSpPr>
          <a:xfrm rot="21540000">
            <a:off x="9792329" y="6087493"/>
            <a:ext cx="62100" cy="106542"/>
            <a:chOff x="4953375" y="7221921"/>
            <a:chExt cx="82800" cy="142056"/>
          </a:xfrm>
        </p:grpSpPr>
        <p:sp>
          <p:nvSpPr>
            <p:cNvPr id="440" name="Rectángulo 43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41" name="Conector recto 44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2" name="Grupo 441"/>
          <p:cNvGrpSpPr/>
          <p:nvPr/>
        </p:nvGrpSpPr>
        <p:grpSpPr>
          <a:xfrm rot="60000" flipH="1">
            <a:off x="9870135" y="6087363"/>
            <a:ext cx="62100" cy="106542"/>
            <a:chOff x="4953375" y="7221921"/>
            <a:chExt cx="82800" cy="142056"/>
          </a:xfrm>
        </p:grpSpPr>
        <p:sp>
          <p:nvSpPr>
            <p:cNvPr id="443" name="Rectángulo 442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44" name="Conector recto 443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5" name="Grupo 444"/>
          <p:cNvGrpSpPr/>
          <p:nvPr/>
        </p:nvGrpSpPr>
        <p:grpSpPr>
          <a:xfrm rot="21540000">
            <a:off x="9941340" y="6086681"/>
            <a:ext cx="62100" cy="106542"/>
            <a:chOff x="4953375" y="7221921"/>
            <a:chExt cx="82800" cy="142056"/>
          </a:xfrm>
        </p:grpSpPr>
        <p:sp>
          <p:nvSpPr>
            <p:cNvPr id="446" name="Rectángulo 445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47" name="Conector recto 446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8" name="Grupo 447"/>
          <p:cNvGrpSpPr/>
          <p:nvPr/>
        </p:nvGrpSpPr>
        <p:grpSpPr>
          <a:xfrm rot="21540000">
            <a:off x="10387758" y="6084447"/>
            <a:ext cx="62100" cy="106542"/>
            <a:chOff x="4953375" y="7221921"/>
            <a:chExt cx="82800" cy="142056"/>
          </a:xfrm>
        </p:grpSpPr>
        <p:sp>
          <p:nvSpPr>
            <p:cNvPr id="449" name="Rectángulo 448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50" name="Conector recto 449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1" name="Grupo 450"/>
          <p:cNvGrpSpPr/>
          <p:nvPr/>
        </p:nvGrpSpPr>
        <p:grpSpPr>
          <a:xfrm rot="60000" flipH="1">
            <a:off x="10461331" y="6084317"/>
            <a:ext cx="62100" cy="106542"/>
            <a:chOff x="4953375" y="7221921"/>
            <a:chExt cx="82800" cy="142056"/>
          </a:xfrm>
        </p:grpSpPr>
        <p:sp>
          <p:nvSpPr>
            <p:cNvPr id="452" name="Rectángulo 451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53" name="Conector recto 452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4" name="Grupo 453"/>
          <p:cNvGrpSpPr/>
          <p:nvPr/>
        </p:nvGrpSpPr>
        <p:grpSpPr>
          <a:xfrm rot="21540000">
            <a:off x="10163926" y="6084467"/>
            <a:ext cx="62100" cy="106542"/>
            <a:chOff x="4953375" y="7221921"/>
            <a:chExt cx="82800" cy="142056"/>
          </a:xfrm>
        </p:grpSpPr>
        <p:sp>
          <p:nvSpPr>
            <p:cNvPr id="455" name="Rectángulo 454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56" name="Conector recto 455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7" name="Grupo 456"/>
          <p:cNvGrpSpPr/>
          <p:nvPr/>
        </p:nvGrpSpPr>
        <p:grpSpPr>
          <a:xfrm rot="60000" flipH="1">
            <a:off x="10237499" y="6084337"/>
            <a:ext cx="62100" cy="106542"/>
            <a:chOff x="4953375" y="7221921"/>
            <a:chExt cx="82800" cy="142056"/>
          </a:xfrm>
        </p:grpSpPr>
        <p:sp>
          <p:nvSpPr>
            <p:cNvPr id="458" name="Rectángulo 457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59" name="Conector recto 458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0" name="Grupo 459"/>
          <p:cNvGrpSpPr/>
          <p:nvPr/>
        </p:nvGrpSpPr>
        <p:grpSpPr>
          <a:xfrm rot="21540000">
            <a:off x="10308704" y="6083655"/>
            <a:ext cx="62100" cy="106542"/>
            <a:chOff x="4953375" y="7221921"/>
            <a:chExt cx="82800" cy="142056"/>
          </a:xfrm>
        </p:grpSpPr>
        <p:sp>
          <p:nvSpPr>
            <p:cNvPr id="461" name="Rectángulo 460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62" name="Conector recto 461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3" name="Grupo 462"/>
          <p:cNvGrpSpPr/>
          <p:nvPr/>
        </p:nvGrpSpPr>
        <p:grpSpPr>
          <a:xfrm rot="60000" flipV="1">
            <a:off x="11278459" y="5568076"/>
            <a:ext cx="62100" cy="106542"/>
            <a:chOff x="4953375" y="7221921"/>
            <a:chExt cx="82800" cy="142056"/>
          </a:xfrm>
        </p:grpSpPr>
        <p:sp>
          <p:nvSpPr>
            <p:cNvPr id="464" name="Rectángulo 463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65" name="Conector recto 464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6" name="Grupo 465"/>
          <p:cNvGrpSpPr/>
          <p:nvPr/>
        </p:nvGrpSpPr>
        <p:grpSpPr>
          <a:xfrm rot="21540000" flipH="1" flipV="1">
            <a:off x="11352032" y="5567946"/>
            <a:ext cx="62100" cy="106542"/>
            <a:chOff x="4953375" y="7221921"/>
            <a:chExt cx="82800" cy="142056"/>
          </a:xfrm>
        </p:grpSpPr>
        <p:sp>
          <p:nvSpPr>
            <p:cNvPr id="467" name="Rectángulo 46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68" name="Conector recto 46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9" name="Grupo 468"/>
          <p:cNvGrpSpPr/>
          <p:nvPr/>
        </p:nvGrpSpPr>
        <p:grpSpPr>
          <a:xfrm rot="60000" flipV="1">
            <a:off x="11423237" y="5567264"/>
            <a:ext cx="62100" cy="106542"/>
            <a:chOff x="4953375" y="7221921"/>
            <a:chExt cx="82800" cy="142056"/>
          </a:xfrm>
        </p:grpSpPr>
        <p:sp>
          <p:nvSpPr>
            <p:cNvPr id="470" name="Rectángulo 46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71" name="Conector recto 47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2" name="Grupo 471"/>
          <p:cNvGrpSpPr/>
          <p:nvPr/>
        </p:nvGrpSpPr>
        <p:grpSpPr>
          <a:xfrm rot="60000" flipV="1">
            <a:off x="11058860" y="5568096"/>
            <a:ext cx="62100" cy="106542"/>
            <a:chOff x="4953375" y="7221921"/>
            <a:chExt cx="82800" cy="142056"/>
          </a:xfrm>
        </p:grpSpPr>
        <p:sp>
          <p:nvSpPr>
            <p:cNvPr id="473" name="Rectángulo 472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74" name="Conector recto 473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5" name="Grupo 474"/>
          <p:cNvGrpSpPr/>
          <p:nvPr/>
        </p:nvGrpSpPr>
        <p:grpSpPr>
          <a:xfrm rot="21540000" flipH="1" flipV="1">
            <a:off x="11132433" y="5567966"/>
            <a:ext cx="62100" cy="106542"/>
            <a:chOff x="4953375" y="7221921"/>
            <a:chExt cx="82800" cy="142056"/>
          </a:xfrm>
        </p:grpSpPr>
        <p:sp>
          <p:nvSpPr>
            <p:cNvPr id="476" name="Rectángulo 475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77" name="Conector recto 476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8" name="Grupo 477"/>
          <p:cNvGrpSpPr/>
          <p:nvPr/>
        </p:nvGrpSpPr>
        <p:grpSpPr>
          <a:xfrm rot="60000" flipV="1">
            <a:off x="11203638" y="5567284"/>
            <a:ext cx="62100" cy="106542"/>
            <a:chOff x="4953375" y="7221921"/>
            <a:chExt cx="82800" cy="142056"/>
          </a:xfrm>
        </p:grpSpPr>
        <p:sp>
          <p:nvSpPr>
            <p:cNvPr id="479" name="Rectángulo 478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80" name="Conector recto 479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1" name="Grupo 480"/>
          <p:cNvGrpSpPr/>
          <p:nvPr/>
        </p:nvGrpSpPr>
        <p:grpSpPr>
          <a:xfrm rot="60000" flipV="1">
            <a:off x="11498340" y="5568076"/>
            <a:ext cx="62100" cy="106542"/>
            <a:chOff x="4953375" y="7221921"/>
            <a:chExt cx="82800" cy="142056"/>
          </a:xfrm>
        </p:grpSpPr>
        <p:sp>
          <p:nvSpPr>
            <p:cNvPr id="482" name="Rectángulo 481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83" name="Conector recto 482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4" name="Grupo 483"/>
          <p:cNvGrpSpPr/>
          <p:nvPr/>
        </p:nvGrpSpPr>
        <p:grpSpPr>
          <a:xfrm rot="21540000" flipH="1" flipV="1">
            <a:off x="11571913" y="5567946"/>
            <a:ext cx="62100" cy="106542"/>
            <a:chOff x="4953375" y="7221921"/>
            <a:chExt cx="82800" cy="142056"/>
          </a:xfrm>
        </p:grpSpPr>
        <p:sp>
          <p:nvSpPr>
            <p:cNvPr id="485" name="Rectángulo 484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86" name="Conector recto 485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7" name="Grupo 486"/>
          <p:cNvGrpSpPr/>
          <p:nvPr/>
        </p:nvGrpSpPr>
        <p:grpSpPr>
          <a:xfrm rot="60000" flipV="1">
            <a:off x="11643118" y="5567264"/>
            <a:ext cx="62100" cy="106542"/>
            <a:chOff x="4953375" y="7221921"/>
            <a:chExt cx="82800" cy="142056"/>
          </a:xfrm>
        </p:grpSpPr>
        <p:sp>
          <p:nvSpPr>
            <p:cNvPr id="488" name="Rectángulo 487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89" name="Conector recto 488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0" name="Grupo 489"/>
          <p:cNvGrpSpPr/>
          <p:nvPr/>
        </p:nvGrpSpPr>
        <p:grpSpPr>
          <a:xfrm>
            <a:off x="11714530" y="5569933"/>
            <a:ext cx="189000" cy="130469"/>
            <a:chOff x="4079020" y="6879809"/>
            <a:chExt cx="252000" cy="173958"/>
          </a:xfrm>
        </p:grpSpPr>
        <p:sp>
          <p:nvSpPr>
            <p:cNvPr id="491" name="Forma libre 490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92" name="Conector recto 491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3" name="Circular 131"/>
          <p:cNvSpPr/>
          <p:nvPr/>
        </p:nvSpPr>
        <p:spPr>
          <a:xfrm rot="20124461" flipH="1">
            <a:off x="10577752" y="5562276"/>
            <a:ext cx="175841" cy="13620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sp>
        <p:nvSpPr>
          <p:cNvPr id="494" name="Estrella de 7 puntas 493"/>
          <p:cNvSpPr/>
          <p:nvPr/>
        </p:nvSpPr>
        <p:spPr>
          <a:xfrm rot="1218321">
            <a:off x="10086906" y="5579971"/>
            <a:ext cx="425307" cy="408664"/>
          </a:xfrm>
          <a:prstGeom prst="star7">
            <a:avLst>
              <a:gd name="adj" fmla="val 23070"/>
              <a:gd name="hf" fmla="val 102572"/>
              <a:gd name="vf" fmla="val 105210"/>
            </a:avLst>
          </a:prstGeom>
          <a:solidFill>
            <a:srgbClr val="66FF33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5" name="CuadroTexto 494"/>
          <p:cNvSpPr txBox="1"/>
          <p:nvPr/>
        </p:nvSpPr>
        <p:spPr>
          <a:xfrm>
            <a:off x="10131852" y="5634113"/>
            <a:ext cx="385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b="1" dirty="0" smtClean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sz="1400" b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96" name="Grupo 495"/>
          <p:cNvGrpSpPr/>
          <p:nvPr/>
        </p:nvGrpSpPr>
        <p:grpSpPr>
          <a:xfrm rot="21540000">
            <a:off x="10535188" y="6082449"/>
            <a:ext cx="62100" cy="106542"/>
            <a:chOff x="4953375" y="7221921"/>
            <a:chExt cx="82800" cy="142056"/>
          </a:xfrm>
        </p:grpSpPr>
        <p:sp>
          <p:nvSpPr>
            <p:cNvPr id="497" name="Rectángulo 49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98" name="Conector recto 49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9" name="Grupo 498"/>
          <p:cNvGrpSpPr/>
          <p:nvPr/>
        </p:nvGrpSpPr>
        <p:grpSpPr>
          <a:xfrm rot="60000" flipH="1">
            <a:off x="10608761" y="6082319"/>
            <a:ext cx="62100" cy="106542"/>
            <a:chOff x="4953375" y="7221921"/>
            <a:chExt cx="82800" cy="142056"/>
          </a:xfrm>
        </p:grpSpPr>
        <p:sp>
          <p:nvSpPr>
            <p:cNvPr id="500" name="Rectángulo 49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501" name="Conector recto 50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3" name="Grupo 502"/>
          <p:cNvGrpSpPr/>
          <p:nvPr/>
        </p:nvGrpSpPr>
        <p:grpSpPr>
          <a:xfrm rot="60000" flipV="1">
            <a:off x="10983184" y="5568076"/>
            <a:ext cx="62100" cy="106542"/>
            <a:chOff x="4953375" y="7221921"/>
            <a:chExt cx="82800" cy="142056"/>
          </a:xfrm>
        </p:grpSpPr>
        <p:sp>
          <p:nvSpPr>
            <p:cNvPr id="504" name="Rectángulo 503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505" name="Conector recto 504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6" name="Grupo 505"/>
          <p:cNvGrpSpPr/>
          <p:nvPr/>
        </p:nvGrpSpPr>
        <p:grpSpPr>
          <a:xfrm rot="60000" flipV="1">
            <a:off x="10763585" y="5568096"/>
            <a:ext cx="62100" cy="106542"/>
            <a:chOff x="4953375" y="7221921"/>
            <a:chExt cx="82800" cy="142056"/>
          </a:xfrm>
        </p:grpSpPr>
        <p:sp>
          <p:nvSpPr>
            <p:cNvPr id="507" name="Rectángulo 50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508" name="Conector recto 50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9" name="Grupo 508"/>
          <p:cNvGrpSpPr/>
          <p:nvPr/>
        </p:nvGrpSpPr>
        <p:grpSpPr>
          <a:xfrm rot="21540000" flipH="1" flipV="1">
            <a:off x="10837158" y="5567966"/>
            <a:ext cx="62100" cy="106542"/>
            <a:chOff x="4953375" y="7221921"/>
            <a:chExt cx="82800" cy="142056"/>
          </a:xfrm>
        </p:grpSpPr>
        <p:sp>
          <p:nvSpPr>
            <p:cNvPr id="510" name="Rectángulo 50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511" name="Conector recto 51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2" name="Grupo 511"/>
          <p:cNvGrpSpPr/>
          <p:nvPr/>
        </p:nvGrpSpPr>
        <p:grpSpPr>
          <a:xfrm rot="60000" flipV="1">
            <a:off x="10908363" y="5567284"/>
            <a:ext cx="62100" cy="106542"/>
            <a:chOff x="4953375" y="7221921"/>
            <a:chExt cx="82800" cy="142056"/>
          </a:xfrm>
        </p:grpSpPr>
        <p:sp>
          <p:nvSpPr>
            <p:cNvPr id="513" name="Rectángulo 512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514" name="Conector recto 513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740" name="Gráfico 7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4961680"/>
              </p:ext>
            </p:extLst>
          </p:nvPr>
        </p:nvGraphicFramePr>
        <p:xfrm>
          <a:off x="103768" y="524621"/>
          <a:ext cx="4490674" cy="24668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41" name="CuadroTexto 740"/>
          <p:cNvSpPr txBox="1"/>
          <p:nvPr/>
        </p:nvSpPr>
        <p:spPr>
          <a:xfrm>
            <a:off x="2118869" y="2656181"/>
            <a:ext cx="8432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cle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2" name="CuadroTexto 741"/>
          <p:cNvSpPr txBox="1"/>
          <p:nvPr/>
        </p:nvSpPr>
        <p:spPr>
          <a:xfrm rot="16200000">
            <a:off x="-631750" y="1450345"/>
            <a:ext cx="21130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luorescence (RFU)</a:t>
            </a:r>
          </a:p>
        </p:txBody>
      </p:sp>
      <p:cxnSp>
        <p:nvCxnSpPr>
          <p:cNvPr id="743" name="Conector recto 742"/>
          <p:cNvCxnSpPr/>
          <p:nvPr/>
        </p:nvCxnSpPr>
        <p:spPr>
          <a:xfrm flipV="1">
            <a:off x="973187" y="2137411"/>
            <a:ext cx="3445368" cy="14232"/>
          </a:xfrm>
          <a:prstGeom prst="line">
            <a:avLst/>
          </a:prstGeom>
          <a:ln w="28575">
            <a:solidFill>
              <a:srgbClr val="FFCC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4" name="Rectángulo 743"/>
          <p:cNvSpPr/>
          <p:nvPr/>
        </p:nvSpPr>
        <p:spPr>
          <a:xfrm>
            <a:off x="2398977" y="1841606"/>
            <a:ext cx="786268" cy="2481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5" name="CuadroTexto 744"/>
          <p:cNvSpPr txBox="1"/>
          <p:nvPr/>
        </p:nvSpPr>
        <p:spPr>
          <a:xfrm>
            <a:off x="2229641" y="1818303"/>
            <a:ext cx="972534" cy="348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000"/>
              </a:lnSpc>
            </a:pP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xponential phase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6" name="Conector recto de flecha 745"/>
          <p:cNvCxnSpPr/>
          <p:nvPr/>
        </p:nvCxnSpPr>
        <p:spPr>
          <a:xfrm>
            <a:off x="3115253" y="2071266"/>
            <a:ext cx="251357" cy="14946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7" name="Rectángulo 746"/>
          <p:cNvSpPr/>
          <p:nvPr/>
        </p:nvSpPr>
        <p:spPr>
          <a:xfrm>
            <a:off x="3686838" y="1727747"/>
            <a:ext cx="567832" cy="1991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8" name="CuadroTexto 747"/>
          <p:cNvSpPr txBox="1"/>
          <p:nvPr/>
        </p:nvSpPr>
        <p:spPr>
          <a:xfrm>
            <a:off x="3619670" y="1761615"/>
            <a:ext cx="702733" cy="2277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000"/>
              </a:lnSpc>
            </a:pP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t or Cq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9" name="Conector recto de flecha 748"/>
          <p:cNvCxnSpPr/>
          <p:nvPr/>
        </p:nvCxnSpPr>
        <p:spPr>
          <a:xfrm flipH="1">
            <a:off x="3427834" y="1936843"/>
            <a:ext cx="298976" cy="18752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0" name="Abrir llave 749"/>
          <p:cNvSpPr/>
          <p:nvPr/>
        </p:nvSpPr>
        <p:spPr>
          <a:xfrm rot="932235">
            <a:off x="3351218" y="966098"/>
            <a:ext cx="160270" cy="975037"/>
          </a:xfrm>
          <a:prstGeom prst="leftBrace">
            <a:avLst>
              <a:gd name="adj1" fmla="val 60548"/>
              <a:gd name="adj2" fmla="val 4972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1" name="Rectángulo 750"/>
          <p:cNvSpPr/>
          <p:nvPr/>
        </p:nvSpPr>
        <p:spPr>
          <a:xfrm>
            <a:off x="2790345" y="1295668"/>
            <a:ext cx="528250" cy="1852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2" name="CuadroTexto 751"/>
          <p:cNvSpPr txBox="1"/>
          <p:nvPr/>
        </p:nvSpPr>
        <p:spPr>
          <a:xfrm>
            <a:off x="2695095" y="1323165"/>
            <a:ext cx="684880" cy="348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000"/>
              </a:lnSpc>
            </a:pP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inear phase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3" name="Rectángulo 752"/>
          <p:cNvSpPr/>
          <p:nvPr/>
        </p:nvSpPr>
        <p:spPr>
          <a:xfrm>
            <a:off x="3904769" y="857460"/>
            <a:ext cx="505117" cy="1345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4" name="CuadroTexto 753"/>
          <p:cNvSpPr txBox="1"/>
          <p:nvPr/>
        </p:nvSpPr>
        <p:spPr>
          <a:xfrm>
            <a:off x="3798288" y="826908"/>
            <a:ext cx="684880" cy="220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000"/>
              </a:lnSpc>
            </a:pP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ateau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5" name="Rectángulo 754"/>
          <p:cNvSpPr/>
          <p:nvPr/>
        </p:nvSpPr>
        <p:spPr>
          <a:xfrm>
            <a:off x="1525480" y="1928341"/>
            <a:ext cx="528250" cy="1852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6" name="CuadroTexto 755"/>
          <p:cNvSpPr txBox="1"/>
          <p:nvPr/>
        </p:nvSpPr>
        <p:spPr>
          <a:xfrm>
            <a:off x="1394915" y="1966786"/>
            <a:ext cx="810464" cy="220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reshol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7" name="CuadroTexto 756"/>
          <p:cNvSpPr txBox="1"/>
          <p:nvPr/>
        </p:nvSpPr>
        <p:spPr>
          <a:xfrm>
            <a:off x="10074439" y="2174230"/>
            <a:ext cx="948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758" name="Rectángulo 757"/>
          <p:cNvSpPr/>
          <p:nvPr/>
        </p:nvSpPr>
        <p:spPr>
          <a:xfrm>
            <a:off x="9668784" y="680063"/>
            <a:ext cx="2405246" cy="187960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9" name="Rectángulo 758"/>
          <p:cNvSpPr/>
          <p:nvPr/>
        </p:nvSpPr>
        <p:spPr>
          <a:xfrm>
            <a:off x="7255200" y="680063"/>
            <a:ext cx="2398315" cy="187960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0" name="Rectángulo 759"/>
          <p:cNvSpPr/>
          <p:nvPr/>
        </p:nvSpPr>
        <p:spPr>
          <a:xfrm>
            <a:off x="4863941" y="681100"/>
            <a:ext cx="2372836" cy="187960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1" name="Rectángulo 760"/>
          <p:cNvSpPr/>
          <p:nvPr/>
        </p:nvSpPr>
        <p:spPr>
          <a:xfrm>
            <a:off x="5365344" y="1127772"/>
            <a:ext cx="1526400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762" name="Conector recto 761"/>
          <p:cNvCxnSpPr/>
          <p:nvPr/>
        </p:nvCxnSpPr>
        <p:spPr>
          <a:xfrm flipV="1">
            <a:off x="5373878" y="1244331"/>
            <a:ext cx="15264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63" name="Imagen 76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>
            <a:off x="5289369" y="1085667"/>
            <a:ext cx="91418" cy="88266"/>
          </a:xfrm>
          <a:prstGeom prst="rect">
            <a:avLst/>
          </a:prstGeom>
        </p:spPr>
      </p:pic>
      <p:pic>
        <p:nvPicPr>
          <p:cNvPr id="764" name="Imagen 76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>
            <a:off x="6892442" y="1048879"/>
            <a:ext cx="90629" cy="88265"/>
          </a:xfrm>
          <a:prstGeom prst="rect">
            <a:avLst/>
          </a:prstGeom>
        </p:spPr>
      </p:pic>
      <p:pic>
        <p:nvPicPr>
          <p:cNvPr id="765" name="Imagen 76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 rot="10800000">
            <a:off x="6518965" y="2008810"/>
            <a:ext cx="91418" cy="88266"/>
          </a:xfrm>
          <a:prstGeom prst="rect">
            <a:avLst/>
          </a:prstGeom>
        </p:spPr>
      </p:pic>
      <p:pic>
        <p:nvPicPr>
          <p:cNvPr id="766" name="Imagen 76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 rot="10800000">
            <a:off x="4879355" y="2019192"/>
            <a:ext cx="90629" cy="88265"/>
          </a:xfrm>
          <a:prstGeom prst="rect">
            <a:avLst/>
          </a:prstGeom>
        </p:spPr>
      </p:pic>
      <p:grpSp>
        <p:nvGrpSpPr>
          <p:cNvPr id="767" name="Grupo 766"/>
          <p:cNvGrpSpPr/>
          <p:nvPr/>
        </p:nvGrpSpPr>
        <p:grpSpPr>
          <a:xfrm rot="1560000">
            <a:off x="5465700" y="1715871"/>
            <a:ext cx="62100" cy="106542"/>
            <a:chOff x="4953375" y="7221921"/>
            <a:chExt cx="82800" cy="142056"/>
          </a:xfrm>
        </p:grpSpPr>
        <p:sp>
          <p:nvSpPr>
            <p:cNvPr id="768" name="Rectángulo 767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769" name="Conector recto 768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70" name="Grupo 769"/>
          <p:cNvGrpSpPr/>
          <p:nvPr/>
        </p:nvGrpSpPr>
        <p:grpSpPr>
          <a:xfrm rot="1560000" flipV="1">
            <a:off x="5702763" y="1647031"/>
            <a:ext cx="62100" cy="106542"/>
            <a:chOff x="4953375" y="7221921"/>
            <a:chExt cx="82800" cy="142056"/>
          </a:xfrm>
        </p:grpSpPr>
        <p:sp>
          <p:nvSpPr>
            <p:cNvPr id="771" name="Rectángulo 770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772" name="Conector recto 771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73" name="Grupo 772"/>
          <p:cNvGrpSpPr/>
          <p:nvPr/>
        </p:nvGrpSpPr>
        <p:grpSpPr>
          <a:xfrm rot="1560000" flipV="1">
            <a:off x="6059879" y="1576901"/>
            <a:ext cx="62100" cy="106542"/>
            <a:chOff x="4953375" y="7221921"/>
            <a:chExt cx="82800" cy="142056"/>
          </a:xfrm>
        </p:grpSpPr>
        <p:sp>
          <p:nvSpPr>
            <p:cNvPr id="774" name="Rectángulo 773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775" name="Conector recto 774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76" name="Grupo 775"/>
          <p:cNvGrpSpPr/>
          <p:nvPr/>
        </p:nvGrpSpPr>
        <p:grpSpPr>
          <a:xfrm rot="60000" flipH="1">
            <a:off x="5870939" y="1489928"/>
            <a:ext cx="62100" cy="106542"/>
            <a:chOff x="4953375" y="7221921"/>
            <a:chExt cx="82800" cy="142056"/>
          </a:xfrm>
        </p:grpSpPr>
        <p:sp>
          <p:nvSpPr>
            <p:cNvPr id="777" name="Rectángulo 77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778" name="Conector recto 77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79" name="Grupo 778"/>
          <p:cNvGrpSpPr/>
          <p:nvPr/>
        </p:nvGrpSpPr>
        <p:grpSpPr>
          <a:xfrm rot="20040000" flipH="1" flipV="1">
            <a:off x="6132327" y="1751980"/>
            <a:ext cx="62100" cy="106542"/>
            <a:chOff x="4953375" y="7221921"/>
            <a:chExt cx="82800" cy="142056"/>
          </a:xfrm>
        </p:grpSpPr>
        <p:sp>
          <p:nvSpPr>
            <p:cNvPr id="780" name="Rectángulo 77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781" name="Conector recto 78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82" name="Grupo 781"/>
          <p:cNvGrpSpPr/>
          <p:nvPr/>
        </p:nvGrpSpPr>
        <p:grpSpPr>
          <a:xfrm rot="20040000" flipH="1" flipV="1">
            <a:off x="5692589" y="1407538"/>
            <a:ext cx="62100" cy="106542"/>
            <a:chOff x="4953375" y="7221921"/>
            <a:chExt cx="82800" cy="142056"/>
          </a:xfrm>
        </p:grpSpPr>
        <p:sp>
          <p:nvSpPr>
            <p:cNvPr id="783" name="Rectángulo 782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784" name="Conector recto 783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85" name="Circular 131"/>
          <p:cNvSpPr/>
          <p:nvPr/>
        </p:nvSpPr>
        <p:spPr>
          <a:xfrm rot="9187987">
            <a:off x="5128810" y="1393183"/>
            <a:ext cx="193512" cy="16387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sp>
        <p:nvSpPr>
          <p:cNvPr id="786" name="Circular 131"/>
          <p:cNvSpPr/>
          <p:nvPr/>
        </p:nvSpPr>
        <p:spPr>
          <a:xfrm rot="2227260">
            <a:off x="6419738" y="1629791"/>
            <a:ext cx="175841" cy="13620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grpSp>
        <p:nvGrpSpPr>
          <p:cNvPr id="787" name="Grupo 786"/>
          <p:cNvGrpSpPr/>
          <p:nvPr/>
        </p:nvGrpSpPr>
        <p:grpSpPr>
          <a:xfrm rot="20040000" flipH="1" flipV="1">
            <a:off x="6097028" y="1339464"/>
            <a:ext cx="62100" cy="106542"/>
            <a:chOff x="4953375" y="7221921"/>
            <a:chExt cx="82800" cy="142056"/>
          </a:xfrm>
        </p:grpSpPr>
        <p:sp>
          <p:nvSpPr>
            <p:cNvPr id="788" name="Rectángulo 787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789" name="Conector recto 788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90" name="Grupo 789"/>
          <p:cNvGrpSpPr/>
          <p:nvPr/>
        </p:nvGrpSpPr>
        <p:grpSpPr>
          <a:xfrm rot="1200000" flipH="1" flipV="1">
            <a:off x="5018619" y="1681626"/>
            <a:ext cx="189000" cy="130469"/>
            <a:chOff x="4079020" y="6879809"/>
            <a:chExt cx="252000" cy="173958"/>
          </a:xfrm>
        </p:grpSpPr>
        <p:sp>
          <p:nvSpPr>
            <p:cNvPr id="791" name="Forma libre 790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792" name="Conector recto 791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93" name="Grupo 792"/>
          <p:cNvGrpSpPr/>
          <p:nvPr/>
        </p:nvGrpSpPr>
        <p:grpSpPr>
          <a:xfrm rot="20778971">
            <a:off x="6631879" y="1383237"/>
            <a:ext cx="189000" cy="130469"/>
            <a:chOff x="4079020" y="6879809"/>
            <a:chExt cx="252000" cy="173958"/>
          </a:xfrm>
        </p:grpSpPr>
        <p:sp>
          <p:nvSpPr>
            <p:cNvPr id="794" name="Forma libre 793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795" name="Conector recto 794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96" name="Grupo 795"/>
          <p:cNvGrpSpPr/>
          <p:nvPr/>
        </p:nvGrpSpPr>
        <p:grpSpPr>
          <a:xfrm rot="20040000">
            <a:off x="5557212" y="1530440"/>
            <a:ext cx="62100" cy="106542"/>
            <a:chOff x="4953375" y="7221921"/>
            <a:chExt cx="82800" cy="142056"/>
          </a:xfrm>
        </p:grpSpPr>
        <p:sp>
          <p:nvSpPr>
            <p:cNvPr id="797" name="Rectángulo 79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798" name="Conector recto 79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99" name="Grupo 798"/>
          <p:cNvGrpSpPr/>
          <p:nvPr/>
        </p:nvGrpSpPr>
        <p:grpSpPr>
          <a:xfrm rot="1560000" flipV="1">
            <a:off x="5368489" y="1546239"/>
            <a:ext cx="62100" cy="106542"/>
            <a:chOff x="4953375" y="7221921"/>
            <a:chExt cx="82800" cy="142056"/>
          </a:xfrm>
        </p:grpSpPr>
        <p:sp>
          <p:nvSpPr>
            <p:cNvPr id="800" name="Rectángulo 79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01" name="Conector recto 80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02" name="Rectángulo 801"/>
          <p:cNvSpPr/>
          <p:nvPr/>
        </p:nvSpPr>
        <p:spPr>
          <a:xfrm>
            <a:off x="4983696" y="1974361"/>
            <a:ext cx="1526400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803" name="Conector recto 802"/>
          <p:cNvCxnSpPr/>
          <p:nvPr/>
        </p:nvCxnSpPr>
        <p:spPr>
          <a:xfrm flipV="1">
            <a:off x="4979531" y="1944872"/>
            <a:ext cx="15372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04" name="Grupo 803"/>
          <p:cNvGrpSpPr/>
          <p:nvPr/>
        </p:nvGrpSpPr>
        <p:grpSpPr>
          <a:xfrm rot="60000" flipV="1">
            <a:off x="8481748" y="1146877"/>
            <a:ext cx="62100" cy="106542"/>
            <a:chOff x="4953375" y="7221921"/>
            <a:chExt cx="82800" cy="142056"/>
          </a:xfrm>
        </p:grpSpPr>
        <p:sp>
          <p:nvSpPr>
            <p:cNvPr id="805" name="Rectángulo 804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06" name="Conector recto 805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7" name="Grupo 806"/>
          <p:cNvGrpSpPr/>
          <p:nvPr/>
        </p:nvGrpSpPr>
        <p:grpSpPr>
          <a:xfrm rot="21540000" flipH="1" flipV="1">
            <a:off x="8555321" y="1146747"/>
            <a:ext cx="62100" cy="106542"/>
            <a:chOff x="4953375" y="7221921"/>
            <a:chExt cx="82800" cy="142056"/>
          </a:xfrm>
        </p:grpSpPr>
        <p:sp>
          <p:nvSpPr>
            <p:cNvPr id="808" name="Rectángulo 807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09" name="Conector recto 808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0" name="Grupo 809"/>
          <p:cNvGrpSpPr/>
          <p:nvPr/>
        </p:nvGrpSpPr>
        <p:grpSpPr>
          <a:xfrm rot="60000" flipV="1">
            <a:off x="8626526" y="1146065"/>
            <a:ext cx="62100" cy="106542"/>
            <a:chOff x="4953375" y="7221921"/>
            <a:chExt cx="82800" cy="142056"/>
          </a:xfrm>
        </p:grpSpPr>
        <p:sp>
          <p:nvSpPr>
            <p:cNvPr id="811" name="Rectángulo 810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12" name="Conector recto 811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3" name="Grupo 812"/>
          <p:cNvGrpSpPr/>
          <p:nvPr/>
        </p:nvGrpSpPr>
        <p:grpSpPr>
          <a:xfrm rot="60000" flipV="1">
            <a:off x="8262149" y="1146897"/>
            <a:ext cx="62100" cy="106542"/>
            <a:chOff x="4953375" y="7221921"/>
            <a:chExt cx="82800" cy="142056"/>
          </a:xfrm>
        </p:grpSpPr>
        <p:sp>
          <p:nvSpPr>
            <p:cNvPr id="814" name="Rectángulo 813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15" name="Conector recto 814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6" name="Grupo 815"/>
          <p:cNvGrpSpPr/>
          <p:nvPr/>
        </p:nvGrpSpPr>
        <p:grpSpPr>
          <a:xfrm rot="21540000" flipH="1" flipV="1">
            <a:off x="8335722" y="1146767"/>
            <a:ext cx="62100" cy="106542"/>
            <a:chOff x="4953375" y="7221921"/>
            <a:chExt cx="82800" cy="142056"/>
          </a:xfrm>
        </p:grpSpPr>
        <p:sp>
          <p:nvSpPr>
            <p:cNvPr id="817" name="Rectángulo 81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18" name="Conector recto 81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9" name="Grupo 818"/>
          <p:cNvGrpSpPr/>
          <p:nvPr/>
        </p:nvGrpSpPr>
        <p:grpSpPr>
          <a:xfrm rot="60000" flipV="1">
            <a:off x="8406927" y="1146085"/>
            <a:ext cx="62100" cy="106542"/>
            <a:chOff x="4953375" y="7221921"/>
            <a:chExt cx="82800" cy="142056"/>
          </a:xfrm>
        </p:grpSpPr>
        <p:sp>
          <p:nvSpPr>
            <p:cNvPr id="820" name="Rectángulo 81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21" name="Conector recto 82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2" name="Grupo 821"/>
          <p:cNvGrpSpPr/>
          <p:nvPr/>
        </p:nvGrpSpPr>
        <p:grpSpPr>
          <a:xfrm rot="60000" flipV="1">
            <a:off x="8701629" y="1146877"/>
            <a:ext cx="62100" cy="106542"/>
            <a:chOff x="4953375" y="7221921"/>
            <a:chExt cx="82800" cy="142056"/>
          </a:xfrm>
        </p:grpSpPr>
        <p:sp>
          <p:nvSpPr>
            <p:cNvPr id="823" name="Rectángulo 822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24" name="Conector recto 823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5" name="Grupo 824"/>
          <p:cNvGrpSpPr/>
          <p:nvPr/>
        </p:nvGrpSpPr>
        <p:grpSpPr>
          <a:xfrm rot="21540000" flipH="1" flipV="1">
            <a:off x="8775202" y="1146747"/>
            <a:ext cx="62100" cy="106542"/>
            <a:chOff x="4953375" y="7221921"/>
            <a:chExt cx="82800" cy="142056"/>
          </a:xfrm>
        </p:grpSpPr>
        <p:sp>
          <p:nvSpPr>
            <p:cNvPr id="826" name="Rectángulo 825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27" name="Conector recto 826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8" name="Grupo 827"/>
          <p:cNvGrpSpPr/>
          <p:nvPr/>
        </p:nvGrpSpPr>
        <p:grpSpPr>
          <a:xfrm rot="60000" flipV="1">
            <a:off x="8846407" y="1146065"/>
            <a:ext cx="62100" cy="106542"/>
            <a:chOff x="4953375" y="7221921"/>
            <a:chExt cx="82800" cy="142056"/>
          </a:xfrm>
        </p:grpSpPr>
        <p:sp>
          <p:nvSpPr>
            <p:cNvPr id="829" name="Rectángulo 828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30" name="Conector recto 829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31" name="Estrella de 5 puntas 830"/>
          <p:cNvSpPr/>
          <p:nvPr/>
        </p:nvSpPr>
        <p:spPr>
          <a:xfrm>
            <a:off x="6221993" y="1452708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2" name="Estrella de 5 puntas 831"/>
          <p:cNvSpPr/>
          <p:nvPr/>
        </p:nvSpPr>
        <p:spPr>
          <a:xfrm>
            <a:off x="5832902" y="1273779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3" name="Estrella de 5 puntas 832"/>
          <p:cNvSpPr/>
          <p:nvPr/>
        </p:nvSpPr>
        <p:spPr>
          <a:xfrm>
            <a:off x="5836963" y="1667977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4" name="Estrella de 5 puntas 833"/>
          <p:cNvSpPr/>
          <p:nvPr/>
        </p:nvSpPr>
        <p:spPr>
          <a:xfrm>
            <a:off x="5393414" y="1330407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5" name="Estrella de 5 puntas 834"/>
          <p:cNvSpPr/>
          <p:nvPr/>
        </p:nvSpPr>
        <p:spPr>
          <a:xfrm>
            <a:off x="6386023" y="1304474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6" name="Estrella de 5 puntas 835"/>
          <p:cNvSpPr/>
          <p:nvPr/>
        </p:nvSpPr>
        <p:spPr>
          <a:xfrm>
            <a:off x="6789836" y="1522999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7" name="Estrella de 5 puntas 836"/>
          <p:cNvSpPr/>
          <p:nvPr/>
        </p:nvSpPr>
        <p:spPr>
          <a:xfrm>
            <a:off x="6279845" y="1722932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8" name="CuadroTexto 837"/>
          <p:cNvSpPr txBox="1"/>
          <p:nvPr/>
        </p:nvSpPr>
        <p:spPr>
          <a:xfrm>
            <a:off x="6463978" y="1622637"/>
            <a:ext cx="8152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lang="es-CO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on </a:t>
            </a:r>
          </a:p>
          <a:p>
            <a:pPr algn="ctr">
              <a:lnSpc>
                <a:spcPts val="800"/>
              </a:lnSpc>
            </a:pPr>
            <a:r>
              <a:rPr lang="es-CO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Fluorescent </a:t>
            </a:r>
          </a:p>
          <a:p>
            <a:pPr algn="ctr">
              <a:lnSpc>
                <a:spcPts val="800"/>
              </a:lnSpc>
            </a:pPr>
            <a:r>
              <a:rPr lang="es-CO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ybr Gree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9" name="Estrella de 5 puntas 838"/>
          <p:cNvSpPr/>
          <p:nvPr/>
        </p:nvSpPr>
        <p:spPr>
          <a:xfrm>
            <a:off x="6952583" y="1448522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0" name="Rectángulo 839"/>
          <p:cNvSpPr/>
          <p:nvPr/>
        </p:nvSpPr>
        <p:spPr>
          <a:xfrm>
            <a:off x="7570023" y="976210"/>
            <a:ext cx="1526400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841" name="Conector recto 840"/>
          <p:cNvCxnSpPr/>
          <p:nvPr/>
        </p:nvCxnSpPr>
        <p:spPr>
          <a:xfrm flipV="1">
            <a:off x="7578557" y="1092769"/>
            <a:ext cx="15264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42" name="Imagen 84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>
            <a:off x="7494048" y="934105"/>
            <a:ext cx="91418" cy="88266"/>
          </a:xfrm>
          <a:prstGeom prst="rect">
            <a:avLst/>
          </a:prstGeom>
        </p:spPr>
      </p:pic>
      <p:pic>
        <p:nvPicPr>
          <p:cNvPr id="843" name="Imagen 84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>
            <a:off x="9097121" y="897317"/>
            <a:ext cx="90629" cy="88265"/>
          </a:xfrm>
          <a:prstGeom prst="rect">
            <a:avLst/>
          </a:prstGeom>
        </p:spPr>
      </p:pic>
      <p:pic>
        <p:nvPicPr>
          <p:cNvPr id="844" name="Imagen 84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 rot="10800000">
            <a:off x="9324777" y="2168398"/>
            <a:ext cx="91418" cy="88266"/>
          </a:xfrm>
          <a:prstGeom prst="rect">
            <a:avLst/>
          </a:prstGeom>
        </p:spPr>
      </p:pic>
      <p:pic>
        <p:nvPicPr>
          <p:cNvPr id="845" name="Imagen 84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 rot="10800000">
            <a:off x="7685167" y="2178780"/>
            <a:ext cx="90629" cy="88265"/>
          </a:xfrm>
          <a:prstGeom prst="rect">
            <a:avLst/>
          </a:prstGeom>
        </p:spPr>
      </p:pic>
      <p:grpSp>
        <p:nvGrpSpPr>
          <p:cNvPr id="846" name="Grupo 845"/>
          <p:cNvGrpSpPr/>
          <p:nvPr/>
        </p:nvGrpSpPr>
        <p:grpSpPr>
          <a:xfrm rot="1560000">
            <a:off x="8781473" y="1702471"/>
            <a:ext cx="62100" cy="106542"/>
            <a:chOff x="4953375" y="7221921"/>
            <a:chExt cx="82800" cy="142056"/>
          </a:xfrm>
        </p:grpSpPr>
        <p:sp>
          <p:nvSpPr>
            <p:cNvPr id="847" name="Rectángulo 84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48" name="Conector recto 84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49" name="Grupo 848"/>
          <p:cNvGrpSpPr/>
          <p:nvPr/>
        </p:nvGrpSpPr>
        <p:grpSpPr>
          <a:xfrm rot="1560000" flipV="1">
            <a:off x="9018536" y="1633631"/>
            <a:ext cx="62100" cy="106542"/>
            <a:chOff x="4953375" y="7221921"/>
            <a:chExt cx="82800" cy="142056"/>
          </a:xfrm>
        </p:grpSpPr>
        <p:sp>
          <p:nvSpPr>
            <p:cNvPr id="850" name="Rectángulo 84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51" name="Conector recto 85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52" name="Grupo 851"/>
          <p:cNvGrpSpPr/>
          <p:nvPr/>
        </p:nvGrpSpPr>
        <p:grpSpPr>
          <a:xfrm rot="1560000" flipV="1">
            <a:off x="8774519" y="1563501"/>
            <a:ext cx="62100" cy="106542"/>
            <a:chOff x="4953375" y="7221921"/>
            <a:chExt cx="82800" cy="142056"/>
          </a:xfrm>
        </p:grpSpPr>
        <p:sp>
          <p:nvSpPr>
            <p:cNvPr id="853" name="Rectángulo 852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54" name="Conector recto 853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55" name="Grupo 854"/>
          <p:cNvGrpSpPr/>
          <p:nvPr/>
        </p:nvGrpSpPr>
        <p:grpSpPr>
          <a:xfrm rot="60000" flipH="1">
            <a:off x="8585579" y="1476528"/>
            <a:ext cx="62100" cy="106542"/>
            <a:chOff x="4953375" y="7221921"/>
            <a:chExt cx="82800" cy="142056"/>
          </a:xfrm>
        </p:grpSpPr>
        <p:sp>
          <p:nvSpPr>
            <p:cNvPr id="856" name="Rectángulo 855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57" name="Conector recto 856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58" name="Grupo 857"/>
          <p:cNvGrpSpPr/>
          <p:nvPr/>
        </p:nvGrpSpPr>
        <p:grpSpPr>
          <a:xfrm flipH="1" flipV="1">
            <a:off x="7817683" y="1710673"/>
            <a:ext cx="62100" cy="106542"/>
            <a:chOff x="4953375" y="7221921"/>
            <a:chExt cx="82800" cy="142056"/>
          </a:xfrm>
        </p:grpSpPr>
        <p:sp>
          <p:nvSpPr>
            <p:cNvPr id="859" name="Rectángulo 858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60" name="Conector recto 859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61" name="Grupo 860"/>
          <p:cNvGrpSpPr/>
          <p:nvPr/>
        </p:nvGrpSpPr>
        <p:grpSpPr>
          <a:xfrm rot="20040000" flipH="1" flipV="1">
            <a:off x="8407229" y="1394138"/>
            <a:ext cx="62100" cy="106542"/>
            <a:chOff x="4953375" y="7221921"/>
            <a:chExt cx="82800" cy="142056"/>
          </a:xfrm>
        </p:grpSpPr>
        <p:sp>
          <p:nvSpPr>
            <p:cNvPr id="862" name="Rectángulo 861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63" name="Conector recto 862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64" name="Circular 131"/>
          <p:cNvSpPr/>
          <p:nvPr/>
        </p:nvSpPr>
        <p:spPr>
          <a:xfrm rot="1475539">
            <a:off x="8649457" y="1941570"/>
            <a:ext cx="175841" cy="13620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grpSp>
        <p:nvGrpSpPr>
          <p:cNvPr id="865" name="Grupo 864"/>
          <p:cNvGrpSpPr/>
          <p:nvPr/>
        </p:nvGrpSpPr>
        <p:grpSpPr>
          <a:xfrm rot="20040000" flipH="1" flipV="1">
            <a:off x="8811668" y="1326064"/>
            <a:ext cx="62100" cy="106542"/>
            <a:chOff x="4953375" y="7221921"/>
            <a:chExt cx="82800" cy="142056"/>
          </a:xfrm>
        </p:grpSpPr>
        <p:sp>
          <p:nvSpPr>
            <p:cNvPr id="866" name="Rectángulo 865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67" name="Conector recto 866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68" name="Grupo 867"/>
          <p:cNvGrpSpPr/>
          <p:nvPr/>
        </p:nvGrpSpPr>
        <p:grpSpPr>
          <a:xfrm flipH="1" flipV="1">
            <a:off x="7793537" y="1919648"/>
            <a:ext cx="189000" cy="130469"/>
            <a:chOff x="4079020" y="6879809"/>
            <a:chExt cx="252000" cy="173958"/>
          </a:xfrm>
        </p:grpSpPr>
        <p:sp>
          <p:nvSpPr>
            <p:cNvPr id="869" name="Forma libre 868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70" name="Conector recto 869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71" name="Grupo 870"/>
          <p:cNvGrpSpPr/>
          <p:nvPr/>
        </p:nvGrpSpPr>
        <p:grpSpPr>
          <a:xfrm>
            <a:off x="8917819" y="1148734"/>
            <a:ext cx="189000" cy="130469"/>
            <a:chOff x="4079020" y="6879809"/>
            <a:chExt cx="252000" cy="173958"/>
          </a:xfrm>
        </p:grpSpPr>
        <p:sp>
          <p:nvSpPr>
            <p:cNvPr id="872" name="Forma libre 871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73" name="Conector recto 872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74" name="Grupo 873"/>
          <p:cNvGrpSpPr/>
          <p:nvPr/>
        </p:nvGrpSpPr>
        <p:grpSpPr>
          <a:xfrm rot="20040000">
            <a:off x="8271852" y="1517040"/>
            <a:ext cx="62100" cy="106542"/>
            <a:chOff x="4953375" y="7221921"/>
            <a:chExt cx="82800" cy="142056"/>
          </a:xfrm>
        </p:grpSpPr>
        <p:sp>
          <p:nvSpPr>
            <p:cNvPr id="875" name="Rectángulo 874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76" name="Conector recto 875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77" name="Grupo 876"/>
          <p:cNvGrpSpPr/>
          <p:nvPr/>
        </p:nvGrpSpPr>
        <p:grpSpPr>
          <a:xfrm rot="1560000" flipV="1">
            <a:off x="8083129" y="1532839"/>
            <a:ext cx="62100" cy="106542"/>
            <a:chOff x="4953375" y="7221921"/>
            <a:chExt cx="82800" cy="142056"/>
          </a:xfrm>
        </p:grpSpPr>
        <p:sp>
          <p:nvSpPr>
            <p:cNvPr id="878" name="Rectángulo 877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79" name="Conector recto 878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80" name="Rectángulo 879"/>
          <p:cNvSpPr/>
          <p:nvPr/>
        </p:nvSpPr>
        <p:spPr>
          <a:xfrm>
            <a:off x="7789508" y="2133949"/>
            <a:ext cx="1526400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881" name="Conector recto 880"/>
          <p:cNvCxnSpPr/>
          <p:nvPr/>
        </p:nvCxnSpPr>
        <p:spPr>
          <a:xfrm flipV="1">
            <a:off x="7785343" y="2104460"/>
            <a:ext cx="15372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2" name="Estrella de 5 puntas 881"/>
          <p:cNvSpPr/>
          <p:nvPr/>
        </p:nvSpPr>
        <p:spPr>
          <a:xfrm>
            <a:off x="7755027" y="1296818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3" name="Estrella de 5 puntas 882"/>
          <p:cNvSpPr/>
          <p:nvPr/>
        </p:nvSpPr>
        <p:spPr>
          <a:xfrm rot="1560000">
            <a:off x="8313355" y="1679274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4" name="Estrella de 5 puntas 883"/>
          <p:cNvSpPr/>
          <p:nvPr/>
        </p:nvSpPr>
        <p:spPr>
          <a:xfrm>
            <a:off x="9066477" y="1406611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5" name="Estrella de 5 puntas 884"/>
          <p:cNvSpPr/>
          <p:nvPr/>
        </p:nvSpPr>
        <p:spPr>
          <a:xfrm>
            <a:off x="8917038" y="1764261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6" name="Estrella de 5 puntas 885"/>
          <p:cNvSpPr/>
          <p:nvPr/>
        </p:nvSpPr>
        <p:spPr>
          <a:xfrm>
            <a:off x="8033877" y="1333696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7" name="Estrella de 5 puntas 886"/>
          <p:cNvSpPr/>
          <p:nvPr/>
        </p:nvSpPr>
        <p:spPr>
          <a:xfrm rot="1560000">
            <a:off x="7874059" y="1507093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8" name="Estrella de 5 puntas 887"/>
          <p:cNvSpPr/>
          <p:nvPr/>
        </p:nvSpPr>
        <p:spPr>
          <a:xfrm rot="1560000">
            <a:off x="7965201" y="1681625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9" name="Estrella de 5 puntas 888"/>
          <p:cNvSpPr/>
          <p:nvPr/>
        </p:nvSpPr>
        <p:spPr>
          <a:xfrm rot="1560000">
            <a:off x="8614253" y="1618161"/>
            <a:ext cx="133588" cy="114835"/>
          </a:xfrm>
          <a:prstGeom prst="star5">
            <a:avLst/>
          </a:prstGeom>
          <a:solidFill>
            <a:srgbClr val="00B05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890" name="Grupo 889"/>
          <p:cNvGrpSpPr/>
          <p:nvPr/>
        </p:nvGrpSpPr>
        <p:grpSpPr>
          <a:xfrm rot="21540000">
            <a:off x="8209452" y="1943760"/>
            <a:ext cx="62100" cy="106542"/>
            <a:chOff x="4953375" y="7221921"/>
            <a:chExt cx="82800" cy="142056"/>
          </a:xfrm>
        </p:grpSpPr>
        <p:sp>
          <p:nvSpPr>
            <p:cNvPr id="891" name="Rectángulo 890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92" name="Conector recto 891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93" name="Grupo 892"/>
          <p:cNvGrpSpPr/>
          <p:nvPr/>
        </p:nvGrpSpPr>
        <p:grpSpPr>
          <a:xfrm rot="60000" flipH="1">
            <a:off x="8283025" y="1943630"/>
            <a:ext cx="62100" cy="106542"/>
            <a:chOff x="4953375" y="7221921"/>
            <a:chExt cx="82800" cy="142056"/>
          </a:xfrm>
        </p:grpSpPr>
        <p:sp>
          <p:nvSpPr>
            <p:cNvPr id="894" name="Rectángulo 893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95" name="Conector recto 894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96" name="Grupo 895"/>
          <p:cNvGrpSpPr/>
          <p:nvPr/>
        </p:nvGrpSpPr>
        <p:grpSpPr>
          <a:xfrm rot="21540000">
            <a:off x="8354230" y="1942948"/>
            <a:ext cx="62100" cy="106542"/>
            <a:chOff x="4953375" y="7221921"/>
            <a:chExt cx="82800" cy="142056"/>
          </a:xfrm>
        </p:grpSpPr>
        <p:sp>
          <p:nvSpPr>
            <p:cNvPr id="897" name="Rectángulo 89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98" name="Conector recto 89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99" name="Grupo 898"/>
          <p:cNvGrpSpPr/>
          <p:nvPr/>
        </p:nvGrpSpPr>
        <p:grpSpPr>
          <a:xfrm rot="21540000">
            <a:off x="7989853" y="1943780"/>
            <a:ext cx="62100" cy="106542"/>
            <a:chOff x="4953375" y="7221921"/>
            <a:chExt cx="82800" cy="142056"/>
          </a:xfrm>
        </p:grpSpPr>
        <p:sp>
          <p:nvSpPr>
            <p:cNvPr id="900" name="Rectángulo 89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901" name="Conector recto 90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02" name="Grupo 901"/>
          <p:cNvGrpSpPr/>
          <p:nvPr/>
        </p:nvGrpSpPr>
        <p:grpSpPr>
          <a:xfrm rot="60000" flipH="1">
            <a:off x="8063426" y="1943650"/>
            <a:ext cx="62100" cy="106542"/>
            <a:chOff x="4953375" y="7221921"/>
            <a:chExt cx="82800" cy="142056"/>
          </a:xfrm>
        </p:grpSpPr>
        <p:sp>
          <p:nvSpPr>
            <p:cNvPr id="903" name="Rectángulo 902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904" name="Conector recto 903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05" name="Grupo 904"/>
          <p:cNvGrpSpPr/>
          <p:nvPr/>
        </p:nvGrpSpPr>
        <p:grpSpPr>
          <a:xfrm rot="21540000">
            <a:off x="8134631" y="1942968"/>
            <a:ext cx="62100" cy="106542"/>
            <a:chOff x="4953375" y="7221921"/>
            <a:chExt cx="82800" cy="142056"/>
          </a:xfrm>
        </p:grpSpPr>
        <p:sp>
          <p:nvSpPr>
            <p:cNvPr id="906" name="Rectángulo 905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907" name="Conector recto 906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08" name="Grupo 907"/>
          <p:cNvGrpSpPr/>
          <p:nvPr/>
        </p:nvGrpSpPr>
        <p:grpSpPr>
          <a:xfrm rot="21540000">
            <a:off x="8429333" y="1943760"/>
            <a:ext cx="62100" cy="106542"/>
            <a:chOff x="4953375" y="7221921"/>
            <a:chExt cx="82800" cy="142056"/>
          </a:xfrm>
        </p:grpSpPr>
        <p:sp>
          <p:nvSpPr>
            <p:cNvPr id="909" name="Rectángulo 908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910" name="Conector recto 909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11" name="Grupo 910"/>
          <p:cNvGrpSpPr/>
          <p:nvPr/>
        </p:nvGrpSpPr>
        <p:grpSpPr>
          <a:xfrm rot="60000" flipH="1">
            <a:off x="8502906" y="1943630"/>
            <a:ext cx="62100" cy="106542"/>
            <a:chOff x="4953375" y="7221921"/>
            <a:chExt cx="82800" cy="142056"/>
          </a:xfrm>
        </p:grpSpPr>
        <p:sp>
          <p:nvSpPr>
            <p:cNvPr id="912" name="Rectángulo 911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913" name="Conector recto 912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14" name="Grupo 913"/>
          <p:cNvGrpSpPr/>
          <p:nvPr/>
        </p:nvGrpSpPr>
        <p:grpSpPr>
          <a:xfrm rot="21540000">
            <a:off x="8574111" y="1942948"/>
            <a:ext cx="62100" cy="106542"/>
            <a:chOff x="4953375" y="7221921"/>
            <a:chExt cx="82800" cy="142056"/>
          </a:xfrm>
        </p:grpSpPr>
        <p:sp>
          <p:nvSpPr>
            <p:cNvPr id="915" name="Rectángulo 914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916" name="Conector recto 915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17" name="Circular 131"/>
          <p:cNvSpPr/>
          <p:nvPr/>
        </p:nvSpPr>
        <p:spPr>
          <a:xfrm rot="20124461" flipH="1">
            <a:off x="8066791" y="1141077"/>
            <a:ext cx="175841" cy="13620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sp>
        <p:nvSpPr>
          <p:cNvPr id="918" name="Rectángulo 917"/>
          <p:cNvSpPr/>
          <p:nvPr/>
        </p:nvSpPr>
        <p:spPr>
          <a:xfrm>
            <a:off x="10027259" y="1027180"/>
            <a:ext cx="1526400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919" name="Conector recto 918"/>
          <p:cNvCxnSpPr/>
          <p:nvPr/>
        </p:nvCxnSpPr>
        <p:spPr>
          <a:xfrm flipV="1">
            <a:off x="10035793" y="1143739"/>
            <a:ext cx="15264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20" name="Imagen 91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>
            <a:off x="9951284" y="985075"/>
            <a:ext cx="91418" cy="88266"/>
          </a:xfrm>
          <a:prstGeom prst="rect">
            <a:avLst/>
          </a:prstGeom>
        </p:spPr>
      </p:pic>
      <p:pic>
        <p:nvPicPr>
          <p:cNvPr id="921" name="Imagen 92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>
            <a:off x="11554357" y="948287"/>
            <a:ext cx="90629" cy="88265"/>
          </a:xfrm>
          <a:prstGeom prst="rect">
            <a:avLst/>
          </a:prstGeom>
        </p:spPr>
      </p:pic>
      <p:pic>
        <p:nvPicPr>
          <p:cNvPr id="922" name="Imagen 92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 rot="10800000">
            <a:off x="11594559" y="2073858"/>
            <a:ext cx="91418" cy="88266"/>
          </a:xfrm>
          <a:prstGeom prst="rect">
            <a:avLst/>
          </a:prstGeom>
        </p:spPr>
      </p:pic>
      <p:pic>
        <p:nvPicPr>
          <p:cNvPr id="923" name="Imagen 92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 rot="10800000">
            <a:off x="9954949" y="2084240"/>
            <a:ext cx="90629" cy="88265"/>
          </a:xfrm>
          <a:prstGeom prst="rect">
            <a:avLst/>
          </a:prstGeom>
        </p:spPr>
      </p:pic>
      <p:grpSp>
        <p:nvGrpSpPr>
          <p:cNvPr id="924" name="Grupo 923"/>
          <p:cNvGrpSpPr/>
          <p:nvPr/>
        </p:nvGrpSpPr>
        <p:grpSpPr>
          <a:xfrm flipH="1" flipV="1">
            <a:off x="10063319" y="1825108"/>
            <a:ext cx="189000" cy="130469"/>
            <a:chOff x="4079020" y="6879809"/>
            <a:chExt cx="252000" cy="173958"/>
          </a:xfrm>
        </p:grpSpPr>
        <p:sp>
          <p:nvSpPr>
            <p:cNvPr id="925" name="Forma libre 924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926" name="Conector recto 925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27" name="Grupo 926"/>
          <p:cNvGrpSpPr/>
          <p:nvPr/>
        </p:nvGrpSpPr>
        <p:grpSpPr>
          <a:xfrm>
            <a:off x="11375055" y="1199704"/>
            <a:ext cx="189000" cy="130469"/>
            <a:chOff x="4079020" y="6879809"/>
            <a:chExt cx="252000" cy="173958"/>
          </a:xfrm>
        </p:grpSpPr>
        <p:sp>
          <p:nvSpPr>
            <p:cNvPr id="928" name="Forma libre 927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929" name="Conector recto 928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30" name="Rectángulo 929"/>
          <p:cNvSpPr/>
          <p:nvPr/>
        </p:nvSpPr>
        <p:spPr>
          <a:xfrm>
            <a:off x="10059290" y="2039409"/>
            <a:ext cx="1526400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931" name="Conector recto 930"/>
          <p:cNvCxnSpPr/>
          <p:nvPr/>
        </p:nvCxnSpPr>
        <p:spPr>
          <a:xfrm flipV="1">
            <a:off x="10055125" y="2009920"/>
            <a:ext cx="15372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32" name="Imagen 93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 rot="10800000">
            <a:off x="11558740" y="1255577"/>
            <a:ext cx="91418" cy="88266"/>
          </a:xfrm>
          <a:prstGeom prst="rect">
            <a:avLst/>
          </a:prstGeom>
        </p:spPr>
      </p:pic>
      <p:pic>
        <p:nvPicPr>
          <p:cNvPr id="933" name="Imagen 93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 rot="10800000">
            <a:off x="9981944" y="1303876"/>
            <a:ext cx="90629" cy="88265"/>
          </a:xfrm>
          <a:prstGeom prst="rect">
            <a:avLst/>
          </a:prstGeom>
        </p:spPr>
      </p:pic>
      <p:sp>
        <p:nvSpPr>
          <p:cNvPr id="934" name="Rectángulo 933"/>
          <p:cNvSpPr/>
          <p:nvPr/>
        </p:nvSpPr>
        <p:spPr>
          <a:xfrm>
            <a:off x="10079370" y="1245705"/>
            <a:ext cx="1260000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935" name="Conector recto 934"/>
          <p:cNvCxnSpPr/>
          <p:nvPr/>
        </p:nvCxnSpPr>
        <p:spPr>
          <a:xfrm flipV="1">
            <a:off x="10068855" y="1203516"/>
            <a:ext cx="12780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6" name="Rectángulo 935"/>
          <p:cNvSpPr/>
          <p:nvPr/>
        </p:nvSpPr>
        <p:spPr>
          <a:xfrm>
            <a:off x="10300094" y="1823411"/>
            <a:ext cx="1260000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937" name="Conector recto 936"/>
          <p:cNvCxnSpPr/>
          <p:nvPr/>
        </p:nvCxnSpPr>
        <p:spPr>
          <a:xfrm flipV="1">
            <a:off x="10295929" y="1946322"/>
            <a:ext cx="12780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8" name="Estrella de 5 puntas 937"/>
          <p:cNvSpPr/>
          <p:nvPr/>
        </p:nvSpPr>
        <p:spPr>
          <a:xfrm>
            <a:off x="10369028" y="1169598"/>
            <a:ext cx="133588" cy="114835"/>
          </a:xfrm>
          <a:prstGeom prst="star5">
            <a:avLst/>
          </a:prstGeom>
          <a:solidFill>
            <a:srgbClr val="FFFF0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9" name="Estrella de 5 puntas 938"/>
          <p:cNvSpPr/>
          <p:nvPr/>
        </p:nvSpPr>
        <p:spPr>
          <a:xfrm rot="1560000">
            <a:off x="10534807" y="1069664"/>
            <a:ext cx="133588" cy="114835"/>
          </a:xfrm>
          <a:prstGeom prst="star5">
            <a:avLst/>
          </a:prstGeom>
          <a:solidFill>
            <a:srgbClr val="FFFF0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0" name="Estrella de 5 puntas 939"/>
          <p:cNvSpPr/>
          <p:nvPr/>
        </p:nvSpPr>
        <p:spPr>
          <a:xfrm>
            <a:off x="11363139" y="1060334"/>
            <a:ext cx="133588" cy="114835"/>
          </a:xfrm>
          <a:prstGeom prst="star5">
            <a:avLst/>
          </a:prstGeom>
          <a:solidFill>
            <a:srgbClr val="FFFF00"/>
          </a:solidFill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1" name="Estrella de 5 puntas 940"/>
          <p:cNvSpPr/>
          <p:nvPr/>
        </p:nvSpPr>
        <p:spPr>
          <a:xfrm>
            <a:off x="11201990" y="1154651"/>
            <a:ext cx="133588" cy="114835"/>
          </a:xfrm>
          <a:prstGeom prst="star5">
            <a:avLst/>
          </a:prstGeom>
          <a:solidFill>
            <a:srgbClr val="FFFF00"/>
          </a:solidFill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2" name="Estrella de 5 puntas 941"/>
          <p:cNvSpPr/>
          <p:nvPr/>
        </p:nvSpPr>
        <p:spPr>
          <a:xfrm>
            <a:off x="11017241" y="1080464"/>
            <a:ext cx="133588" cy="114835"/>
          </a:xfrm>
          <a:prstGeom prst="star5">
            <a:avLst/>
          </a:prstGeom>
          <a:solidFill>
            <a:srgbClr val="FFFF00"/>
          </a:solidFill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3" name="Estrella de 5 puntas 942"/>
          <p:cNvSpPr/>
          <p:nvPr/>
        </p:nvSpPr>
        <p:spPr>
          <a:xfrm rot="1560000">
            <a:off x="10013087" y="1122122"/>
            <a:ext cx="133588" cy="114835"/>
          </a:xfrm>
          <a:prstGeom prst="star5">
            <a:avLst/>
          </a:prstGeom>
          <a:solidFill>
            <a:srgbClr val="FFFF0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4" name="Estrella de 5 puntas 943"/>
          <p:cNvSpPr/>
          <p:nvPr/>
        </p:nvSpPr>
        <p:spPr>
          <a:xfrm rot="1560000">
            <a:off x="10186653" y="1072015"/>
            <a:ext cx="133588" cy="114835"/>
          </a:xfrm>
          <a:prstGeom prst="star5">
            <a:avLst/>
          </a:prstGeom>
          <a:solidFill>
            <a:srgbClr val="FFFF0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5" name="Estrella de 5 puntas 944"/>
          <p:cNvSpPr/>
          <p:nvPr/>
        </p:nvSpPr>
        <p:spPr>
          <a:xfrm rot="1560000">
            <a:off x="10765855" y="1135551"/>
            <a:ext cx="133588" cy="114835"/>
          </a:xfrm>
          <a:prstGeom prst="star5">
            <a:avLst/>
          </a:prstGeom>
          <a:solidFill>
            <a:srgbClr val="FFFF00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6" name="Estrella de 5 puntas 945"/>
          <p:cNvSpPr/>
          <p:nvPr/>
        </p:nvSpPr>
        <p:spPr>
          <a:xfrm rot="1560000" flipH="1" flipV="1">
            <a:off x="10265368" y="1927058"/>
            <a:ext cx="133588" cy="114835"/>
          </a:xfrm>
          <a:prstGeom prst="star5">
            <a:avLst/>
          </a:prstGeom>
          <a:solidFill>
            <a:srgbClr val="FFFF00"/>
          </a:solidFill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7" name="Estrella de 5 puntas 946"/>
          <p:cNvSpPr/>
          <p:nvPr/>
        </p:nvSpPr>
        <p:spPr>
          <a:xfrm flipH="1" flipV="1">
            <a:off x="10896711" y="2000515"/>
            <a:ext cx="133588" cy="114835"/>
          </a:xfrm>
          <a:prstGeom prst="star5">
            <a:avLst/>
          </a:prstGeom>
          <a:solidFill>
            <a:srgbClr val="FFFF00"/>
          </a:solidFill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8" name="Estrella de 5 puntas 947"/>
          <p:cNvSpPr/>
          <p:nvPr/>
        </p:nvSpPr>
        <p:spPr>
          <a:xfrm flipH="1" flipV="1">
            <a:off x="10723001" y="1935845"/>
            <a:ext cx="133588" cy="114835"/>
          </a:xfrm>
          <a:prstGeom prst="star5">
            <a:avLst/>
          </a:prstGeom>
          <a:solidFill>
            <a:srgbClr val="FFFF00"/>
          </a:solidFill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9" name="Estrella de 5 puntas 948"/>
          <p:cNvSpPr/>
          <p:nvPr/>
        </p:nvSpPr>
        <p:spPr>
          <a:xfrm rot="1560000" flipH="1" flipV="1">
            <a:off x="10521816" y="1878645"/>
            <a:ext cx="133588" cy="114835"/>
          </a:xfrm>
          <a:prstGeom prst="star5">
            <a:avLst/>
          </a:prstGeom>
          <a:solidFill>
            <a:srgbClr val="FFFF00"/>
          </a:solidFill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0" name="Estrella de 5 puntas 949"/>
          <p:cNvSpPr/>
          <p:nvPr/>
        </p:nvSpPr>
        <p:spPr>
          <a:xfrm flipH="1" flipV="1">
            <a:off x="11436659" y="1840685"/>
            <a:ext cx="133588" cy="114835"/>
          </a:xfrm>
          <a:prstGeom prst="star5">
            <a:avLst/>
          </a:prstGeom>
          <a:solidFill>
            <a:srgbClr val="FFFF00"/>
          </a:solidFill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1" name="Estrella de 5 puntas 950"/>
          <p:cNvSpPr/>
          <p:nvPr/>
        </p:nvSpPr>
        <p:spPr>
          <a:xfrm flipH="1" flipV="1">
            <a:off x="11262548" y="1921833"/>
            <a:ext cx="133588" cy="114835"/>
          </a:xfrm>
          <a:prstGeom prst="star5">
            <a:avLst/>
          </a:prstGeom>
          <a:solidFill>
            <a:srgbClr val="FFFF00"/>
          </a:solidFill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2" name="Estrella de 5 puntas 951"/>
          <p:cNvSpPr/>
          <p:nvPr/>
        </p:nvSpPr>
        <p:spPr>
          <a:xfrm rot="1560000" flipH="1" flipV="1">
            <a:off x="10037155" y="1943098"/>
            <a:ext cx="133588" cy="114835"/>
          </a:xfrm>
          <a:prstGeom prst="star5">
            <a:avLst/>
          </a:prstGeom>
          <a:solidFill>
            <a:srgbClr val="FFFF00"/>
          </a:solidFill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3" name="Estrella de 5 puntas 952"/>
          <p:cNvSpPr/>
          <p:nvPr/>
        </p:nvSpPr>
        <p:spPr>
          <a:xfrm rot="1560000" flipH="1" flipV="1">
            <a:off x="11066979" y="1914650"/>
            <a:ext cx="133588" cy="114835"/>
          </a:xfrm>
          <a:prstGeom prst="star5">
            <a:avLst/>
          </a:prstGeom>
          <a:solidFill>
            <a:srgbClr val="FFFF00"/>
          </a:solidFill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4" name="CuadroTexto 953"/>
          <p:cNvSpPr txBox="1"/>
          <p:nvPr/>
        </p:nvSpPr>
        <p:spPr>
          <a:xfrm>
            <a:off x="10433589" y="1299956"/>
            <a:ext cx="1302401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lang="es-CO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Fluorescent </a:t>
            </a:r>
          </a:p>
          <a:p>
            <a:pPr algn="ctr">
              <a:lnSpc>
                <a:spcPts val="800"/>
              </a:lnSpc>
            </a:pPr>
            <a:r>
              <a:rPr lang="es-CO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ntercalated Sybr Gree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55" name="Imagen 95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>
            <a:off x="9992758" y="1787189"/>
            <a:ext cx="91418" cy="88266"/>
          </a:xfrm>
          <a:prstGeom prst="rect">
            <a:avLst/>
          </a:prstGeom>
        </p:spPr>
      </p:pic>
      <p:pic>
        <p:nvPicPr>
          <p:cNvPr id="956" name="Imagen 95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>
            <a:off x="11568905" y="1758738"/>
            <a:ext cx="90629" cy="88265"/>
          </a:xfrm>
          <a:prstGeom prst="rect">
            <a:avLst/>
          </a:prstGeom>
        </p:spPr>
      </p:pic>
      <p:sp>
        <p:nvSpPr>
          <p:cNvPr id="957" name="Estrella de 5 puntas 956"/>
          <p:cNvSpPr/>
          <p:nvPr/>
        </p:nvSpPr>
        <p:spPr>
          <a:xfrm>
            <a:off x="10369028" y="1169599"/>
            <a:ext cx="133588" cy="114835"/>
          </a:xfrm>
          <a:prstGeom prst="star5">
            <a:avLst/>
          </a:prstGeom>
          <a:solidFill>
            <a:srgbClr val="FFFF00"/>
          </a:solidFill>
          <a:ln w="3175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8" name="Estrella de 5 puntas 957"/>
          <p:cNvSpPr/>
          <p:nvPr/>
        </p:nvSpPr>
        <p:spPr>
          <a:xfrm rot="1560000">
            <a:off x="10534807" y="1069665"/>
            <a:ext cx="133588" cy="114835"/>
          </a:xfrm>
          <a:prstGeom prst="star5">
            <a:avLst/>
          </a:prstGeom>
          <a:solidFill>
            <a:srgbClr val="FFFF00"/>
          </a:solidFill>
          <a:ln w="3175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9" name="Estrella de 5 puntas 958"/>
          <p:cNvSpPr/>
          <p:nvPr/>
        </p:nvSpPr>
        <p:spPr>
          <a:xfrm rot="1560000">
            <a:off x="10013087" y="1122123"/>
            <a:ext cx="133588" cy="114835"/>
          </a:xfrm>
          <a:prstGeom prst="star5">
            <a:avLst/>
          </a:prstGeom>
          <a:solidFill>
            <a:srgbClr val="FFFF00"/>
          </a:solidFill>
          <a:ln w="3175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0" name="Estrella de 5 puntas 959"/>
          <p:cNvSpPr/>
          <p:nvPr/>
        </p:nvSpPr>
        <p:spPr>
          <a:xfrm rot="1560000">
            <a:off x="10186653" y="1072016"/>
            <a:ext cx="133588" cy="114835"/>
          </a:xfrm>
          <a:prstGeom prst="star5">
            <a:avLst/>
          </a:prstGeom>
          <a:solidFill>
            <a:srgbClr val="FFFF00"/>
          </a:solidFill>
          <a:ln w="3175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1" name="Estrella de 5 puntas 960"/>
          <p:cNvSpPr/>
          <p:nvPr/>
        </p:nvSpPr>
        <p:spPr>
          <a:xfrm rot="1560000">
            <a:off x="10766205" y="1135551"/>
            <a:ext cx="133588" cy="114835"/>
          </a:xfrm>
          <a:prstGeom prst="star5">
            <a:avLst/>
          </a:prstGeom>
          <a:solidFill>
            <a:srgbClr val="FFFF00"/>
          </a:solidFill>
          <a:ln w="3175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2" name="CuadroTexto 961"/>
          <p:cNvSpPr txBox="1"/>
          <p:nvPr/>
        </p:nvSpPr>
        <p:spPr>
          <a:xfrm>
            <a:off x="5870014" y="2299396"/>
            <a:ext cx="17824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natura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3" name="CuadroTexto 962"/>
          <p:cNvSpPr txBox="1"/>
          <p:nvPr/>
        </p:nvSpPr>
        <p:spPr>
          <a:xfrm>
            <a:off x="7883034" y="2307523"/>
            <a:ext cx="17824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aling-Extens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4" name="CuadroTexto 963"/>
          <p:cNvSpPr txBox="1"/>
          <p:nvPr/>
        </p:nvSpPr>
        <p:spPr>
          <a:xfrm>
            <a:off x="10449813" y="2264922"/>
            <a:ext cx="17824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uble</a:t>
            </a:r>
            <a:r>
              <a:rPr lang="es-CO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CO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rand</a:t>
            </a:r>
            <a:r>
              <a:rPr lang="es-CO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D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5" name="CuadroTexto 964"/>
          <p:cNvSpPr txBox="1"/>
          <p:nvPr/>
        </p:nvSpPr>
        <p:spPr>
          <a:xfrm>
            <a:off x="103768" y="449230"/>
            <a:ext cx="3509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6" name="CuadroTexto 965"/>
          <p:cNvSpPr txBox="1"/>
          <p:nvPr/>
        </p:nvSpPr>
        <p:spPr>
          <a:xfrm>
            <a:off x="4521366" y="472440"/>
            <a:ext cx="3509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7" name="CuadroTexto 966"/>
          <p:cNvSpPr txBox="1"/>
          <p:nvPr/>
        </p:nvSpPr>
        <p:spPr>
          <a:xfrm>
            <a:off x="171894" y="3377333"/>
            <a:ext cx="3509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8" name="CuadroTexto 967"/>
          <p:cNvSpPr txBox="1"/>
          <p:nvPr/>
        </p:nvSpPr>
        <p:spPr>
          <a:xfrm>
            <a:off x="4573693" y="3429539"/>
            <a:ext cx="3509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9" name="CuadroTexto 968"/>
          <p:cNvSpPr txBox="1"/>
          <p:nvPr/>
        </p:nvSpPr>
        <p:spPr>
          <a:xfrm>
            <a:off x="9019510" y="3413163"/>
            <a:ext cx="3530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1" name="CuadroTexto 970"/>
          <p:cNvSpPr txBox="1"/>
          <p:nvPr/>
        </p:nvSpPr>
        <p:spPr>
          <a:xfrm>
            <a:off x="1055030" y="3839111"/>
            <a:ext cx="116421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ligonucleotide     Probe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53811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0</TotalTime>
  <Words>62</Words>
  <Application>Microsoft Office PowerPoint</Application>
  <PresentationFormat>Panorámica</PresentationFormat>
  <Paragraphs>4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ime E. Castellanos</dc:creator>
  <cp:lastModifiedBy>Jaime E. Castellanos</cp:lastModifiedBy>
  <cp:revision>37</cp:revision>
  <dcterms:created xsi:type="dcterms:W3CDTF">2023-12-26T14:58:44Z</dcterms:created>
  <dcterms:modified xsi:type="dcterms:W3CDTF">2024-01-11T22:22:35Z</dcterms:modified>
</cp:coreProperties>
</file>